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32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2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-1434" y="-84"/>
      </p:cViewPr>
      <p:guideLst>
        <p:guide orient="horz" pos="232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teve\Desktop\fst%20for%20darcie\met%20outcome\kao.xlsm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3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578608923884513"/>
          <c:y val="0.16666719856515064"/>
          <c:w val="0.71570550204536421"/>
          <c:h val="0.6143810456911436"/>
        </c:manualLayout>
      </c:layout>
      <c:scatterChart>
        <c:scatterStyle val="lineMarker"/>
        <c:varyColors val="0"/>
        <c:ser>
          <c:idx val="1"/>
          <c:order val="0"/>
          <c:tx>
            <c:v>high</c:v>
          </c:tx>
          <c:spPr>
            <a:ln w="25400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Survival!$B$1777:$B$2031</c:f>
              <c:numCache>
                <c:formatCode>General</c:formatCode>
                <c:ptCount val="255"/>
                <c:pt idx="0">
                  <c:v>0</c:v>
                </c:pt>
                <c:pt idx="1">
                  <c:v>43</c:v>
                </c:pt>
                <c:pt idx="2">
                  <c:v>247</c:v>
                </c:pt>
                <c:pt idx="3">
                  <c:v>255</c:v>
                </c:pt>
                <c:pt idx="4">
                  <c:v>313</c:v>
                </c:pt>
                <c:pt idx="5">
                  <c:v>335</c:v>
                </c:pt>
                <c:pt idx="6">
                  <c:v>368</c:v>
                </c:pt>
                <c:pt idx="7">
                  <c:v>368</c:v>
                </c:pt>
                <c:pt idx="8">
                  <c:v>423</c:v>
                </c:pt>
                <c:pt idx="9">
                  <c:v>423</c:v>
                </c:pt>
                <c:pt idx="10">
                  <c:v>453</c:v>
                </c:pt>
                <c:pt idx="11">
                  <c:v>471</c:v>
                </c:pt>
                <c:pt idx="12">
                  <c:v>471</c:v>
                </c:pt>
                <c:pt idx="13">
                  <c:v>511</c:v>
                </c:pt>
                <c:pt idx="14">
                  <c:v>630</c:v>
                </c:pt>
                <c:pt idx="15">
                  <c:v>630</c:v>
                </c:pt>
                <c:pt idx="16">
                  <c:v>684</c:v>
                </c:pt>
                <c:pt idx="17">
                  <c:v>718</c:v>
                </c:pt>
                <c:pt idx="18">
                  <c:v>718</c:v>
                </c:pt>
                <c:pt idx="19">
                  <c:v>729</c:v>
                </c:pt>
                <c:pt idx="20">
                  <c:v>729</c:v>
                </c:pt>
                <c:pt idx="21">
                  <c:v>769</c:v>
                </c:pt>
                <c:pt idx="22">
                  <c:v>769</c:v>
                </c:pt>
                <c:pt idx="23">
                  <c:v>922</c:v>
                </c:pt>
                <c:pt idx="24">
                  <c:v>930</c:v>
                </c:pt>
                <c:pt idx="25">
                  <c:v>930</c:v>
                </c:pt>
                <c:pt idx="26">
                  <c:v>965</c:v>
                </c:pt>
                <c:pt idx="27">
                  <c:v>990</c:v>
                </c:pt>
                <c:pt idx="28">
                  <c:v>990</c:v>
                </c:pt>
                <c:pt idx="29">
                  <c:v>1001</c:v>
                </c:pt>
                <c:pt idx="30">
                  <c:v>1001</c:v>
                </c:pt>
                <c:pt idx="31">
                  <c:v>1111</c:v>
                </c:pt>
                <c:pt idx="32">
                  <c:v>1111</c:v>
                </c:pt>
                <c:pt idx="33">
                  <c:v>1121</c:v>
                </c:pt>
                <c:pt idx="34">
                  <c:v>1157</c:v>
                </c:pt>
                <c:pt idx="35">
                  <c:v>1157</c:v>
                </c:pt>
                <c:pt idx="36">
                  <c:v>1176</c:v>
                </c:pt>
                <c:pt idx="37">
                  <c:v>1246</c:v>
                </c:pt>
                <c:pt idx="38">
                  <c:v>1246</c:v>
                </c:pt>
                <c:pt idx="39">
                  <c:v>1296</c:v>
                </c:pt>
                <c:pt idx="40">
                  <c:v>1296</c:v>
                </c:pt>
                <c:pt idx="41">
                  <c:v>1299</c:v>
                </c:pt>
                <c:pt idx="42">
                  <c:v>1299</c:v>
                </c:pt>
                <c:pt idx="43">
                  <c:v>1327</c:v>
                </c:pt>
                <c:pt idx="44">
                  <c:v>1338</c:v>
                </c:pt>
                <c:pt idx="45">
                  <c:v>1338</c:v>
                </c:pt>
                <c:pt idx="46">
                  <c:v>1345</c:v>
                </c:pt>
                <c:pt idx="47">
                  <c:v>1345</c:v>
                </c:pt>
                <c:pt idx="48">
                  <c:v>1360</c:v>
                </c:pt>
                <c:pt idx="49">
                  <c:v>1368</c:v>
                </c:pt>
                <c:pt idx="50">
                  <c:v>1368</c:v>
                </c:pt>
                <c:pt idx="51">
                  <c:v>1371</c:v>
                </c:pt>
                <c:pt idx="52">
                  <c:v>1371</c:v>
                </c:pt>
                <c:pt idx="53">
                  <c:v>1415</c:v>
                </c:pt>
                <c:pt idx="54">
                  <c:v>1437</c:v>
                </c:pt>
                <c:pt idx="55">
                  <c:v>1437</c:v>
                </c:pt>
                <c:pt idx="56">
                  <c:v>1476</c:v>
                </c:pt>
                <c:pt idx="57">
                  <c:v>1476</c:v>
                </c:pt>
                <c:pt idx="58">
                  <c:v>1479</c:v>
                </c:pt>
                <c:pt idx="59">
                  <c:v>1479</c:v>
                </c:pt>
                <c:pt idx="60">
                  <c:v>1481</c:v>
                </c:pt>
                <c:pt idx="61">
                  <c:v>1502</c:v>
                </c:pt>
                <c:pt idx="62">
                  <c:v>1525</c:v>
                </c:pt>
                <c:pt idx="63">
                  <c:v>1536</c:v>
                </c:pt>
                <c:pt idx="64">
                  <c:v>1536</c:v>
                </c:pt>
                <c:pt idx="65">
                  <c:v>1651</c:v>
                </c:pt>
                <c:pt idx="66">
                  <c:v>1651</c:v>
                </c:pt>
                <c:pt idx="67">
                  <c:v>1655</c:v>
                </c:pt>
                <c:pt idx="68">
                  <c:v>1664</c:v>
                </c:pt>
                <c:pt idx="69">
                  <c:v>1664</c:v>
                </c:pt>
                <c:pt idx="70">
                  <c:v>1667</c:v>
                </c:pt>
                <c:pt idx="71">
                  <c:v>1673</c:v>
                </c:pt>
                <c:pt idx="72">
                  <c:v>1704</c:v>
                </c:pt>
                <c:pt idx="73">
                  <c:v>1730</c:v>
                </c:pt>
                <c:pt idx="74">
                  <c:v>1730</c:v>
                </c:pt>
                <c:pt idx="75">
                  <c:v>1738</c:v>
                </c:pt>
                <c:pt idx="76">
                  <c:v>1759</c:v>
                </c:pt>
                <c:pt idx="77">
                  <c:v>1759</c:v>
                </c:pt>
                <c:pt idx="78">
                  <c:v>1768</c:v>
                </c:pt>
                <c:pt idx="79">
                  <c:v>1788</c:v>
                </c:pt>
                <c:pt idx="80">
                  <c:v>1788</c:v>
                </c:pt>
                <c:pt idx="81">
                  <c:v>1808</c:v>
                </c:pt>
                <c:pt idx="82">
                  <c:v>1808</c:v>
                </c:pt>
                <c:pt idx="83">
                  <c:v>1809</c:v>
                </c:pt>
                <c:pt idx="84">
                  <c:v>1821</c:v>
                </c:pt>
                <c:pt idx="85">
                  <c:v>1838</c:v>
                </c:pt>
                <c:pt idx="86">
                  <c:v>1841</c:v>
                </c:pt>
                <c:pt idx="87">
                  <c:v>1851</c:v>
                </c:pt>
                <c:pt idx="88">
                  <c:v>1859</c:v>
                </c:pt>
                <c:pt idx="89">
                  <c:v>1870</c:v>
                </c:pt>
                <c:pt idx="90">
                  <c:v>1876</c:v>
                </c:pt>
                <c:pt idx="91">
                  <c:v>1883</c:v>
                </c:pt>
                <c:pt idx="92">
                  <c:v>1883</c:v>
                </c:pt>
                <c:pt idx="93">
                  <c:v>1884</c:v>
                </c:pt>
                <c:pt idx="94">
                  <c:v>1885</c:v>
                </c:pt>
                <c:pt idx="95">
                  <c:v>1885</c:v>
                </c:pt>
                <c:pt idx="96">
                  <c:v>1903</c:v>
                </c:pt>
                <c:pt idx="97">
                  <c:v>1918</c:v>
                </c:pt>
                <c:pt idx="98">
                  <c:v>1930</c:v>
                </c:pt>
                <c:pt idx="99">
                  <c:v>1938</c:v>
                </c:pt>
                <c:pt idx="100">
                  <c:v>1940</c:v>
                </c:pt>
                <c:pt idx="101">
                  <c:v>1958</c:v>
                </c:pt>
                <c:pt idx="102">
                  <c:v>1967</c:v>
                </c:pt>
                <c:pt idx="103">
                  <c:v>1992</c:v>
                </c:pt>
                <c:pt idx="104">
                  <c:v>2038</c:v>
                </c:pt>
                <c:pt idx="105">
                  <c:v>2125</c:v>
                </c:pt>
                <c:pt idx="106">
                  <c:v>2143</c:v>
                </c:pt>
                <c:pt idx="107">
                  <c:v>2143</c:v>
                </c:pt>
                <c:pt idx="108">
                  <c:v>2144</c:v>
                </c:pt>
                <c:pt idx="109">
                  <c:v>2155</c:v>
                </c:pt>
                <c:pt idx="110">
                  <c:v>2191</c:v>
                </c:pt>
                <c:pt idx="111">
                  <c:v>2198</c:v>
                </c:pt>
                <c:pt idx="112">
                  <c:v>2204</c:v>
                </c:pt>
                <c:pt idx="113">
                  <c:v>2211</c:v>
                </c:pt>
                <c:pt idx="114">
                  <c:v>2211</c:v>
                </c:pt>
                <c:pt idx="115">
                  <c:v>2258</c:v>
                </c:pt>
                <c:pt idx="116">
                  <c:v>2283</c:v>
                </c:pt>
                <c:pt idx="117">
                  <c:v>2319</c:v>
                </c:pt>
                <c:pt idx="118">
                  <c:v>2330</c:v>
                </c:pt>
                <c:pt idx="119">
                  <c:v>2330</c:v>
                </c:pt>
                <c:pt idx="120">
                  <c:v>2394</c:v>
                </c:pt>
                <c:pt idx="121">
                  <c:v>2401</c:v>
                </c:pt>
                <c:pt idx="122">
                  <c:v>2425</c:v>
                </c:pt>
                <c:pt idx="123">
                  <c:v>2554</c:v>
                </c:pt>
                <c:pt idx="124">
                  <c:v>2569</c:v>
                </c:pt>
                <c:pt idx="125">
                  <c:v>2576</c:v>
                </c:pt>
                <c:pt idx="126">
                  <c:v>2576</c:v>
                </c:pt>
                <c:pt idx="127">
                  <c:v>2582</c:v>
                </c:pt>
                <c:pt idx="128">
                  <c:v>2611</c:v>
                </c:pt>
                <c:pt idx="129">
                  <c:v>2612</c:v>
                </c:pt>
                <c:pt idx="130">
                  <c:v>2626</c:v>
                </c:pt>
                <c:pt idx="131">
                  <c:v>2626</c:v>
                </c:pt>
                <c:pt idx="132">
                  <c:v>2712</c:v>
                </c:pt>
                <c:pt idx="133">
                  <c:v>2712</c:v>
                </c:pt>
                <c:pt idx="134">
                  <c:v>2724</c:v>
                </c:pt>
                <c:pt idx="135">
                  <c:v>2724</c:v>
                </c:pt>
                <c:pt idx="136">
                  <c:v>2782</c:v>
                </c:pt>
                <c:pt idx="137">
                  <c:v>2782</c:v>
                </c:pt>
                <c:pt idx="138">
                  <c:v>2801</c:v>
                </c:pt>
                <c:pt idx="139">
                  <c:v>2801</c:v>
                </c:pt>
                <c:pt idx="140">
                  <c:v>2816</c:v>
                </c:pt>
                <c:pt idx="141">
                  <c:v>2876</c:v>
                </c:pt>
                <c:pt idx="142">
                  <c:v>2928</c:v>
                </c:pt>
                <c:pt idx="143">
                  <c:v>2928</c:v>
                </c:pt>
                <c:pt idx="144">
                  <c:v>2933</c:v>
                </c:pt>
                <c:pt idx="145">
                  <c:v>2933</c:v>
                </c:pt>
                <c:pt idx="146">
                  <c:v>2964</c:v>
                </c:pt>
                <c:pt idx="147">
                  <c:v>2999</c:v>
                </c:pt>
                <c:pt idx="148">
                  <c:v>2999</c:v>
                </c:pt>
                <c:pt idx="149">
                  <c:v>3038</c:v>
                </c:pt>
                <c:pt idx="150">
                  <c:v>3047</c:v>
                </c:pt>
                <c:pt idx="151">
                  <c:v>3064</c:v>
                </c:pt>
                <c:pt idx="152">
                  <c:v>3150</c:v>
                </c:pt>
                <c:pt idx="153">
                  <c:v>3245</c:v>
                </c:pt>
                <c:pt idx="154">
                  <c:v>3308</c:v>
                </c:pt>
                <c:pt idx="155">
                  <c:v>3319</c:v>
                </c:pt>
                <c:pt idx="156">
                  <c:v>3327</c:v>
                </c:pt>
                <c:pt idx="157">
                  <c:v>3415</c:v>
                </c:pt>
                <c:pt idx="158">
                  <c:v>3415</c:v>
                </c:pt>
                <c:pt idx="159">
                  <c:v>3469</c:v>
                </c:pt>
                <c:pt idx="160">
                  <c:v>3469</c:v>
                </c:pt>
                <c:pt idx="161">
                  <c:v>3509</c:v>
                </c:pt>
                <c:pt idx="162">
                  <c:v>3625</c:v>
                </c:pt>
                <c:pt idx="163">
                  <c:v>3652</c:v>
                </c:pt>
                <c:pt idx="164">
                  <c:v>3675</c:v>
                </c:pt>
                <c:pt idx="165">
                  <c:v>3695</c:v>
                </c:pt>
                <c:pt idx="166">
                  <c:v>3723</c:v>
                </c:pt>
                <c:pt idx="167">
                  <c:v>3726</c:v>
                </c:pt>
                <c:pt idx="168">
                  <c:v>3726</c:v>
                </c:pt>
                <c:pt idx="169">
                  <c:v>3752</c:v>
                </c:pt>
                <c:pt idx="170">
                  <c:v>3752</c:v>
                </c:pt>
                <c:pt idx="171">
                  <c:v>3793</c:v>
                </c:pt>
                <c:pt idx="172">
                  <c:v>3850</c:v>
                </c:pt>
                <c:pt idx="173">
                  <c:v>3948</c:v>
                </c:pt>
                <c:pt idx="174">
                  <c:v>3950</c:v>
                </c:pt>
                <c:pt idx="175">
                  <c:v>3950</c:v>
                </c:pt>
                <c:pt idx="176">
                  <c:v>4020</c:v>
                </c:pt>
                <c:pt idx="177">
                  <c:v>4028</c:v>
                </c:pt>
                <c:pt idx="178">
                  <c:v>4028</c:v>
                </c:pt>
                <c:pt idx="179">
                  <c:v>4056</c:v>
                </c:pt>
                <c:pt idx="180">
                  <c:v>4118</c:v>
                </c:pt>
                <c:pt idx="181">
                  <c:v>4120</c:v>
                </c:pt>
                <c:pt idx="182">
                  <c:v>4134</c:v>
                </c:pt>
                <c:pt idx="183">
                  <c:v>4135</c:v>
                </c:pt>
                <c:pt idx="184">
                  <c:v>4136</c:v>
                </c:pt>
                <c:pt idx="185">
                  <c:v>4153</c:v>
                </c:pt>
                <c:pt idx="186">
                  <c:v>4231</c:v>
                </c:pt>
                <c:pt idx="187">
                  <c:v>4241</c:v>
                </c:pt>
                <c:pt idx="188">
                  <c:v>4305</c:v>
                </c:pt>
                <c:pt idx="189">
                  <c:v>4374</c:v>
                </c:pt>
                <c:pt idx="190">
                  <c:v>4374</c:v>
                </c:pt>
                <c:pt idx="191">
                  <c:v>4403</c:v>
                </c:pt>
                <c:pt idx="192">
                  <c:v>4408</c:v>
                </c:pt>
                <c:pt idx="193">
                  <c:v>4518</c:v>
                </c:pt>
                <c:pt idx="194">
                  <c:v>4518</c:v>
                </c:pt>
                <c:pt idx="195">
                  <c:v>4521</c:v>
                </c:pt>
                <c:pt idx="196">
                  <c:v>4535</c:v>
                </c:pt>
                <c:pt idx="197">
                  <c:v>4548</c:v>
                </c:pt>
                <c:pt idx="198">
                  <c:v>4554</c:v>
                </c:pt>
                <c:pt idx="199">
                  <c:v>4562</c:v>
                </c:pt>
                <c:pt idx="200">
                  <c:v>4562</c:v>
                </c:pt>
                <c:pt idx="201">
                  <c:v>4662</c:v>
                </c:pt>
                <c:pt idx="202">
                  <c:v>4690</c:v>
                </c:pt>
                <c:pt idx="203">
                  <c:v>4703</c:v>
                </c:pt>
                <c:pt idx="204">
                  <c:v>4735</c:v>
                </c:pt>
                <c:pt idx="205">
                  <c:v>4735</c:v>
                </c:pt>
                <c:pt idx="206">
                  <c:v>4741</c:v>
                </c:pt>
                <c:pt idx="207">
                  <c:v>4787</c:v>
                </c:pt>
                <c:pt idx="208">
                  <c:v>4803</c:v>
                </c:pt>
                <c:pt idx="209">
                  <c:v>4807</c:v>
                </c:pt>
                <c:pt idx="210">
                  <c:v>4850</c:v>
                </c:pt>
                <c:pt idx="211">
                  <c:v>4850</c:v>
                </c:pt>
                <c:pt idx="212">
                  <c:v>4858</c:v>
                </c:pt>
                <c:pt idx="213">
                  <c:v>4858</c:v>
                </c:pt>
                <c:pt idx="214">
                  <c:v>4861</c:v>
                </c:pt>
                <c:pt idx="215">
                  <c:v>4930</c:v>
                </c:pt>
                <c:pt idx="216">
                  <c:v>4973</c:v>
                </c:pt>
                <c:pt idx="217">
                  <c:v>4989</c:v>
                </c:pt>
                <c:pt idx="218">
                  <c:v>5133</c:v>
                </c:pt>
                <c:pt idx="219">
                  <c:v>5153</c:v>
                </c:pt>
                <c:pt idx="220">
                  <c:v>5173</c:v>
                </c:pt>
                <c:pt idx="221">
                  <c:v>5192</c:v>
                </c:pt>
                <c:pt idx="222">
                  <c:v>5240</c:v>
                </c:pt>
                <c:pt idx="223">
                  <c:v>5245</c:v>
                </c:pt>
                <c:pt idx="224">
                  <c:v>5291</c:v>
                </c:pt>
                <c:pt idx="225">
                  <c:v>5362</c:v>
                </c:pt>
                <c:pt idx="226">
                  <c:v>5423</c:v>
                </c:pt>
                <c:pt idx="227">
                  <c:v>5423</c:v>
                </c:pt>
                <c:pt idx="228">
                  <c:v>5469</c:v>
                </c:pt>
                <c:pt idx="229">
                  <c:v>5529</c:v>
                </c:pt>
                <c:pt idx="230">
                  <c:v>5605</c:v>
                </c:pt>
                <c:pt idx="231">
                  <c:v>5605</c:v>
                </c:pt>
                <c:pt idx="232">
                  <c:v>5688</c:v>
                </c:pt>
                <c:pt idx="233">
                  <c:v>5812</c:v>
                </c:pt>
                <c:pt idx="234">
                  <c:v>5958</c:v>
                </c:pt>
                <c:pt idx="235">
                  <c:v>5958</c:v>
                </c:pt>
                <c:pt idx="236">
                  <c:v>5966</c:v>
                </c:pt>
                <c:pt idx="237">
                  <c:v>5977</c:v>
                </c:pt>
                <c:pt idx="238">
                  <c:v>5998</c:v>
                </c:pt>
                <c:pt idx="239">
                  <c:v>6048</c:v>
                </c:pt>
                <c:pt idx="240">
                  <c:v>6083</c:v>
                </c:pt>
                <c:pt idx="241">
                  <c:v>6184</c:v>
                </c:pt>
                <c:pt idx="242">
                  <c:v>6184</c:v>
                </c:pt>
                <c:pt idx="243">
                  <c:v>6261</c:v>
                </c:pt>
                <c:pt idx="244">
                  <c:v>6575</c:v>
                </c:pt>
                <c:pt idx="245">
                  <c:v>6575</c:v>
                </c:pt>
                <c:pt idx="246">
                  <c:v>6660</c:v>
                </c:pt>
                <c:pt idx="247">
                  <c:v>6828</c:v>
                </c:pt>
                <c:pt idx="248">
                  <c:v>6982</c:v>
                </c:pt>
                <c:pt idx="249">
                  <c:v>7441</c:v>
                </c:pt>
                <c:pt idx="250">
                  <c:v>8183</c:v>
                </c:pt>
                <c:pt idx="251">
                  <c:v>8441</c:v>
                </c:pt>
                <c:pt idx="252">
                  <c:v>8441</c:v>
                </c:pt>
                <c:pt idx="253">
                  <c:v>8735</c:v>
                </c:pt>
                <c:pt idx="254">
                  <c:v>9218</c:v>
                </c:pt>
              </c:numCache>
            </c:numRef>
          </c:xVal>
          <c:yVal>
            <c:numRef>
              <c:f>Survival!$C$1777:$C$2031</c:f>
              <c:numCache>
                <c:formatCode>General</c:formatCode>
                <c:ptCount val="255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0.99479166666666663</c:v>
                </c:pt>
                <c:pt idx="8">
                  <c:v>0.99479166666666663</c:v>
                </c:pt>
                <c:pt idx="9">
                  <c:v>0.98958333333333326</c:v>
                </c:pt>
                <c:pt idx="10">
                  <c:v>0.98958333333333326</c:v>
                </c:pt>
                <c:pt idx="11">
                  <c:v>0.98958333333333326</c:v>
                </c:pt>
                <c:pt idx="12">
                  <c:v>0.9843474426807759</c:v>
                </c:pt>
                <c:pt idx="13">
                  <c:v>0.9843474426807759</c:v>
                </c:pt>
                <c:pt idx="14">
                  <c:v>0.9843474426807759</c:v>
                </c:pt>
                <c:pt idx="15">
                  <c:v>0.97908355261296431</c:v>
                </c:pt>
                <c:pt idx="16">
                  <c:v>0.97908355261296431</c:v>
                </c:pt>
                <c:pt idx="17">
                  <c:v>0.97908355261296431</c:v>
                </c:pt>
                <c:pt idx="18">
                  <c:v>0.97379120908532668</c:v>
                </c:pt>
                <c:pt idx="19">
                  <c:v>0.97379120908532668</c:v>
                </c:pt>
                <c:pt idx="20">
                  <c:v>0.96849886555768905</c:v>
                </c:pt>
                <c:pt idx="21">
                  <c:v>0.96849886555768905</c:v>
                </c:pt>
                <c:pt idx="22">
                  <c:v>0.96320652203005142</c:v>
                </c:pt>
                <c:pt idx="23">
                  <c:v>0.96320652203005142</c:v>
                </c:pt>
                <c:pt idx="24">
                  <c:v>0.96320652203005142</c:v>
                </c:pt>
                <c:pt idx="25">
                  <c:v>0.95788493903541028</c:v>
                </c:pt>
                <c:pt idx="26">
                  <c:v>0.95788493903541028</c:v>
                </c:pt>
                <c:pt idx="27">
                  <c:v>0.95788493903541028</c:v>
                </c:pt>
                <c:pt idx="28">
                  <c:v>0.9525336265268326</c:v>
                </c:pt>
                <c:pt idx="29">
                  <c:v>0.9525336265268326</c:v>
                </c:pt>
                <c:pt idx="30">
                  <c:v>0.94718231401825492</c:v>
                </c:pt>
                <c:pt idx="31">
                  <c:v>0.94718231401825492</c:v>
                </c:pt>
                <c:pt idx="32">
                  <c:v>0.94183100150967725</c:v>
                </c:pt>
                <c:pt idx="33">
                  <c:v>0.94183100150967725</c:v>
                </c:pt>
                <c:pt idx="34">
                  <c:v>0.94183100150967725</c:v>
                </c:pt>
                <c:pt idx="35">
                  <c:v>0.93644911007247911</c:v>
                </c:pt>
                <c:pt idx="36">
                  <c:v>0.93644911007247911</c:v>
                </c:pt>
                <c:pt idx="37">
                  <c:v>0.93644911007247911</c:v>
                </c:pt>
                <c:pt idx="38">
                  <c:v>0.93103610943622195</c:v>
                </c:pt>
                <c:pt idx="39">
                  <c:v>0.93103610943622195</c:v>
                </c:pt>
                <c:pt idx="40">
                  <c:v>0.92562310879996479</c:v>
                </c:pt>
                <c:pt idx="41">
                  <c:v>0.92562310879996479</c:v>
                </c:pt>
                <c:pt idx="42">
                  <c:v>0.92021010816370774</c:v>
                </c:pt>
                <c:pt idx="43">
                  <c:v>0.92021010816370774</c:v>
                </c:pt>
                <c:pt idx="44">
                  <c:v>0.92021010816370774</c:v>
                </c:pt>
                <c:pt idx="45">
                  <c:v>0.91476507793788697</c:v>
                </c:pt>
                <c:pt idx="46">
                  <c:v>0.91476507793788697</c:v>
                </c:pt>
                <c:pt idx="47">
                  <c:v>0.9093200477120662</c:v>
                </c:pt>
                <c:pt idx="48">
                  <c:v>0.9093200477120662</c:v>
                </c:pt>
                <c:pt idx="49">
                  <c:v>0.9093200477120662</c:v>
                </c:pt>
                <c:pt idx="50">
                  <c:v>0.9038422160993429</c:v>
                </c:pt>
                <c:pt idx="51">
                  <c:v>0.9038422160993429</c:v>
                </c:pt>
                <c:pt idx="52">
                  <c:v>0.89836438448661959</c:v>
                </c:pt>
                <c:pt idx="53">
                  <c:v>0.89836438448661959</c:v>
                </c:pt>
                <c:pt idx="54">
                  <c:v>0.89836438448661959</c:v>
                </c:pt>
                <c:pt idx="55">
                  <c:v>0.89285294654498393</c:v>
                </c:pt>
                <c:pt idx="56">
                  <c:v>0.89285294654498393</c:v>
                </c:pt>
                <c:pt idx="57">
                  <c:v>0.88734150860334826</c:v>
                </c:pt>
                <c:pt idx="58">
                  <c:v>0.88734150860334826</c:v>
                </c:pt>
                <c:pt idx="59">
                  <c:v>0.8818300706617126</c:v>
                </c:pt>
                <c:pt idx="60">
                  <c:v>0.8818300706617126</c:v>
                </c:pt>
                <c:pt idx="61">
                  <c:v>0.8818300706617126</c:v>
                </c:pt>
                <c:pt idx="62">
                  <c:v>0.8818300706617126</c:v>
                </c:pt>
                <c:pt idx="63">
                  <c:v>0.8818300706617126</c:v>
                </c:pt>
                <c:pt idx="64">
                  <c:v>0.87621331861928131</c:v>
                </c:pt>
                <c:pt idx="65">
                  <c:v>0.87621331861928131</c:v>
                </c:pt>
                <c:pt idx="66">
                  <c:v>0.87059656657685003</c:v>
                </c:pt>
                <c:pt idx="67">
                  <c:v>0.87059656657685003</c:v>
                </c:pt>
                <c:pt idx="68">
                  <c:v>0.87059656657685003</c:v>
                </c:pt>
                <c:pt idx="69">
                  <c:v>0.86494334211855883</c:v>
                </c:pt>
                <c:pt idx="70">
                  <c:v>0.86494334211855883</c:v>
                </c:pt>
                <c:pt idx="71">
                  <c:v>0.86494334211855883</c:v>
                </c:pt>
                <c:pt idx="72">
                  <c:v>0.86494334211855883</c:v>
                </c:pt>
                <c:pt idx="73">
                  <c:v>0.86494334211855883</c:v>
                </c:pt>
                <c:pt idx="74">
                  <c:v>0.85917705317110182</c:v>
                </c:pt>
                <c:pt idx="75">
                  <c:v>0.85917705317110182</c:v>
                </c:pt>
                <c:pt idx="76">
                  <c:v>0.85917705317110182</c:v>
                </c:pt>
                <c:pt idx="77">
                  <c:v>0.85337180281183767</c:v>
                </c:pt>
                <c:pt idx="78">
                  <c:v>0.85337180281183767</c:v>
                </c:pt>
                <c:pt idx="79">
                  <c:v>0.85337180281183767</c:v>
                </c:pt>
                <c:pt idx="80">
                  <c:v>0.84752679046381141</c:v>
                </c:pt>
                <c:pt idx="81">
                  <c:v>0.84752679046381141</c:v>
                </c:pt>
                <c:pt idx="82">
                  <c:v>0.84168177811578515</c:v>
                </c:pt>
                <c:pt idx="83">
                  <c:v>0.84168177811578515</c:v>
                </c:pt>
                <c:pt idx="84">
                  <c:v>0.84168177811578515</c:v>
                </c:pt>
                <c:pt idx="85">
                  <c:v>0.84168177811578515</c:v>
                </c:pt>
                <c:pt idx="86">
                  <c:v>0.84168177811578515</c:v>
                </c:pt>
                <c:pt idx="87">
                  <c:v>0.84168177811578515</c:v>
                </c:pt>
                <c:pt idx="88">
                  <c:v>0.84168177811578515</c:v>
                </c:pt>
                <c:pt idx="89">
                  <c:v>0.84168177811578515</c:v>
                </c:pt>
                <c:pt idx="90">
                  <c:v>0.84168177811578515</c:v>
                </c:pt>
                <c:pt idx="91">
                  <c:v>0.84168177811578515</c:v>
                </c:pt>
                <c:pt idx="92">
                  <c:v>0.83540057081641361</c:v>
                </c:pt>
                <c:pt idx="93">
                  <c:v>0.83540057081641361</c:v>
                </c:pt>
                <c:pt idx="94">
                  <c:v>0.83540057081641361</c:v>
                </c:pt>
                <c:pt idx="95">
                  <c:v>0.82907177861325898</c:v>
                </c:pt>
                <c:pt idx="96">
                  <c:v>0.82907177861325898</c:v>
                </c:pt>
                <c:pt idx="97">
                  <c:v>0.82907177861325898</c:v>
                </c:pt>
                <c:pt idx="98">
                  <c:v>0.82907177861325898</c:v>
                </c:pt>
                <c:pt idx="99">
                  <c:v>0.82907177861325898</c:v>
                </c:pt>
                <c:pt idx="100">
                  <c:v>0.82907177861325898</c:v>
                </c:pt>
                <c:pt idx="101">
                  <c:v>0.82907177861325898</c:v>
                </c:pt>
                <c:pt idx="102">
                  <c:v>0.82907177861325898</c:v>
                </c:pt>
                <c:pt idx="103">
                  <c:v>0.82907177861325898</c:v>
                </c:pt>
                <c:pt idx="104">
                  <c:v>0.82907177861325898</c:v>
                </c:pt>
                <c:pt idx="105">
                  <c:v>0.82907177861325898</c:v>
                </c:pt>
                <c:pt idx="106">
                  <c:v>0.82907177861325898</c:v>
                </c:pt>
                <c:pt idx="107">
                  <c:v>0.82216284712481513</c:v>
                </c:pt>
                <c:pt idx="108">
                  <c:v>0.82216284712481513</c:v>
                </c:pt>
                <c:pt idx="109">
                  <c:v>0.82216284712481513</c:v>
                </c:pt>
                <c:pt idx="110">
                  <c:v>0.82216284712481513</c:v>
                </c:pt>
                <c:pt idx="111">
                  <c:v>0.82216284712481513</c:v>
                </c:pt>
                <c:pt idx="112">
                  <c:v>0.82216284712481513</c:v>
                </c:pt>
                <c:pt idx="113">
                  <c:v>0.82216284712481513</c:v>
                </c:pt>
                <c:pt idx="114">
                  <c:v>0.81495089232547469</c:v>
                </c:pt>
                <c:pt idx="115">
                  <c:v>0.81495089232547469</c:v>
                </c:pt>
                <c:pt idx="116">
                  <c:v>0.81495089232547469</c:v>
                </c:pt>
                <c:pt idx="117">
                  <c:v>0.81495089232547469</c:v>
                </c:pt>
                <c:pt idx="118">
                  <c:v>0.81495089232547469</c:v>
                </c:pt>
                <c:pt idx="119">
                  <c:v>0.80754224784978856</c:v>
                </c:pt>
                <c:pt idx="120">
                  <c:v>0.80754224784978856</c:v>
                </c:pt>
                <c:pt idx="121">
                  <c:v>0.80754224784978856</c:v>
                </c:pt>
                <c:pt idx="122">
                  <c:v>0.80754224784978856</c:v>
                </c:pt>
                <c:pt idx="123">
                  <c:v>0.80754224784978856</c:v>
                </c:pt>
                <c:pt idx="124">
                  <c:v>0.80754224784978856</c:v>
                </c:pt>
                <c:pt idx="125">
                  <c:v>0.80754224784978856</c:v>
                </c:pt>
                <c:pt idx="126">
                  <c:v>0.79977741854354056</c:v>
                </c:pt>
                <c:pt idx="127">
                  <c:v>0.79977741854354056</c:v>
                </c:pt>
                <c:pt idx="128">
                  <c:v>0.79977741854354056</c:v>
                </c:pt>
                <c:pt idx="129">
                  <c:v>0.79977741854354056</c:v>
                </c:pt>
                <c:pt idx="130">
                  <c:v>0.79977741854354056</c:v>
                </c:pt>
                <c:pt idx="131">
                  <c:v>0.79177964435810511</c:v>
                </c:pt>
                <c:pt idx="132">
                  <c:v>0.79177964435810511</c:v>
                </c:pt>
                <c:pt idx="133">
                  <c:v>0.78378187017266965</c:v>
                </c:pt>
                <c:pt idx="134">
                  <c:v>0.78378187017266965</c:v>
                </c:pt>
                <c:pt idx="135">
                  <c:v>0.77578409598723419</c:v>
                </c:pt>
                <c:pt idx="136">
                  <c:v>0.77578409598723419</c:v>
                </c:pt>
                <c:pt idx="137">
                  <c:v>0.76778632180179873</c:v>
                </c:pt>
                <c:pt idx="138">
                  <c:v>0.76778632180179873</c:v>
                </c:pt>
                <c:pt idx="139">
                  <c:v>0.75978854761636327</c:v>
                </c:pt>
                <c:pt idx="140">
                  <c:v>0.75978854761636327</c:v>
                </c:pt>
                <c:pt idx="141">
                  <c:v>0.75978854761636327</c:v>
                </c:pt>
                <c:pt idx="142">
                  <c:v>0.75978854761636327</c:v>
                </c:pt>
                <c:pt idx="143">
                  <c:v>0.75161877828715506</c:v>
                </c:pt>
                <c:pt idx="144">
                  <c:v>0.75161877828715506</c:v>
                </c:pt>
                <c:pt idx="145">
                  <c:v>0.74344900895794686</c:v>
                </c:pt>
                <c:pt idx="146">
                  <c:v>0.74344900895794686</c:v>
                </c:pt>
                <c:pt idx="147">
                  <c:v>0.74344900895794686</c:v>
                </c:pt>
                <c:pt idx="148">
                  <c:v>0.73509564930673399</c:v>
                </c:pt>
                <c:pt idx="149">
                  <c:v>0.73509564930673399</c:v>
                </c:pt>
                <c:pt idx="150">
                  <c:v>0.73509564930673399</c:v>
                </c:pt>
                <c:pt idx="151">
                  <c:v>0.73509564930673399</c:v>
                </c:pt>
                <c:pt idx="152">
                  <c:v>0.73509564930673399</c:v>
                </c:pt>
                <c:pt idx="153">
                  <c:v>0.73509564930673399</c:v>
                </c:pt>
                <c:pt idx="154">
                  <c:v>0.73509564930673399</c:v>
                </c:pt>
                <c:pt idx="155">
                  <c:v>0.73509564930673399</c:v>
                </c:pt>
                <c:pt idx="156">
                  <c:v>0.73509564930673399</c:v>
                </c:pt>
                <c:pt idx="157">
                  <c:v>0.73509564930673399</c:v>
                </c:pt>
                <c:pt idx="158">
                  <c:v>0.72590695369039981</c:v>
                </c:pt>
                <c:pt idx="159">
                  <c:v>0.72590695369039981</c:v>
                </c:pt>
                <c:pt idx="160">
                  <c:v>0.71671825807406564</c:v>
                </c:pt>
                <c:pt idx="161">
                  <c:v>0.71671825807406564</c:v>
                </c:pt>
                <c:pt idx="162">
                  <c:v>0.71671825807406564</c:v>
                </c:pt>
                <c:pt idx="163">
                  <c:v>0.71671825807406564</c:v>
                </c:pt>
                <c:pt idx="164">
                  <c:v>0.71671825807406564</c:v>
                </c:pt>
                <c:pt idx="165">
                  <c:v>0.71671825807406564</c:v>
                </c:pt>
                <c:pt idx="166">
                  <c:v>0.71671825807406564</c:v>
                </c:pt>
                <c:pt idx="167">
                  <c:v>0.71671825807406564</c:v>
                </c:pt>
                <c:pt idx="168">
                  <c:v>0.70676383782303698</c:v>
                </c:pt>
                <c:pt idx="169">
                  <c:v>0.70676383782303698</c:v>
                </c:pt>
                <c:pt idx="170">
                  <c:v>0.69680941757200832</c:v>
                </c:pt>
                <c:pt idx="171">
                  <c:v>0.69680941757200832</c:v>
                </c:pt>
                <c:pt idx="172">
                  <c:v>0.69680941757200832</c:v>
                </c:pt>
                <c:pt idx="173">
                  <c:v>0.69680941757200832</c:v>
                </c:pt>
                <c:pt idx="174">
                  <c:v>0.69680941757200832</c:v>
                </c:pt>
                <c:pt idx="175">
                  <c:v>0.68640927701123211</c:v>
                </c:pt>
                <c:pt idx="176">
                  <c:v>0.68640927701123211</c:v>
                </c:pt>
                <c:pt idx="177">
                  <c:v>0.68640927701123211</c:v>
                </c:pt>
                <c:pt idx="178">
                  <c:v>0.67584913428798243</c:v>
                </c:pt>
                <c:pt idx="179">
                  <c:v>0.67584913428798243</c:v>
                </c:pt>
                <c:pt idx="180">
                  <c:v>0.67584913428798243</c:v>
                </c:pt>
                <c:pt idx="181">
                  <c:v>0.67584913428798243</c:v>
                </c:pt>
                <c:pt idx="182">
                  <c:v>0.67584913428798243</c:v>
                </c:pt>
                <c:pt idx="183">
                  <c:v>0.67584913428798243</c:v>
                </c:pt>
                <c:pt idx="184">
                  <c:v>0.67584913428798243</c:v>
                </c:pt>
                <c:pt idx="185">
                  <c:v>0.67584913428798243</c:v>
                </c:pt>
                <c:pt idx="186">
                  <c:v>0.67584913428798243</c:v>
                </c:pt>
                <c:pt idx="187">
                  <c:v>0.67584913428798243</c:v>
                </c:pt>
                <c:pt idx="188">
                  <c:v>0.67584913428798243</c:v>
                </c:pt>
                <c:pt idx="189">
                  <c:v>0.67584913428798243</c:v>
                </c:pt>
                <c:pt idx="190">
                  <c:v>0.66333340957894571</c:v>
                </c:pt>
                <c:pt idx="191">
                  <c:v>0.66333340957894571</c:v>
                </c:pt>
                <c:pt idx="192">
                  <c:v>0.66333340957894571</c:v>
                </c:pt>
                <c:pt idx="193">
                  <c:v>0.66333340957894571</c:v>
                </c:pt>
                <c:pt idx="194">
                  <c:v>0.65032687213622131</c:v>
                </c:pt>
                <c:pt idx="195">
                  <c:v>0.65032687213622131</c:v>
                </c:pt>
                <c:pt idx="196">
                  <c:v>0.65032687213622131</c:v>
                </c:pt>
                <c:pt idx="197">
                  <c:v>0.65032687213622131</c:v>
                </c:pt>
                <c:pt idx="198">
                  <c:v>0.65032687213622131</c:v>
                </c:pt>
                <c:pt idx="199">
                  <c:v>0.65032687213622131</c:v>
                </c:pt>
                <c:pt idx="200">
                  <c:v>0.63618933143760781</c:v>
                </c:pt>
                <c:pt idx="201">
                  <c:v>0.63618933143760781</c:v>
                </c:pt>
                <c:pt idx="202">
                  <c:v>0.63618933143760781</c:v>
                </c:pt>
                <c:pt idx="203">
                  <c:v>0.63618933143760781</c:v>
                </c:pt>
                <c:pt idx="204">
                  <c:v>0.63618933143760781</c:v>
                </c:pt>
                <c:pt idx="205">
                  <c:v>0.62104196640337905</c:v>
                </c:pt>
                <c:pt idx="206">
                  <c:v>0.62104196640337905</c:v>
                </c:pt>
                <c:pt idx="207">
                  <c:v>0.62104196640337905</c:v>
                </c:pt>
                <c:pt idx="208">
                  <c:v>0.62104196640337905</c:v>
                </c:pt>
                <c:pt idx="209">
                  <c:v>0.62104196640337905</c:v>
                </c:pt>
                <c:pt idx="210">
                  <c:v>0.62104196640337905</c:v>
                </c:pt>
                <c:pt idx="211">
                  <c:v>0.60425704839247696</c:v>
                </c:pt>
                <c:pt idx="212">
                  <c:v>0.60425704839247696</c:v>
                </c:pt>
                <c:pt idx="213">
                  <c:v>0.58747213038157486</c:v>
                </c:pt>
                <c:pt idx="214">
                  <c:v>0.58747213038157486</c:v>
                </c:pt>
                <c:pt idx="215">
                  <c:v>0.58747213038157486</c:v>
                </c:pt>
                <c:pt idx="216">
                  <c:v>0.58747213038157486</c:v>
                </c:pt>
                <c:pt idx="217">
                  <c:v>0.58747213038157486</c:v>
                </c:pt>
                <c:pt idx="218">
                  <c:v>0.58747213038157486</c:v>
                </c:pt>
                <c:pt idx="219">
                  <c:v>0.58747213038157486</c:v>
                </c:pt>
                <c:pt idx="220">
                  <c:v>0.58747213038157486</c:v>
                </c:pt>
                <c:pt idx="221">
                  <c:v>0.58747213038157486</c:v>
                </c:pt>
                <c:pt idx="222">
                  <c:v>0.58747213038157486</c:v>
                </c:pt>
                <c:pt idx="223">
                  <c:v>0.58747213038157486</c:v>
                </c:pt>
                <c:pt idx="224">
                  <c:v>0.58747213038157486</c:v>
                </c:pt>
                <c:pt idx="225">
                  <c:v>0.58747213038157486</c:v>
                </c:pt>
                <c:pt idx="226">
                  <c:v>0.58747213038157486</c:v>
                </c:pt>
                <c:pt idx="227">
                  <c:v>0.5619298638432455</c:v>
                </c:pt>
                <c:pt idx="228">
                  <c:v>0.5619298638432455</c:v>
                </c:pt>
                <c:pt idx="229">
                  <c:v>0.5619298638432455</c:v>
                </c:pt>
                <c:pt idx="230">
                  <c:v>0.5619298638432455</c:v>
                </c:pt>
                <c:pt idx="231">
                  <c:v>0.53383337065108327</c:v>
                </c:pt>
                <c:pt idx="232">
                  <c:v>0.53383337065108327</c:v>
                </c:pt>
                <c:pt idx="233">
                  <c:v>0.53383337065108327</c:v>
                </c:pt>
                <c:pt idx="234">
                  <c:v>0.53383337065108327</c:v>
                </c:pt>
                <c:pt idx="235">
                  <c:v>0.50243140767160777</c:v>
                </c:pt>
                <c:pt idx="236">
                  <c:v>0.50243140767160777</c:v>
                </c:pt>
                <c:pt idx="237">
                  <c:v>0.50243140767160777</c:v>
                </c:pt>
                <c:pt idx="238">
                  <c:v>0.50243140767160777</c:v>
                </c:pt>
                <c:pt idx="239">
                  <c:v>0.50243140767160777</c:v>
                </c:pt>
                <c:pt idx="240">
                  <c:v>0.50243140767160777</c:v>
                </c:pt>
                <c:pt idx="241">
                  <c:v>0.50243140767160777</c:v>
                </c:pt>
                <c:pt idx="242">
                  <c:v>0.45675582515600704</c:v>
                </c:pt>
                <c:pt idx="243">
                  <c:v>0.45675582515600704</c:v>
                </c:pt>
                <c:pt idx="244">
                  <c:v>0.45675582515600704</c:v>
                </c:pt>
                <c:pt idx="245">
                  <c:v>0.40600517791645069</c:v>
                </c:pt>
                <c:pt idx="246">
                  <c:v>0.40600517791645069</c:v>
                </c:pt>
                <c:pt idx="247">
                  <c:v>0.40600517791645069</c:v>
                </c:pt>
                <c:pt idx="248">
                  <c:v>0.40600517791645069</c:v>
                </c:pt>
                <c:pt idx="249">
                  <c:v>0.40600517791645069</c:v>
                </c:pt>
                <c:pt idx="250">
                  <c:v>0.40600517791645069</c:v>
                </c:pt>
                <c:pt idx="251">
                  <c:v>0.40600517791645069</c:v>
                </c:pt>
                <c:pt idx="252">
                  <c:v>0.27067011861096713</c:v>
                </c:pt>
                <c:pt idx="253">
                  <c:v>0.27067011861096713</c:v>
                </c:pt>
                <c:pt idx="254">
                  <c:v>0.2706701186109671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5BE-4834-A852-601CC64CF308}"/>
            </c:ext>
          </c:extLst>
        </c:ser>
        <c:ser>
          <c:idx val="2"/>
          <c:order val="1"/>
          <c:tx>
            <c:v>low</c:v>
          </c:tx>
          <c:spPr>
            <a:ln w="25400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Survival!$B$2032:$B$4321</c:f>
              <c:numCache>
                <c:formatCode>General</c:formatCode>
                <c:ptCount val="2290"/>
                <c:pt idx="0">
                  <c:v>0</c:v>
                </c:pt>
                <c:pt idx="1">
                  <c:v>3</c:v>
                </c:pt>
                <c:pt idx="2">
                  <c:v>3</c:v>
                </c:pt>
                <c:pt idx="3">
                  <c:v>8</c:v>
                </c:pt>
                <c:pt idx="4">
                  <c:v>8</c:v>
                </c:pt>
                <c:pt idx="5">
                  <c:v>21</c:v>
                </c:pt>
                <c:pt idx="6">
                  <c:v>23</c:v>
                </c:pt>
                <c:pt idx="7">
                  <c:v>37</c:v>
                </c:pt>
                <c:pt idx="8">
                  <c:v>49</c:v>
                </c:pt>
                <c:pt idx="9">
                  <c:v>53</c:v>
                </c:pt>
                <c:pt idx="10">
                  <c:v>56</c:v>
                </c:pt>
                <c:pt idx="11">
                  <c:v>59</c:v>
                </c:pt>
                <c:pt idx="12">
                  <c:v>60</c:v>
                </c:pt>
                <c:pt idx="13">
                  <c:v>69</c:v>
                </c:pt>
                <c:pt idx="14">
                  <c:v>69</c:v>
                </c:pt>
                <c:pt idx="15">
                  <c:v>76</c:v>
                </c:pt>
                <c:pt idx="16">
                  <c:v>76</c:v>
                </c:pt>
                <c:pt idx="17">
                  <c:v>77</c:v>
                </c:pt>
                <c:pt idx="18">
                  <c:v>77</c:v>
                </c:pt>
                <c:pt idx="19">
                  <c:v>101</c:v>
                </c:pt>
                <c:pt idx="20">
                  <c:v>105</c:v>
                </c:pt>
                <c:pt idx="21">
                  <c:v>105</c:v>
                </c:pt>
                <c:pt idx="22">
                  <c:v>125</c:v>
                </c:pt>
                <c:pt idx="23">
                  <c:v>125</c:v>
                </c:pt>
                <c:pt idx="24">
                  <c:v>126</c:v>
                </c:pt>
                <c:pt idx="25">
                  <c:v>130</c:v>
                </c:pt>
                <c:pt idx="26">
                  <c:v>133</c:v>
                </c:pt>
                <c:pt idx="27">
                  <c:v>133</c:v>
                </c:pt>
                <c:pt idx="28">
                  <c:v>135</c:v>
                </c:pt>
                <c:pt idx="29">
                  <c:v>146</c:v>
                </c:pt>
                <c:pt idx="30">
                  <c:v>152</c:v>
                </c:pt>
                <c:pt idx="31">
                  <c:v>152</c:v>
                </c:pt>
                <c:pt idx="32">
                  <c:v>159</c:v>
                </c:pt>
                <c:pt idx="33">
                  <c:v>159</c:v>
                </c:pt>
                <c:pt idx="34">
                  <c:v>163</c:v>
                </c:pt>
                <c:pt idx="35">
                  <c:v>169</c:v>
                </c:pt>
                <c:pt idx="36">
                  <c:v>175</c:v>
                </c:pt>
                <c:pt idx="37">
                  <c:v>175</c:v>
                </c:pt>
                <c:pt idx="38">
                  <c:v>179</c:v>
                </c:pt>
                <c:pt idx="39">
                  <c:v>180</c:v>
                </c:pt>
                <c:pt idx="40">
                  <c:v>185</c:v>
                </c:pt>
                <c:pt idx="41">
                  <c:v>188</c:v>
                </c:pt>
                <c:pt idx="42">
                  <c:v>188</c:v>
                </c:pt>
                <c:pt idx="43">
                  <c:v>202</c:v>
                </c:pt>
                <c:pt idx="44">
                  <c:v>205</c:v>
                </c:pt>
                <c:pt idx="45">
                  <c:v>205</c:v>
                </c:pt>
                <c:pt idx="46">
                  <c:v>232</c:v>
                </c:pt>
                <c:pt idx="47">
                  <c:v>234</c:v>
                </c:pt>
                <c:pt idx="48">
                  <c:v>234</c:v>
                </c:pt>
                <c:pt idx="49">
                  <c:v>236</c:v>
                </c:pt>
                <c:pt idx="50">
                  <c:v>236</c:v>
                </c:pt>
                <c:pt idx="51">
                  <c:v>242</c:v>
                </c:pt>
                <c:pt idx="52">
                  <c:v>242</c:v>
                </c:pt>
                <c:pt idx="53">
                  <c:v>253</c:v>
                </c:pt>
                <c:pt idx="54">
                  <c:v>257</c:v>
                </c:pt>
                <c:pt idx="55">
                  <c:v>260</c:v>
                </c:pt>
                <c:pt idx="56">
                  <c:v>272</c:v>
                </c:pt>
                <c:pt idx="57">
                  <c:v>272</c:v>
                </c:pt>
                <c:pt idx="58">
                  <c:v>273</c:v>
                </c:pt>
                <c:pt idx="59">
                  <c:v>274</c:v>
                </c:pt>
                <c:pt idx="60">
                  <c:v>274</c:v>
                </c:pt>
                <c:pt idx="61">
                  <c:v>283</c:v>
                </c:pt>
                <c:pt idx="62">
                  <c:v>283</c:v>
                </c:pt>
                <c:pt idx="63">
                  <c:v>288</c:v>
                </c:pt>
                <c:pt idx="64">
                  <c:v>288</c:v>
                </c:pt>
                <c:pt idx="65">
                  <c:v>291</c:v>
                </c:pt>
                <c:pt idx="66">
                  <c:v>291</c:v>
                </c:pt>
                <c:pt idx="67">
                  <c:v>295</c:v>
                </c:pt>
                <c:pt idx="68">
                  <c:v>295</c:v>
                </c:pt>
                <c:pt idx="69">
                  <c:v>299</c:v>
                </c:pt>
                <c:pt idx="70">
                  <c:v>302</c:v>
                </c:pt>
                <c:pt idx="71">
                  <c:v>302</c:v>
                </c:pt>
                <c:pt idx="72">
                  <c:v>318</c:v>
                </c:pt>
                <c:pt idx="73">
                  <c:v>318</c:v>
                </c:pt>
                <c:pt idx="74">
                  <c:v>319</c:v>
                </c:pt>
                <c:pt idx="75">
                  <c:v>319</c:v>
                </c:pt>
                <c:pt idx="76">
                  <c:v>325</c:v>
                </c:pt>
                <c:pt idx="77">
                  <c:v>325</c:v>
                </c:pt>
                <c:pt idx="78">
                  <c:v>326</c:v>
                </c:pt>
                <c:pt idx="79">
                  <c:v>326</c:v>
                </c:pt>
                <c:pt idx="80">
                  <c:v>339</c:v>
                </c:pt>
                <c:pt idx="81">
                  <c:v>339</c:v>
                </c:pt>
                <c:pt idx="82">
                  <c:v>342</c:v>
                </c:pt>
                <c:pt idx="83">
                  <c:v>348</c:v>
                </c:pt>
                <c:pt idx="84">
                  <c:v>348</c:v>
                </c:pt>
                <c:pt idx="85">
                  <c:v>351</c:v>
                </c:pt>
                <c:pt idx="86">
                  <c:v>351</c:v>
                </c:pt>
                <c:pt idx="87">
                  <c:v>356</c:v>
                </c:pt>
                <c:pt idx="88">
                  <c:v>356</c:v>
                </c:pt>
                <c:pt idx="89">
                  <c:v>358</c:v>
                </c:pt>
                <c:pt idx="90">
                  <c:v>358</c:v>
                </c:pt>
                <c:pt idx="91">
                  <c:v>363</c:v>
                </c:pt>
                <c:pt idx="92">
                  <c:v>364</c:v>
                </c:pt>
                <c:pt idx="93">
                  <c:v>372</c:v>
                </c:pt>
                <c:pt idx="94">
                  <c:v>385</c:v>
                </c:pt>
                <c:pt idx="95">
                  <c:v>387</c:v>
                </c:pt>
                <c:pt idx="96">
                  <c:v>388</c:v>
                </c:pt>
                <c:pt idx="97">
                  <c:v>388</c:v>
                </c:pt>
                <c:pt idx="98">
                  <c:v>394</c:v>
                </c:pt>
                <c:pt idx="99">
                  <c:v>399</c:v>
                </c:pt>
                <c:pt idx="100">
                  <c:v>402</c:v>
                </c:pt>
                <c:pt idx="101">
                  <c:v>402</c:v>
                </c:pt>
                <c:pt idx="102">
                  <c:v>406</c:v>
                </c:pt>
                <c:pt idx="103">
                  <c:v>406</c:v>
                </c:pt>
                <c:pt idx="104">
                  <c:v>414</c:v>
                </c:pt>
                <c:pt idx="105">
                  <c:v>414</c:v>
                </c:pt>
                <c:pt idx="106">
                  <c:v>424</c:v>
                </c:pt>
                <c:pt idx="107">
                  <c:v>424</c:v>
                </c:pt>
                <c:pt idx="108">
                  <c:v>425</c:v>
                </c:pt>
                <c:pt idx="109">
                  <c:v>425</c:v>
                </c:pt>
                <c:pt idx="110">
                  <c:v>426</c:v>
                </c:pt>
                <c:pt idx="111">
                  <c:v>426</c:v>
                </c:pt>
                <c:pt idx="112">
                  <c:v>427</c:v>
                </c:pt>
                <c:pt idx="113">
                  <c:v>432</c:v>
                </c:pt>
                <c:pt idx="114">
                  <c:v>432</c:v>
                </c:pt>
                <c:pt idx="115">
                  <c:v>433</c:v>
                </c:pt>
                <c:pt idx="116">
                  <c:v>433</c:v>
                </c:pt>
                <c:pt idx="117">
                  <c:v>437</c:v>
                </c:pt>
                <c:pt idx="118">
                  <c:v>441</c:v>
                </c:pt>
                <c:pt idx="119">
                  <c:v>441</c:v>
                </c:pt>
                <c:pt idx="120">
                  <c:v>444</c:v>
                </c:pt>
                <c:pt idx="121">
                  <c:v>444</c:v>
                </c:pt>
                <c:pt idx="122">
                  <c:v>452</c:v>
                </c:pt>
                <c:pt idx="123">
                  <c:v>452</c:v>
                </c:pt>
                <c:pt idx="124">
                  <c:v>456</c:v>
                </c:pt>
                <c:pt idx="125">
                  <c:v>456</c:v>
                </c:pt>
                <c:pt idx="126">
                  <c:v>459</c:v>
                </c:pt>
                <c:pt idx="127">
                  <c:v>459</c:v>
                </c:pt>
                <c:pt idx="128">
                  <c:v>461</c:v>
                </c:pt>
                <c:pt idx="129">
                  <c:v>461</c:v>
                </c:pt>
                <c:pt idx="130">
                  <c:v>463</c:v>
                </c:pt>
                <c:pt idx="131">
                  <c:v>465</c:v>
                </c:pt>
                <c:pt idx="132">
                  <c:v>465</c:v>
                </c:pt>
                <c:pt idx="133">
                  <c:v>466</c:v>
                </c:pt>
                <c:pt idx="134">
                  <c:v>466</c:v>
                </c:pt>
                <c:pt idx="135">
                  <c:v>468</c:v>
                </c:pt>
                <c:pt idx="136">
                  <c:v>468</c:v>
                </c:pt>
                <c:pt idx="137">
                  <c:v>469</c:v>
                </c:pt>
                <c:pt idx="138">
                  <c:v>469</c:v>
                </c:pt>
                <c:pt idx="139">
                  <c:v>475</c:v>
                </c:pt>
                <c:pt idx="140">
                  <c:v>476</c:v>
                </c:pt>
                <c:pt idx="141">
                  <c:v>476</c:v>
                </c:pt>
                <c:pt idx="142">
                  <c:v>485</c:v>
                </c:pt>
                <c:pt idx="143">
                  <c:v>485</c:v>
                </c:pt>
                <c:pt idx="144">
                  <c:v>487</c:v>
                </c:pt>
                <c:pt idx="145">
                  <c:v>489</c:v>
                </c:pt>
                <c:pt idx="146">
                  <c:v>489</c:v>
                </c:pt>
                <c:pt idx="147">
                  <c:v>497</c:v>
                </c:pt>
                <c:pt idx="148">
                  <c:v>497</c:v>
                </c:pt>
                <c:pt idx="149">
                  <c:v>498</c:v>
                </c:pt>
                <c:pt idx="150">
                  <c:v>498</c:v>
                </c:pt>
                <c:pt idx="151">
                  <c:v>499</c:v>
                </c:pt>
                <c:pt idx="152">
                  <c:v>501</c:v>
                </c:pt>
                <c:pt idx="153">
                  <c:v>501</c:v>
                </c:pt>
                <c:pt idx="154">
                  <c:v>502</c:v>
                </c:pt>
                <c:pt idx="155">
                  <c:v>502</c:v>
                </c:pt>
                <c:pt idx="156">
                  <c:v>505</c:v>
                </c:pt>
                <c:pt idx="157">
                  <c:v>505</c:v>
                </c:pt>
                <c:pt idx="158">
                  <c:v>514</c:v>
                </c:pt>
                <c:pt idx="159">
                  <c:v>514</c:v>
                </c:pt>
                <c:pt idx="160">
                  <c:v>516</c:v>
                </c:pt>
                <c:pt idx="161">
                  <c:v>516</c:v>
                </c:pt>
                <c:pt idx="162">
                  <c:v>522</c:v>
                </c:pt>
                <c:pt idx="163">
                  <c:v>530</c:v>
                </c:pt>
                <c:pt idx="164">
                  <c:v>530</c:v>
                </c:pt>
                <c:pt idx="165">
                  <c:v>535</c:v>
                </c:pt>
                <c:pt idx="166">
                  <c:v>536</c:v>
                </c:pt>
                <c:pt idx="167">
                  <c:v>538</c:v>
                </c:pt>
                <c:pt idx="168">
                  <c:v>538</c:v>
                </c:pt>
                <c:pt idx="169">
                  <c:v>547</c:v>
                </c:pt>
                <c:pt idx="170">
                  <c:v>547</c:v>
                </c:pt>
                <c:pt idx="171">
                  <c:v>548</c:v>
                </c:pt>
                <c:pt idx="172">
                  <c:v>548</c:v>
                </c:pt>
                <c:pt idx="173">
                  <c:v>560</c:v>
                </c:pt>
                <c:pt idx="174">
                  <c:v>560</c:v>
                </c:pt>
                <c:pt idx="175">
                  <c:v>564</c:v>
                </c:pt>
                <c:pt idx="176">
                  <c:v>564</c:v>
                </c:pt>
                <c:pt idx="177">
                  <c:v>565</c:v>
                </c:pt>
                <c:pt idx="178">
                  <c:v>565</c:v>
                </c:pt>
                <c:pt idx="179">
                  <c:v>570</c:v>
                </c:pt>
                <c:pt idx="180">
                  <c:v>570</c:v>
                </c:pt>
                <c:pt idx="181">
                  <c:v>573</c:v>
                </c:pt>
                <c:pt idx="182">
                  <c:v>573</c:v>
                </c:pt>
                <c:pt idx="183">
                  <c:v>575</c:v>
                </c:pt>
                <c:pt idx="184">
                  <c:v>575</c:v>
                </c:pt>
                <c:pt idx="185">
                  <c:v>582</c:v>
                </c:pt>
                <c:pt idx="186">
                  <c:v>582</c:v>
                </c:pt>
                <c:pt idx="187">
                  <c:v>587</c:v>
                </c:pt>
                <c:pt idx="188">
                  <c:v>587</c:v>
                </c:pt>
                <c:pt idx="189">
                  <c:v>592</c:v>
                </c:pt>
                <c:pt idx="190">
                  <c:v>592</c:v>
                </c:pt>
                <c:pt idx="191">
                  <c:v>595</c:v>
                </c:pt>
                <c:pt idx="192">
                  <c:v>595</c:v>
                </c:pt>
                <c:pt idx="193">
                  <c:v>597</c:v>
                </c:pt>
                <c:pt idx="194">
                  <c:v>597</c:v>
                </c:pt>
                <c:pt idx="195">
                  <c:v>600</c:v>
                </c:pt>
                <c:pt idx="196">
                  <c:v>600</c:v>
                </c:pt>
                <c:pt idx="197">
                  <c:v>604</c:v>
                </c:pt>
                <c:pt idx="198">
                  <c:v>604</c:v>
                </c:pt>
                <c:pt idx="199">
                  <c:v>606</c:v>
                </c:pt>
                <c:pt idx="200">
                  <c:v>606</c:v>
                </c:pt>
                <c:pt idx="201">
                  <c:v>608</c:v>
                </c:pt>
                <c:pt idx="202">
                  <c:v>613</c:v>
                </c:pt>
                <c:pt idx="203">
                  <c:v>613</c:v>
                </c:pt>
                <c:pt idx="204">
                  <c:v>620</c:v>
                </c:pt>
                <c:pt idx="205">
                  <c:v>620</c:v>
                </c:pt>
                <c:pt idx="206">
                  <c:v>625</c:v>
                </c:pt>
                <c:pt idx="207">
                  <c:v>625</c:v>
                </c:pt>
                <c:pt idx="208">
                  <c:v>626</c:v>
                </c:pt>
                <c:pt idx="209">
                  <c:v>632</c:v>
                </c:pt>
                <c:pt idx="210">
                  <c:v>632</c:v>
                </c:pt>
                <c:pt idx="211">
                  <c:v>635</c:v>
                </c:pt>
                <c:pt idx="212">
                  <c:v>635</c:v>
                </c:pt>
                <c:pt idx="213">
                  <c:v>639</c:v>
                </c:pt>
                <c:pt idx="214">
                  <c:v>639</c:v>
                </c:pt>
                <c:pt idx="215">
                  <c:v>642</c:v>
                </c:pt>
                <c:pt idx="216">
                  <c:v>647</c:v>
                </c:pt>
                <c:pt idx="217">
                  <c:v>647</c:v>
                </c:pt>
                <c:pt idx="218">
                  <c:v>651</c:v>
                </c:pt>
                <c:pt idx="219">
                  <c:v>651</c:v>
                </c:pt>
                <c:pt idx="220">
                  <c:v>657</c:v>
                </c:pt>
                <c:pt idx="221">
                  <c:v>657</c:v>
                </c:pt>
                <c:pt idx="222">
                  <c:v>658</c:v>
                </c:pt>
                <c:pt idx="223">
                  <c:v>658</c:v>
                </c:pt>
                <c:pt idx="224">
                  <c:v>661</c:v>
                </c:pt>
                <c:pt idx="225">
                  <c:v>661</c:v>
                </c:pt>
                <c:pt idx="226">
                  <c:v>664</c:v>
                </c:pt>
                <c:pt idx="227">
                  <c:v>664</c:v>
                </c:pt>
                <c:pt idx="228">
                  <c:v>667</c:v>
                </c:pt>
                <c:pt idx="229">
                  <c:v>667</c:v>
                </c:pt>
                <c:pt idx="230">
                  <c:v>672</c:v>
                </c:pt>
                <c:pt idx="231">
                  <c:v>672</c:v>
                </c:pt>
                <c:pt idx="232">
                  <c:v>674</c:v>
                </c:pt>
                <c:pt idx="233">
                  <c:v>674</c:v>
                </c:pt>
                <c:pt idx="234">
                  <c:v>680</c:v>
                </c:pt>
                <c:pt idx="235">
                  <c:v>680</c:v>
                </c:pt>
                <c:pt idx="236">
                  <c:v>691</c:v>
                </c:pt>
                <c:pt idx="237">
                  <c:v>691</c:v>
                </c:pt>
                <c:pt idx="238">
                  <c:v>696</c:v>
                </c:pt>
                <c:pt idx="239">
                  <c:v>696</c:v>
                </c:pt>
                <c:pt idx="240">
                  <c:v>698</c:v>
                </c:pt>
                <c:pt idx="241">
                  <c:v>698</c:v>
                </c:pt>
                <c:pt idx="242">
                  <c:v>701</c:v>
                </c:pt>
                <c:pt idx="243">
                  <c:v>701</c:v>
                </c:pt>
                <c:pt idx="244">
                  <c:v>703</c:v>
                </c:pt>
                <c:pt idx="245">
                  <c:v>703</c:v>
                </c:pt>
                <c:pt idx="246">
                  <c:v>712</c:v>
                </c:pt>
                <c:pt idx="247">
                  <c:v>712</c:v>
                </c:pt>
                <c:pt idx="248">
                  <c:v>713</c:v>
                </c:pt>
                <c:pt idx="249">
                  <c:v>715</c:v>
                </c:pt>
                <c:pt idx="250">
                  <c:v>715</c:v>
                </c:pt>
                <c:pt idx="251">
                  <c:v>718</c:v>
                </c:pt>
                <c:pt idx="252">
                  <c:v>718</c:v>
                </c:pt>
                <c:pt idx="253">
                  <c:v>723</c:v>
                </c:pt>
                <c:pt idx="254">
                  <c:v>723</c:v>
                </c:pt>
                <c:pt idx="255">
                  <c:v>727</c:v>
                </c:pt>
                <c:pt idx="256">
                  <c:v>727</c:v>
                </c:pt>
                <c:pt idx="257">
                  <c:v>730</c:v>
                </c:pt>
                <c:pt idx="258">
                  <c:v>730</c:v>
                </c:pt>
                <c:pt idx="259">
                  <c:v>732</c:v>
                </c:pt>
                <c:pt idx="260">
                  <c:v>732</c:v>
                </c:pt>
                <c:pt idx="261">
                  <c:v>737</c:v>
                </c:pt>
                <c:pt idx="262">
                  <c:v>739</c:v>
                </c:pt>
                <c:pt idx="263">
                  <c:v>739</c:v>
                </c:pt>
                <c:pt idx="264">
                  <c:v>746</c:v>
                </c:pt>
                <c:pt idx="265">
                  <c:v>746</c:v>
                </c:pt>
                <c:pt idx="266">
                  <c:v>747</c:v>
                </c:pt>
                <c:pt idx="267">
                  <c:v>747</c:v>
                </c:pt>
                <c:pt idx="268">
                  <c:v>749</c:v>
                </c:pt>
                <c:pt idx="269">
                  <c:v>751</c:v>
                </c:pt>
                <c:pt idx="270">
                  <c:v>757</c:v>
                </c:pt>
                <c:pt idx="271">
                  <c:v>757</c:v>
                </c:pt>
                <c:pt idx="272">
                  <c:v>760</c:v>
                </c:pt>
                <c:pt idx="273">
                  <c:v>763</c:v>
                </c:pt>
                <c:pt idx="274">
                  <c:v>763</c:v>
                </c:pt>
                <c:pt idx="275">
                  <c:v>764</c:v>
                </c:pt>
                <c:pt idx="276">
                  <c:v>764</c:v>
                </c:pt>
                <c:pt idx="277">
                  <c:v>771</c:v>
                </c:pt>
                <c:pt idx="278">
                  <c:v>775</c:v>
                </c:pt>
                <c:pt idx="279">
                  <c:v>780</c:v>
                </c:pt>
                <c:pt idx="280">
                  <c:v>780</c:v>
                </c:pt>
                <c:pt idx="281">
                  <c:v>787</c:v>
                </c:pt>
                <c:pt idx="282">
                  <c:v>788</c:v>
                </c:pt>
                <c:pt idx="283">
                  <c:v>788</c:v>
                </c:pt>
                <c:pt idx="284">
                  <c:v>790</c:v>
                </c:pt>
                <c:pt idx="285">
                  <c:v>790</c:v>
                </c:pt>
                <c:pt idx="286">
                  <c:v>797</c:v>
                </c:pt>
                <c:pt idx="287">
                  <c:v>797</c:v>
                </c:pt>
                <c:pt idx="288">
                  <c:v>800</c:v>
                </c:pt>
                <c:pt idx="289">
                  <c:v>800</c:v>
                </c:pt>
                <c:pt idx="290">
                  <c:v>802</c:v>
                </c:pt>
                <c:pt idx="291">
                  <c:v>802</c:v>
                </c:pt>
                <c:pt idx="292">
                  <c:v>803</c:v>
                </c:pt>
                <c:pt idx="293">
                  <c:v>803</c:v>
                </c:pt>
                <c:pt idx="294">
                  <c:v>806</c:v>
                </c:pt>
                <c:pt idx="295">
                  <c:v>806</c:v>
                </c:pt>
                <c:pt idx="296">
                  <c:v>810</c:v>
                </c:pt>
                <c:pt idx="297">
                  <c:v>810</c:v>
                </c:pt>
                <c:pt idx="298">
                  <c:v>812</c:v>
                </c:pt>
                <c:pt idx="299">
                  <c:v>812</c:v>
                </c:pt>
                <c:pt idx="300">
                  <c:v>816</c:v>
                </c:pt>
                <c:pt idx="301">
                  <c:v>816</c:v>
                </c:pt>
                <c:pt idx="302">
                  <c:v>819</c:v>
                </c:pt>
                <c:pt idx="303">
                  <c:v>819</c:v>
                </c:pt>
                <c:pt idx="304">
                  <c:v>822</c:v>
                </c:pt>
                <c:pt idx="305">
                  <c:v>822</c:v>
                </c:pt>
                <c:pt idx="306">
                  <c:v>824</c:v>
                </c:pt>
                <c:pt idx="307">
                  <c:v>824</c:v>
                </c:pt>
                <c:pt idx="308">
                  <c:v>834</c:v>
                </c:pt>
                <c:pt idx="309">
                  <c:v>834</c:v>
                </c:pt>
                <c:pt idx="310">
                  <c:v>836</c:v>
                </c:pt>
                <c:pt idx="311">
                  <c:v>836</c:v>
                </c:pt>
                <c:pt idx="312">
                  <c:v>839</c:v>
                </c:pt>
                <c:pt idx="313">
                  <c:v>840</c:v>
                </c:pt>
                <c:pt idx="314">
                  <c:v>840</c:v>
                </c:pt>
                <c:pt idx="315">
                  <c:v>842</c:v>
                </c:pt>
                <c:pt idx="316">
                  <c:v>842</c:v>
                </c:pt>
                <c:pt idx="317">
                  <c:v>855</c:v>
                </c:pt>
                <c:pt idx="318">
                  <c:v>855</c:v>
                </c:pt>
                <c:pt idx="319">
                  <c:v>857</c:v>
                </c:pt>
                <c:pt idx="320">
                  <c:v>857</c:v>
                </c:pt>
                <c:pt idx="321">
                  <c:v>858</c:v>
                </c:pt>
                <c:pt idx="322">
                  <c:v>858</c:v>
                </c:pt>
                <c:pt idx="323">
                  <c:v>860</c:v>
                </c:pt>
                <c:pt idx="324">
                  <c:v>861</c:v>
                </c:pt>
                <c:pt idx="325">
                  <c:v>861</c:v>
                </c:pt>
                <c:pt idx="326">
                  <c:v>862</c:v>
                </c:pt>
                <c:pt idx="327">
                  <c:v>862</c:v>
                </c:pt>
                <c:pt idx="328">
                  <c:v>865</c:v>
                </c:pt>
                <c:pt idx="329">
                  <c:v>865</c:v>
                </c:pt>
                <c:pt idx="330">
                  <c:v>866</c:v>
                </c:pt>
                <c:pt idx="331">
                  <c:v>866</c:v>
                </c:pt>
                <c:pt idx="332">
                  <c:v>867</c:v>
                </c:pt>
                <c:pt idx="333">
                  <c:v>870</c:v>
                </c:pt>
                <c:pt idx="334">
                  <c:v>870</c:v>
                </c:pt>
                <c:pt idx="335">
                  <c:v>871</c:v>
                </c:pt>
                <c:pt idx="336">
                  <c:v>871</c:v>
                </c:pt>
                <c:pt idx="337">
                  <c:v>872</c:v>
                </c:pt>
                <c:pt idx="338">
                  <c:v>872</c:v>
                </c:pt>
                <c:pt idx="339">
                  <c:v>875</c:v>
                </c:pt>
                <c:pt idx="340">
                  <c:v>877</c:v>
                </c:pt>
                <c:pt idx="341">
                  <c:v>877</c:v>
                </c:pt>
                <c:pt idx="342">
                  <c:v>879</c:v>
                </c:pt>
                <c:pt idx="343">
                  <c:v>879</c:v>
                </c:pt>
                <c:pt idx="344">
                  <c:v>880</c:v>
                </c:pt>
                <c:pt idx="345">
                  <c:v>880</c:v>
                </c:pt>
                <c:pt idx="346">
                  <c:v>897</c:v>
                </c:pt>
                <c:pt idx="347">
                  <c:v>897</c:v>
                </c:pt>
                <c:pt idx="348">
                  <c:v>902</c:v>
                </c:pt>
                <c:pt idx="349">
                  <c:v>902</c:v>
                </c:pt>
                <c:pt idx="350">
                  <c:v>904</c:v>
                </c:pt>
                <c:pt idx="351">
                  <c:v>904</c:v>
                </c:pt>
                <c:pt idx="352">
                  <c:v>905</c:v>
                </c:pt>
                <c:pt idx="353">
                  <c:v>905</c:v>
                </c:pt>
                <c:pt idx="354">
                  <c:v>909</c:v>
                </c:pt>
                <c:pt idx="355">
                  <c:v>909</c:v>
                </c:pt>
                <c:pt idx="356">
                  <c:v>911</c:v>
                </c:pt>
                <c:pt idx="357">
                  <c:v>911</c:v>
                </c:pt>
                <c:pt idx="358">
                  <c:v>913</c:v>
                </c:pt>
                <c:pt idx="359">
                  <c:v>913</c:v>
                </c:pt>
                <c:pt idx="360">
                  <c:v>921</c:v>
                </c:pt>
                <c:pt idx="361">
                  <c:v>921</c:v>
                </c:pt>
                <c:pt idx="362">
                  <c:v>922</c:v>
                </c:pt>
                <c:pt idx="363">
                  <c:v>924</c:v>
                </c:pt>
                <c:pt idx="364">
                  <c:v>924</c:v>
                </c:pt>
                <c:pt idx="365">
                  <c:v>926</c:v>
                </c:pt>
                <c:pt idx="366">
                  <c:v>926</c:v>
                </c:pt>
                <c:pt idx="367">
                  <c:v>928</c:v>
                </c:pt>
                <c:pt idx="368">
                  <c:v>928</c:v>
                </c:pt>
                <c:pt idx="369">
                  <c:v>929</c:v>
                </c:pt>
                <c:pt idx="370">
                  <c:v>929</c:v>
                </c:pt>
                <c:pt idx="371">
                  <c:v>932</c:v>
                </c:pt>
                <c:pt idx="372">
                  <c:v>932</c:v>
                </c:pt>
                <c:pt idx="373">
                  <c:v>935</c:v>
                </c:pt>
                <c:pt idx="374">
                  <c:v>939</c:v>
                </c:pt>
                <c:pt idx="375">
                  <c:v>939</c:v>
                </c:pt>
                <c:pt idx="376">
                  <c:v>940</c:v>
                </c:pt>
                <c:pt idx="377">
                  <c:v>940</c:v>
                </c:pt>
                <c:pt idx="378">
                  <c:v>943</c:v>
                </c:pt>
                <c:pt idx="379">
                  <c:v>943</c:v>
                </c:pt>
                <c:pt idx="380">
                  <c:v>944</c:v>
                </c:pt>
                <c:pt idx="381">
                  <c:v>944</c:v>
                </c:pt>
                <c:pt idx="382">
                  <c:v>954</c:v>
                </c:pt>
                <c:pt idx="383">
                  <c:v>954</c:v>
                </c:pt>
                <c:pt idx="384">
                  <c:v>958</c:v>
                </c:pt>
                <c:pt idx="385">
                  <c:v>958</c:v>
                </c:pt>
                <c:pt idx="386">
                  <c:v>961</c:v>
                </c:pt>
                <c:pt idx="387">
                  <c:v>961</c:v>
                </c:pt>
                <c:pt idx="388">
                  <c:v>962</c:v>
                </c:pt>
                <c:pt idx="389">
                  <c:v>962</c:v>
                </c:pt>
                <c:pt idx="390">
                  <c:v>969</c:v>
                </c:pt>
                <c:pt idx="391">
                  <c:v>969</c:v>
                </c:pt>
                <c:pt idx="392">
                  <c:v>971</c:v>
                </c:pt>
                <c:pt idx="393">
                  <c:v>978</c:v>
                </c:pt>
                <c:pt idx="394">
                  <c:v>982</c:v>
                </c:pt>
                <c:pt idx="395">
                  <c:v>982</c:v>
                </c:pt>
                <c:pt idx="396">
                  <c:v>985</c:v>
                </c:pt>
                <c:pt idx="397">
                  <c:v>985</c:v>
                </c:pt>
                <c:pt idx="398">
                  <c:v>988</c:v>
                </c:pt>
                <c:pt idx="399">
                  <c:v>988</c:v>
                </c:pt>
                <c:pt idx="400">
                  <c:v>989</c:v>
                </c:pt>
                <c:pt idx="401">
                  <c:v>989</c:v>
                </c:pt>
                <c:pt idx="402">
                  <c:v>994</c:v>
                </c:pt>
                <c:pt idx="403">
                  <c:v>994</c:v>
                </c:pt>
                <c:pt idx="404">
                  <c:v>1008</c:v>
                </c:pt>
                <c:pt idx="405">
                  <c:v>1010</c:v>
                </c:pt>
                <c:pt idx="406">
                  <c:v>1011</c:v>
                </c:pt>
                <c:pt idx="407">
                  <c:v>1011</c:v>
                </c:pt>
                <c:pt idx="408">
                  <c:v>1014</c:v>
                </c:pt>
                <c:pt idx="409">
                  <c:v>1014</c:v>
                </c:pt>
                <c:pt idx="410">
                  <c:v>1017</c:v>
                </c:pt>
                <c:pt idx="411">
                  <c:v>1017</c:v>
                </c:pt>
                <c:pt idx="412">
                  <c:v>1019</c:v>
                </c:pt>
                <c:pt idx="413">
                  <c:v>1019</c:v>
                </c:pt>
                <c:pt idx="414">
                  <c:v>1023</c:v>
                </c:pt>
                <c:pt idx="415">
                  <c:v>1029</c:v>
                </c:pt>
                <c:pt idx="416">
                  <c:v>1029</c:v>
                </c:pt>
                <c:pt idx="417">
                  <c:v>1030</c:v>
                </c:pt>
                <c:pt idx="418">
                  <c:v>1030</c:v>
                </c:pt>
                <c:pt idx="419">
                  <c:v>1033</c:v>
                </c:pt>
                <c:pt idx="420">
                  <c:v>1033</c:v>
                </c:pt>
                <c:pt idx="421">
                  <c:v>1037</c:v>
                </c:pt>
                <c:pt idx="422">
                  <c:v>1037</c:v>
                </c:pt>
                <c:pt idx="423">
                  <c:v>1039</c:v>
                </c:pt>
                <c:pt idx="424">
                  <c:v>1039</c:v>
                </c:pt>
                <c:pt idx="425">
                  <c:v>1040</c:v>
                </c:pt>
                <c:pt idx="426">
                  <c:v>1040</c:v>
                </c:pt>
                <c:pt idx="427">
                  <c:v>1041</c:v>
                </c:pt>
                <c:pt idx="428">
                  <c:v>1041</c:v>
                </c:pt>
                <c:pt idx="429">
                  <c:v>1048</c:v>
                </c:pt>
                <c:pt idx="430">
                  <c:v>1050</c:v>
                </c:pt>
                <c:pt idx="431">
                  <c:v>1050</c:v>
                </c:pt>
                <c:pt idx="432">
                  <c:v>1051</c:v>
                </c:pt>
                <c:pt idx="433">
                  <c:v>1051</c:v>
                </c:pt>
                <c:pt idx="434">
                  <c:v>1056</c:v>
                </c:pt>
                <c:pt idx="435">
                  <c:v>1056</c:v>
                </c:pt>
                <c:pt idx="436">
                  <c:v>1057</c:v>
                </c:pt>
                <c:pt idx="437">
                  <c:v>1057</c:v>
                </c:pt>
                <c:pt idx="438">
                  <c:v>1061</c:v>
                </c:pt>
                <c:pt idx="439">
                  <c:v>1061</c:v>
                </c:pt>
                <c:pt idx="440">
                  <c:v>1062</c:v>
                </c:pt>
                <c:pt idx="441">
                  <c:v>1062</c:v>
                </c:pt>
                <c:pt idx="442">
                  <c:v>1064</c:v>
                </c:pt>
                <c:pt idx="443">
                  <c:v>1064</c:v>
                </c:pt>
                <c:pt idx="444">
                  <c:v>1065</c:v>
                </c:pt>
                <c:pt idx="445">
                  <c:v>1068</c:v>
                </c:pt>
                <c:pt idx="446">
                  <c:v>1068</c:v>
                </c:pt>
                <c:pt idx="447">
                  <c:v>1069</c:v>
                </c:pt>
                <c:pt idx="448">
                  <c:v>1069</c:v>
                </c:pt>
                <c:pt idx="449">
                  <c:v>1071</c:v>
                </c:pt>
                <c:pt idx="450">
                  <c:v>1071</c:v>
                </c:pt>
                <c:pt idx="451">
                  <c:v>1079</c:v>
                </c:pt>
                <c:pt idx="452">
                  <c:v>1085</c:v>
                </c:pt>
                <c:pt idx="453">
                  <c:v>1085</c:v>
                </c:pt>
                <c:pt idx="454">
                  <c:v>1088</c:v>
                </c:pt>
                <c:pt idx="455">
                  <c:v>1088</c:v>
                </c:pt>
                <c:pt idx="456">
                  <c:v>1091</c:v>
                </c:pt>
                <c:pt idx="457">
                  <c:v>1091</c:v>
                </c:pt>
                <c:pt idx="458">
                  <c:v>1092</c:v>
                </c:pt>
                <c:pt idx="459">
                  <c:v>1092</c:v>
                </c:pt>
                <c:pt idx="460">
                  <c:v>1093</c:v>
                </c:pt>
                <c:pt idx="461">
                  <c:v>1093</c:v>
                </c:pt>
                <c:pt idx="462">
                  <c:v>1097</c:v>
                </c:pt>
                <c:pt idx="463">
                  <c:v>1097</c:v>
                </c:pt>
                <c:pt idx="464">
                  <c:v>1099</c:v>
                </c:pt>
                <c:pt idx="465">
                  <c:v>1099</c:v>
                </c:pt>
                <c:pt idx="466">
                  <c:v>1103</c:v>
                </c:pt>
                <c:pt idx="467">
                  <c:v>1103</c:v>
                </c:pt>
                <c:pt idx="468">
                  <c:v>1108</c:v>
                </c:pt>
                <c:pt idx="469">
                  <c:v>1108</c:v>
                </c:pt>
                <c:pt idx="470">
                  <c:v>1110</c:v>
                </c:pt>
                <c:pt idx="471">
                  <c:v>1110</c:v>
                </c:pt>
                <c:pt idx="472">
                  <c:v>1112</c:v>
                </c:pt>
                <c:pt idx="473">
                  <c:v>1118</c:v>
                </c:pt>
                <c:pt idx="474">
                  <c:v>1118</c:v>
                </c:pt>
                <c:pt idx="475">
                  <c:v>1121</c:v>
                </c:pt>
                <c:pt idx="476">
                  <c:v>1125</c:v>
                </c:pt>
                <c:pt idx="477">
                  <c:v>1125</c:v>
                </c:pt>
                <c:pt idx="478">
                  <c:v>1132</c:v>
                </c:pt>
                <c:pt idx="479">
                  <c:v>1132</c:v>
                </c:pt>
                <c:pt idx="480">
                  <c:v>1133</c:v>
                </c:pt>
                <c:pt idx="481">
                  <c:v>1133</c:v>
                </c:pt>
                <c:pt idx="482">
                  <c:v>1134</c:v>
                </c:pt>
                <c:pt idx="483">
                  <c:v>1134</c:v>
                </c:pt>
                <c:pt idx="484">
                  <c:v>1136</c:v>
                </c:pt>
                <c:pt idx="485">
                  <c:v>1136</c:v>
                </c:pt>
                <c:pt idx="486">
                  <c:v>1137</c:v>
                </c:pt>
                <c:pt idx="487">
                  <c:v>1137</c:v>
                </c:pt>
                <c:pt idx="488">
                  <c:v>1138</c:v>
                </c:pt>
                <c:pt idx="489">
                  <c:v>1138</c:v>
                </c:pt>
                <c:pt idx="490">
                  <c:v>1139</c:v>
                </c:pt>
                <c:pt idx="491">
                  <c:v>1139</c:v>
                </c:pt>
                <c:pt idx="492">
                  <c:v>1141</c:v>
                </c:pt>
                <c:pt idx="493">
                  <c:v>1141</c:v>
                </c:pt>
                <c:pt idx="494">
                  <c:v>1145</c:v>
                </c:pt>
                <c:pt idx="495">
                  <c:v>1145</c:v>
                </c:pt>
                <c:pt idx="496">
                  <c:v>1153</c:v>
                </c:pt>
                <c:pt idx="497">
                  <c:v>1153</c:v>
                </c:pt>
                <c:pt idx="498">
                  <c:v>1164</c:v>
                </c:pt>
                <c:pt idx="499">
                  <c:v>1164</c:v>
                </c:pt>
                <c:pt idx="500">
                  <c:v>1169</c:v>
                </c:pt>
                <c:pt idx="501">
                  <c:v>1171</c:v>
                </c:pt>
                <c:pt idx="502">
                  <c:v>1175</c:v>
                </c:pt>
                <c:pt idx="503">
                  <c:v>1175</c:v>
                </c:pt>
                <c:pt idx="504">
                  <c:v>1176</c:v>
                </c:pt>
                <c:pt idx="505">
                  <c:v>1176</c:v>
                </c:pt>
                <c:pt idx="506">
                  <c:v>1179</c:v>
                </c:pt>
                <c:pt idx="507">
                  <c:v>1179</c:v>
                </c:pt>
                <c:pt idx="508">
                  <c:v>1183</c:v>
                </c:pt>
                <c:pt idx="509">
                  <c:v>1184</c:v>
                </c:pt>
                <c:pt idx="510">
                  <c:v>1184</c:v>
                </c:pt>
                <c:pt idx="511">
                  <c:v>1186</c:v>
                </c:pt>
                <c:pt idx="512">
                  <c:v>1186</c:v>
                </c:pt>
                <c:pt idx="513">
                  <c:v>1194</c:v>
                </c:pt>
                <c:pt idx="514">
                  <c:v>1194</c:v>
                </c:pt>
                <c:pt idx="515">
                  <c:v>1195</c:v>
                </c:pt>
                <c:pt idx="516">
                  <c:v>1195</c:v>
                </c:pt>
                <c:pt idx="517">
                  <c:v>1196</c:v>
                </c:pt>
                <c:pt idx="518">
                  <c:v>1196</c:v>
                </c:pt>
                <c:pt idx="519">
                  <c:v>1200</c:v>
                </c:pt>
                <c:pt idx="520">
                  <c:v>1200</c:v>
                </c:pt>
                <c:pt idx="521">
                  <c:v>1204</c:v>
                </c:pt>
                <c:pt idx="522">
                  <c:v>1213</c:v>
                </c:pt>
                <c:pt idx="523">
                  <c:v>1213</c:v>
                </c:pt>
                <c:pt idx="524">
                  <c:v>1215</c:v>
                </c:pt>
                <c:pt idx="525">
                  <c:v>1219</c:v>
                </c:pt>
                <c:pt idx="526">
                  <c:v>1219</c:v>
                </c:pt>
                <c:pt idx="527">
                  <c:v>1221</c:v>
                </c:pt>
                <c:pt idx="528">
                  <c:v>1221</c:v>
                </c:pt>
                <c:pt idx="529">
                  <c:v>1227</c:v>
                </c:pt>
                <c:pt idx="530">
                  <c:v>1235</c:v>
                </c:pt>
                <c:pt idx="531">
                  <c:v>1235</c:v>
                </c:pt>
                <c:pt idx="532">
                  <c:v>1241</c:v>
                </c:pt>
                <c:pt idx="533">
                  <c:v>1241</c:v>
                </c:pt>
                <c:pt idx="534">
                  <c:v>1244</c:v>
                </c:pt>
                <c:pt idx="535">
                  <c:v>1244</c:v>
                </c:pt>
                <c:pt idx="536">
                  <c:v>1255</c:v>
                </c:pt>
                <c:pt idx="537">
                  <c:v>1255</c:v>
                </c:pt>
                <c:pt idx="538">
                  <c:v>1256</c:v>
                </c:pt>
                <c:pt idx="539">
                  <c:v>1262</c:v>
                </c:pt>
                <c:pt idx="540">
                  <c:v>1262</c:v>
                </c:pt>
                <c:pt idx="541">
                  <c:v>1269</c:v>
                </c:pt>
                <c:pt idx="542">
                  <c:v>1269</c:v>
                </c:pt>
                <c:pt idx="543">
                  <c:v>1270</c:v>
                </c:pt>
                <c:pt idx="544">
                  <c:v>1270</c:v>
                </c:pt>
                <c:pt idx="545">
                  <c:v>1271</c:v>
                </c:pt>
                <c:pt idx="546">
                  <c:v>1271</c:v>
                </c:pt>
                <c:pt idx="547">
                  <c:v>1273</c:v>
                </c:pt>
                <c:pt idx="548">
                  <c:v>1273</c:v>
                </c:pt>
                <c:pt idx="549">
                  <c:v>1275</c:v>
                </c:pt>
                <c:pt idx="550">
                  <c:v>1275</c:v>
                </c:pt>
                <c:pt idx="551">
                  <c:v>1277</c:v>
                </c:pt>
                <c:pt idx="552">
                  <c:v>1277</c:v>
                </c:pt>
                <c:pt idx="553">
                  <c:v>1278</c:v>
                </c:pt>
                <c:pt idx="554">
                  <c:v>1278</c:v>
                </c:pt>
                <c:pt idx="555">
                  <c:v>1279</c:v>
                </c:pt>
                <c:pt idx="556">
                  <c:v>1279</c:v>
                </c:pt>
                <c:pt idx="557">
                  <c:v>1280</c:v>
                </c:pt>
                <c:pt idx="558">
                  <c:v>1280</c:v>
                </c:pt>
                <c:pt idx="559">
                  <c:v>1281</c:v>
                </c:pt>
                <c:pt idx="560">
                  <c:v>1281</c:v>
                </c:pt>
                <c:pt idx="561">
                  <c:v>1283</c:v>
                </c:pt>
                <c:pt idx="562">
                  <c:v>1287</c:v>
                </c:pt>
                <c:pt idx="563">
                  <c:v>1287</c:v>
                </c:pt>
                <c:pt idx="564">
                  <c:v>1289</c:v>
                </c:pt>
                <c:pt idx="565">
                  <c:v>1289</c:v>
                </c:pt>
                <c:pt idx="566">
                  <c:v>1291</c:v>
                </c:pt>
                <c:pt idx="567">
                  <c:v>1291</c:v>
                </c:pt>
                <c:pt idx="568">
                  <c:v>1293</c:v>
                </c:pt>
                <c:pt idx="569">
                  <c:v>1293</c:v>
                </c:pt>
                <c:pt idx="570">
                  <c:v>1294</c:v>
                </c:pt>
                <c:pt idx="571">
                  <c:v>1294</c:v>
                </c:pt>
                <c:pt idx="572">
                  <c:v>1295</c:v>
                </c:pt>
                <c:pt idx="573">
                  <c:v>1295</c:v>
                </c:pt>
                <c:pt idx="574">
                  <c:v>1296</c:v>
                </c:pt>
                <c:pt idx="575">
                  <c:v>1296</c:v>
                </c:pt>
                <c:pt idx="576">
                  <c:v>1298</c:v>
                </c:pt>
                <c:pt idx="577">
                  <c:v>1298</c:v>
                </c:pt>
                <c:pt idx="578">
                  <c:v>1299</c:v>
                </c:pt>
                <c:pt idx="579">
                  <c:v>1299</c:v>
                </c:pt>
                <c:pt idx="580">
                  <c:v>1301</c:v>
                </c:pt>
                <c:pt idx="581">
                  <c:v>1302</c:v>
                </c:pt>
                <c:pt idx="582">
                  <c:v>1302</c:v>
                </c:pt>
                <c:pt idx="583">
                  <c:v>1315</c:v>
                </c:pt>
                <c:pt idx="584">
                  <c:v>1315</c:v>
                </c:pt>
                <c:pt idx="585">
                  <c:v>1317</c:v>
                </c:pt>
                <c:pt idx="586">
                  <c:v>1317</c:v>
                </c:pt>
                <c:pt idx="587">
                  <c:v>1324</c:v>
                </c:pt>
                <c:pt idx="588">
                  <c:v>1324</c:v>
                </c:pt>
                <c:pt idx="589">
                  <c:v>1332</c:v>
                </c:pt>
                <c:pt idx="590">
                  <c:v>1332</c:v>
                </c:pt>
                <c:pt idx="591">
                  <c:v>1333</c:v>
                </c:pt>
                <c:pt idx="592">
                  <c:v>1339</c:v>
                </c:pt>
                <c:pt idx="593">
                  <c:v>1339</c:v>
                </c:pt>
                <c:pt idx="594">
                  <c:v>1340</c:v>
                </c:pt>
                <c:pt idx="595">
                  <c:v>1342</c:v>
                </c:pt>
                <c:pt idx="596">
                  <c:v>1342</c:v>
                </c:pt>
                <c:pt idx="597">
                  <c:v>1343</c:v>
                </c:pt>
                <c:pt idx="598">
                  <c:v>1343</c:v>
                </c:pt>
                <c:pt idx="599">
                  <c:v>1346</c:v>
                </c:pt>
                <c:pt idx="600">
                  <c:v>1346</c:v>
                </c:pt>
                <c:pt idx="601">
                  <c:v>1351</c:v>
                </c:pt>
                <c:pt idx="602">
                  <c:v>1351</c:v>
                </c:pt>
                <c:pt idx="603">
                  <c:v>1355</c:v>
                </c:pt>
                <c:pt idx="604">
                  <c:v>1355</c:v>
                </c:pt>
                <c:pt idx="605">
                  <c:v>1360</c:v>
                </c:pt>
                <c:pt idx="606">
                  <c:v>1360</c:v>
                </c:pt>
                <c:pt idx="607">
                  <c:v>1361</c:v>
                </c:pt>
                <c:pt idx="608">
                  <c:v>1365</c:v>
                </c:pt>
                <c:pt idx="609">
                  <c:v>1365</c:v>
                </c:pt>
                <c:pt idx="610">
                  <c:v>1366</c:v>
                </c:pt>
                <c:pt idx="611">
                  <c:v>1369</c:v>
                </c:pt>
                <c:pt idx="612">
                  <c:v>1369</c:v>
                </c:pt>
                <c:pt idx="613">
                  <c:v>1372</c:v>
                </c:pt>
                <c:pt idx="614">
                  <c:v>1372</c:v>
                </c:pt>
                <c:pt idx="615">
                  <c:v>1378</c:v>
                </c:pt>
                <c:pt idx="616">
                  <c:v>1378</c:v>
                </c:pt>
                <c:pt idx="617">
                  <c:v>1382</c:v>
                </c:pt>
                <c:pt idx="618">
                  <c:v>1382</c:v>
                </c:pt>
                <c:pt idx="619">
                  <c:v>1384</c:v>
                </c:pt>
                <c:pt idx="620">
                  <c:v>1385</c:v>
                </c:pt>
                <c:pt idx="621">
                  <c:v>1385</c:v>
                </c:pt>
                <c:pt idx="622">
                  <c:v>1391</c:v>
                </c:pt>
                <c:pt idx="623">
                  <c:v>1391</c:v>
                </c:pt>
                <c:pt idx="624">
                  <c:v>1393</c:v>
                </c:pt>
                <c:pt idx="625">
                  <c:v>1393</c:v>
                </c:pt>
                <c:pt idx="626">
                  <c:v>1395</c:v>
                </c:pt>
                <c:pt idx="627">
                  <c:v>1396</c:v>
                </c:pt>
                <c:pt idx="628">
                  <c:v>1396</c:v>
                </c:pt>
                <c:pt idx="629">
                  <c:v>1400</c:v>
                </c:pt>
                <c:pt idx="630">
                  <c:v>1400</c:v>
                </c:pt>
                <c:pt idx="631">
                  <c:v>1403</c:v>
                </c:pt>
                <c:pt idx="632">
                  <c:v>1403</c:v>
                </c:pt>
                <c:pt idx="633">
                  <c:v>1405</c:v>
                </c:pt>
                <c:pt idx="634">
                  <c:v>1405</c:v>
                </c:pt>
                <c:pt idx="635">
                  <c:v>1410</c:v>
                </c:pt>
                <c:pt idx="636">
                  <c:v>1411</c:v>
                </c:pt>
                <c:pt idx="637">
                  <c:v>1411</c:v>
                </c:pt>
                <c:pt idx="638">
                  <c:v>1414</c:v>
                </c:pt>
                <c:pt idx="639">
                  <c:v>1414</c:v>
                </c:pt>
                <c:pt idx="640">
                  <c:v>1420</c:v>
                </c:pt>
                <c:pt idx="641">
                  <c:v>1433</c:v>
                </c:pt>
                <c:pt idx="642">
                  <c:v>1437</c:v>
                </c:pt>
                <c:pt idx="643">
                  <c:v>1437</c:v>
                </c:pt>
                <c:pt idx="644">
                  <c:v>1440</c:v>
                </c:pt>
                <c:pt idx="645">
                  <c:v>1441</c:v>
                </c:pt>
                <c:pt idx="646">
                  <c:v>1444</c:v>
                </c:pt>
                <c:pt idx="647">
                  <c:v>1444</c:v>
                </c:pt>
                <c:pt idx="648">
                  <c:v>1445</c:v>
                </c:pt>
                <c:pt idx="649">
                  <c:v>1445</c:v>
                </c:pt>
                <c:pt idx="650">
                  <c:v>1447</c:v>
                </c:pt>
                <c:pt idx="651">
                  <c:v>1448</c:v>
                </c:pt>
                <c:pt idx="652">
                  <c:v>1448</c:v>
                </c:pt>
                <c:pt idx="653">
                  <c:v>1453</c:v>
                </c:pt>
                <c:pt idx="654">
                  <c:v>1453</c:v>
                </c:pt>
                <c:pt idx="655">
                  <c:v>1456</c:v>
                </c:pt>
                <c:pt idx="656">
                  <c:v>1456</c:v>
                </c:pt>
                <c:pt idx="657">
                  <c:v>1458</c:v>
                </c:pt>
                <c:pt idx="658">
                  <c:v>1458</c:v>
                </c:pt>
                <c:pt idx="659">
                  <c:v>1464</c:v>
                </c:pt>
                <c:pt idx="660">
                  <c:v>1466</c:v>
                </c:pt>
                <c:pt idx="661">
                  <c:v>1476</c:v>
                </c:pt>
                <c:pt idx="662">
                  <c:v>1477</c:v>
                </c:pt>
                <c:pt idx="663">
                  <c:v>1477</c:v>
                </c:pt>
                <c:pt idx="664">
                  <c:v>1479</c:v>
                </c:pt>
                <c:pt idx="665">
                  <c:v>1482</c:v>
                </c:pt>
                <c:pt idx="666">
                  <c:v>1483</c:v>
                </c:pt>
                <c:pt idx="667">
                  <c:v>1483</c:v>
                </c:pt>
                <c:pt idx="668">
                  <c:v>1484</c:v>
                </c:pt>
                <c:pt idx="669">
                  <c:v>1484</c:v>
                </c:pt>
                <c:pt idx="670">
                  <c:v>1486</c:v>
                </c:pt>
                <c:pt idx="671">
                  <c:v>1486</c:v>
                </c:pt>
                <c:pt idx="672">
                  <c:v>1487</c:v>
                </c:pt>
                <c:pt idx="673">
                  <c:v>1487</c:v>
                </c:pt>
                <c:pt idx="674">
                  <c:v>1490</c:v>
                </c:pt>
                <c:pt idx="675">
                  <c:v>1490</c:v>
                </c:pt>
                <c:pt idx="676">
                  <c:v>1492</c:v>
                </c:pt>
                <c:pt idx="677">
                  <c:v>1492</c:v>
                </c:pt>
                <c:pt idx="678">
                  <c:v>1493</c:v>
                </c:pt>
                <c:pt idx="679">
                  <c:v>1493</c:v>
                </c:pt>
                <c:pt idx="680">
                  <c:v>1494</c:v>
                </c:pt>
                <c:pt idx="681">
                  <c:v>1498</c:v>
                </c:pt>
                <c:pt idx="682">
                  <c:v>1500</c:v>
                </c:pt>
                <c:pt idx="683">
                  <c:v>1500</c:v>
                </c:pt>
                <c:pt idx="684">
                  <c:v>1503</c:v>
                </c:pt>
                <c:pt idx="685">
                  <c:v>1503</c:v>
                </c:pt>
                <c:pt idx="686">
                  <c:v>1507</c:v>
                </c:pt>
                <c:pt idx="687">
                  <c:v>1507</c:v>
                </c:pt>
                <c:pt idx="688">
                  <c:v>1514</c:v>
                </c:pt>
                <c:pt idx="689">
                  <c:v>1516</c:v>
                </c:pt>
                <c:pt idx="690">
                  <c:v>1516</c:v>
                </c:pt>
                <c:pt idx="691">
                  <c:v>1520</c:v>
                </c:pt>
                <c:pt idx="692">
                  <c:v>1520</c:v>
                </c:pt>
                <c:pt idx="693">
                  <c:v>1524</c:v>
                </c:pt>
                <c:pt idx="694">
                  <c:v>1527</c:v>
                </c:pt>
                <c:pt idx="695">
                  <c:v>1528</c:v>
                </c:pt>
                <c:pt idx="696">
                  <c:v>1530</c:v>
                </c:pt>
                <c:pt idx="697">
                  <c:v>1530</c:v>
                </c:pt>
                <c:pt idx="698">
                  <c:v>1536</c:v>
                </c:pt>
                <c:pt idx="699">
                  <c:v>1536</c:v>
                </c:pt>
                <c:pt idx="700">
                  <c:v>1540</c:v>
                </c:pt>
                <c:pt idx="701">
                  <c:v>1542</c:v>
                </c:pt>
                <c:pt idx="702">
                  <c:v>1542</c:v>
                </c:pt>
                <c:pt idx="703">
                  <c:v>1543</c:v>
                </c:pt>
                <c:pt idx="704">
                  <c:v>1544</c:v>
                </c:pt>
                <c:pt idx="705">
                  <c:v>1544</c:v>
                </c:pt>
                <c:pt idx="706">
                  <c:v>1550</c:v>
                </c:pt>
                <c:pt idx="707">
                  <c:v>1550</c:v>
                </c:pt>
                <c:pt idx="708">
                  <c:v>1551</c:v>
                </c:pt>
                <c:pt idx="709">
                  <c:v>1551</c:v>
                </c:pt>
                <c:pt idx="710">
                  <c:v>1553</c:v>
                </c:pt>
                <c:pt idx="711">
                  <c:v>1553</c:v>
                </c:pt>
                <c:pt idx="712">
                  <c:v>1559</c:v>
                </c:pt>
                <c:pt idx="713">
                  <c:v>1559</c:v>
                </c:pt>
                <c:pt idx="714">
                  <c:v>1561</c:v>
                </c:pt>
                <c:pt idx="715">
                  <c:v>1562</c:v>
                </c:pt>
                <c:pt idx="716">
                  <c:v>1562</c:v>
                </c:pt>
                <c:pt idx="717">
                  <c:v>1569</c:v>
                </c:pt>
                <c:pt idx="718">
                  <c:v>1569</c:v>
                </c:pt>
                <c:pt idx="719">
                  <c:v>1570</c:v>
                </c:pt>
                <c:pt idx="720">
                  <c:v>1570</c:v>
                </c:pt>
                <c:pt idx="721">
                  <c:v>1574</c:v>
                </c:pt>
                <c:pt idx="722">
                  <c:v>1574</c:v>
                </c:pt>
                <c:pt idx="723">
                  <c:v>1575</c:v>
                </c:pt>
                <c:pt idx="724">
                  <c:v>1575</c:v>
                </c:pt>
                <c:pt idx="725">
                  <c:v>1577</c:v>
                </c:pt>
                <c:pt idx="726">
                  <c:v>1579</c:v>
                </c:pt>
                <c:pt idx="727">
                  <c:v>1579</c:v>
                </c:pt>
                <c:pt idx="728">
                  <c:v>1582</c:v>
                </c:pt>
                <c:pt idx="729">
                  <c:v>1582</c:v>
                </c:pt>
                <c:pt idx="730">
                  <c:v>1583</c:v>
                </c:pt>
                <c:pt idx="731">
                  <c:v>1584</c:v>
                </c:pt>
                <c:pt idx="732">
                  <c:v>1585</c:v>
                </c:pt>
                <c:pt idx="733">
                  <c:v>1586</c:v>
                </c:pt>
                <c:pt idx="734">
                  <c:v>1586</c:v>
                </c:pt>
                <c:pt idx="735">
                  <c:v>1589</c:v>
                </c:pt>
                <c:pt idx="736">
                  <c:v>1589</c:v>
                </c:pt>
                <c:pt idx="737">
                  <c:v>1592</c:v>
                </c:pt>
                <c:pt idx="738">
                  <c:v>1594</c:v>
                </c:pt>
                <c:pt idx="739">
                  <c:v>1601</c:v>
                </c:pt>
                <c:pt idx="740">
                  <c:v>1601</c:v>
                </c:pt>
                <c:pt idx="741">
                  <c:v>1603</c:v>
                </c:pt>
                <c:pt idx="742">
                  <c:v>1607</c:v>
                </c:pt>
                <c:pt idx="743">
                  <c:v>1608</c:v>
                </c:pt>
                <c:pt idx="744">
                  <c:v>1609</c:v>
                </c:pt>
                <c:pt idx="745">
                  <c:v>1609</c:v>
                </c:pt>
                <c:pt idx="746">
                  <c:v>1617</c:v>
                </c:pt>
                <c:pt idx="747">
                  <c:v>1617</c:v>
                </c:pt>
                <c:pt idx="748">
                  <c:v>1623</c:v>
                </c:pt>
                <c:pt idx="749">
                  <c:v>1623</c:v>
                </c:pt>
                <c:pt idx="750">
                  <c:v>1625</c:v>
                </c:pt>
                <c:pt idx="751">
                  <c:v>1628</c:v>
                </c:pt>
                <c:pt idx="752">
                  <c:v>1628</c:v>
                </c:pt>
                <c:pt idx="753">
                  <c:v>1630</c:v>
                </c:pt>
                <c:pt idx="754">
                  <c:v>1630</c:v>
                </c:pt>
                <c:pt idx="755">
                  <c:v>1637</c:v>
                </c:pt>
                <c:pt idx="756">
                  <c:v>1643</c:v>
                </c:pt>
                <c:pt idx="757">
                  <c:v>1643</c:v>
                </c:pt>
                <c:pt idx="758">
                  <c:v>1647</c:v>
                </c:pt>
                <c:pt idx="759">
                  <c:v>1648</c:v>
                </c:pt>
                <c:pt idx="760">
                  <c:v>1648</c:v>
                </c:pt>
                <c:pt idx="761">
                  <c:v>1650</c:v>
                </c:pt>
                <c:pt idx="762">
                  <c:v>1650</c:v>
                </c:pt>
                <c:pt idx="763">
                  <c:v>1651</c:v>
                </c:pt>
                <c:pt idx="764">
                  <c:v>1652</c:v>
                </c:pt>
                <c:pt idx="765">
                  <c:v>1653</c:v>
                </c:pt>
                <c:pt idx="766">
                  <c:v>1653</c:v>
                </c:pt>
                <c:pt idx="767">
                  <c:v>1655</c:v>
                </c:pt>
                <c:pt idx="768">
                  <c:v>1656</c:v>
                </c:pt>
                <c:pt idx="769">
                  <c:v>1656</c:v>
                </c:pt>
                <c:pt idx="770">
                  <c:v>1657</c:v>
                </c:pt>
                <c:pt idx="771">
                  <c:v>1657</c:v>
                </c:pt>
                <c:pt idx="772">
                  <c:v>1661</c:v>
                </c:pt>
                <c:pt idx="773">
                  <c:v>1662</c:v>
                </c:pt>
                <c:pt idx="774">
                  <c:v>1662</c:v>
                </c:pt>
                <c:pt idx="775">
                  <c:v>1669</c:v>
                </c:pt>
                <c:pt idx="776">
                  <c:v>1669</c:v>
                </c:pt>
                <c:pt idx="777">
                  <c:v>1670</c:v>
                </c:pt>
                <c:pt idx="778">
                  <c:v>1670</c:v>
                </c:pt>
                <c:pt idx="779">
                  <c:v>1672</c:v>
                </c:pt>
                <c:pt idx="780">
                  <c:v>1672</c:v>
                </c:pt>
                <c:pt idx="781">
                  <c:v>1675</c:v>
                </c:pt>
                <c:pt idx="782">
                  <c:v>1675</c:v>
                </c:pt>
                <c:pt idx="783">
                  <c:v>1678</c:v>
                </c:pt>
                <c:pt idx="784">
                  <c:v>1688</c:v>
                </c:pt>
                <c:pt idx="785">
                  <c:v>1688</c:v>
                </c:pt>
                <c:pt idx="786">
                  <c:v>1690</c:v>
                </c:pt>
                <c:pt idx="787">
                  <c:v>1690</c:v>
                </c:pt>
                <c:pt idx="788">
                  <c:v>1694</c:v>
                </c:pt>
                <c:pt idx="789">
                  <c:v>1695</c:v>
                </c:pt>
                <c:pt idx="790">
                  <c:v>1695</c:v>
                </c:pt>
                <c:pt idx="791">
                  <c:v>1701</c:v>
                </c:pt>
                <c:pt idx="792">
                  <c:v>1703</c:v>
                </c:pt>
                <c:pt idx="793">
                  <c:v>1703</c:v>
                </c:pt>
                <c:pt idx="794">
                  <c:v>1704</c:v>
                </c:pt>
                <c:pt idx="795">
                  <c:v>1708</c:v>
                </c:pt>
                <c:pt idx="796">
                  <c:v>1708</c:v>
                </c:pt>
                <c:pt idx="797">
                  <c:v>1717</c:v>
                </c:pt>
                <c:pt idx="798">
                  <c:v>1717</c:v>
                </c:pt>
                <c:pt idx="799">
                  <c:v>1718</c:v>
                </c:pt>
                <c:pt idx="800">
                  <c:v>1719</c:v>
                </c:pt>
                <c:pt idx="801">
                  <c:v>1719</c:v>
                </c:pt>
                <c:pt idx="802">
                  <c:v>1721</c:v>
                </c:pt>
                <c:pt idx="803">
                  <c:v>1722</c:v>
                </c:pt>
                <c:pt idx="804">
                  <c:v>1722</c:v>
                </c:pt>
                <c:pt idx="805">
                  <c:v>1729</c:v>
                </c:pt>
                <c:pt idx="806">
                  <c:v>1730</c:v>
                </c:pt>
                <c:pt idx="807">
                  <c:v>1737</c:v>
                </c:pt>
                <c:pt idx="808">
                  <c:v>1740</c:v>
                </c:pt>
                <c:pt idx="809">
                  <c:v>1740</c:v>
                </c:pt>
                <c:pt idx="810">
                  <c:v>1744</c:v>
                </c:pt>
                <c:pt idx="811">
                  <c:v>1744</c:v>
                </c:pt>
                <c:pt idx="812">
                  <c:v>1753</c:v>
                </c:pt>
                <c:pt idx="813">
                  <c:v>1754</c:v>
                </c:pt>
                <c:pt idx="814">
                  <c:v>1754</c:v>
                </c:pt>
                <c:pt idx="815">
                  <c:v>1758</c:v>
                </c:pt>
                <c:pt idx="816">
                  <c:v>1758</c:v>
                </c:pt>
                <c:pt idx="817">
                  <c:v>1760</c:v>
                </c:pt>
                <c:pt idx="818">
                  <c:v>1760</c:v>
                </c:pt>
                <c:pt idx="819">
                  <c:v>1761</c:v>
                </c:pt>
                <c:pt idx="820">
                  <c:v>1763</c:v>
                </c:pt>
                <c:pt idx="821">
                  <c:v>1763</c:v>
                </c:pt>
                <c:pt idx="822">
                  <c:v>1764</c:v>
                </c:pt>
                <c:pt idx="823">
                  <c:v>1766</c:v>
                </c:pt>
                <c:pt idx="824">
                  <c:v>1767</c:v>
                </c:pt>
                <c:pt idx="825">
                  <c:v>1772</c:v>
                </c:pt>
                <c:pt idx="826">
                  <c:v>1772</c:v>
                </c:pt>
                <c:pt idx="827">
                  <c:v>1778</c:v>
                </c:pt>
                <c:pt idx="828">
                  <c:v>1778</c:v>
                </c:pt>
                <c:pt idx="829">
                  <c:v>1784</c:v>
                </c:pt>
                <c:pt idx="830">
                  <c:v>1785</c:v>
                </c:pt>
                <c:pt idx="831">
                  <c:v>1785</c:v>
                </c:pt>
                <c:pt idx="832">
                  <c:v>1790</c:v>
                </c:pt>
                <c:pt idx="833">
                  <c:v>1791</c:v>
                </c:pt>
                <c:pt idx="834">
                  <c:v>1791</c:v>
                </c:pt>
                <c:pt idx="835">
                  <c:v>1793</c:v>
                </c:pt>
                <c:pt idx="836">
                  <c:v>1794</c:v>
                </c:pt>
                <c:pt idx="837">
                  <c:v>1798</c:v>
                </c:pt>
                <c:pt idx="838">
                  <c:v>1798</c:v>
                </c:pt>
                <c:pt idx="839">
                  <c:v>1799</c:v>
                </c:pt>
                <c:pt idx="840">
                  <c:v>1799</c:v>
                </c:pt>
                <c:pt idx="841">
                  <c:v>1805</c:v>
                </c:pt>
                <c:pt idx="842">
                  <c:v>1816</c:v>
                </c:pt>
                <c:pt idx="843">
                  <c:v>1820</c:v>
                </c:pt>
                <c:pt idx="844">
                  <c:v>1826</c:v>
                </c:pt>
                <c:pt idx="845">
                  <c:v>1826</c:v>
                </c:pt>
                <c:pt idx="846">
                  <c:v>1827</c:v>
                </c:pt>
                <c:pt idx="847">
                  <c:v>1827</c:v>
                </c:pt>
                <c:pt idx="848">
                  <c:v>1828</c:v>
                </c:pt>
                <c:pt idx="849">
                  <c:v>1829</c:v>
                </c:pt>
                <c:pt idx="850">
                  <c:v>1835</c:v>
                </c:pt>
                <c:pt idx="851">
                  <c:v>1840</c:v>
                </c:pt>
                <c:pt idx="852">
                  <c:v>1841</c:v>
                </c:pt>
                <c:pt idx="853">
                  <c:v>1844</c:v>
                </c:pt>
                <c:pt idx="854">
                  <c:v>1844</c:v>
                </c:pt>
                <c:pt idx="855">
                  <c:v>1846</c:v>
                </c:pt>
                <c:pt idx="856">
                  <c:v>1847</c:v>
                </c:pt>
                <c:pt idx="857">
                  <c:v>1848</c:v>
                </c:pt>
                <c:pt idx="858">
                  <c:v>1851</c:v>
                </c:pt>
                <c:pt idx="859">
                  <c:v>1854</c:v>
                </c:pt>
                <c:pt idx="860">
                  <c:v>1854</c:v>
                </c:pt>
                <c:pt idx="861">
                  <c:v>1856</c:v>
                </c:pt>
                <c:pt idx="862">
                  <c:v>1857</c:v>
                </c:pt>
                <c:pt idx="863">
                  <c:v>1857</c:v>
                </c:pt>
                <c:pt idx="864">
                  <c:v>1860</c:v>
                </c:pt>
                <c:pt idx="865">
                  <c:v>1864</c:v>
                </c:pt>
                <c:pt idx="866">
                  <c:v>1864</c:v>
                </c:pt>
                <c:pt idx="867">
                  <c:v>1866</c:v>
                </c:pt>
                <c:pt idx="868">
                  <c:v>1869</c:v>
                </c:pt>
                <c:pt idx="869">
                  <c:v>1871</c:v>
                </c:pt>
                <c:pt idx="870">
                  <c:v>1876</c:v>
                </c:pt>
                <c:pt idx="871">
                  <c:v>1877</c:v>
                </c:pt>
                <c:pt idx="872">
                  <c:v>1881</c:v>
                </c:pt>
                <c:pt idx="873">
                  <c:v>1882</c:v>
                </c:pt>
                <c:pt idx="874">
                  <c:v>1883</c:v>
                </c:pt>
                <c:pt idx="875">
                  <c:v>1883</c:v>
                </c:pt>
                <c:pt idx="876">
                  <c:v>1884</c:v>
                </c:pt>
                <c:pt idx="877">
                  <c:v>1887</c:v>
                </c:pt>
                <c:pt idx="878">
                  <c:v>1887</c:v>
                </c:pt>
                <c:pt idx="879">
                  <c:v>1889</c:v>
                </c:pt>
                <c:pt idx="880">
                  <c:v>1890</c:v>
                </c:pt>
                <c:pt idx="881">
                  <c:v>1891</c:v>
                </c:pt>
                <c:pt idx="882">
                  <c:v>1891</c:v>
                </c:pt>
                <c:pt idx="883">
                  <c:v>1896</c:v>
                </c:pt>
                <c:pt idx="884">
                  <c:v>1896</c:v>
                </c:pt>
                <c:pt idx="885">
                  <c:v>1897</c:v>
                </c:pt>
                <c:pt idx="886">
                  <c:v>1900</c:v>
                </c:pt>
                <c:pt idx="887">
                  <c:v>1905</c:v>
                </c:pt>
                <c:pt idx="888">
                  <c:v>1905</c:v>
                </c:pt>
                <c:pt idx="889">
                  <c:v>1906</c:v>
                </c:pt>
                <c:pt idx="890">
                  <c:v>1906</c:v>
                </c:pt>
                <c:pt idx="891">
                  <c:v>1907</c:v>
                </c:pt>
                <c:pt idx="892">
                  <c:v>1907</c:v>
                </c:pt>
                <c:pt idx="893">
                  <c:v>1910</c:v>
                </c:pt>
                <c:pt idx="894">
                  <c:v>1911</c:v>
                </c:pt>
                <c:pt idx="895">
                  <c:v>1915</c:v>
                </c:pt>
                <c:pt idx="896">
                  <c:v>1915</c:v>
                </c:pt>
                <c:pt idx="897">
                  <c:v>1916</c:v>
                </c:pt>
                <c:pt idx="898">
                  <c:v>1916</c:v>
                </c:pt>
                <c:pt idx="899">
                  <c:v>1917</c:v>
                </c:pt>
                <c:pt idx="900">
                  <c:v>1918</c:v>
                </c:pt>
                <c:pt idx="901">
                  <c:v>1919</c:v>
                </c:pt>
                <c:pt idx="902">
                  <c:v>1920</c:v>
                </c:pt>
                <c:pt idx="903">
                  <c:v>1920</c:v>
                </c:pt>
                <c:pt idx="904">
                  <c:v>1922</c:v>
                </c:pt>
                <c:pt idx="905">
                  <c:v>1927</c:v>
                </c:pt>
                <c:pt idx="906">
                  <c:v>1929</c:v>
                </c:pt>
                <c:pt idx="907">
                  <c:v>1929</c:v>
                </c:pt>
                <c:pt idx="908">
                  <c:v>1930</c:v>
                </c:pt>
                <c:pt idx="909">
                  <c:v>1938</c:v>
                </c:pt>
                <c:pt idx="910">
                  <c:v>1940</c:v>
                </c:pt>
                <c:pt idx="911">
                  <c:v>1941</c:v>
                </c:pt>
                <c:pt idx="912">
                  <c:v>1941</c:v>
                </c:pt>
                <c:pt idx="913">
                  <c:v>1944</c:v>
                </c:pt>
                <c:pt idx="914">
                  <c:v>1945</c:v>
                </c:pt>
                <c:pt idx="915">
                  <c:v>1946</c:v>
                </c:pt>
                <c:pt idx="916">
                  <c:v>1946</c:v>
                </c:pt>
                <c:pt idx="917">
                  <c:v>1948</c:v>
                </c:pt>
                <c:pt idx="918">
                  <c:v>1948</c:v>
                </c:pt>
                <c:pt idx="919">
                  <c:v>1954</c:v>
                </c:pt>
                <c:pt idx="920">
                  <c:v>1954</c:v>
                </c:pt>
                <c:pt idx="921">
                  <c:v>1955</c:v>
                </c:pt>
                <c:pt idx="922">
                  <c:v>1955</c:v>
                </c:pt>
                <c:pt idx="923">
                  <c:v>1957</c:v>
                </c:pt>
                <c:pt idx="924">
                  <c:v>1957</c:v>
                </c:pt>
                <c:pt idx="925">
                  <c:v>1959</c:v>
                </c:pt>
                <c:pt idx="926">
                  <c:v>1960</c:v>
                </c:pt>
                <c:pt idx="927">
                  <c:v>1960</c:v>
                </c:pt>
                <c:pt idx="928">
                  <c:v>1964</c:v>
                </c:pt>
                <c:pt idx="929">
                  <c:v>1964</c:v>
                </c:pt>
                <c:pt idx="930">
                  <c:v>1965</c:v>
                </c:pt>
                <c:pt idx="931">
                  <c:v>1965</c:v>
                </c:pt>
                <c:pt idx="932">
                  <c:v>1966</c:v>
                </c:pt>
                <c:pt idx="933">
                  <c:v>1967</c:v>
                </c:pt>
                <c:pt idx="934">
                  <c:v>1967</c:v>
                </c:pt>
                <c:pt idx="935">
                  <c:v>1968</c:v>
                </c:pt>
                <c:pt idx="936">
                  <c:v>1970</c:v>
                </c:pt>
                <c:pt idx="937">
                  <c:v>1975</c:v>
                </c:pt>
                <c:pt idx="938">
                  <c:v>1975</c:v>
                </c:pt>
                <c:pt idx="939">
                  <c:v>1992</c:v>
                </c:pt>
                <c:pt idx="940">
                  <c:v>1995</c:v>
                </c:pt>
                <c:pt idx="941">
                  <c:v>1996</c:v>
                </c:pt>
                <c:pt idx="942">
                  <c:v>1999</c:v>
                </c:pt>
                <c:pt idx="943">
                  <c:v>1999</c:v>
                </c:pt>
                <c:pt idx="944">
                  <c:v>2001</c:v>
                </c:pt>
                <c:pt idx="945">
                  <c:v>2002</c:v>
                </c:pt>
                <c:pt idx="946">
                  <c:v>2002</c:v>
                </c:pt>
                <c:pt idx="947">
                  <c:v>2004</c:v>
                </c:pt>
                <c:pt idx="948">
                  <c:v>2005</c:v>
                </c:pt>
                <c:pt idx="949">
                  <c:v>2006</c:v>
                </c:pt>
                <c:pt idx="950">
                  <c:v>2008</c:v>
                </c:pt>
                <c:pt idx="951">
                  <c:v>2010</c:v>
                </c:pt>
                <c:pt idx="952">
                  <c:v>2015</c:v>
                </c:pt>
                <c:pt idx="953">
                  <c:v>2018</c:v>
                </c:pt>
                <c:pt idx="954">
                  <c:v>2019</c:v>
                </c:pt>
                <c:pt idx="955">
                  <c:v>2021</c:v>
                </c:pt>
                <c:pt idx="956">
                  <c:v>2022</c:v>
                </c:pt>
                <c:pt idx="957">
                  <c:v>2024</c:v>
                </c:pt>
                <c:pt idx="958">
                  <c:v>2034</c:v>
                </c:pt>
                <c:pt idx="959">
                  <c:v>2034</c:v>
                </c:pt>
                <c:pt idx="960">
                  <c:v>2036</c:v>
                </c:pt>
                <c:pt idx="961">
                  <c:v>2037</c:v>
                </c:pt>
                <c:pt idx="962">
                  <c:v>2040</c:v>
                </c:pt>
                <c:pt idx="963">
                  <c:v>2042</c:v>
                </c:pt>
                <c:pt idx="964">
                  <c:v>2042</c:v>
                </c:pt>
                <c:pt idx="965">
                  <c:v>2044</c:v>
                </c:pt>
                <c:pt idx="966">
                  <c:v>2044</c:v>
                </c:pt>
                <c:pt idx="967">
                  <c:v>2045</c:v>
                </c:pt>
                <c:pt idx="968">
                  <c:v>2045</c:v>
                </c:pt>
                <c:pt idx="969">
                  <c:v>2046</c:v>
                </c:pt>
                <c:pt idx="970">
                  <c:v>2046</c:v>
                </c:pt>
                <c:pt idx="971">
                  <c:v>2048</c:v>
                </c:pt>
                <c:pt idx="972">
                  <c:v>2048</c:v>
                </c:pt>
                <c:pt idx="973">
                  <c:v>2050</c:v>
                </c:pt>
                <c:pt idx="974">
                  <c:v>2061</c:v>
                </c:pt>
                <c:pt idx="975">
                  <c:v>2063</c:v>
                </c:pt>
                <c:pt idx="976">
                  <c:v>2063</c:v>
                </c:pt>
                <c:pt idx="977">
                  <c:v>2073</c:v>
                </c:pt>
                <c:pt idx="978">
                  <c:v>2073</c:v>
                </c:pt>
                <c:pt idx="979">
                  <c:v>2079</c:v>
                </c:pt>
                <c:pt idx="980">
                  <c:v>2079</c:v>
                </c:pt>
                <c:pt idx="981">
                  <c:v>2081</c:v>
                </c:pt>
                <c:pt idx="982">
                  <c:v>2082</c:v>
                </c:pt>
                <c:pt idx="983">
                  <c:v>2083</c:v>
                </c:pt>
                <c:pt idx="984">
                  <c:v>2088</c:v>
                </c:pt>
                <c:pt idx="985">
                  <c:v>2090</c:v>
                </c:pt>
                <c:pt idx="986">
                  <c:v>2090</c:v>
                </c:pt>
                <c:pt idx="987">
                  <c:v>2098</c:v>
                </c:pt>
                <c:pt idx="988">
                  <c:v>2098</c:v>
                </c:pt>
                <c:pt idx="989">
                  <c:v>2102</c:v>
                </c:pt>
                <c:pt idx="990">
                  <c:v>2105</c:v>
                </c:pt>
                <c:pt idx="991">
                  <c:v>2107</c:v>
                </c:pt>
                <c:pt idx="992">
                  <c:v>2108</c:v>
                </c:pt>
                <c:pt idx="993">
                  <c:v>2112</c:v>
                </c:pt>
                <c:pt idx="994">
                  <c:v>2112</c:v>
                </c:pt>
                <c:pt idx="995">
                  <c:v>2116</c:v>
                </c:pt>
                <c:pt idx="996">
                  <c:v>2116</c:v>
                </c:pt>
                <c:pt idx="997">
                  <c:v>2118</c:v>
                </c:pt>
                <c:pt idx="998">
                  <c:v>2118</c:v>
                </c:pt>
                <c:pt idx="999">
                  <c:v>2120</c:v>
                </c:pt>
                <c:pt idx="1000">
                  <c:v>2127</c:v>
                </c:pt>
                <c:pt idx="1001">
                  <c:v>2127</c:v>
                </c:pt>
                <c:pt idx="1002">
                  <c:v>2130</c:v>
                </c:pt>
                <c:pt idx="1003">
                  <c:v>2132</c:v>
                </c:pt>
                <c:pt idx="1004">
                  <c:v>2132</c:v>
                </c:pt>
                <c:pt idx="1005">
                  <c:v>2135</c:v>
                </c:pt>
                <c:pt idx="1006">
                  <c:v>2135</c:v>
                </c:pt>
                <c:pt idx="1007">
                  <c:v>2141</c:v>
                </c:pt>
                <c:pt idx="1008">
                  <c:v>2143</c:v>
                </c:pt>
                <c:pt idx="1009">
                  <c:v>2147</c:v>
                </c:pt>
                <c:pt idx="1010">
                  <c:v>2147</c:v>
                </c:pt>
                <c:pt idx="1011">
                  <c:v>2149</c:v>
                </c:pt>
                <c:pt idx="1012">
                  <c:v>2149</c:v>
                </c:pt>
                <c:pt idx="1013">
                  <c:v>2150</c:v>
                </c:pt>
                <c:pt idx="1014">
                  <c:v>2153</c:v>
                </c:pt>
                <c:pt idx="1015">
                  <c:v>2153</c:v>
                </c:pt>
                <c:pt idx="1016">
                  <c:v>2163</c:v>
                </c:pt>
                <c:pt idx="1017">
                  <c:v>2166</c:v>
                </c:pt>
                <c:pt idx="1018">
                  <c:v>2166</c:v>
                </c:pt>
                <c:pt idx="1019">
                  <c:v>2171</c:v>
                </c:pt>
                <c:pt idx="1020">
                  <c:v>2173</c:v>
                </c:pt>
                <c:pt idx="1021">
                  <c:v>2173</c:v>
                </c:pt>
                <c:pt idx="1022">
                  <c:v>2177</c:v>
                </c:pt>
                <c:pt idx="1023">
                  <c:v>2177</c:v>
                </c:pt>
                <c:pt idx="1024">
                  <c:v>2178</c:v>
                </c:pt>
                <c:pt idx="1025">
                  <c:v>2179</c:v>
                </c:pt>
                <c:pt idx="1026">
                  <c:v>2184</c:v>
                </c:pt>
                <c:pt idx="1027">
                  <c:v>2194</c:v>
                </c:pt>
                <c:pt idx="1028">
                  <c:v>2194</c:v>
                </c:pt>
                <c:pt idx="1029">
                  <c:v>2204</c:v>
                </c:pt>
                <c:pt idx="1030">
                  <c:v>2204</c:v>
                </c:pt>
                <c:pt idx="1031">
                  <c:v>2215</c:v>
                </c:pt>
                <c:pt idx="1032">
                  <c:v>2215</c:v>
                </c:pt>
                <c:pt idx="1033">
                  <c:v>2218</c:v>
                </c:pt>
                <c:pt idx="1034">
                  <c:v>2221</c:v>
                </c:pt>
                <c:pt idx="1035">
                  <c:v>2223</c:v>
                </c:pt>
                <c:pt idx="1036">
                  <c:v>2223</c:v>
                </c:pt>
                <c:pt idx="1037">
                  <c:v>2225</c:v>
                </c:pt>
                <c:pt idx="1038">
                  <c:v>2226</c:v>
                </c:pt>
                <c:pt idx="1039">
                  <c:v>2242</c:v>
                </c:pt>
                <c:pt idx="1040">
                  <c:v>2242</c:v>
                </c:pt>
                <c:pt idx="1041">
                  <c:v>2244</c:v>
                </c:pt>
                <c:pt idx="1042">
                  <c:v>2244</c:v>
                </c:pt>
                <c:pt idx="1043">
                  <c:v>2245</c:v>
                </c:pt>
                <c:pt idx="1044">
                  <c:v>2248</c:v>
                </c:pt>
                <c:pt idx="1045">
                  <c:v>2248</c:v>
                </c:pt>
                <c:pt idx="1046">
                  <c:v>2253</c:v>
                </c:pt>
                <c:pt idx="1047">
                  <c:v>2254</c:v>
                </c:pt>
                <c:pt idx="1048">
                  <c:v>2257</c:v>
                </c:pt>
                <c:pt idx="1049">
                  <c:v>2257</c:v>
                </c:pt>
                <c:pt idx="1050">
                  <c:v>2259</c:v>
                </c:pt>
                <c:pt idx="1051">
                  <c:v>2260</c:v>
                </c:pt>
                <c:pt idx="1052">
                  <c:v>2260</c:v>
                </c:pt>
                <c:pt idx="1053">
                  <c:v>2261</c:v>
                </c:pt>
                <c:pt idx="1054">
                  <c:v>2261</c:v>
                </c:pt>
                <c:pt idx="1055">
                  <c:v>2265</c:v>
                </c:pt>
                <c:pt idx="1056">
                  <c:v>2265</c:v>
                </c:pt>
                <c:pt idx="1057">
                  <c:v>2266</c:v>
                </c:pt>
                <c:pt idx="1058">
                  <c:v>2267</c:v>
                </c:pt>
                <c:pt idx="1059">
                  <c:v>2268</c:v>
                </c:pt>
                <c:pt idx="1060">
                  <c:v>2268</c:v>
                </c:pt>
                <c:pt idx="1061">
                  <c:v>2271</c:v>
                </c:pt>
                <c:pt idx="1062">
                  <c:v>2273</c:v>
                </c:pt>
                <c:pt idx="1063">
                  <c:v>2276</c:v>
                </c:pt>
                <c:pt idx="1064">
                  <c:v>2279</c:v>
                </c:pt>
                <c:pt idx="1065">
                  <c:v>2279</c:v>
                </c:pt>
                <c:pt idx="1066">
                  <c:v>2280</c:v>
                </c:pt>
                <c:pt idx="1067">
                  <c:v>2280</c:v>
                </c:pt>
                <c:pt idx="1068">
                  <c:v>2282</c:v>
                </c:pt>
                <c:pt idx="1069">
                  <c:v>2283</c:v>
                </c:pt>
                <c:pt idx="1070">
                  <c:v>2284</c:v>
                </c:pt>
                <c:pt idx="1071">
                  <c:v>2284</c:v>
                </c:pt>
                <c:pt idx="1072">
                  <c:v>2287</c:v>
                </c:pt>
                <c:pt idx="1073">
                  <c:v>2287</c:v>
                </c:pt>
                <c:pt idx="1074">
                  <c:v>2296</c:v>
                </c:pt>
                <c:pt idx="1075">
                  <c:v>2297</c:v>
                </c:pt>
                <c:pt idx="1076">
                  <c:v>2302</c:v>
                </c:pt>
                <c:pt idx="1077">
                  <c:v>2306</c:v>
                </c:pt>
                <c:pt idx="1078">
                  <c:v>2310</c:v>
                </c:pt>
                <c:pt idx="1079">
                  <c:v>2314</c:v>
                </c:pt>
                <c:pt idx="1080">
                  <c:v>2317</c:v>
                </c:pt>
                <c:pt idx="1081">
                  <c:v>2317</c:v>
                </c:pt>
                <c:pt idx="1082">
                  <c:v>2322</c:v>
                </c:pt>
                <c:pt idx="1083">
                  <c:v>2324</c:v>
                </c:pt>
                <c:pt idx="1084">
                  <c:v>2324</c:v>
                </c:pt>
                <c:pt idx="1085">
                  <c:v>2325</c:v>
                </c:pt>
                <c:pt idx="1086">
                  <c:v>2325</c:v>
                </c:pt>
                <c:pt idx="1087">
                  <c:v>2330</c:v>
                </c:pt>
                <c:pt idx="1088">
                  <c:v>2336</c:v>
                </c:pt>
                <c:pt idx="1089">
                  <c:v>2336</c:v>
                </c:pt>
                <c:pt idx="1090">
                  <c:v>2338</c:v>
                </c:pt>
                <c:pt idx="1091">
                  <c:v>2344</c:v>
                </c:pt>
                <c:pt idx="1092">
                  <c:v>2345</c:v>
                </c:pt>
                <c:pt idx="1093">
                  <c:v>2352</c:v>
                </c:pt>
                <c:pt idx="1094">
                  <c:v>2354</c:v>
                </c:pt>
                <c:pt idx="1095">
                  <c:v>2354</c:v>
                </c:pt>
                <c:pt idx="1096">
                  <c:v>2358</c:v>
                </c:pt>
                <c:pt idx="1097">
                  <c:v>2358</c:v>
                </c:pt>
                <c:pt idx="1098">
                  <c:v>2361</c:v>
                </c:pt>
                <c:pt idx="1099">
                  <c:v>2363</c:v>
                </c:pt>
                <c:pt idx="1100">
                  <c:v>2366</c:v>
                </c:pt>
                <c:pt idx="1101">
                  <c:v>2366</c:v>
                </c:pt>
                <c:pt idx="1102">
                  <c:v>2368</c:v>
                </c:pt>
                <c:pt idx="1103">
                  <c:v>2373</c:v>
                </c:pt>
                <c:pt idx="1104">
                  <c:v>2373</c:v>
                </c:pt>
                <c:pt idx="1105">
                  <c:v>2374</c:v>
                </c:pt>
                <c:pt idx="1106">
                  <c:v>2374</c:v>
                </c:pt>
                <c:pt idx="1107">
                  <c:v>2375</c:v>
                </c:pt>
                <c:pt idx="1108">
                  <c:v>2375</c:v>
                </c:pt>
                <c:pt idx="1109">
                  <c:v>2379</c:v>
                </c:pt>
                <c:pt idx="1110">
                  <c:v>2380</c:v>
                </c:pt>
                <c:pt idx="1111">
                  <c:v>2380</c:v>
                </c:pt>
                <c:pt idx="1112">
                  <c:v>2382</c:v>
                </c:pt>
                <c:pt idx="1113">
                  <c:v>2384</c:v>
                </c:pt>
                <c:pt idx="1114">
                  <c:v>2392</c:v>
                </c:pt>
                <c:pt idx="1115">
                  <c:v>2394</c:v>
                </c:pt>
                <c:pt idx="1116">
                  <c:v>2394</c:v>
                </c:pt>
                <c:pt idx="1117">
                  <c:v>2396</c:v>
                </c:pt>
                <c:pt idx="1118">
                  <c:v>2396</c:v>
                </c:pt>
                <c:pt idx="1119">
                  <c:v>2398</c:v>
                </c:pt>
                <c:pt idx="1120">
                  <c:v>2399</c:v>
                </c:pt>
                <c:pt idx="1121">
                  <c:v>2399</c:v>
                </c:pt>
                <c:pt idx="1122">
                  <c:v>2404</c:v>
                </c:pt>
                <c:pt idx="1123">
                  <c:v>2407</c:v>
                </c:pt>
                <c:pt idx="1124">
                  <c:v>2411</c:v>
                </c:pt>
                <c:pt idx="1125">
                  <c:v>2411</c:v>
                </c:pt>
                <c:pt idx="1126">
                  <c:v>2415</c:v>
                </c:pt>
                <c:pt idx="1127">
                  <c:v>2415</c:v>
                </c:pt>
                <c:pt idx="1128">
                  <c:v>2421</c:v>
                </c:pt>
                <c:pt idx="1129">
                  <c:v>2422</c:v>
                </c:pt>
                <c:pt idx="1130">
                  <c:v>2422</c:v>
                </c:pt>
                <c:pt idx="1131">
                  <c:v>2431</c:v>
                </c:pt>
                <c:pt idx="1132">
                  <c:v>2432</c:v>
                </c:pt>
                <c:pt idx="1133">
                  <c:v>2432</c:v>
                </c:pt>
                <c:pt idx="1134">
                  <c:v>2433</c:v>
                </c:pt>
                <c:pt idx="1135">
                  <c:v>2433</c:v>
                </c:pt>
                <c:pt idx="1136">
                  <c:v>2434</c:v>
                </c:pt>
                <c:pt idx="1137">
                  <c:v>2434</c:v>
                </c:pt>
                <c:pt idx="1138">
                  <c:v>2440</c:v>
                </c:pt>
                <c:pt idx="1139">
                  <c:v>2440</c:v>
                </c:pt>
                <c:pt idx="1140">
                  <c:v>2447</c:v>
                </c:pt>
                <c:pt idx="1141">
                  <c:v>2447</c:v>
                </c:pt>
                <c:pt idx="1142">
                  <c:v>2454</c:v>
                </c:pt>
                <c:pt idx="1143">
                  <c:v>2454</c:v>
                </c:pt>
                <c:pt idx="1144">
                  <c:v>2457</c:v>
                </c:pt>
                <c:pt idx="1145">
                  <c:v>2457</c:v>
                </c:pt>
                <c:pt idx="1146">
                  <c:v>2474</c:v>
                </c:pt>
                <c:pt idx="1147">
                  <c:v>2476</c:v>
                </c:pt>
                <c:pt idx="1148">
                  <c:v>2479</c:v>
                </c:pt>
                <c:pt idx="1149">
                  <c:v>2479</c:v>
                </c:pt>
                <c:pt idx="1150">
                  <c:v>2482</c:v>
                </c:pt>
                <c:pt idx="1151">
                  <c:v>2482</c:v>
                </c:pt>
                <c:pt idx="1152">
                  <c:v>2484</c:v>
                </c:pt>
                <c:pt idx="1153">
                  <c:v>2484</c:v>
                </c:pt>
                <c:pt idx="1154">
                  <c:v>2489</c:v>
                </c:pt>
                <c:pt idx="1155">
                  <c:v>2494</c:v>
                </c:pt>
                <c:pt idx="1156">
                  <c:v>2494</c:v>
                </c:pt>
                <c:pt idx="1157">
                  <c:v>2501</c:v>
                </c:pt>
                <c:pt idx="1158">
                  <c:v>2501</c:v>
                </c:pt>
                <c:pt idx="1159">
                  <c:v>2502</c:v>
                </c:pt>
                <c:pt idx="1160">
                  <c:v>2504</c:v>
                </c:pt>
                <c:pt idx="1161">
                  <c:v>2506</c:v>
                </c:pt>
                <c:pt idx="1162">
                  <c:v>2506</c:v>
                </c:pt>
                <c:pt idx="1163">
                  <c:v>2509</c:v>
                </c:pt>
                <c:pt idx="1164">
                  <c:v>2509</c:v>
                </c:pt>
                <c:pt idx="1165">
                  <c:v>2510</c:v>
                </c:pt>
                <c:pt idx="1166">
                  <c:v>2510</c:v>
                </c:pt>
                <c:pt idx="1167">
                  <c:v>2526</c:v>
                </c:pt>
                <c:pt idx="1168">
                  <c:v>2526</c:v>
                </c:pt>
                <c:pt idx="1169">
                  <c:v>2527</c:v>
                </c:pt>
                <c:pt idx="1170">
                  <c:v>2527</c:v>
                </c:pt>
                <c:pt idx="1171">
                  <c:v>2533</c:v>
                </c:pt>
                <c:pt idx="1172">
                  <c:v>2535</c:v>
                </c:pt>
                <c:pt idx="1173">
                  <c:v>2535</c:v>
                </c:pt>
                <c:pt idx="1174">
                  <c:v>2542</c:v>
                </c:pt>
                <c:pt idx="1175">
                  <c:v>2542</c:v>
                </c:pt>
                <c:pt idx="1176">
                  <c:v>2545</c:v>
                </c:pt>
                <c:pt idx="1177">
                  <c:v>2545</c:v>
                </c:pt>
                <c:pt idx="1178">
                  <c:v>2547</c:v>
                </c:pt>
                <c:pt idx="1179">
                  <c:v>2547</c:v>
                </c:pt>
                <c:pt idx="1180">
                  <c:v>2550</c:v>
                </c:pt>
                <c:pt idx="1181">
                  <c:v>2550</c:v>
                </c:pt>
                <c:pt idx="1182">
                  <c:v>2551</c:v>
                </c:pt>
                <c:pt idx="1183">
                  <c:v>2551</c:v>
                </c:pt>
                <c:pt idx="1184">
                  <c:v>2556</c:v>
                </c:pt>
                <c:pt idx="1185">
                  <c:v>2556</c:v>
                </c:pt>
                <c:pt idx="1186">
                  <c:v>2559</c:v>
                </c:pt>
                <c:pt idx="1187">
                  <c:v>2559</c:v>
                </c:pt>
                <c:pt idx="1188">
                  <c:v>2561</c:v>
                </c:pt>
                <c:pt idx="1189">
                  <c:v>2562</c:v>
                </c:pt>
                <c:pt idx="1190">
                  <c:v>2562</c:v>
                </c:pt>
                <c:pt idx="1191">
                  <c:v>2565</c:v>
                </c:pt>
                <c:pt idx="1192">
                  <c:v>2565</c:v>
                </c:pt>
                <c:pt idx="1193">
                  <c:v>2566</c:v>
                </c:pt>
                <c:pt idx="1194">
                  <c:v>2567</c:v>
                </c:pt>
                <c:pt idx="1195">
                  <c:v>2567</c:v>
                </c:pt>
                <c:pt idx="1196">
                  <c:v>2570</c:v>
                </c:pt>
                <c:pt idx="1197">
                  <c:v>2572</c:v>
                </c:pt>
                <c:pt idx="1198">
                  <c:v>2572</c:v>
                </c:pt>
                <c:pt idx="1199">
                  <c:v>2577</c:v>
                </c:pt>
                <c:pt idx="1200">
                  <c:v>2578</c:v>
                </c:pt>
                <c:pt idx="1201">
                  <c:v>2578</c:v>
                </c:pt>
                <c:pt idx="1202">
                  <c:v>2580</c:v>
                </c:pt>
                <c:pt idx="1203">
                  <c:v>2582</c:v>
                </c:pt>
                <c:pt idx="1204">
                  <c:v>2582</c:v>
                </c:pt>
                <c:pt idx="1205">
                  <c:v>2583</c:v>
                </c:pt>
                <c:pt idx="1206">
                  <c:v>2587</c:v>
                </c:pt>
                <c:pt idx="1207">
                  <c:v>2587</c:v>
                </c:pt>
                <c:pt idx="1208">
                  <c:v>2591</c:v>
                </c:pt>
                <c:pt idx="1209">
                  <c:v>2591</c:v>
                </c:pt>
                <c:pt idx="1210">
                  <c:v>2592</c:v>
                </c:pt>
                <c:pt idx="1211">
                  <c:v>2596</c:v>
                </c:pt>
                <c:pt idx="1212">
                  <c:v>2598</c:v>
                </c:pt>
                <c:pt idx="1213">
                  <c:v>2605</c:v>
                </c:pt>
                <c:pt idx="1214">
                  <c:v>2610</c:v>
                </c:pt>
                <c:pt idx="1215">
                  <c:v>2610</c:v>
                </c:pt>
                <c:pt idx="1216">
                  <c:v>2613</c:v>
                </c:pt>
                <c:pt idx="1217">
                  <c:v>2613</c:v>
                </c:pt>
                <c:pt idx="1218">
                  <c:v>2617</c:v>
                </c:pt>
                <c:pt idx="1219">
                  <c:v>2617</c:v>
                </c:pt>
                <c:pt idx="1220">
                  <c:v>2624</c:v>
                </c:pt>
                <c:pt idx="1221">
                  <c:v>2624</c:v>
                </c:pt>
                <c:pt idx="1222">
                  <c:v>2631</c:v>
                </c:pt>
                <c:pt idx="1223">
                  <c:v>2631</c:v>
                </c:pt>
                <c:pt idx="1224">
                  <c:v>2632</c:v>
                </c:pt>
                <c:pt idx="1225">
                  <c:v>2632</c:v>
                </c:pt>
                <c:pt idx="1226">
                  <c:v>2637</c:v>
                </c:pt>
                <c:pt idx="1227">
                  <c:v>2650</c:v>
                </c:pt>
                <c:pt idx="1228">
                  <c:v>2650</c:v>
                </c:pt>
                <c:pt idx="1229">
                  <c:v>2653</c:v>
                </c:pt>
                <c:pt idx="1230">
                  <c:v>2654</c:v>
                </c:pt>
                <c:pt idx="1231">
                  <c:v>2655</c:v>
                </c:pt>
                <c:pt idx="1232">
                  <c:v>2658</c:v>
                </c:pt>
                <c:pt idx="1233">
                  <c:v>2660</c:v>
                </c:pt>
                <c:pt idx="1234">
                  <c:v>2660</c:v>
                </c:pt>
                <c:pt idx="1235">
                  <c:v>2664</c:v>
                </c:pt>
                <c:pt idx="1236">
                  <c:v>2664</c:v>
                </c:pt>
                <c:pt idx="1237">
                  <c:v>2665</c:v>
                </c:pt>
                <c:pt idx="1238">
                  <c:v>2665</c:v>
                </c:pt>
                <c:pt idx="1239">
                  <c:v>2668</c:v>
                </c:pt>
                <c:pt idx="1240">
                  <c:v>2668</c:v>
                </c:pt>
                <c:pt idx="1241">
                  <c:v>2671</c:v>
                </c:pt>
                <c:pt idx="1242">
                  <c:v>2671</c:v>
                </c:pt>
                <c:pt idx="1243">
                  <c:v>2673</c:v>
                </c:pt>
                <c:pt idx="1244">
                  <c:v>2673</c:v>
                </c:pt>
                <c:pt idx="1245">
                  <c:v>2680</c:v>
                </c:pt>
                <c:pt idx="1246">
                  <c:v>2680</c:v>
                </c:pt>
                <c:pt idx="1247">
                  <c:v>2688</c:v>
                </c:pt>
                <c:pt idx="1248">
                  <c:v>2688</c:v>
                </c:pt>
                <c:pt idx="1249">
                  <c:v>2693</c:v>
                </c:pt>
                <c:pt idx="1250">
                  <c:v>2694</c:v>
                </c:pt>
                <c:pt idx="1251">
                  <c:v>2697</c:v>
                </c:pt>
                <c:pt idx="1252">
                  <c:v>2697</c:v>
                </c:pt>
                <c:pt idx="1253">
                  <c:v>2699</c:v>
                </c:pt>
                <c:pt idx="1254">
                  <c:v>2699</c:v>
                </c:pt>
                <c:pt idx="1255">
                  <c:v>2700</c:v>
                </c:pt>
                <c:pt idx="1256">
                  <c:v>2700</c:v>
                </c:pt>
                <c:pt idx="1257">
                  <c:v>2704</c:v>
                </c:pt>
                <c:pt idx="1258">
                  <c:v>2704</c:v>
                </c:pt>
                <c:pt idx="1259">
                  <c:v>2707</c:v>
                </c:pt>
                <c:pt idx="1260">
                  <c:v>2707</c:v>
                </c:pt>
                <c:pt idx="1261">
                  <c:v>2708</c:v>
                </c:pt>
                <c:pt idx="1262">
                  <c:v>2708</c:v>
                </c:pt>
                <c:pt idx="1263">
                  <c:v>2709</c:v>
                </c:pt>
                <c:pt idx="1264">
                  <c:v>2709</c:v>
                </c:pt>
                <c:pt idx="1265">
                  <c:v>2713</c:v>
                </c:pt>
                <c:pt idx="1266">
                  <c:v>2720</c:v>
                </c:pt>
                <c:pt idx="1267">
                  <c:v>2720</c:v>
                </c:pt>
                <c:pt idx="1268">
                  <c:v>2724</c:v>
                </c:pt>
                <c:pt idx="1269">
                  <c:v>2724</c:v>
                </c:pt>
                <c:pt idx="1270">
                  <c:v>2730</c:v>
                </c:pt>
                <c:pt idx="1271">
                  <c:v>2732</c:v>
                </c:pt>
                <c:pt idx="1272">
                  <c:v>2733</c:v>
                </c:pt>
                <c:pt idx="1273">
                  <c:v>2733</c:v>
                </c:pt>
                <c:pt idx="1274">
                  <c:v>2734</c:v>
                </c:pt>
                <c:pt idx="1275">
                  <c:v>2734</c:v>
                </c:pt>
                <c:pt idx="1276">
                  <c:v>2737</c:v>
                </c:pt>
                <c:pt idx="1277">
                  <c:v>2745</c:v>
                </c:pt>
                <c:pt idx="1278">
                  <c:v>2746</c:v>
                </c:pt>
                <c:pt idx="1279">
                  <c:v>2749</c:v>
                </c:pt>
                <c:pt idx="1280">
                  <c:v>2749</c:v>
                </c:pt>
                <c:pt idx="1281">
                  <c:v>2752</c:v>
                </c:pt>
                <c:pt idx="1282">
                  <c:v>2752</c:v>
                </c:pt>
                <c:pt idx="1283">
                  <c:v>2755</c:v>
                </c:pt>
                <c:pt idx="1284">
                  <c:v>2767</c:v>
                </c:pt>
                <c:pt idx="1285">
                  <c:v>2768</c:v>
                </c:pt>
                <c:pt idx="1286">
                  <c:v>2772</c:v>
                </c:pt>
                <c:pt idx="1287">
                  <c:v>2772</c:v>
                </c:pt>
                <c:pt idx="1288">
                  <c:v>2775</c:v>
                </c:pt>
                <c:pt idx="1289">
                  <c:v>2775</c:v>
                </c:pt>
                <c:pt idx="1290">
                  <c:v>2787</c:v>
                </c:pt>
                <c:pt idx="1291">
                  <c:v>2810</c:v>
                </c:pt>
                <c:pt idx="1292">
                  <c:v>2810</c:v>
                </c:pt>
                <c:pt idx="1293">
                  <c:v>2821</c:v>
                </c:pt>
                <c:pt idx="1294">
                  <c:v>2821</c:v>
                </c:pt>
                <c:pt idx="1295">
                  <c:v>2827</c:v>
                </c:pt>
                <c:pt idx="1296">
                  <c:v>2827</c:v>
                </c:pt>
                <c:pt idx="1297">
                  <c:v>2841</c:v>
                </c:pt>
                <c:pt idx="1298">
                  <c:v>2842</c:v>
                </c:pt>
                <c:pt idx="1299">
                  <c:v>2842</c:v>
                </c:pt>
                <c:pt idx="1300">
                  <c:v>2843</c:v>
                </c:pt>
                <c:pt idx="1301">
                  <c:v>2843</c:v>
                </c:pt>
                <c:pt idx="1302">
                  <c:v>2847</c:v>
                </c:pt>
                <c:pt idx="1303">
                  <c:v>2847</c:v>
                </c:pt>
                <c:pt idx="1304">
                  <c:v>2872</c:v>
                </c:pt>
                <c:pt idx="1305">
                  <c:v>2872</c:v>
                </c:pt>
                <c:pt idx="1306">
                  <c:v>2875</c:v>
                </c:pt>
                <c:pt idx="1307">
                  <c:v>2875</c:v>
                </c:pt>
                <c:pt idx="1308">
                  <c:v>2886</c:v>
                </c:pt>
                <c:pt idx="1309">
                  <c:v>2886</c:v>
                </c:pt>
                <c:pt idx="1310">
                  <c:v>2905</c:v>
                </c:pt>
                <c:pt idx="1311">
                  <c:v>2905</c:v>
                </c:pt>
                <c:pt idx="1312">
                  <c:v>2909</c:v>
                </c:pt>
                <c:pt idx="1313">
                  <c:v>2909</c:v>
                </c:pt>
                <c:pt idx="1314">
                  <c:v>2922</c:v>
                </c:pt>
                <c:pt idx="1315">
                  <c:v>2923</c:v>
                </c:pt>
                <c:pt idx="1316">
                  <c:v>2923</c:v>
                </c:pt>
                <c:pt idx="1317">
                  <c:v>2925</c:v>
                </c:pt>
                <c:pt idx="1318">
                  <c:v>2935</c:v>
                </c:pt>
                <c:pt idx="1319">
                  <c:v>2935</c:v>
                </c:pt>
                <c:pt idx="1320">
                  <c:v>2947</c:v>
                </c:pt>
                <c:pt idx="1321">
                  <c:v>2948</c:v>
                </c:pt>
                <c:pt idx="1322">
                  <c:v>2951</c:v>
                </c:pt>
                <c:pt idx="1323">
                  <c:v>2954</c:v>
                </c:pt>
                <c:pt idx="1324">
                  <c:v>2955</c:v>
                </c:pt>
                <c:pt idx="1325">
                  <c:v>2955</c:v>
                </c:pt>
                <c:pt idx="1326">
                  <c:v>2957</c:v>
                </c:pt>
                <c:pt idx="1327">
                  <c:v>2957</c:v>
                </c:pt>
                <c:pt idx="1328">
                  <c:v>2961</c:v>
                </c:pt>
                <c:pt idx="1329">
                  <c:v>2961</c:v>
                </c:pt>
                <c:pt idx="1330">
                  <c:v>2963</c:v>
                </c:pt>
                <c:pt idx="1331">
                  <c:v>2963</c:v>
                </c:pt>
                <c:pt idx="1332">
                  <c:v>2965</c:v>
                </c:pt>
                <c:pt idx="1333">
                  <c:v>2965</c:v>
                </c:pt>
                <c:pt idx="1334">
                  <c:v>2970</c:v>
                </c:pt>
                <c:pt idx="1335">
                  <c:v>2970</c:v>
                </c:pt>
                <c:pt idx="1336">
                  <c:v>2981</c:v>
                </c:pt>
                <c:pt idx="1337">
                  <c:v>2981</c:v>
                </c:pt>
                <c:pt idx="1338">
                  <c:v>2982</c:v>
                </c:pt>
                <c:pt idx="1339">
                  <c:v>2982</c:v>
                </c:pt>
                <c:pt idx="1340">
                  <c:v>2990</c:v>
                </c:pt>
                <c:pt idx="1341">
                  <c:v>2991</c:v>
                </c:pt>
                <c:pt idx="1342">
                  <c:v>2991</c:v>
                </c:pt>
                <c:pt idx="1343">
                  <c:v>2993</c:v>
                </c:pt>
                <c:pt idx="1344">
                  <c:v>2993</c:v>
                </c:pt>
                <c:pt idx="1345">
                  <c:v>2999</c:v>
                </c:pt>
                <c:pt idx="1346">
                  <c:v>3001</c:v>
                </c:pt>
                <c:pt idx="1347">
                  <c:v>3004</c:v>
                </c:pt>
                <c:pt idx="1348">
                  <c:v>3004</c:v>
                </c:pt>
                <c:pt idx="1349">
                  <c:v>3005</c:v>
                </c:pt>
                <c:pt idx="1350">
                  <c:v>3005</c:v>
                </c:pt>
                <c:pt idx="1351">
                  <c:v>3009</c:v>
                </c:pt>
                <c:pt idx="1352">
                  <c:v>3009</c:v>
                </c:pt>
                <c:pt idx="1353">
                  <c:v>3011</c:v>
                </c:pt>
                <c:pt idx="1354">
                  <c:v>3018</c:v>
                </c:pt>
                <c:pt idx="1355">
                  <c:v>3026</c:v>
                </c:pt>
                <c:pt idx="1356">
                  <c:v>3026</c:v>
                </c:pt>
                <c:pt idx="1357">
                  <c:v>3032</c:v>
                </c:pt>
                <c:pt idx="1358">
                  <c:v>3032</c:v>
                </c:pt>
                <c:pt idx="1359">
                  <c:v>3037</c:v>
                </c:pt>
                <c:pt idx="1360">
                  <c:v>3038</c:v>
                </c:pt>
                <c:pt idx="1361">
                  <c:v>3038</c:v>
                </c:pt>
                <c:pt idx="1362">
                  <c:v>3042</c:v>
                </c:pt>
                <c:pt idx="1363">
                  <c:v>3049</c:v>
                </c:pt>
                <c:pt idx="1364">
                  <c:v>3049</c:v>
                </c:pt>
                <c:pt idx="1365">
                  <c:v>3053</c:v>
                </c:pt>
                <c:pt idx="1366">
                  <c:v>3056</c:v>
                </c:pt>
                <c:pt idx="1367">
                  <c:v>3060</c:v>
                </c:pt>
                <c:pt idx="1368">
                  <c:v>3060</c:v>
                </c:pt>
                <c:pt idx="1369">
                  <c:v>3061</c:v>
                </c:pt>
                <c:pt idx="1370">
                  <c:v>3062</c:v>
                </c:pt>
                <c:pt idx="1371">
                  <c:v>3062</c:v>
                </c:pt>
                <c:pt idx="1372">
                  <c:v>3063</c:v>
                </c:pt>
                <c:pt idx="1373">
                  <c:v>3066</c:v>
                </c:pt>
                <c:pt idx="1374">
                  <c:v>3069</c:v>
                </c:pt>
                <c:pt idx="1375">
                  <c:v>3069</c:v>
                </c:pt>
                <c:pt idx="1376">
                  <c:v>3072</c:v>
                </c:pt>
                <c:pt idx="1377">
                  <c:v>3072</c:v>
                </c:pt>
                <c:pt idx="1378">
                  <c:v>3075</c:v>
                </c:pt>
                <c:pt idx="1379">
                  <c:v>3075</c:v>
                </c:pt>
                <c:pt idx="1380">
                  <c:v>3079</c:v>
                </c:pt>
                <c:pt idx="1381">
                  <c:v>3079</c:v>
                </c:pt>
                <c:pt idx="1382">
                  <c:v>3083</c:v>
                </c:pt>
                <c:pt idx="1383">
                  <c:v>3083</c:v>
                </c:pt>
                <c:pt idx="1384">
                  <c:v>3089</c:v>
                </c:pt>
                <c:pt idx="1385">
                  <c:v>3089</c:v>
                </c:pt>
                <c:pt idx="1386">
                  <c:v>3093</c:v>
                </c:pt>
                <c:pt idx="1387">
                  <c:v>3093</c:v>
                </c:pt>
                <c:pt idx="1388">
                  <c:v>3104</c:v>
                </c:pt>
                <c:pt idx="1389">
                  <c:v>3114</c:v>
                </c:pt>
                <c:pt idx="1390">
                  <c:v>3114</c:v>
                </c:pt>
                <c:pt idx="1391">
                  <c:v>3115</c:v>
                </c:pt>
                <c:pt idx="1392">
                  <c:v>3115</c:v>
                </c:pt>
                <c:pt idx="1393">
                  <c:v>3120</c:v>
                </c:pt>
                <c:pt idx="1394">
                  <c:v>3120</c:v>
                </c:pt>
                <c:pt idx="1395">
                  <c:v>3121</c:v>
                </c:pt>
                <c:pt idx="1396">
                  <c:v>3121</c:v>
                </c:pt>
                <c:pt idx="1397">
                  <c:v>3123</c:v>
                </c:pt>
                <c:pt idx="1398">
                  <c:v>3123</c:v>
                </c:pt>
                <c:pt idx="1399">
                  <c:v>3128</c:v>
                </c:pt>
                <c:pt idx="1400">
                  <c:v>3133</c:v>
                </c:pt>
                <c:pt idx="1401">
                  <c:v>3140</c:v>
                </c:pt>
                <c:pt idx="1402">
                  <c:v>3140</c:v>
                </c:pt>
                <c:pt idx="1403">
                  <c:v>3143</c:v>
                </c:pt>
                <c:pt idx="1404">
                  <c:v>3143</c:v>
                </c:pt>
                <c:pt idx="1405">
                  <c:v>3148</c:v>
                </c:pt>
                <c:pt idx="1406">
                  <c:v>3150</c:v>
                </c:pt>
                <c:pt idx="1407">
                  <c:v>3156</c:v>
                </c:pt>
                <c:pt idx="1408">
                  <c:v>3156</c:v>
                </c:pt>
                <c:pt idx="1409">
                  <c:v>3164</c:v>
                </c:pt>
                <c:pt idx="1410">
                  <c:v>3170</c:v>
                </c:pt>
                <c:pt idx="1411">
                  <c:v>3170</c:v>
                </c:pt>
                <c:pt idx="1412">
                  <c:v>3176</c:v>
                </c:pt>
                <c:pt idx="1413">
                  <c:v>3184</c:v>
                </c:pt>
                <c:pt idx="1414">
                  <c:v>3197</c:v>
                </c:pt>
                <c:pt idx="1415">
                  <c:v>3197</c:v>
                </c:pt>
                <c:pt idx="1416">
                  <c:v>3198</c:v>
                </c:pt>
                <c:pt idx="1417">
                  <c:v>3204</c:v>
                </c:pt>
                <c:pt idx="1418">
                  <c:v>3204</c:v>
                </c:pt>
                <c:pt idx="1419">
                  <c:v>3212</c:v>
                </c:pt>
                <c:pt idx="1420">
                  <c:v>3213</c:v>
                </c:pt>
                <c:pt idx="1421">
                  <c:v>3213</c:v>
                </c:pt>
                <c:pt idx="1422">
                  <c:v>3218</c:v>
                </c:pt>
                <c:pt idx="1423">
                  <c:v>3218</c:v>
                </c:pt>
                <c:pt idx="1424">
                  <c:v>3221</c:v>
                </c:pt>
                <c:pt idx="1425">
                  <c:v>3221</c:v>
                </c:pt>
                <c:pt idx="1426">
                  <c:v>3233</c:v>
                </c:pt>
                <c:pt idx="1427">
                  <c:v>3233</c:v>
                </c:pt>
                <c:pt idx="1428">
                  <c:v>3236</c:v>
                </c:pt>
                <c:pt idx="1429">
                  <c:v>3241</c:v>
                </c:pt>
                <c:pt idx="1430">
                  <c:v>3242</c:v>
                </c:pt>
                <c:pt idx="1431">
                  <c:v>3242</c:v>
                </c:pt>
                <c:pt idx="1432">
                  <c:v>3249</c:v>
                </c:pt>
                <c:pt idx="1433">
                  <c:v>3249</c:v>
                </c:pt>
                <c:pt idx="1434">
                  <c:v>3254</c:v>
                </c:pt>
                <c:pt idx="1435">
                  <c:v>3254</c:v>
                </c:pt>
                <c:pt idx="1436">
                  <c:v>3258</c:v>
                </c:pt>
                <c:pt idx="1437">
                  <c:v>3258</c:v>
                </c:pt>
                <c:pt idx="1438">
                  <c:v>3259</c:v>
                </c:pt>
                <c:pt idx="1439">
                  <c:v>3263</c:v>
                </c:pt>
                <c:pt idx="1440">
                  <c:v>3270</c:v>
                </c:pt>
                <c:pt idx="1441">
                  <c:v>3270</c:v>
                </c:pt>
                <c:pt idx="1442">
                  <c:v>3277</c:v>
                </c:pt>
                <c:pt idx="1443">
                  <c:v>3288</c:v>
                </c:pt>
                <c:pt idx="1444">
                  <c:v>3288</c:v>
                </c:pt>
                <c:pt idx="1445">
                  <c:v>3289</c:v>
                </c:pt>
                <c:pt idx="1446">
                  <c:v>3293</c:v>
                </c:pt>
                <c:pt idx="1447">
                  <c:v>3295</c:v>
                </c:pt>
                <c:pt idx="1448">
                  <c:v>3295</c:v>
                </c:pt>
                <c:pt idx="1449">
                  <c:v>3296</c:v>
                </c:pt>
                <c:pt idx="1450">
                  <c:v>3297</c:v>
                </c:pt>
                <c:pt idx="1451">
                  <c:v>3303</c:v>
                </c:pt>
                <c:pt idx="1452">
                  <c:v>3309</c:v>
                </c:pt>
                <c:pt idx="1453">
                  <c:v>3317</c:v>
                </c:pt>
                <c:pt idx="1454">
                  <c:v>3318</c:v>
                </c:pt>
                <c:pt idx="1455">
                  <c:v>3318</c:v>
                </c:pt>
                <c:pt idx="1456">
                  <c:v>3323</c:v>
                </c:pt>
                <c:pt idx="1457">
                  <c:v>3323</c:v>
                </c:pt>
                <c:pt idx="1458">
                  <c:v>3324</c:v>
                </c:pt>
                <c:pt idx="1459">
                  <c:v>3325</c:v>
                </c:pt>
                <c:pt idx="1460">
                  <c:v>3325</c:v>
                </c:pt>
                <c:pt idx="1461">
                  <c:v>3328</c:v>
                </c:pt>
                <c:pt idx="1462">
                  <c:v>3328</c:v>
                </c:pt>
                <c:pt idx="1463">
                  <c:v>3331</c:v>
                </c:pt>
                <c:pt idx="1464">
                  <c:v>3335</c:v>
                </c:pt>
                <c:pt idx="1465">
                  <c:v>3335</c:v>
                </c:pt>
                <c:pt idx="1466">
                  <c:v>3339</c:v>
                </c:pt>
                <c:pt idx="1467">
                  <c:v>3341</c:v>
                </c:pt>
                <c:pt idx="1468">
                  <c:v>3344</c:v>
                </c:pt>
                <c:pt idx="1469">
                  <c:v>3346</c:v>
                </c:pt>
                <c:pt idx="1470">
                  <c:v>3346</c:v>
                </c:pt>
                <c:pt idx="1471">
                  <c:v>3347</c:v>
                </c:pt>
                <c:pt idx="1472">
                  <c:v>3347</c:v>
                </c:pt>
                <c:pt idx="1473">
                  <c:v>3348</c:v>
                </c:pt>
                <c:pt idx="1474">
                  <c:v>3348</c:v>
                </c:pt>
                <c:pt idx="1475">
                  <c:v>3349</c:v>
                </c:pt>
                <c:pt idx="1476">
                  <c:v>3352</c:v>
                </c:pt>
                <c:pt idx="1477">
                  <c:v>3355</c:v>
                </c:pt>
                <c:pt idx="1478">
                  <c:v>3355</c:v>
                </c:pt>
                <c:pt idx="1479">
                  <c:v>3359</c:v>
                </c:pt>
                <c:pt idx="1480">
                  <c:v>3359</c:v>
                </c:pt>
                <c:pt idx="1481">
                  <c:v>3367</c:v>
                </c:pt>
                <c:pt idx="1482">
                  <c:v>3368</c:v>
                </c:pt>
                <c:pt idx="1483">
                  <c:v>3374</c:v>
                </c:pt>
                <c:pt idx="1484">
                  <c:v>3374</c:v>
                </c:pt>
                <c:pt idx="1485">
                  <c:v>3379</c:v>
                </c:pt>
                <c:pt idx="1486">
                  <c:v>3379</c:v>
                </c:pt>
                <c:pt idx="1487">
                  <c:v>3385</c:v>
                </c:pt>
                <c:pt idx="1488">
                  <c:v>3389</c:v>
                </c:pt>
                <c:pt idx="1489">
                  <c:v>3389</c:v>
                </c:pt>
                <c:pt idx="1490">
                  <c:v>3391</c:v>
                </c:pt>
                <c:pt idx="1491">
                  <c:v>3394</c:v>
                </c:pt>
                <c:pt idx="1492">
                  <c:v>3401</c:v>
                </c:pt>
                <c:pt idx="1493">
                  <c:v>3406</c:v>
                </c:pt>
                <c:pt idx="1494">
                  <c:v>3409</c:v>
                </c:pt>
                <c:pt idx="1495">
                  <c:v>3410</c:v>
                </c:pt>
                <c:pt idx="1496">
                  <c:v>3410</c:v>
                </c:pt>
                <c:pt idx="1497">
                  <c:v>3411</c:v>
                </c:pt>
                <c:pt idx="1498">
                  <c:v>3421</c:v>
                </c:pt>
                <c:pt idx="1499">
                  <c:v>3421</c:v>
                </c:pt>
                <c:pt idx="1500">
                  <c:v>3435</c:v>
                </c:pt>
                <c:pt idx="1501">
                  <c:v>3435</c:v>
                </c:pt>
                <c:pt idx="1502">
                  <c:v>3436</c:v>
                </c:pt>
                <c:pt idx="1503">
                  <c:v>3436</c:v>
                </c:pt>
                <c:pt idx="1504">
                  <c:v>3438</c:v>
                </c:pt>
                <c:pt idx="1505">
                  <c:v>3447</c:v>
                </c:pt>
                <c:pt idx="1506">
                  <c:v>3447</c:v>
                </c:pt>
                <c:pt idx="1507">
                  <c:v>3460</c:v>
                </c:pt>
                <c:pt idx="1508">
                  <c:v>3461</c:v>
                </c:pt>
                <c:pt idx="1509">
                  <c:v>3463</c:v>
                </c:pt>
                <c:pt idx="1510">
                  <c:v>3467</c:v>
                </c:pt>
                <c:pt idx="1511">
                  <c:v>3468</c:v>
                </c:pt>
                <c:pt idx="1512">
                  <c:v>3468</c:v>
                </c:pt>
                <c:pt idx="1513">
                  <c:v>3469</c:v>
                </c:pt>
                <c:pt idx="1514">
                  <c:v>3477</c:v>
                </c:pt>
                <c:pt idx="1515">
                  <c:v>3478</c:v>
                </c:pt>
                <c:pt idx="1516">
                  <c:v>3478</c:v>
                </c:pt>
                <c:pt idx="1517">
                  <c:v>3487</c:v>
                </c:pt>
                <c:pt idx="1518">
                  <c:v>3487</c:v>
                </c:pt>
                <c:pt idx="1519">
                  <c:v>3493</c:v>
                </c:pt>
                <c:pt idx="1520">
                  <c:v>3493</c:v>
                </c:pt>
                <c:pt idx="1521">
                  <c:v>3494</c:v>
                </c:pt>
                <c:pt idx="1522">
                  <c:v>3494</c:v>
                </c:pt>
                <c:pt idx="1523">
                  <c:v>3496</c:v>
                </c:pt>
                <c:pt idx="1524">
                  <c:v>3496</c:v>
                </c:pt>
                <c:pt idx="1525">
                  <c:v>3506</c:v>
                </c:pt>
                <c:pt idx="1526">
                  <c:v>3509</c:v>
                </c:pt>
                <c:pt idx="1527">
                  <c:v>3510</c:v>
                </c:pt>
                <c:pt idx="1528">
                  <c:v>3511</c:v>
                </c:pt>
                <c:pt idx="1529">
                  <c:v>3512</c:v>
                </c:pt>
                <c:pt idx="1530">
                  <c:v>3520</c:v>
                </c:pt>
                <c:pt idx="1531">
                  <c:v>3520</c:v>
                </c:pt>
                <c:pt idx="1532">
                  <c:v>3524</c:v>
                </c:pt>
                <c:pt idx="1533">
                  <c:v>3526</c:v>
                </c:pt>
                <c:pt idx="1534">
                  <c:v>3527</c:v>
                </c:pt>
                <c:pt idx="1535">
                  <c:v>3527</c:v>
                </c:pt>
                <c:pt idx="1536">
                  <c:v>3528</c:v>
                </c:pt>
                <c:pt idx="1537">
                  <c:v>3530</c:v>
                </c:pt>
                <c:pt idx="1538">
                  <c:v>3530</c:v>
                </c:pt>
                <c:pt idx="1539">
                  <c:v>3536</c:v>
                </c:pt>
                <c:pt idx="1540">
                  <c:v>3537</c:v>
                </c:pt>
                <c:pt idx="1541">
                  <c:v>3537</c:v>
                </c:pt>
                <c:pt idx="1542">
                  <c:v>3538</c:v>
                </c:pt>
                <c:pt idx="1543">
                  <c:v>3540</c:v>
                </c:pt>
                <c:pt idx="1544">
                  <c:v>3540</c:v>
                </c:pt>
                <c:pt idx="1545">
                  <c:v>3541</c:v>
                </c:pt>
                <c:pt idx="1546">
                  <c:v>3541</c:v>
                </c:pt>
                <c:pt idx="1547">
                  <c:v>3542</c:v>
                </c:pt>
                <c:pt idx="1548">
                  <c:v>3544</c:v>
                </c:pt>
                <c:pt idx="1549">
                  <c:v>3544</c:v>
                </c:pt>
                <c:pt idx="1550">
                  <c:v>3549</c:v>
                </c:pt>
                <c:pt idx="1551">
                  <c:v>3549</c:v>
                </c:pt>
                <c:pt idx="1552">
                  <c:v>3556</c:v>
                </c:pt>
                <c:pt idx="1553">
                  <c:v>3556</c:v>
                </c:pt>
                <c:pt idx="1554">
                  <c:v>3558</c:v>
                </c:pt>
                <c:pt idx="1555">
                  <c:v>3558</c:v>
                </c:pt>
                <c:pt idx="1556">
                  <c:v>3559</c:v>
                </c:pt>
                <c:pt idx="1557">
                  <c:v>3561</c:v>
                </c:pt>
                <c:pt idx="1558">
                  <c:v>3561</c:v>
                </c:pt>
                <c:pt idx="1559">
                  <c:v>3567</c:v>
                </c:pt>
                <c:pt idx="1560">
                  <c:v>3570</c:v>
                </c:pt>
                <c:pt idx="1561">
                  <c:v>3570</c:v>
                </c:pt>
                <c:pt idx="1562">
                  <c:v>3576</c:v>
                </c:pt>
                <c:pt idx="1563">
                  <c:v>3579</c:v>
                </c:pt>
                <c:pt idx="1564">
                  <c:v>3579</c:v>
                </c:pt>
                <c:pt idx="1565">
                  <c:v>3580</c:v>
                </c:pt>
                <c:pt idx="1566">
                  <c:v>3581</c:v>
                </c:pt>
                <c:pt idx="1567">
                  <c:v>3581</c:v>
                </c:pt>
                <c:pt idx="1568">
                  <c:v>3583</c:v>
                </c:pt>
                <c:pt idx="1569">
                  <c:v>3584</c:v>
                </c:pt>
                <c:pt idx="1570">
                  <c:v>3584</c:v>
                </c:pt>
                <c:pt idx="1571">
                  <c:v>3586</c:v>
                </c:pt>
                <c:pt idx="1572">
                  <c:v>3595</c:v>
                </c:pt>
                <c:pt idx="1573">
                  <c:v>3596</c:v>
                </c:pt>
                <c:pt idx="1574">
                  <c:v>3596</c:v>
                </c:pt>
                <c:pt idx="1575">
                  <c:v>3597</c:v>
                </c:pt>
                <c:pt idx="1576">
                  <c:v>3598</c:v>
                </c:pt>
                <c:pt idx="1577">
                  <c:v>3602</c:v>
                </c:pt>
                <c:pt idx="1578">
                  <c:v>3604</c:v>
                </c:pt>
                <c:pt idx="1579">
                  <c:v>3604</c:v>
                </c:pt>
                <c:pt idx="1580">
                  <c:v>3610</c:v>
                </c:pt>
                <c:pt idx="1581">
                  <c:v>3615</c:v>
                </c:pt>
                <c:pt idx="1582">
                  <c:v>3622</c:v>
                </c:pt>
                <c:pt idx="1583">
                  <c:v>3625</c:v>
                </c:pt>
                <c:pt idx="1584">
                  <c:v>3628</c:v>
                </c:pt>
                <c:pt idx="1585">
                  <c:v>3646</c:v>
                </c:pt>
                <c:pt idx="1586">
                  <c:v>3650</c:v>
                </c:pt>
                <c:pt idx="1587">
                  <c:v>3650</c:v>
                </c:pt>
                <c:pt idx="1588">
                  <c:v>3653</c:v>
                </c:pt>
                <c:pt idx="1589">
                  <c:v>3658</c:v>
                </c:pt>
                <c:pt idx="1590">
                  <c:v>3660</c:v>
                </c:pt>
                <c:pt idx="1591">
                  <c:v>3660</c:v>
                </c:pt>
                <c:pt idx="1592">
                  <c:v>3663</c:v>
                </c:pt>
                <c:pt idx="1593">
                  <c:v>3664</c:v>
                </c:pt>
                <c:pt idx="1594">
                  <c:v>3666</c:v>
                </c:pt>
                <c:pt idx="1595">
                  <c:v>3672</c:v>
                </c:pt>
                <c:pt idx="1596">
                  <c:v>3674</c:v>
                </c:pt>
                <c:pt idx="1597">
                  <c:v>3675</c:v>
                </c:pt>
                <c:pt idx="1598">
                  <c:v>3675</c:v>
                </c:pt>
                <c:pt idx="1599">
                  <c:v>3684</c:v>
                </c:pt>
                <c:pt idx="1600">
                  <c:v>3684</c:v>
                </c:pt>
                <c:pt idx="1601">
                  <c:v>3687</c:v>
                </c:pt>
                <c:pt idx="1602">
                  <c:v>3696</c:v>
                </c:pt>
                <c:pt idx="1603">
                  <c:v>3698</c:v>
                </c:pt>
                <c:pt idx="1604">
                  <c:v>3699</c:v>
                </c:pt>
                <c:pt idx="1605">
                  <c:v>3699</c:v>
                </c:pt>
                <c:pt idx="1606">
                  <c:v>3700</c:v>
                </c:pt>
                <c:pt idx="1607">
                  <c:v>3700</c:v>
                </c:pt>
                <c:pt idx="1608">
                  <c:v>3706</c:v>
                </c:pt>
                <c:pt idx="1609">
                  <c:v>3708</c:v>
                </c:pt>
                <c:pt idx="1610">
                  <c:v>3711</c:v>
                </c:pt>
                <c:pt idx="1611">
                  <c:v>3712</c:v>
                </c:pt>
                <c:pt idx="1612">
                  <c:v>3716</c:v>
                </c:pt>
                <c:pt idx="1613">
                  <c:v>3720</c:v>
                </c:pt>
                <c:pt idx="1614">
                  <c:v>3720</c:v>
                </c:pt>
                <c:pt idx="1615">
                  <c:v>3721</c:v>
                </c:pt>
                <c:pt idx="1616">
                  <c:v>3723</c:v>
                </c:pt>
                <c:pt idx="1617">
                  <c:v>3724</c:v>
                </c:pt>
                <c:pt idx="1618">
                  <c:v>3724</c:v>
                </c:pt>
                <c:pt idx="1619">
                  <c:v>3726</c:v>
                </c:pt>
                <c:pt idx="1620">
                  <c:v>3728</c:v>
                </c:pt>
                <c:pt idx="1621">
                  <c:v>3736</c:v>
                </c:pt>
                <c:pt idx="1622">
                  <c:v>3737</c:v>
                </c:pt>
                <c:pt idx="1623">
                  <c:v>3737</c:v>
                </c:pt>
                <c:pt idx="1624">
                  <c:v>3743</c:v>
                </c:pt>
                <c:pt idx="1625">
                  <c:v>3743</c:v>
                </c:pt>
                <c:pt idx="1626">
                  <c:v>3744</c:v>
                </c:pt>
                <c:pt idx="1627">
                  <c:v>3744</c:v>
                </c:pt>
                <c:pt idx="1628">
                  <c:v>3746</c:v>
                </c:pt>
                <c:pt idx="1629">
                  <c:v>3751</c:v>
                </c:pt>
                <c:pt idx="1630">
                  <c:v>3751</c:v>
                </c:pt>
                <c:pt idx="1631">
                  <c:v>3752</c:v>
                </c:pt>
                <c:pt idx="1632">
                  <c:v>3758</c:v>
                </c:pt>
                <c:pt idx="1633">
                  <c:v>3758</c:v>
                </c:pt>
                <c:pt idx="1634">
                  <c:v>3760</c:v>
                </c:pt>
                <c:pt idx="1635">
                  <c:v>3760</c:v>
                </c:pt>
                <c:pt idx="1636">
                  <c:v>3766</c:v>
                </c:pt>
                <c:pt idx="1637">
                  <c:v>3768</c:v>
                </c:pt>
                <c:pt idx="1638">
                  <c:v>3768</c:v>
                </c:pt>
                <c:pt idx="1639">
                  <c:v>3771</c:v>
                </c:pt>
                <c:pt idx="1640">
                  <c:v>3771</c:v>
                </c:pt>
                <c:pt idx="1641">
                  <c:v>3772</c:v>
                </c:pt>
                <c:pt idx="1642">
                  <c:v>3773</c:v>
                </c:pt>
                <c:pt idx="1643">
                  <c:v>3773</c:v>
                </c:pt>
                <c:pt idx="1644">
                  <c:v>3775</c:v>
                </c:pt>
                <c:pt idx="1645">
                  <c:v>3777</c:v>
                </c:pt>
                <c:pt idx="1646">
                  <c:v>3777</c:v>
                </c:pt>
                <c:pt idx="1647">
                  <c:v>3779</c:v>
                </c:pt>
                <c:pt idx="1648">
                  <c:v>3781</c:v>
                </c:pt>
                <c:pt idx="1649">
                  <c:v>3784</c:v>
                </c:pt>
                <c:pt idx="1650">
                  <c:v>3792</c:v>
                </c:pt>
                <c:pt idx="1651">
                  <c:v>3792</c:v>
                </c:pt>
                <c:pt idx="1652">
                  <c:v>3794</c:v>
                </c:pt>
                <c:pt idx="1653">
                  <c:v>3794</c:v>
                </c:pt>
                <c:pt idx="1654">
                  <c:v>3799</c:v>
                </c:pt>
                <c:pt idx="1655">
                  <c:v>3799</c:v>
                </c:pt>
                <c:pt idx="1656">
                  <c:v>3800</c:v>
                </c:pt>
                <c:pt idx="1657">
                  <c:v>3800</c:v>
                </c:pt>
                <c:pt idx="1658">
                  <c:v>3803</c:v>
                </c:pt>
                <c:pt idx="1659">
                  <c:v>3806</c:v>
                </c:pt>
                <c:pt idx="1660">
                  <c:v>3807</c:v>
                </c:pt>
                <c:pt idx="1661">
                  <c:v>3808</c:v>
                </c:pt>
                <c:pt idx="1662">
                  <c:v>3819</c:v>
                </c:pt>
                <c:pt idx="1663">
                  <c:v>3821</c:v>
                </c:pt>
                <c:pt idx="1664">
                  <c:v>3826</c:v>
                </c:pt>
                <c:pt idx="1665">
                  <c:v>3835</c:v>
                </c:pt>
                <c:pt idx="1666">
                  <c:v>3836</c:v>
                </c:pt>
                <c:pt idx="1667">
                  <c:v>3838</c:v>
                </c:pt>
                <c:pt idx="1668">
                  <c:v>3838</c:v>
                </c:pt>
                <c:pt idx="1669">
                  <c:v>3846</c:v>
                </c:pt>
                <c:pt idx="1670">
                  <c:v>3846</c:v>
                </c:pt>
                <c:pt idx="1671">
                  <c:v>3848</c:v>
                </c:pt>
                <c:pt idx="1672">
                  <c:v>3851</c:v>
                </c:pt>
                <c:pt idx="1673">
                  <c:v>3851</c:v>
                </c:pt>
                <c:pt idx="1674">
                  <c:v>3852</c:v>
                </c:pt>
                <c:pt idx="1675">
                  <c:v>3852</c:v>
                </c:pt>
                <c:pt idx="1676">
                  <c:v>3856</c:v>
                </c:pt>
                <c:pt idx="1677">
                  <c:v>3856</c:v>
                </c:pt>
                <c:pt idx="1678">
                  <c:v>3861</c:v>
                </c:pt>
                <c:pt idx="1679">
                  <c:v>3869</c:v>
                </c:pt>
                <c:pt idx="1680">
                  <c:v>3872</c:v>
                </c:pt>
                <c:pt idx="1681">
                  <c:v>3874</c:v>
                </c:pt>
                <c:pt idx="1682">
                  <c:v>3877</c:v>
                </c:pt>
                <c:pt idx="1683">
                  <c:v>3877</c:v>
                </c:pt>
                <c:pt idx="1684">
                  <c:v>3880</c:v>
                </c:pt>
                <c:pt idx="1685">
                  <c:v>3880</c:v>
                </c:pt>
                <c:pt idx="1686">
                  <c:v>3884</c:v>
                </c:pt>
                <c:pt idx="1687">
                  <c:v>3894</c:v>
                </c:pt>
                <c:pt idx="1688">
                  <c:v>3894</c:v>
                </c:pt>
                <c:pt idx="1689">
                  <c:v>3898</c:v>
                </c:pt>
                <c:pt idx="1690">
                  <c:v>3901</c:v>
                </c:pt>
                <c:pt idx="1691">
                  <c:v>3911</c:v>
                </c:pt>
                <c:pt idx="1692">
                  <c:v>3911</c:v>
                </c:pt>
                <c:pt idx="1693">
                  <c:v>3915</c:v>
                </c:pt>
                <c:pt idx="1694">
                  <c:v>3921</c:v>
                </c:pt>
                <c:pt idx="1695">
                  <c:v>3921</c:v>
                </c:pt>
                <c:pt idx="1696">
                  <c:v>3939</c:v>
                </c:pt>
                <c:pt idx="1697">
                  <c:v>3939</c:v>
                </c:pt>
                <c:pt idx="1698">
                  <c:v>3940</c:v>
                </c:pt>
                <c:pt idx="1699">
                  <c:v>3940</c:v>
                </c:pt>
                <c:pt idx="1700">
                  <c:v>3948</c:v>
                </c:pt>
                <c:pt idx="1701">
                  <c:v>3961</c:v>
                </c:pt>
                <c:pt idx="1702">
                  <c:v>3964</c:v>
                </c:pt>
                <c:pt idx="1703">
                  <c:v>3966</c:v>
                </c:pt>
                <c:pt idx="1704">
                  <c:v>3966</c:v>
                </c:pt>
                <c:pt idx="1705">
                  <c:v>3971</c:v>
                </c:pt>
                <c:pt idx="1706">
                  <c:v>3985</c:v>
                </c:pt>
                <c:pt idx="1707">
                  <c:v>3986</c:v>
                </c:pt>
                <c:pt idx="1708">
                  <c:v>3997</c:v>
                </c:pt>
                <c:pt idx="1709">
                  <c:v>3997</c:v>
                </c:pt>
                <c:pt idx="1710">
                  <c:v>4006</c:v>
                </c:pt>
                <c:pt idx="1711">
                  <c:v>4026</c:v>
                </c:pt>
                <c:pt idx="1712">
                  <c:v>4027</c:v>
                </c:pt>
                <c:pt idx="1713">
                  <c:v>4028</c:v>
                </c:pt>
                <c:pt idx="1714">
                  <c:v>4035</c:v>
                </c:pt>
                <c:pt idx="1715">
                  <c:v>4037</c:v>
                </c:pt>
                <c:pt idx="1716">
                  <c:v>4040</c:v>
                </c:pt>
                <c:pt idx="1717">
                  <c:v>4042</c:v>
                </c:pt>
                <c:pt idx="1718">
                  <c:v>4042</c:v>
                </c:pt>
                <c:pt idx="1719">
                  <c:v>4046</c:v>
                </c:pt>
                <c:pt idx="1720">
                  <c:v>4056</c:v>
                </c:pt>
                <c:pt idx="1721">
                  <c:v>4059</c:v>
                </c:pt>
                <c:pt idx="1722">
                  <c:v>4059</c:v>
                </c:pt>
                <c:pt idx="1723">
                  <c:v>4060</c:v>
                </c:pt>
                <c:pt idx="1724">
                  <c:v>4076</c:v>
                </c:pt>
                <c:pt idx="1725">
                  <c:v>4079</c:v>
                </c:pt>
                <c:pt idx="1726">
                  <c:v>4080</c:v>
                </c:pt>
                <c:pt idx="1727">
                  <c:v>4087</c:v>
                </c:pt>
                <c:pt idx="1728">
                  <c:v>4088</c:v>
                </c:pt>
                <c:pt idx="1729">
                  <c:v>4098</c:v>
                </c:pt>
                <c:pt idx="1730">
                  <c:v>4108</c:v>
                </c:pt>
                <c:pt idx="1731">
                  <c:v>4124</c:v>
                </c:pt>
                <c:pt idx="1732">
                  <c:v>4125</c:v>
                </c:pt>
                <c:pt idx="1733">
                  <c:v>4130</c:v>
                </c:pt>
                <c:pt idx="1734">
                  <c:v>4131</c:v>
                </c:pt>
                <c:pt idx="1735">
                  <c:v>4134</c:v>
                </c:pt>
                <c:pt idx="1736">
                  <c:v>4134</c:v>
                </c:pt>
                <c:pt idx="1737">
                  <c:v>4135</c:v>
                </c:pt>
                <c:pt idx="1738">
                  <c:v>4136</c:v>
                </c:pt>
                <c:pt idx="1739">
                  <c:v>4150</c:v>
                </c:pt>
                <c:pt idx="1740">
                  <c:v>4152</c:v>
                </c:pt>
                <c:pt idx="1741">
                  <c:v>4157</c:v>
                </c:pt>
                <c:pt idx="1742">
                  <c:v>4178</c:v>
                </c:pt>
                <c:pt idx="1743">
                  <c:v>4179</c:v>
                </c:pt>
                <c:pt idx="1744">
                  <c:v>4179</c:v>
                </c:pt>
                <c:pt idx="1745">
                  <c:v>4180</c:v>
                </c:pt>
                <c:pt idx="1746">
                  <c:v>4183</c:v>
                </c:pt>
                <c:pt idx="1747">
                  <c:v>4186</c:v>
                </c:pt>
                <c:pt idx="1748">
                  <c:v>4186</c:v>
                </c:pt>
                <c:pt idx="1749">
                  <c:v>4188</c:v>
                </c:pt>
                <c:pt idx="1750">
                  <c:v>4188</c:v>
                </c:pt>
                <c:pt idx="1751">
                  <c:v>4206</c:v>
                </c:pt>
                <c:pt idx="1752">
                  <c:v>4207</c:v>
                </c:pt>
                <c:pt idx="1753">
                  <c:v>4209</c:v>
                </c:pt>
                <c:pt idx="1754">
                  <c:v>4213</c:v>
                </c:pt>
                <c:pt idx="1755">
                  <c:v>4215</c:v>
                </c:pt>
                <c:pt idx="1756">
                  <c:v>4217</c:v>
                </c:pt>
                <c:pt idx="1757">
                  <c:v>4218</c:v>
                </c:pt>
                <c:pt idx="1758">
                  <c:v>4218</c:v>
                </c:pt>
                <c:pt idx="1759">
                  <c:v>4223</c:v>
                </c:pt>
                <c:pt idx="1760">
                  <c:v>4230</c:v>
                </c:pt>
                <c:pt idx="1761">
                  <c:v>4241</c:v>
                </c:pt>
                <c:pt idx="1762">
                  <c:v>4243</c:v>
                </c:pt>
                <c:pt idx="1763">
                  <c:v>4245</c:v>
                </c:pt>
                <c:pt idx="1764">
                  <c:v>4246</c:v>
                </c:pt>
                <c:pt idx="1765">
                  <c:v>4247</c:v>
                </c:pt>
                <c:pt idx="1766">
                  <c:v>4247</c:v>
                </c:pt>
                <c:pt idx="1767">
                  <c:v>4252</c:v>
                </c:pt>
                <c:pt idx="1768">
                  <c:v>4252</c:v>
                </c:pt>
                <c:pt idx="1769">
                  <c:v>4257</c:v>
                </c:pt>
                <c:pt idx="1770">
                  <c:v>4263</c:v>
                </c:pt>
                <c:pt idx="1771">
                  <c:v>4265</c:v>
                </c:pt>
                <c:pt idx="1772">
                  <c:v>4265</c:v>
                </c:pt>
                <c:pt idx="1773">
                  <c:v>4267</c:v>
                </c:pt>
                <c:pt idx="1774">
                  <c:v>4273</c:v>
                </c:pt>
                <c:pt idx="1775">
                  <c:v>4273</c:v>
                </c:pt>
                <c:pt idx="1776">
                  <c:v>4277</c:v>
                </c:pt>
                <c:pt idx="1777">
                  <c:v>4277</c:v>
                </c:pt>
                <c:pt idx="1778">
                  <c:v>4284</c:v>
                </c:pt>
                <c:pt idx="1779">
                  <c:v>4290</c:v>
                </c:pt>
                <c:pt idx="1780">
                  <c:v>4290</c:v>
                </c:pt>
                <c:pt idx="1781">
                  <c:v>4295</c:v>
                </c:pt>
                <c:pt idx="1782">
                  <c:v>4295</c:v>
                </c:pt>
                <c:pt idx="1783">
                  <c:v>4306</c:v>
                </c:pt>
                <c:pt idx="1784">
                  <c:v>4306</c:v>
                </c:pt>
                <c:pt idx="1785">
                  <c:v>4307</c:v>
                </c:pt>
                <c:pt idx="1786">
                  <c:v>4308</c:v>
                </c:pt>
                <c:pt idx="1787">
                  <c:v>4308</c:v>
                </c:pt>
                <c:pt idx="1788">
                  <c:v>4311</c:v>
                </c:pt>
                <c:pt idx="1789">
                  <c:v>4312</c:v>
                </c:pt>
                <c:pt idx="1790">
                  <c:v>4333</c:v>
                </c:pt>
                <c:pt idx="1791">
                  <c:v>4333</c:v>
                </c:pt>
                <c:pt idx="1792">
                  <c:v>4339</c:v>
                </c:pt>
                <c:pt idx="1793">
                  <c:v>4340</c:v>
                </c:pt>
                <c:pt idx="1794">
                  <c:v>4340</c:v>
                </c:pt>
                <c:pt idx="1795">
                  <c:v>4348</c:v>
                </c:pt>
                <c:pt idx="1796">
                  <c:v>4356</c:v>
                </c:pt>
                <c:pt idx="1797">
                  <c:v>4357</c:v>
                </c:pt>
                <c:pt idx="1798">
                  <c:v>4361</c:v>
                </c:pt>
                <c:pt idx="1799">
                  <c:v>4361</c:v>
                </c:pt>
                <c:pt idx="1800">
                  <c:v>4369</c:v>
                </c:pt>
                <c:pt idx="1801">
                  <c:v>4372</c:v>
                </c:pt>
                <c:pt idx="1802">
                  <c:v>4372</c:v>
                </c:pt>
                <c:pt idx="1803">
                  <c:v>4377</c:v>
                </c:pt>
                <c:pt idx="1804">
                  <c:v>4381</c:v>
                </c:pt>
                <c:pt idx="1805">
                  <c:v>4382</c:v>
                </c:pt>
                <c:pt idx="1806">
                  <c:v>4388</c:v>
                </c:pt>
                <c:pt idx="1807">
                  <c:v>4390</c:v>
                </c:pt>
                <c:pt idx="1808">
                  <c:v>4391</c:v>
                </c:pt>
                <c:pt idx="1809">
                  <c:v>4398</c:v>
                </c:pt>
                <c:pt idx="1810">
                  <c:v>4402</c:v>
                </c:pt>
                <c:pt idx="1811">
                  <c:v>4403</c:v>
                </c:pt>
                <c:pt idx="1812">
                  <c:v>4403</c:v>
                </c:pt>
                <c:pt idx="1813">
                  <c:v>4405</c:v>
                </c:pt>
                <c:pt idx="1814">
                  <c:v>4408</c:v>
                </c:pt>
                <c:pt idx="1815">
                  <c:v>4408</c:v>
                </c:pt>
                <c:pt idx="1816">
                  <c:v>4412</c:v>
                </c:pt>
                <c:pt idx="1817">
                  <c:v>4414</c:v>
                </c:pt>
                <c:pt idx="1818">
                  <c:v>4414</c:v>
                </c:pt>
                <c:pt idx="1819">
                  <c:v>4415</c:v>
                </c:pt>
                <c:pt idx="1820">
                  <c:v>4422</c:v>
                </c:pt>
                <c:pt idx="1821">
                  <c:v>4423</c:v>
                </c:pt>
                <c:pt idx="1822">
                  <c:v>4426</c:v>
                </c:pt>
                <c:pt idx="1823">
                  <c:v>4430</c:v>
                </c:pt>
                <c:pt idx="1824">
                  <c:v>4434</c:v>
                </c:pt>
                <c:pt idx="1825">
                  <c:v>4434</c:v>
                </c:pt>
                <c:pt idx="1826">
                  <c:v>4435</c:v>
                </c:pt>
                <c:pt idx="1827">
                  <c:v>4435</c:v>
                </c:pt>
                <c:pt idx="1828">
                  <c:v>4436</c:v>
                </c:pt>
                <c:pt idx="1829">
                  <c:v>4437</c:v>
                </c:pt>
                <c:pt idx="1830">
                  <c:v>4441</c:v>
                </c:pt>
                <c:pt idx="1831">
                  <c:v>4442</c:v>
                </c:pt>
                <c:pt idx="1832">
                  <c:v>4443</c:v>
                </c:pt>
                <c:pt idx="1833">
                  <c:v>4443</c:v>
                </c:pt>
                <c:pt idx="1834">
                  <c:v>4457</c:v>
                </c:pt>
                <c:pt idx="1835">
                  <c:v>4457</c:v>
                </c:pt>
                <c:pt idx="1836">
                  <c:v>4464</c:v>
                </c:pt>
                <c:pt idx="1837">
                  <c:v>4464</c:v>
                </c:pt>
                <c:pt idx="1838">
                  <c:v>4466</c:v>
                </c:pt>
                <c:pt idx="1839">
                  <c:v>4466</c:v>
                </c:pt>
                <c:pt idx="1840">
                  <c:v>4468</c:v>
                </c:pt>
                <c:pt idx="1841">
                  <c:v>4474</c:v>
                </c:pt>
                <c:pt idx="1842">
                  <c:v>4475</c:v>
                </c:pt>
                <c:pt idx="1843">
                  <c:v>4479</c:v>
                </c:pt>
                <c:pt idx="1844">
                  <c:v>4481</c:v>
                </c:pt>
                <c:pt idx="1845">
                  <c:v>4482</c:v>
                </c:pt>
                <c:pt idx="1846">
                  <c:v>4483</c:v>
                </c:pt>
                <c:pt idx="1847">
                  <c:v>4483</c:v>
                </c:pt>
                <c:pt idx="1848">
                  <c:v>4488</c:v>
                </c:pt>
                <c:pt idx="1849">
                  <c:v>4489</c:v>
                </c:pt>
                <c:pt idx="1850">
                  <c:v>4490</c:v>
                </c:pt>
                <c:pt idx="1851">
                  <c:v>4491</c:v>
                </c:pt>
                <c:pt idx="1852">
                  <c:v>4491</c:v>
                </c:pt>
                <c:pt idx="1853">
                  <c:v>4493</c:v>
                </c:pt>
                <c:pt idx="1854">
                  <c:v>4494</c:v>
                </c:pt>
                <c:pt idx="1855">
                  <c:v>4496</c:v>
                </c:pt>
                <c:pt idx="1856">
                  <c:v>4503</c:v>
                </c:pt>
                <c:pt idx="1857">
                  <c:v>4503</c:v>
                </c:pt>
                <c:pt idx="1858">
                  <c:v>4506</c:v>
                </c:pt>
                <c:pt idx="1859">
                  <c:v>4514</c:v>
                </c:pt>
                <c:pt idx="1860">
                  <c:v>4515</c:v>
                </c:pt>
                <c:pt idx="1861">
                  <c:v>4518</c:v>
                </c:pt>
                <c:pt idx="1862">
                  <c:v>4518</c:v>
                </c:pt>
                <c:pt idx="1863">
                  <c:v>4521</c:v>
                </c:pt>
                <c:pt idx="1864">
                  <c:v>4522</c:v>
                </c:pt>
                <c:pt idx="1865">
                  <c:v>4524</c:v>
                </c:pt>
                <c:pt idx="1866">
                  <c:v>4528</c:v>
                </c:pt>
                <c:pt idx="1867">
                  <c:v>4532</c:v>
                </c:pt>
                <c:pt idx="1868">
                  <c:v>4535</c:v>
                </c:pt>
                <c:pt idx="1869">
                  <c:v>4536</c:v>
                </c:pt>
                <c:pt idx="1870">
                  <c:v>4536</c:v>
                </c:pt>
                <c:pt idx="1871">
                  <c:v>4550</c:v>
                </c:pt>
                <c:pt idx="1872">
                  <c:v>4550</c:v>
                </c:pt>
                <c:pt idx="1873">
                  <c:v>4551</c:v>
                </c:pt>
                <c:pt idx="1874">
                  <c:v>4557</c:v>
                </c:pt>
                <c:pt idx="1875">
                  <c:v>4562</c:v>
                </c:pt>
                <c:pt idx="1876">
                  <c:v>4562</c:v>
                </c:pt>
                <c:pt idx="1877">
                  <c:v>4570</c:v>
                </c:pt>
                <c:pt idx="1878">
                  <c:v>4570</c:v>
                </c:pt>
                <c:pt idx="1879">
                  <c:v>4584</c:v>
                </c:pt>
                <c:pt idx="1880">
                  <c:v>4588</c:v>
                </c:pt>
                <c:pt idx="1881">
                  <c:v>4588</c:v>
                </c:pt>
                <c:pt idx="1882">
                  <c:v>4590</c:v>
                </c:pt>
                <c:pt idx="1883">
                  <c:v>4590</c:v>
                </c:pt>
                <c:pt idx="1884">
                  <c:v>4606</c:v>
                </c:pt>
                <c:pt idx="1885">
                  <c:v>4608</c:v>
                </c:pt>
                <c:pt idx="1886">
                  <c:v>4614</c:v>
                </c:pt>
                <c:pt idx="1887">
                  <c:v>4616</c:v>
                </c:pt>
                <c:pt idx="1888">
                  <c:v>4616</c:v>
                </c:pt>
                <c:pt idx="1889">
                  <c:v>4617</c:v>
                </c:pt>
                <c:pt idx="1890">
                  <c:v>4617</c:v>
                </c:pt>
                <c:pt idx="1891">
                  <c:v>4619</c:v>
                </c:pt>
                <c:pt idx="1892">
                  <c:v>4620</c:v>
                </c:pt>
                <c:pt idx="1893">
                  <c:v>4620</c:v>
                </c:pt>
                <c:pt idx="1894">
                  <c:v>4628</c:v>
                </c:pt>
                <c:pt idx="1895">
                  <c:v>4633</c:v>
                </c:pt>
                <c:pt idx="1896">
                  <c:v>4635</c:v>
                </c:pt>
                <c:pt idx="1897">
                  <c:v>4635</c:v>
                </c:pt>
                <c:pt idx="1898">
                  <c:v>4639</c:v>
                </c:pt>
                <c:pt idx="1899">
                  <c:v>4647</c:v>
                </c:pt>
                <c:pt idx="1900">
                  <c:v>4648</c:v>
                </c:pt>
                <c:pt idx="1901">
                  <c:v>4648</c:v>
                </c:pt>
                <c:pt idx="1902">
                  <c:v>4662</c:v>
                </c:pt>
                <c:pt idx="1903">
                  <c:v>4665</c:v>
                </c:pt>
                <c:pt idx="1904">
                  <c:v>4668</c:v>
                </c:pt>
                <c:pt idx="1905">
                  <c:v>4669</c:v>
                </c:pt>
                <c:pt idx="1906">
                  <c:v>4671</c:v>
                </c:pt>
                <c:pt idx="1907">
                  <c:v>4672</c:v>
                </c:pt>
                <c:pt idx="1908">
                  <c:v>4672</c:v>
                </c:pt>
                <c:pt idx="1909">
                  <c:v>4673</c:v>
                </c:pt>
                <c:pt idx="1910">
                  <c:v>4694</c:v>
                </c:pt>
                <c:pt idx="1911">
                  <c:v>4697</c:v>
                </c:pt>
                <c:pt idx="1912">
                  <c:v>4703</c:v>
                </c:pt>
                <c:pt idx="1913">
                  <c:v>4704</c:v>
                </c:pt>
                <c:pt idx="1914">
                  <c:v>4709</c:v>
                </c:pt>
                <c:pt idx="1915">
                  <c:v>4713</c:v>
                </c:pt>
                <c:pt idx="1916">
                  <c:v>4717</c:v>
                </c:pt>
                <c:pt idx="1917">
                  <c:v>4721</c:v>
                </c:pt>
                <c:pt idx="1918">
                  <c:v>4726</c:v>
                </c:pt>
                <c:pt idx="1919">
                  <c:v>4732</c:v>
                </c:pt>
                <c:pt idx="1920">
                  <c:v>4733</c:v>
                </c:pt>
                <c:pt idx="1921">
                  <c:v>4734</c:v>
                </c:pt>
                <c:pt idx="1922">
                  <c:v>4734</c:v>
                </c:pt>
                <c:pt idx="1923">
                  <c:v>4736</c:v>
                </c:pt>
                <c:pt idx="1924">
                  <c:v>4737</c:v>
                </c:pt>
                <c:pt idx="1925">
                  <c:v>4740</c:v>
                </c:pt>
                <c:pt idx="1926">
                  <c:v>4741</c:v>
                </c:pt>
                <c:pt idx="1927">
                  <c:v>4743</c:v>
                </c:pt>
                <c:pt idx="1928">
                  <c:v>4748</c:v>
                </c:pt>
                <c:pt idx="1929">
                  <c:v>4749</c:v>
                </c:pt>
                <c:pt idx="1930">
                  <c:v>4751</c:v>
                </c:pt>
                <c:pt idx="1931">
                  <c:v>4759</c:v>
                </c:pt>
                <c:pt idx="1932">
                  <c:v>4759</c:v>
                </c:pt>
                <c:pt idx="1933">
                  <c:v>4767</c:v>
                </c:pt>
                <c:pt idx="1934">
                  <c:v>4770</c:v>
                </c:pt>
                <c:pt idx="1935">
                  <c:v>4771</c:v>
                </c:pt>
                <c:pt idx="1936">
                  <c:v>4773</c:v>
                </c:pt>
                <c:pt idx="1937">
                  <c:v>4777</c:v>
                </c:pt>
                <c:pt idx="1938">
                  <c:v>4777</c:v>
                </c:pt>
                <c:pt idx="1939">
                  <c:v>4778</c:v>
                </c:pt>
                <c:pt idx="1940">
                  <c:v>4792</c:v>
                </c:pt>
                <c:pt idx="1941">
                  <c:v>4794</c:v>
                </c:pt>
                <c:pt idx="1942">
                  <c:v>4800</c:v>
                </c:pt>
                <c:pt idx="1943">
                  <c:v>4802</c:v>
                </c:pt>
                <c:pt idx="1944">
                  <c:v>4804</c:v>
                </c:pt>
                <c:pt idx="1945">
                  <c:v>4810</c:v>
                </c:pt>
                <c:pt idx="1946">
                  <c:v>4810</c:v>
                </c:pt>
                <c:pt idx="1947">
                  <c:v>4811</c:v>
                </c:pt>
                <c:pt idx="1948">
                  <c:v>4816</c:v>
                </c:pt>
                <c:pt idx="1949">
                  <c:v>4817</c:v>
                </c:pt>
                <c:pt idx="1950">
                  <c:v>4820</c:v>
                </c:pt>
                <c:pt idx="1951">
                  <c:v>4828</c:v>
                </c:pt>
                <c:pt idx="1952">
                  <c:v>4828</c:v>
                </c:pt>
                <c:pt idx="1953">
                  <c:v>4832</c:v>
                </c:pt>
                <c:pt idx="1954">
                  <c:v>4834</c:v>
                </c:pt>
                <c:pt idx="1955">
                  <c:v>4834</c:v>
                </c:pt>
                <c:pt idx="1956">
                  <c:v>4846</c:v>
                </c:pt>
                <c:pt idx="1957">
                  <c:v>4850</c:v>
                </c:pt>
                <c:pt idx="1958">
                  <c:v>4857</c:v>
                </c:pt>
                <c:pt idx="1959">
                  <c:v>4860</c:v>
                </c:pt>
                <c:pt idx="1960">
                  <c:v>4866</c:v>
                </c:pt>
                <c:pt idx="1961">
                  <c:v>4869</c:v>
                </c:pt>
                <c:pt idx="1962">
                  <c:v>4883</c:v>
                </c:pt>
                <c:pt idx="1963">
                  <c:v>4885</c:v>
                </c:pt>
                <c:pt idx="1964">
                  <c:v>4885</c:v>
                </c:pt>
                <c:pt idx="1965">
                  <c:v>4891</c:v>
                </c:pt>
                <c:pt idx="1966">
                  <c:v>4895</c:v>
                </c:pt>
                <c:pt idx="1967">
                  <c:v>4896</c:v>
                </c:pt>
                <c:pt idx="1968">
                  <c:v>4896</c:v>
                </c:pt>
                <c:pt idx="1969">
                  <c:v>4899</c:v>
                </c:pt>
                <c:pt idx="1970">
                  <c:v>4902</c:v>
                </c:pt>
                <c:pt idx="1971">
                  <c:v>4903</c:v>
                </c:pt>
                <c:pt idx="1972">
                  <c:v>4906</c:v>
                </c:pt>
                <c:pt idx="1973">
                  <c:v>4910</c:v>
                </c:pt>
                <c:pt idx="1974">
                  <c:v>4912</c:v>
                </c:pt>
                <c:pt idx="1975">
                  <c:v>4921</c:v>
                </c:pt>
                <c:pt idx="1976">
                  <c:v>4921</c:v>
                </c:pt>
                <c:pt idx="1977">
                  <c:v>4923</c:v>
                </c:pt>
                <c:pt idx="1978">
                  <c:v>4930</c:v>
                </c:pt>
                <c:pt idx="1979">
                  <c:v>4930</c:v>
                </c:pt>
                <c:pt idx="1980">
                  <c:v>4936</c:v>
                </c:pt>
                <c:pt idx="1981">
                  <c:v>4944</c:v>
                </c:pt>
                <c:pt idx="1982">
                  <c:v>4949</c:v>
                </c:pt>
                <c:pt idx="1983">
                  <c:v>4949</c:v>
                </c:pt>
                <c:pt idx="1984">
                  <c:v>4955</c:v>
                </c:pt>
                <c:pt idx="1985">
                  <c:v>4956</c:v>
                </c:pt>
                <c:pt idx="1986">
                  <c:v>4960</c:v>
                </c:pt>
                <c:pt idx="1987">
                  <c:v>4961</c:v>
                </c:pt>
                <c:pt idx="1988">
                  <c:v>4962</c:v>
                </c:pt>
                <c:pt idx="1989">
                  <c:v>4962</c:v>
                </c:pt>
                <c:pt idx="1990">
                  <c:v>4963</c:v>
                </c:pt>
                <c:pt idx="1991">
                  <c:v>4970</c:v>
                </c:pt>
                <c:pt idx="1992">
                  <c:v>4978</c:v>
                </c:pt>
                <c:pt idx="1993">
                  <c:v>4981</c:v>
                </c:pt>
                <c:pt idx="1994">
                  <c:v>5000</c:v>
                </c:pt>
                <c:pt idx="1995">
                  <c:v>5023</c:v>
                </c:pt>
                <c:pt idx="1996">
                  <c:v>5025</c:v>
                </c:pt>
                <c:pt idx="1997">
                  <c:v>5036</c:v>
                </c:pt>
                <c:pt idx="1998">
                  <c:v>5040</c:v>
                </c:pt>
                <c:pt idx="1999">
                  <c:v>5046</c:v>
                </c:pt>
                <c:pt idx="2000">
                  <c:v>5046</c:v>
                </c:pt>
                <c:pt idx="2001">
                  <c:v>5048</c:v>
                </c:pt>
                <c:pt idx="2002">
                  <c:v>5049</c:v>
                </c:pt>
                <c:pt idx="2003">
                  <c:v>5049</c:v>
                </c:pt>
                <c:pt idx="2004">
                  <c:v>5056</c:v>
                </c:pt>
                <c:pt idx="2005">
                  <c:v>5056</c:v>
                </c:pt>
                <c:pt idx="2006">
                  <c:v>5059</c:v>
                </c:pt>
                <c:pt idx="2007">
                  <c:v>5064</c:v>
                </c:pt>
                <c:pt idx="2008">
                  <c:v>5066</c:v>
                </c:pt>
                <c:pt idx="2009">
                  <c:v>5069</c:v>
                </c:pt>
                <c:pt idx="2010">
                  <c:v>5069</c:v>
                </c:pt>
                <c:pt idx="2011">
                  <c:v>5082</c:v>
                </c:pt>
                <c:pt idx="2012">
                  <c:v>5085</c:v>
                </c:pt>
                <c:pt idx="2013">
                  <c:v>5086</c:v>
                </c:pt>
                <c:pt idx="2014">
                  <c:v>5087</c:v>
                </c:pt>
                <c:pt idx="2015">
                  <c:v>5089</c:v>
                </c:pt>
                <c:pt idx="2016">
                  <c:v>5090</c:v>
                </c:pt>
                <c:pt idx="2017">
                  <c:v>5092</c:v>
                </c:pt>
                <c:pt idx="2018">
                  <c:v>5102</c:v>
                </c:pt>
                <c:pt idx="2019">
                  <c:v>5108</c:v>
                </c:pt>
                <c:pt idx="2020">
                  <c:v>5108</c:v>
                </c:pt>
                <c:pt idx="2021">
                  <c:v>5114</c:v>
                </c:pt>
                <c:pt idx="2022">
                  <c:v>5116</c:v>
                </c:pt>
                <c:pt idx="2023">
                  <c:v>5120</c:v>
                </c:pt>
                <c:pt idx="2024">
                  <c:v>5120</c:v>
                </c:pt>
                <c:pt idx="2025">
                  <c:v>5124</c:v>
                </c:pt>
                <c:pt idx="2026">
                  <c:v>5125</c:v>
                </c:pt>
                <c:pt idx="2027">
                  <c:v>5127</c:v>
                </c:pt>
                <c:pt idx="2028">
                  <c:v>5127</c:v>
                </c:pt>
                <c:pt idx="2029">
                  <c:v>5131</c:v>
                </c:pt>
                <c:pt idx="2030">
                  <c:v>5132</c:v>
                </c:pt>
                <c:pt idx="2031">
                  <c:v>5137</c:v>
                </c:pt>
                <c:pt idx="2032">
                  <c:v>5145</c:v>
                </c:pt>
                <c:pt idx="2033">
                  <c:v>5147</c:v>
                </c:pt>
                <c:pt idx="2034">
                  <c:v>5157</c:v>
                </c:pt>
                <c:pt idx="2035">
                  <c:v>5159</c:v>
                </c:pt>
                <c:pt idx="2036">
                  <c:v>5160</c:v>
                </c:pt>
                <c:pt idx="2037">
                  <c:v>5160</c:v>
                </c:pt>
                <c:pt idx="2038">
                  <c:v>5173</c:v>
                </c:pt>
                <c:pt idx="2039">
                  <c:v>5187</c:v>
                </c:pt>
                <c:pt idx="2040">
                  <c:v>5190</c:v>
                </c:pt>
                <c:pt idx="2041">
                  <c:v>5194</c:v>
                </c:pt>
                <c:pt idx="2042">
                  <c:v>5196</c:v>
                </c:pt>
                <c:pt idx="2043">
                  <c:v>5202</c:v>
                </c:pt>
                <c:pt idx="2044">
                  <c:v>5203</c:v>
                </c:pt>
                <c:pt idx="2045">
                  <c:v>5208</c:v>
                </c:pt>
                <c:pt idx="2046">
                  <c:v>5208</c:v>
                </c:pt>
                <c:pt idx="2047">
                  <c:v>5212</c:v>
                </c:pt>
                <c:pt idx="2048">
                  <c:v>5213</c:v>
                </c:pt>
                <c:pt idx="2049">
                  <c:v>5214</c:v>
                </c:pt>
                <c:pt idx="2050">
                  <c:v>5215</c:v>
                </c:pt>
                <c:pt idx="2051">
                  <c:v>5215</c:v>
                </c:pt>
                <c:pt idx="2052">
                  <c:v>5221</c:v>
                </c:pt>
                <c:pt idx="2053">
                  <c:v>5222</c:v>
                </c:pt>
                <c:pt idx="2054">
                  <c:v>5224</c:v>
                </c:pt>
                <c:pt idx="2055">
                  <c:v>5224</c:v>
                </c:pt>
                <c:pt idx="2056">
                  <c:v>5237</c:v>
                </c:pt>
                <c:pt idx="2057">
                  <c:v>5237</c:v>
                </c:pt>
                <c:pt idx="2058">
                  <c:v>5244</c:v>
                </c:pt>
                <c:pt idx="2059">
                  <c:v>5244</c:v>
                </c:pt>
                <c:pt idx="2060">
                  <c:v>5245</c:v>
                </c:pt>
                <c:pt idx="2061">
                  <c:v>5255</c:v>
                </c:pt>
                <c:pt idx="2062">
                  <c:v>5260</c:v>
                </c:pt>
                <c:pt idx="2063">
                  <c:v>5262</c:v>
                </c:pt>
                <c:pt idx="2064">
                  <c:v>5269</c:v>
                </c:pt>
                <c:pt idx="2065">
                  <c:v>5275</c:v>
                </c:pt>
                <c:pt idx="2066">
                  <c:v>5279</c:v>
                </c:pt>
                <c:pt idx="2067">
                  <c:v>5279</c:v>
                </c:pt>
                <c:pt idx="2068">
                  <c:v>5282</c:v>
                </c:pt>
                <c:pt idx="2069">
                  <c:v>5283</c:v>
                </c:pt>
                <c:pt idx="2070">
                  <c:v>5283</c:v>
                </c:pt>
                <c:pt idx="2071">
                  <c:v>5288</c:v>
                </c:pt>
                <c:pt idx="2072">
                  <c:v>5288</c:v>
                </c:pt>
                <c:pt idx="2073">
                  <c:v>5292</c:v>
                </c:pt>
                <c:pt idx="2074">
                  <c:v>5294</c:v>
                </c:pt>
                <c:pt idx="2075">
                  <c:v>5296</c:v>
                </c:pt>
                <c:pt idx="2076">
                  <c:v>5301</c:v>
                </c:pt>
                <c:pt idx="2077">
                  <c:v>5305</c:v>
                </c:pt>
                <c:pt idx="2078">
                  <c:v>5318</c:v>
                </c:pt>
                <c:pt idx="2079">
                  <c:v>5328</c:v>
                </c:pt>
                <c:pt idx="2080">
                  <c:v>5337</c:v>
                </c:pt>
                <c:pt idx="2081">
                  <c:v>5349</c:v>
                </c:pt>
                <c:pt idx="2082">
                  <c:v>5352</c:v>
                </c:pt>
                <c:pt idx="2083">
                  <c:v>5353</c:v>
                </c:pt>
                <c:pt idx="2084">
                  <c:v>5354</c:v>
                </c:pt>
                <c:pt idx="2085">
                  <c:v>5359</c:v>
                </c:pt>
                <c:pt idx="2086">
                  <c:v>5362</c:v>
                </c:pt>
                <c:pt idx="2087">
                  <c:v>5362</c:v>
                </c:pt>
                <c:pt idx="2088">
                  <c:v>5386</c:v>
                </c:pt>
                <c:pt idx="2089">
                  <c:v>5391</c:v>
                </c:pt>
                <c:pt idx="2090">
                  <c:v>5405</c:v>
                </c:pt>
                <c:pt idx="2091">
                  <c:v>5414</c:v>
                </c:pt>
                <c:pt idx="2092">
                  <c:v>5422</c:v>
                </c:pt>
                <c:pt idx="2093">
                  <c:v>5438</c:v>
                </c:pt>
                <c:pt idx="2094">
                  <c:v>5453</c:v>
                </c:pt>
                <c:pt idx="2095">
                  <c:v>5460</c:v>
                </c:pt>
                <c:pt idx="2096">
                  <c:v>5470</c:v>
                </c:pt>
                <c:pt idx="2097">
                  <c:v>5470</c:v>
                </c:pt>
                <c:pt idx="2098">
                  <c:v>5475</c:v>
                </c:pt>
                <c:pt idx="2099">
                  <c:v>5478</c:v>
                </c:pt>
                <c:pt idx="2100">
                  <c:v>5478</c:v>
                </c:pt>
                <c:pt idx="2101">
                  <c:v>5488</c:v>
                </c:pt>
                <c:pt idx="2102">
                  <c:v>5490</c:v>
                </c:pt>
                <c:pt idx="2103">
                  <c:v>5503</c:v>
                </c:pt>
                <c:pt idx="2104">
                  <c:v>5525</c:v>
                </c:pt>
                <c:pt idx="2105">
                  <c:v>5528</c:v>
                </c:pt>
                <c:pt idx="2106">
                  <c:v>5530</c:v>
                </c:pt>
                <c:pt idx="2107">
                  <c:v>5532</c:v>
                </c:pt>
                <c:pt idx="2108">
                  <c:v>5541</c:v>
                </c:pt>
                <c:pt idx="2109">
                  <c:v>5541</c:v>
                </c:pt>
                <c:pt idx="2110">
                  <c:v>5544</c:v>
                </c:pt>
                <c:pt idx="2111">
                  <c:v>5550</c:v>
                </c:pt>
                <c:pt idx="2112">
                  <c:v>5550</c:v>
                </c:pt>
                <c:pt idx="2113">
                  <c:v>5553</c:v>
                </c:pt>
                <c:pt idx="2114">
                  <c:v>5559</c:v>
                </c:pt>
                <c:pt idx="2115">
                  <c:v>5560</c:v>
                </c:pt>
                <c:pt idx="2116">
                  <c:v>5580</c:v>
                </c:pt>
                <c:pt idx="2117">
                  <c:v>5584</c:v>
                </c:pt>
                <c:pt idx="2118">
                  <c:v>5592</c:v>
                </c:pt>
                <c:pt idx="2119">
                  <c:v>5592</c:v>
                </c:pt>
                <c:pt idx="2120">
                  <c:v>5596</c:v>
                </c:pt>
                <c:pt idx="2121">
                  <c:v>5598</c:v>
                </c:pt>
                <c:pt idx="2122">
                  <c:v>5599</c:v>
                </c:pt>
                <c:pt idx="2123">
                  <c:v>5599</c:v>
                </c:pt>
                <c:pt idx="2124">
                  <c:v>5602</c:v>
                </c:pt>
                <c:pt idx="2125">
                  <c:v>5603</c:v>
                </c:pt>
                <c:pt idx="2126">
                  <c:v>5611</c:v>
                </c:pt>
                <c:pt idx="2127">
                  <c:v>5615</c:v>
                </c:pt>
                <c:pt idx="2128">
                  <c:v>5616</c:v>
                </c:pt>
                <c:pt idx="2129">
                  <c:v>5617</c:v>
                </c:pt>
                <c:pt idx="2130">
                  <c:v>5619</c:v>
                </c:pt>
                <c:pt idx="2131">
                  <c:v>5631</c:v>
                </c:pt>
                <c:pt idx="2132">
                  <c:v>5637</c:v>
                </c:pt>
                <c:pt idx="2133">
                  <c:v>5638</c:v>
                </c:pt>
                <c:pt idx="2134">
                  <c:v>5656</c:v>
                </c:pt>
                <c:pt idx="2135">
                  <c:v>5656</c:v>
                </c:pt>
                <c:pt idx="2136">
                  <c:v>5671</c:v>
                </c:pt>
                <c:pt idx="2137">
                  <c:v>5678</c:v>
                </c:pt>
                <c:pt idx="2138">
                  <c:v>5683</c:v>
                </c:pt>
                <c:pt idx="2139">
                  <c:v>5692</c:v>
                </c:pt>
                <c:pt idx="2140">
                  <c:v>5696</c:v>
                </c:pt>
                <c:pt idx="2141">
                  <c:v>5698</c:v>
                </c:pt>
                <c:pt idx="2142">
                  <c:v>5704</c:v>
                </c:pt>
                <c:pt idx="2143">
                  <c:v>5706</c:v>
                </c:pt>
                <c:pt idx="2144">
                  <c:v>5715</c:v>
                </c:pt>
                <c:pt idx="2145">
                  <c:v>5718</c:v>
                </c:pt>
                <c:pt idx="2146">
                  <c:v>5731</c:v>
                </c:pt>
                <c:pt idx="2147">
                  <c:v>5735</c:v>
                </c:pt>
                <c:pt idx="2148">
                  <c:v>5736</c:v>
                </c:pt>
                <c:pt idx="2149">
                  <c:v>5758</c:v>
                </c:pt>
                <c:pt idx="2150">
                  <c:v>5758</c:v>
                </c:pt>
                <c:pt idx="2151">
                  <c:v>5762</c:v>
                </c:pt>
                <c:pt idx="2152">
                  <c:v>5766</c:v>
                </c:pt>
                <c:pt idx="2153">
                  <c:v>5782</c:v>
                </c:pt>
                <c:pt idx="2154">
                  <c:v>5806</c:v>
                </c:pt>
                <c:pt idx="2155">
                  <c:v>5820</c:v>
                </c:pt>
                <c:pt idx="2156">
                  <c:v>5826</c:v>
                </c:pt>
                <c:pt idx="2157">
                  <c:v>5831</c:v>
                </c:pt>
                <c:pt idx="2158">
                  <c:v>5860</c:v>
                </c:pt>
                <c:pt idx="2159">
                  <c:v>5860</c:v>
                </c:pt>
                <c:pt idx="2160">
                  <c:v>5861</c:v>
                </c:pt>
                <c:pt idx="2161">
                  <c:v>5865</c:v>
                </c:pt>
                <c:pt idx="2162">
                  <c:v>5866</c:v>
                </c:pt>
                <c:pt idx="2163">
                  <c:v>5893</c:v>
                </c:pt>
                <c:pt idx="2164">
                  <c:v>5894</c:v>
                </c:pt>
                <c:pt idx="2165">
                  <c:v>5894</c:v>
                </c:pt>
                <c:pt idx="2166">
                  <c:v>5906</c:v>
                </c:pt>
                <c:pt idx="2167">
                  <c:v>5908</c:v>
                </c:pt>
                <c:pt idx="2168">
                  <c:v>5910</c:v>
                </c:pt>
                <c:pt idx="2169">
                  <c:v>5920</c:v>
                </c:pt>
                <c:pt idx="2170">
                  <c:v>5920</c:v>
                </c:pt>
                <c:pt idx="2171">
                  <c:v>5923</c:v>
                </c:pt>
                <c:pt idx="2172">
                  <c:v>5930</c:v>
                </c:pt>
                <c:pt idx="2173">
                  <c:v>5930</c:v>
                </c:pt>
                <c:pt idx="2174">
                  <c:v>5933</c:v>
                </c:pt>
                <c:pt idx="2175">
                  <c:v>5936</c:v>
                </c:pt>
                <c:pt idx="2176">
                  <c:v>5943</c:v>
                </c:pt>
                <c:pt idx="2177">
                  <c:v>5943</c:v>
                </c:pt>
                <c:pt idx="2178">
                  <c:v>5949</c:v>
                </c:pt>
                <c:pt idx="2179">
                  <c:v>5950</c:v>
                </c:pt>
                <c:pt idx="2180">
                  <c:v>5950</c:v>
                </c:pt>
                <c:pt idx="2181">
                  <c:v>5953</c:v>
                </c:pt>
                <c:pt idx="2182">
                  <c:v>5958</c:v>
                </c:pt>
                <c:pt idx="2183">
                  <c:v>5978</c:v>
                </c:pt>
                <c:pt idx="2184">
                  <c:v>5978</c:v>
                </c:pt>
                <c:pt idx="2185">
                  <c:v>5981</c:v>
                </c:pt>
                <c:pt idx="2186">
                  <c:v>6015</c:v>
                </c:pt>
                <c:pt idx="2187">
                  <c:v>6018</c:v>
                </c:pt>
                <c:pt idx="2188">
                  <c:v>6023</c:v>
                </c:pt>
                <c:pt idx="2189">
                  <c:v>6023</c:v>
                </c:pt>
                <c:pt idx="2190">
                  <c:v>6032</c:v>
                </c:pt>
                <c:pt idx="2191">
                  <c:v>6050</c:v>
                </c:pt>
                <c:pt idx="2192">
                  <c:v>6053</c:v>
                </c:pt>
                <c:pt idx="2193">
                  <c:v>6053</c:v>
                </c:pt>
                <c:pt idx="2194">
                  <c:v>6060</c:v>
                </c:pt>
                <c:pt idx="2195">
                  <c:v>6077</c:v>
                </c:pt>
                <c:pt idx="2196">
                  <c:v>6080</c:v>
                </c:pt>
                <c:pt idx="2197">
                  <c:v>6111</c:v>
                </c:pt>
                <c:pt idx="2198">
                  <c:v>6111</c:v>
                </c:pt>
                <c:pt idx="2199">
                  <c:v>6112</c:v>
                </c:pt>
                <c:pt idx="2200">
                  <c:v>6118</c:v>
                </c:pt>
                <c:pt idx="2201">
                  <c:v>6160</c:v>
                </c:pt>
                <c:pt idx="2202">
                  <c:v>6167</c:v>
                </c:pt>
                <c:pt idx="2203">
                  <c:v>6167</c:v>
                </c:pt>
                <c:pt idx="2204">
                  <c:v>6172</c:v>
                </c:pt>
                <c:pt idx="2205">
                  <c:v>6185</c:v>
                </c:pt>
                <c:pt idx="2206">
                  <c:v>6197</c:v>
                </c:pt>
                <c:pt idx="2207">
                  <c:v>6197</c:v>
                </c:pt>
                <c:pt idx="2208">
                  <c:v>6201</c:v>
                </c:pt>
                <c:pt idx="2209">
                  <c:v>6208</c:v>
                </c:pt>
                <c:pt idx="2210">
                  <c:v>6239</c:v>
                </c:pt>
                <c:pt idx="2211">
                  <c:v>6239</c:v>
                </c:pt>
                <c:pt idx="2212">
                  <c:v>6246</c:v>
                </c:pt>
                <c:pt idx="2213">
                  <c:v>6269</c:v>
                </c:pt>
                <c:pt idx="2214">
                  <c:v>6313</c:v>
                </c:pt>
                <c:pt idx="2215">
                  <c:v>6313</c:v>
                </c:pt>
                <c:pt idx="2216">
                  <c:v>6315</c:v>
                </c:pt>
                <c:pt idx="2217">
                  <c:v>6329</c:v>
                </c:pt>
                <c:pt idx="2218">
                  <c:v>6334</c:v>
                </c:pt>
                <c:pt idx="2219">
                  <c:v>6334</c:v>
                </c:pt>
                <c:pt idx="2220">
                  <c:v>6358</c:v>
                </c:pt>
                <c:pt idx="2221">
                  <c:v>6359</c:v>
                </c:pt>
                <c:pt idx="2222">
                  <c:v>6393</c:v>
                </c:pt>
                <c:pt idx="2223">
                  <c:v>6393</c:v>
                </c:pt>
                <c:pt idx="2224">
                  <c:v>6404</c:v>
                </c:pt>
                <c:pt idx="2225">
                  <c:v>6513</c:v>
                </c:pt>
                <c:pt idx="2226">
                  <c:v>6513</c:v>
                </c:pt>
                <c:pt idx="2227">
                  <c:v>6529</c:v>
                </c:pt>
                <c:pt idx="2228">
                  <c:v>6529</c:v>
                </c:pt>
                <c:pt idx="2229">
                  <c:v>6567</c:v>
                </c:pt>
                <c:pt idx="2230">
                  <c:v>6628</c:v>
                </c:pt>
                <c:pt idx="2231">
                  <c:v>6628</c:v>
                </c:pt>
                <c:pt idx="2232">
                  <c:v>6636</c:v>
                </c:pt>
                <c:pt idx="2233">
                  <c:v>6690</c:v>
                </c:pt>
                <c:pt idx="2234">
                  <c:v>6705</c:v>
                </c:pt>
                <c:pt idx="2235">
                  <c:v>6749</c:v>
                </c:pt>
                <c:pt idx="2236">
                  <c:v>6786</c:v>
                </c:pt>
                <c:pt idx="2237">
                  <c:v>6786</c:v>
                </c:pt>
                <c:pt idx="2238">
                  <c:v>6808</c:v>
                </c:pt>
                <c:pt idx="2239">
                  <c:v>6837</c:v>
                </c:pt>
                <c:pt idx="2240">
                  <c:v>6837</c:v>
                </c:pt>
                <c:pt idx="2241">
                  <c:v>6852</c:v>
                </c:pt>
                <c:pt idx="2242">
                  <c:v>6860</c:v>
                </c:pt>
                <c:pt idx="2243">
                  <c:v>6889</c:v>
                </c:pt>
                <c:pt idx="2244">
                  <c:v>6905</c:v>
                </c:pt>
                <c:pt idx="2245">
                  <c:v>6933</c:v>
                </c:pt>
                <c:pt idx="2246">
                  <c:v>6950</c:v>
                </c:pt>
                <c:pt idx="2247">
                  <c:v>6974</c:v>
                </c:pt>
                <c:pt idx="2248">
                  <c:v>6990</c:v>
                </c:pt>
                <c:pt idx="2249">
                  <c:v>7027</c:v>
                </c:pt>
                <c:pt idx="2250">
                  <c:v>7041</c:v>
                </c:pt>
                <c:pt idx="2251">
                  <c:v>7041</c:v>
                </c:pt>
                <c:pt idx="2252">
                  <c:v>7049</c:v>
                </c:pt>
                <c:pt idx="2253">
                  <c:v>7067</c:v>
                </c:pt>
                <c:pt idx="2254">
                  <c:v>7067</c:v>
                </c:pt>
                <c:pt idx="2255">
                  <c:v>7099</c:v>
                </c:pt>
                <c:pt idx="2256">
                  <c:v>7110</c:v>
                </c:pt>
                <c:pt idx="2257">
                  <c:v>7177</c:v>
                </c:pt>
                <c:pt idx="2258">
                  <c:v>7180</c:v>
                </c:pt>
                <c:pt idx="2259">
                  <c:v>7248</c:v>
                </c:pt>
                <c:pt idx="2260">
                  <c:v>7248</c:v>
                </c:pt>
                <c:pt idx="2261">
                  <c:v>7326</c:v>
                </c:pt>
                <c:pt idx="2262">
                  <c:v>7326</c:v>
                </c:pt>
                <c:pt idx="2263">
                  <c:v>7351</c:v>
                </c:pt>
                <c:pt idx="2264">
                  <c:v>7390</c:v>
                </c:pt>
                <c:pt idx="2265">
                  <c:v>7495</c:v>
                </c:pt>
                <c:pt idx="2266">
                  <c:v>7606</c:v>
                </c:pt>
                <c:pt idx="2267">
                  <c:v>7606</c:v>
                </c:pt>
                <c:pt idx="2268">
                  <c:v>7673</c:v>
                </c:pt>
                <c:pt idx="2269">
                  <c:v>7745</c:v>
                </c:pt>
                <c:pt idx="2270">
                  <c:v>7745</c:v>
                </c:pt>
                <c:pt idx="2271">
                  <c:v>7801</c:v>
                </c:pt>
                <c:pt idx="2272">
                  <c:v>7801</c:v>
                </c:pt>
                <c:pt idx="2273">
                  <c:v>7943</c:v>
                </c:pt>
                <c:pt idx="2274">
                  <c:v>7943</c:v>
                </c:pt>
                <c:pt idx="2275">
                  <c:v>7954</c:v>
                </c:pt>
                <c:pt idx="2276">
                  <c:v>7967</c:v>
                </c:pt>
                <c:pt idx="2277">
                  <c:v>7967</c:v>
                </c:pt>
                <c:pt idx="2278">
                  <c:v>8220</c:v>
                </c:pt>
                <c:pt idx="2279">
                  <c:v>8303</c:v>
                </c:pt>
                <c:pt idx="2280">
                  <c:v>8321</c:v>
                </c:pt>
                <c:pt idx="2281">
                  <c:v>8321</c:v>
                </c:pt>
                <c:pt idx="2282">
                  <c:v>8507</c:v>
                </c:pt>
                <c:pt idx="2283">
                  <c:v>8555</c:v>
                </c:pt>
                <c:pt idx="2284">
                  <c:v>8725</c:v>
                </c:pt>
                <c:pt idx="2285">
                  <c:v>8805</c:v>
                </c:pt>
                <c:pt idx="2286">
                  <c:v>8941</c:v>
                </c:pt>
                <c:pt idx="2287">
                  <c:v>8941</c:v>
                </c:pt>
                <c:pt idx="2288">
                  <c:v>9184</c:v>
                </c:pt>
                <c:pt idx="2289">
                  <c:v>9193</c:v>
                </c:pt>
              </c:numCache>
            </c:numRef>
          </c:xVal>
          <c:yVal>
            <c:numRef>
              <c:f>Survival!$C$2032:$C$4321</c:f>
              <c:numCache>
                <c:formatCode>General</c:formatCode>
                <c:ptCount val="2290"/>
                <c:pt idx="0">
                  <c:v>1</c:v>
                </c:pt>
                <c:pt idx="1">
                  <c:v>1</c:v>
                </c:pt>
                <c:pt idx="2">
                  <c:v>0.99943630214205181</c:v>
                </c:pt>
                <c:pt idx="3">
                  <c:v>0.99943630214205181</c:v>
                </c:pt>
                <c:pt idx="4">
                  <c:v>0.99887260428410363</c:v>
                </c:pt>
                <c:pt idx="5">
                  <c:v>0.99887260428410363</c:v>
                </c:pt>
                <c:pt idx="6">
                  <c:v>0.99887260428410363</c:v>
                </c:pt>
                <c:pt idx="7">
                  <c:v>0.99887260428410363</c:v>
                </c:pt>
                <c:pt idx="8">
                  <c:v>0.99887260428410363</c:v>
                </c:pt>
                <c:pt idx="9">
                  <c:v>0.99887260428410363</c:v>
                </c:pt>
                <c:pt idx="10">
                  <c:v>0.99887260428410363</c:v>
                </c:pt>
                <c:pt idx="11">
                  <c:v>0.99887260428410363</c:v>
                </c:pt>
                <c:pt idx="12">
                  <c:v>0.99887260428410363</c:v>
                </c:pt>
                <c:pt idx="13">
                  <c:v>0.99887260428410363</c:v>
                </c:pt>
                <c:pt idx="14">
                  <c:v>0.99830634997328493</c:v>
                </c:pt>
                <c:pt idx="15">
                  <c:v>0.99830634997328493</c:v>
                </c:pt>
                <c:pt idx="16">
                  <c:v>0.99774009566246624</c:v>
                </c:pt>
                <c:pt idx="17">
                  <c:v>0.99774009566246624</c:v>
                </c:pt>
                <c:pt idx="18">
                  <c:v>0.99717351979894409</c:v>
                </c:pt>
                <c:pt idx="19">
                  <c:v>0.99717351979894409</c:v>
                </c:pt>
                <c:pt idx="20">
                  <c:v>0.99717351979894409</c:v>
                </c:pt>
                <c:pt idx="21">
                  <c:v>0.99660662183430571</c:v>
                </c:pt>
                <c:pt idx="22">
                  <c:v>0.99660662183430571</c:v>
                </c:pt>
                <c:pt idx="23">
                  <c:v>0.99603972386966733</c:v>
                </c:pt>
                <c:pt idx="24">
                  <c:v>0.99603972386966733</c:v>
                </c:pt>
                <c:pt idx="25">
                  <c:v>0.99603972386966733</c:v>
                </c:pt>
                <c:pt idx="26">
                  <c:v>0.99603972386966733</c:v>
                </c:pt>
                <c:pt idx="27">
                  <c:v>0.99547217986746239</c:v>
                </c:pt>
                <c:pt idx="28">
                  <c:v>0.99547217986746239</c:v>
                </c:pt>
                <c:pt idx="29">
                  <c:v>0.99547217986746239</c:v>
                </c:pt>
                <c:pt idx="30">
                  <c:v>0.99547217986746239</c:v>
                </c:pt>
                <c:pt idx="31">
                  <c:v>0.99490398798397639</c:v>
                </c:pt>
                <c:pt idx="32">
                  <c:v>0.99490398798397639</c:v>
                </c:pt>
                <c:pt idx="33">
                  <c:v>0.99433579610049039</c:v>
                </c:pt>
                <c:pt idx="34">
                  <c:v>0.99433579610049039</c:v>
                </c:pt>
                <c:pt idx="35">
                  <c:v>0.99433579610049039</c:v>
                </c:pt>
                <c:pt idx="36">
                  <c:v>0.99433579610049039</c:v>
                </c:pt>
                <c:pt idx="37">
                  <c:v>0.99376695411187455</c:v>
                </c:pt>
                <c:pt idx="38">
                  <c:v>0.99376695411187455</c:v>
                </c:pt>
                <c:pt idx="39">
                  <c:v>0.99376695411187455</c:v>
                </c:pt>
                <c:pt idx="40">
                  <c:v>0.99376695411187455</c:v>
                </c:pt>
                <c:pt idx="41">
                  <c:v>0.99376695411187455</c:v>
                </c:pt>
                <c:pt idx="42">
                  <c:v>0.99319680669127108</c:v>
                </c:pt>
                <c:pt idx="43">
                  <c:v>0.99319680669127108</c:v>
                </c:pt>
                <c:pt idx="44">
                  <c:v>0.99319680669127108</c:v>
                </c:pt>
                <c:pt idx="45">
                  <c:v>0.99262633178794468</c:v>
                </c:pt>
                <c:pt idx="46">
                  <c:v>0.99262633178794468</c:v>
                </c:pt>
                <c:pt idx="47">
                  <c:v>0.99262633178794468</c:v>
                </c:pt>
                <c:pt idx="48">
                  <c:v>0.99205552883694526</c:v>
                </c:pt>
                <c:pt idx="49">
                  <c:v>0.99205552883694526</c:v>
                </c:pt>
                <c:pt idx="50">
                  <c:v>0.99148472588594583</c:v>
                </c:pt>
                <c:pt idx="51">
                  <c:v>0.99148472588594583</c:v>
                </c:pt>
                <c:pt idx="52">
                  <c:v>0.9909139229349464</c:v>
                </c:pt>
                <c:pt idx="53">
                  <c:v>0.9909139229349464</c:v>
                </c:pt>
                <c:pt idx="54">
                  <c:v>0.9909139229349464</c:v>
                </c:pt>
                <c:pt idx="55">
                  <c:v>0.9909139229349464</c:v>
                </c:pt>
                <c:pt idx="56">
                  <c:v>0.9909139229349464</c:v>
                </c:pt>
                <c:pt idx="57">
                  <c:v>0.99034213186573983</c:v>
                </c:pt>
                <c:pt idx="58">
                  <c:v>0.99034213186573983</c:v>
                </c:pt>
                <c:pt idx="59">
                  <c:v>0.99034213186573983</c:v>
                </c:pt>
                <c:pt idx="60">
                  <c:v>0.98977001047240321</c:v>
                </c:pt>
                <c:pt idx="61">
                  <c:v>0.98977001047240321</c:v>
                </c:pt>
                <c:pt idx="62">
                  <c:v>0.98919788907906658</c:v>
                </c:pt>
                <c:pt idx="63">
                  <c:v>0.98919788907906658</c:v>
                </c:pt>
                <c:pt idx="64">
                  <c:v>0.98862543659696067</c:v>
                </c:pt>
                <c:pt idx="65">
                  <c:v>0.98862543659696067</c:v>
                </c:pt>
                <c:pt idx="66">
                  <c:v>0.98805298411485476</c:v>
                </c:pt>
                <c:pt idx="67">
                  <c:v>0.98805298411485476</c:v>
                </c:pt>
                <c:pt idx="68">
                  <c:v>0.98748053163274885</c:v>
                </c:pt>
                <c:pt idx="69">
                  <c:v>0.98748053163274885</c:v>
                </c:pt>
                <c:pt idx="70">
                  <c:v>0.98748053163274885</c:v>
                </c:pt>
                <c:pt idx="71">
                  <c:v>0.98690774710163931</c:v>
                </c:pt>
                <c:pt idx="72">
                  <c:v>0.98690774710163931</c:v>
                </c:pt>
                <c:pt idx="73">
                  <c:v>0.98633496257052977</c:v>
                </c:pt>
                <c:pt idx="74">
                  <c:v>0.98633496257052977</c:v>
                </c:pt>
                <c:pt idx="75">
                  <c:v>0.98576217803942023</c:v>
                </c:pt>
                <c:pt idx="76">
                  <c:v>0.98576217803942023</c:v>
                </c:pt>
                <c:pt idx="77">
                  <c:v>0.9851893935083107</c:v>
                </c:pt>
                <c:pt idx="78">
                  <c:v>0.9851893935083107</c:v>
                </c:pt>
                <c:pt idx="79">
                  <c:v>0.9846162757692134</c:v>
                </c:pt>
                <c:pt idx="80">
                  <c:v>0.9846162757692134</c:v>
                </c:pt>
                <c:pt idx="81">
                  <c:v>0.98404315803011611</c:v>
                </c:pt>
                <c:pt idx="82">
                  <c:v>0.98404315803011611</c:v>
                </c:pt>
                <c:pt idx="83">
                  <c:v>0.98404315803011611</c:v>
                </c:pt>
                <c:pt idx="84">
                  <c:v>0.98346970630632236</c:v>
                </c:pt>
                <c:pt idx="85">
                  <c:v>0.98346970630632236</c:v>
                </c:pt>
                <c:pt idx="86">
                  <c:v>0.98289625458252861</c:v>
                </c:pt>
                <c:pt idx="87">
                  <c:v>0.98289625458252861</c:v>
                </c:pt>
                <c:pt idx="88">
                  <c:v>0.98174935113494111</c:v>
                </c:pt>
                <c:pt idx="89">
                  <c:v>0.98174935113494111</c:v>
                </c:pt>
                <c:pt idx="90">
                  <c:v>0.98117589941114736</c:v>
                </c:pt>
                <c:pt idx="91">
                  <c:v>0.98117589941114736</c:v>
                </c:pt>
                <c:pt idx="92">
                  <c:v>0.98117589941114736</c:v>
                </c:pt>
                <c:pt idx="93">
                  <c:v>0.98117589941114736</c:v>
                </c:pt>
                <c:pt idx="94">
                  <c:v>0.98117589941114736</c:v>
                </c:pt>
                <c:pt idx="95">
                  <c:v>0.98117589941114736</c:v>
                </c:pt>
                <c:pt idx="96">
                  <c:v>0.98117589941114736</c:v>
                </c:pt>
                <c:pt idx="97">
                  <c:v>0.98060076699648668</c:v>
                </c:pt>
                <c:pt idx="98">
                  <c:v>0.98060076699648668</c:v>
                </c:pt>
                <c:pt idx="99">
                  <c:v>0.98060076699648668</c:v>
                </c:pt>
                <c:pt idx="100">
                  <c:v>0.98060076699648668</c:v>
                </c:pt>
                <c:pt idx="101">
                  <c:v>0.98002495914739896</c:v>
                </c:pt>
                <c:pt idx="102">
                  <c:v>0.98002495914739896</c:v>
                </c:pt>
                <c:pt idx="103">
                  <c:v>0.97944847387731226</c:v>
                </c:pt>
                <c:pt idx="104">
                  <c:v>0.97944847387731226</c:v>
                </c:pt>
                <c:pt idx="105">
                  <c:v>0.97887198860722557</c:v>
                </c:pt>
                <c:pt idx="106">
                  <c:v>0.97887198860722557</c:v>
                </c:pt>
                <c:pt idx="107">
                  <c:v>0.97829550333713888</c:v>
                </c:pt>
                <c:pt idx="108">
                  <c:v>0.97829550333713888</c:v>
                </c:pt>
                <c:pt idx="109">
                  <c:v>0.97771901806705219</c:v>
                </c:pt>
                <c:pt idx="110">
                  <c:v>0.97771901806705219</c:v>
                </c:pt>
                <c:pt idx="111">
                  <c:v>0.9771425327969655</c:v>
                </c:pt>
                <c:pt idx="112">
                  <c:v>0.9771425327969655</c:v>
                </c:pt>
                <c:pt idx="113">
                  <c:v>0.9771425327969655</c:v>
                </c:pt>
                <c:pt idx="114">
                  <c:v>0.97656536650470505</c:v>
                </c:pt>
                <c:pt idx="115">
                  <c:v>0.97656536650470505</c:v>
                </c:pt>
                <c:pt idx="116">
                  <c:v>0.97598820021244459</c:v>
                </c:pt>
                <c:pt idx="117">
                  <c:v>0.97598820021244459</c:v>
                </c:pt>
                <c:pt idx="118">
                  <c:v>0.97598820021244459</c:v>
                </c:pt>
                <c:pt idx="119">
                  <c:v>0.975410692401668</c:v>
                </c:pt>
                <c:pt idx="120">
                  <c:v>0.975410692401668</c:v>
                </c:pt>
                <c:pt idx="121">
                  <c:v>0.97483318459089141</c:v>
                </c:pt>
                <c:pt idx="122">
                  <c:v>0.97483318459089141</c:v>
                </c:pt>
                <c:pt idx="123">
                  <c:v>0.97367816896933823</c:v>
                </c:pt>
                <c:pt idx="124">
                  <c:v>0.97367816896933823</c:v>
                </c:pt>
                <c:pt idx="125">
                  <c:v>0.97310066115856164</c:v>
                </c:pt>
                <c:pt idx="126">
                  <c:v>0.97310066115856164</c:v>
                </c:pt>
                <c:pt idx="127">
                  <c:v>0.97252315334778505</c:v>
                </c:pt>
                <c:pt idx="128">
                  <c:v>0.97252315334778505</c:v>
                </c:pt>
                <c:pt idx="129">
                  <c:v>0.97079062991545528</c:v>
                </c:pt>
                <c:pt idx="130">
                  <c:v>0.97079062991545528</c:v>
                </c:pt>
                <c:pt idx="131">
                  <c:v>0.97079062991545528</c:v>
                </c:pt>
                <c:pt idx="132">
                  <c:v>0.97021277835002939</c:v>
                </c:pt>
                <c:pt idx="133">
                  <c:v>0.97021277835002939</c:v>
                </c:pt>
                <c:pt idx="134">
                  <c:v>0.9696349267846035</c:v>
                </c:pt>
                <c:pt idx="135">
                  <c:v>0.9696349267846035</c:v>
                </c:pt>
                <c:pt idx="136">
                  <c:v>0.96905707521917761</c:v>
                </c:pt>
                <c:pt idx="137">
                  <c:v>0.96905707521917761</c:v>
                </c:pt>
                <c:pt idx="138">
                  <c:v>0.96847922365375172</c:v>
                </c:pt>
                <c:pt idx="139">
                  <c:v>0.96847922365375172</c:v>
                </c:pt>
                <c:pt idx="140">
                  <c:v>0.96847922365375172</c:v>
                </c:pt>
                <c:pt idx="141">
                  <c:v>0.96732283055088153</c:v>
                </c:pt>
                <c:pt idx="142">
                  <c:v>0.96732283055088153</c:v>
                </c:pt>
                <c:pt idx="143">
                  <c:v>0.96674463399944643</c:v>
                </c:pt>
                <c:pt idx="144">
                  <c:v>0.96674463399944643</c:v>
                </c:pt>
                <c:pt idx="145">
                  <c:v>0.96674463399944643</c:v>
                </c:pt>
                <c:pt idx="146">
                  <c:v>0.96616609142972798</c:v>
                </c:pt>
                <c:pt idx="147">
                  <c:v>0.96616609142972798</c:v>
                </c:pt>
                <c:pt idx="148">
                  <c:v>0.96558720221976413</c:v>
                </c:pt>
                <c:pt idx="149">
                  <c:v>0.96558720221976413</c:v>
                </c:pt>
                <c:pt idx="150">
                  <c:v>0.96500831300980028</c:v>
                </c:pt>
                <c:pt idx="151">
                  <c:v>0.96500831300980028</c:v>
                </c:pt>
                <c:pt idx="152">
                  <c:v>0.96500831300980028</c:v>
                </c:pt>
                <c:pt idx="153">
                  <c:v>0.96327060296236366</c:v>
                </c:pt>
                <c:pt idx="154">
                  <c:v>0.96327060296236366</c:v>
                </c:pt>
                <c:pt idx="155">
                  <c:v>0.96269101776202526</c:v>
                </c:pt>
                <c:pt idx="156">
                  <c:v>0.96269101776202526</c:v>
                </c:pt>
                <c:pt idx="157">
                  <c:v>0.96211143256168685</c:v>
                </c:pt>
                <c:pt idx="158">
                  <c:v>0.96211143256168685</c:v>
                </c:pt>
                <c:pt idx="159">
                  <c:v>0.96153184736134845</c:v>
                </c:pt>
                <c:pt idx="160">
                  <c:v>0.96153184736134845</c:v>
                </c:pt>
                <c:pt idx="161">
                  <c:v>0.96095226216101004</c:v>
                </c:pt>
                <c:pt idx="162">
                  <c:v>0.96095226216101004</c:v>
                </c:pt>
                <c:pt idx="163">
                  <c:v>0.96095226216101004</c:v>
                </c:pt>
                <c:pt idx="164">
                  <c:v>0.96037232718082843</c:v>
                </c:pt>
                <c:pt idx="165">
                  <c:v>0.96037232718082843</c:v>
                </c:pt>
                <c:pt idx="166">
                  <c:v>0.96037232718082843</c:v>
                </c:pt>
                <c:pt idx="167">
                  <c:v>0.96037232718082843</c:v>
                </c:pt>
                <c:pt idx="168">
                  <c:v>0.95979169094915928</c:v>
                </c:pt>
                <c:pt idx="169">
                  <c:v>0.95979169094915928</c:v>
                </c:pt>
                <c:pt idx="170">
                  <c:v>0.95921105471749013</c:v>
                </c:pt>
                <c:pt idx="171">
                  <c:v>0.95921105471749013</c:v>
                </c:pt>
                <c:pt idx="172">
                  <c:v>0.95863041848582098</c:v>
                </c:pt>
                <c:pt idx="173">
                  <c:v>0.95863041848582098</c:v>
                </c:pt>
                <c:pt idx="174">
                  <c:v>0.95804978225415183</c:v>
                </c:pt>
                <c:pt idx="175">
                  <c:v>0.95804978225415183</c:v>
                </c:pt>
                <c:pt idx="176">
                  <c:v>0.95688850979081341</c:v>
                </c:pt>
                <c:pt idx="177">
                  <c:v>0.95688850979081341</c:v>
                </c:pt>
                <c:pt idx="178">
                  <c:v>0.95630787355914426</c:v>
                </c:pt>
                <c:pt idx="179">
                  <c:v>0.95630787355914426</c:v>
                </c:pt>
                <c:pt idx="180">
                  <c:v>0.95572723732747511</c:v>
                </c:pt>
                <c:pt idx="181">
                  <c:v>0.95572723732747511</c:v>
                </c:pt>
                <c:pt idx="182">
                  <c:v>0.95514660109580596</c:v>
                </c:pt>
                <c:pt idx="183">
                  <c:v>0.95514660109580596</c:v>
                </c:pt>
                <c:pt idx="184">
                  <c:v>0.95456596486413681</c:v>
                </c:pt>
                <c:pt idx="185">
                  <c:v>0.95456596486413681</c:v>
                </c:pt>
                <c:pt idx="186">
                  <c:v>0.95398532863246766</c:v>
                </c:pt>
                <c:pt idx="187">
                  <c:v>0.95398532863246766</c:v>
                </c:pt>
                <c:pt idx="188">
                  <c:v>0.9534046924007985</c:v>
                </c:pt>
                <c:pt idx="189">
                  <c:v>0.9534046924007985</c:v>
                </c:pt>
                <c:pt idx="190">
                  <c:v>0.95224341993746009</c:v>
                </c:pt>
                <c:pt idx="191">
                  <c:v>0.95224341993746009</c:v>
                </c:pt>
                <c:pt idx="192">
                  <c:v>0.95166278370579094</c:v>
                </c:pt>
                <c:pt idx="193">
                  <c:v>0.95166278370579094</c:v>
                </c:pt>
                <c:pt idx="194">
                  <c:v>0.95108214747412179</c:v>
                </c:pt>
                <c:pt idx="195">
                  <c:v>0.95108214747412179</c:v>
                </c:pt>
                <c:pt idx="196">
                  <c:v>0.95050151124245263</c:v>
                </c:pt>
                <c:pt idx="197">
                  <c:v>0.95050151124245263</c:v>
                </c:pt>
                <c:pt idx="198">
                  <c:v>0.94992087501078348</c:v>
                </c:pt>
                <c:pt idx="199">
                  <c:v>0.94992087501078348</c:v>
                </c:pt>
                <c:pt idx="200">
                  <c:v>0.94934023877911433</c:v>
                </c:pt>
                <c:pt idx="201">
                  <c:v>0.94934023877911433</c:v>
                </c:pt>
                <c:pt idx="202">
                  <c:v>0.94934023877911433</c:v>
                </c:pt>
                <c:pt idx="203">
                  <c:v>0.94875924720091409</c:v>
                </c:pt>
                <c:pt idx="204">
                  <c:v>0.94875924720091409</c:v>
                </c:pt>
                <c:pt idx="205">
                  <c:v>0.94817825562271385</c:v>
                </c:pt>
                <c:pt idx="206">
                  <c:v>0.94817825562271385</c:v>
                </c:pt>
                <c:pt idx="207">
                  <c:v>0.94759726404451361</c:v>
                </c:pt>
                <c:pt idx="208">
                  <c:v>0.94759726404451361</c:v>
                </c:pt>
                <c:pt idx="209">
                  <c:v>0.94759726404451361</c:v>
                </c:pt>
                <c:pt idx="210">
                  <c:v>0.94701591602976243</c:v>
                </c:pt>
                <c:pt idx="211">
                  <c:v>0.94701591602976243</c:v>
                </c:pt>
                <c:pt idx="212">
                  <c:v>0.94643456801501125</c:v>
                </c:pt>
                <c:pt idx="213">
                  <c:v>0.94643456801501125</c:v>
                </c:pt>
                <c:pt idx="214">
                  <c:v>0.94527187198550877</c:v>
                </c:pt>
                <c:pt idx="215">
                  <c:v>0.94527187198550877</c:v>
                </c:pt>
                <c:pt idx="216">
                  <c:v>0.94527187198550877</c:v>
                </c:pt>
                <c:pt idx="217">
                  <c:v>0.94469016621813307</c:v>
                </c:pt>
                <c:pt idx="218">
                  <c:v>0.94469016621813307</c:v>
                </c:pt>
                <c:pt idx="219">
                  <c:v>0.94410846045075736</c:v>
                </c:pt>
                <c:pt idx="220">
                  <c:v>0.94410846045075736</c:v>
                </c:pt>
                <c:pt idx="221">
                  <c:v>0.94352675468338165</c:v>
                </c:pt>
                <c:pt idx="222">
                  <c:v>0.94352675468338165</c:v>
                </c:pt>
                <c:pt idx="223">
                  <c:v>0.94294504891600595</c:v>
                </c:pt>
                <c:pt idx="224">
                  <c:v>0.94294504891600595</c:v>
                </c:pt>
                <c:pt idx="225">
                  <c:v>0.94236334314863024</c:v>
                </c:pt>
                <c:pt idx="226">
                  <c:v>0.94236334314863024</c:v>
                </c:pt>
                <c:pt idx="227">
                  <c:v>0.94178163738125453</c:v>
                </c:pt>
                <c:pt idx="228">
                  <c:v>0.94178163738125453</c:v>
                </c:pt>
                <c:pt idx="229">
                  <c:v>0.94119993161387883</c:v>
                </c:pt>
                <c:pt idx="230">
                  <c:v>0.94119993161387883</c:v>
                </c:pt>
                <c:pt idx="231">
                  <c:v>0.94003652007912741</c:v>
                </c:pt>
                <c:pt idx="232">
                  <c:v>0.94003652007912741</c:v>
                </c:pt>
                <c:pt idx="233">
                  <c:v>0.938873108544376</c:v>
                </c:pt>
                <c:pt idx="234">
                  <c:v>0.938873108544376</c:v>
                </c:pt>
                <c:pt idx="235">
                  <c:v>0.93770969700962459</c:v>
                </c:pt>
                <c:pt idx="236">
                  <c:v>0.93770969700962459</c:v>
                </c:pt>
                <c:pt idx="237">
                  <c:v>0.93712799124224888</c:v>
                </c:pt>
                <c:pt idx="238">
                  <c:v>0.93712799124224888</c:v>
                </c:pt>
                <c:pt idx="239">
                  <c:v>0.93654628547487317</c:v>
                </c:pt>
                <c:pt idx="240">
                  <c:v>0.93654628547487317</c:v>
                </c:pt>
                <c:pt idx="241">
                  <c:v>0.93596457970749747</c:v>
                </c:pt>
                <c:pt idx="242">
                  <c:v>0.93596457970749747</c:v>
                </c:pt>
                <c:pt idx="243">
                  <c:v>0.93538287394012176</c:v>
                </c:pt>
                <c:pt idx="244">
                  <c:v>0.93538287394012176</c:v>
                </c:pt>
                <c:pt idx="245">
                  <c:v>0.93480116817274606</c:v>
                </c:pt>
                <c:pt idx="246">
                  <c:v>0.93480116817274606</c:v>
                </c:pt>
                <c:pt idx="247">
                  <c:v>0.93421946240537035</c:v>
                </c:pt>
                <c:pt idx="248">
                  <c:v>0.93421946240537035</c:v>
                </c:pt>
                <c:pt idx="249">
                  <c:v>0.93421946240537035</c:v>
                </c:pt>
                <c:pt idx="250">
                  <c:v>0.93363739420449476</c:v>
                </c:pt>
                <c:pt idx="251">
                  <c:v>0.93363739420449476</c:v>
                </c:pt>
                <c:pt idx="252">
                  <c:v>0.93305532600361918</c:v>
                </c:pt>
                <c:pt idx="253">
                  <c:v>0.93305532600361918</c:v>
                </c:pt>
                <c:pt idx="254">
                  <c:v>0.93247325780274359</c:v>
                </c:pt>
                <c:pt idx="255">
                  <c:v>0.93247325780274359</c:v>
                </c:pt>
                <c:pt idx="256">
                  <c:v>0.93189118960186801</c:v>
                </c:pt>
                <c:pt idx="257">
                  <c:v>0.93189118960186801</c:v>
                </c:pt>
                <c:pt idx="258">
                  <c:v>0.93130912140099242</c:v>
                </c:pt>
                <c:pt idx="259">
                  <c:v>0.93130912140099242</c:v>
                </c:pt>
                <c:pt idx="260">
                  <c:v>0.93072668917997869</c:v>
                </c:pt>
                <c:pt idx="261">
                  <c:v>0.93072668917997869</c:v>
                </c:pt>
                <c:pt idx="262">
                  <c:v>0.93072668917997869</c:v>
                </c:pt>
                <c:pt idx="263">
                  <c:v>0.93014389225500693</c:v>
                </c:pt>
                <c:pt idx="264">
                  <c:v>0.93014389225500693</c:v>
                </c:pt>
                <c:pt idx="265">
                  <c:v>0.9289782984050633</c:v>
                </c:pt>
                <c:pt idx="266">
                  <c:v>0.9289782984050633</c:v>
                </c:pt>
                <c:pt idx="267">
                  <c:v>0.92839550148009153</c:v>
                </c:pt>
                <c:pt idx="268">
                  <c:v>0.92839550148009153</c:v>
                </c:pt>
                <c:pt idx="269">
                  <c:v>0.92839550148009153</c:v>
                </c:pt>
                <c:pt idx="270">
                  <c:v>0.92839550148009153</c:v>
                </c:pt>
                <c:pt idx="271">
                  <c:v>0.92781197193799214</c:v>
                </c:pt>
                <c:pt idx="272">
                  <c:v>0.92781197193799214</c:v>
                </c:pt>
                <c:pt idx="273">
                  <c:v>0.92781197193799214</c:v>
                </c:pt>
                <c:pt idx="274">
                  <c:v>0.9272277074720362</c:v>
                </c:pt>
                <c:pt idx="275">
                  <c:v>0.9272277074720362</c:v>
                </c:pt>
                <c:pt idx="276">
                  <c:v>0.92664344300608026</c:v>
                </c:pt>
                <c:pt idx="277">
                  <c:v>0.92664344300608026</c:v>
                </c:pt>
                <c:pt idx="278">
                  <c:v>0.92664344300608026</c:v>
                </c:pt>
                <c:pt idx="279">
                  <c:v>0.92664344300608026</c:v>
                </c:pt>
                <c:pt idx="280">
                  <c:v>0.92605807127960771</c:v>
                </c:pt>
                <c:pt idx="281">
                  <c:v>0.92605807127960771</c:v>
                </c:pt>
                <c:pt idx="282">
                  <c:v>0.92605807127960771</c:v>
                </c:pt>
                <c:pt idx="283">
                  <c:v>0.92547232929903867</c:v>
                </c:pt>
                <c:pt idx="284">
                  <c:v>0.92547232929903867</c:v>
                </c:pt>
                <c:pt idx="285">
                  <c:v>0.92488658731846962</c:v>
                </c:pt>
                <c:pt idx="286">
                  <c:v>0.92488658731846962</c:v>
                </c:pt>
                <c:pt idx="287">
                  <c:v>0.92430084533790058</c:v>
                </c:pt>
                <c:pt idx="288">
                  <c:v>0.92430084533790058</c:v>
                </c:pt>
                <c:pt idx="289">
                  <c:v>0.92371510335733154</c:v>
                </c:pt>
                <c:pt idx="290">
                  <c:v>0.92371510335733154</c:v>
                </c:pt>
                <c:pt idx="291">
                  <c:v>0.92312936137676249</c:v>
                </c:pt>
                <c:pt idx="292">
                  <c:v>0.92312936137676249</c:v>
                </c:pt>
                <c:pt idx="293">
                  <c:v>0.92195787741562452</c:v>
                </c:pt>
                <c:pt idx="294">
                  <c:v>0.92195787741562452</c:v>
                </c:pt>
                <c:pt idx="295">
                  <c:v>0.92137213543505547</c:v>
                </c:pt>
                <c:pt idx="296">
                  <c:v>0.92137213543505547</c:v>
                </c:pt>
                <c:pt idx="297">
                  <c:v>0.92078639345448643</c:v>
                </c:pt>
                <c:pt idx="298">
                  <c:v>0.92078639345448643</c:v>
                </c:pt>
                <c:pt idx="299">
                  <c:v>0.92020065147391739</c:v>
                </c:pt>
                <c:pt idx="300">
                  <c:v>0.92020065147391739</c:v>
                </c:pt>
                <c:pt idx="301">
                  <c:v>0.91961490949334834</c:v>
                </c:pt>
                <c:pt idx="302">
                  <c:v>0.91961490949334834</c:v>
                </c:pt>
                <c:pt idx="303">
                  <c:v>0.9190291675127793</c:v>
                </c:pt>
                <c:pt idx="304">
                  <c:v>0.9190291675127793</c:v>
                </c:pt>
                <c:pt idx="305">
                  <c:v>0.91844305197227372</c:v>
                </c:pt>
                <c:pt idx="306">
                  <c:v>0.91844305197227372</c:v>
                </c:pt>
                <c:pt idx="307">
                  <c:v>0.91727082089126255</c:v>
                </c:pt>
                <c:pt idx="308">
                  <c:v>0.91727082089126255</c:v>
                </c:pt>
                <c:pt idx="309">
                  <c:v>0.91668470535075697</c:v>
                </c:pt>
                <c:pt idx="310">
                  <c:v>0.91668470535075697</c:v>
                </c:pt>
                <c:pt idx="311">
                  <c:v>0.91609858981025138</c:v>
                </c:pt>
                <c:pt idx="312">
                  <c:v>0.91609858981025138</c:v>
                </c:pt>
                <c:pt idx="313">
                  <c:v>0.91609858981025138</c:v>
                </c:pt>
                <c:pt idx="314">
                  <c:v>0.91551209903572495</c:v>
                </c:pt>
                <c:pt idx="315">
                  <c:v>0.91551209903572495</c:v>
                </c:pt>
                <c:pt idx="316">
                  <c:v>0.91492560826119851</c:v>
                </c:pt>
                <c:pt idx="317">
                  <c:v>0.91492560826119851</c:v>
                </c:pt>
                <c:pt idx="318">
                  <c:v>0.91375262671214574</c:v>
                </c:pt>
                <c:pt idx="319">
                  <c:v>0.91375262671214574</c:v>
                </c:pt>
                <c:pt idx="320">
                  <c:v>0.91257964516309298</c:v>
                </c:pt>
                <c:pt idx="321">
                  <c:v>0.91257964516309298</c:v>
                </c:pt>
                <c:pt idx="322">
                  <c:v>0.91199315438856654</c:v>
                </c:pt>
                <c:pt idx="323">
                  <c:v>0.91199315438856654</c:v>
                </c:pt>
                <c:pt idx="324">
                  <c:v>0.91199315438856654</c:v>
                </c:pt>
                <c:pt idx="325">
                  <c:v>0.91140628620684927</c:v>
                </c:pt>
                <c:pt idx="326">
                  <c:v>0.91140628620684927</c:v>
                </c:pt>
                <c:pt idx="327">
                  <c:v>0.910819418025132</c:v>
                </c:pt>
                <c:pt idx="328">
                  <c:v>0.910819418025132</c:v>
                </c:pt>
                <c:pt idx="329">
                  <c:v>0.91023254984341473</c:v>
                </c:pt>
                <c:pt idx="330">
                  <c:v>0.91023254984341473</c:v>
                </c:pt>
                <c:pt idx="331">
                  <c:v>0.90964568166169746</c:v>
                </c:pt>
                <c:pt idx="332">
                  <c:v>0.90964568166169746</c:v>
                </c:pt>
                <c:pt idx="333">
                  <c:v>0.90964568166169746</c:v>
                </c:pt>
                <c:pt idx="334">
                  <c:v>0.90905843461091518</c:v>
                </c:pt>
                <c:pt idx="335">
                  <c:v>0.90905843461091518</c:v>
                </c:pt>
                <c:pt idx="336">
                  <c:v>0.9084711875601329</c:v>
                </c:pt>
                <c:pt idx="337">
                  <c:v>0.9084711875601329</c:v>
                </c:pt>
                <c:pt idx="338">
                  <c:v>0.90788394050935062</c:v>
                </c:pt>
                <c:pt idx="339">
                  <c:v>0.90788394050935062</c:v>
                </c:pt>
                <c:pt idx="340">
                  <c:v>0.90788394050935062</c:v>
                </c:pt>
                <c:pt idx="341">
                  <c:v>0.90670868621742917</c:v>
                </c:pt>
                <c:pt idx="342">
                  <c:v>0.90670868621742917</c:v>
                </c:pt>
                <c:pt idx="343">
                  <c:v>0.90612105907146845</c:v>
                </c:pt>
                <c:pt idx="344">
                  <c:v>0.90612105907146845</c:v>
                </c:pt>
                <c:pt idx="345">
                  <c:v>0.90553343192550773</c:v>
                </c:pt>
                <c:pt idx="346">
                  <c:v>0.90553343192550773</c:v>
                </c:pt>
                <c:pt idx="347">
                  <c:v>0.904945804779547</c:v>
                </c:pt>
                <c:pt idx="348">
                  <c:v>0.904945804779547</c:v>
                </c:pt>
                <c:pt idx="349">
                  <c:v>0.90435817763358628</c:v>
                </c:pt>
                <c:pt idx="350">
                  <c:v>0.90435817763358628</c:v>
                </c:pt>
                <c:pt idx="351">
                  <c:v>0.90377055048762556</c:v>
                </c:pt>
                <c:pt idx="352">
                  <c:v>0.90377055048762556</c:v>
                </c:pt>
                <c:pt idx="353">
                  <c:v>0.90318292334166483</c:v>
                </c:pt>
                <c:pt idx="354">
                  <c:v>0.90318292334166483</c:v>
                </c:pt>
                <c:pt idx="355">
                  <c:v>0.90259529619570411</c:v>
                </c:pt>
                <c:pt idx="356">
                  <c:v>0.90259529619570411</c:v>
                </c:pt>
                <c:pt idx="357">
                  <c:v>0.90200766904974339</c:v>
                </c:pt>
                <c:pt idx="358">
                  <c:v>0.90200766904974339</c:v>
                </c:pt>
                <c:pt idx="359">
                  <c:v>0.90142004190378267</c:v>
                </c:pt>
                <c:pt idx="360">
                  <c:v>0.90142004190378267</c:v>
                </c:pt>
                <c:pt idx="361">
                  <c:v>0.90083241475782194</c:v>
                </c:pt>
                <c:pt idx="362">
                  <c:v>0.90083241475782194</c:v>
                </c:pt>
                <c:pt idx="363">
                  <c:v>0.90083241475782194</c:v>
                </c:pt>
                <c:pt idx="364">
                  <c:v>0.90024440404322803</c:v>
                </c:pt>
                <c:pt idx="365">
                  <c:v>0.90024440404322803</c:v>
                </c:pt>
                <c:pt idx="366">
                  <c:v>0.89965639332863412</c:v>
                </c:pt>
                <c:pt idx="367">
                  <c:v>0.89965639332863412</c:v>
                </c:pt>
                <c:pt idx="368">
                  <c:v>0.89906838261404021</c:v>
                </c:pt>
                <c:pt idx="369">
                  <c:v>0.89906838261404021</c:v>
                </c:pt>
                <c:pt idx="370">
                  <c:v>0.8984803718994463</c:v>
                </c:pt>
                <c:pt idx="371">
                  <c:v>0.8984803718994463</c:v>
                </c:pt>
                <c:pt idx="372">
                  <c:v>0.89789236118485238</c:v>
                </c:pt>
                <c:pt idx="373">
                  <c:v>0.89789236118485238</c:v>
                </c:pt>
                <c:pt idx="374">
                  <c:v>0.89789236118485238</c:v>
                </c:pt>
                <c:pt idx="375">
                  <c:v>0.89730396514213628</c:v>
                </c:pt>
                <c:pt idx="376">
                  <c:v>0.89730396514213628</c:v>
                </c:pt>
                <c:pt idx="377">
                  <c:v>0.89671556909942018</c:v>
                </c:pt>
                <c:pt idx="378">
                  <c:v>0.89671556909942018</c:v>
                </c:pt>
                <c:pt idx="379">
                  <c:v>0.89612717305670397</c:v>
                </c:pt>
                <c:pt idx="380">
                  <c:v>0.89612717305670397</c:v>
                </c:pt>
                <c:pt idx="381">
                  <c:v>0.89553877701398787</c:v>
                </c:pt>
                <c:pt idx="382">
                  <c:v>0.89553877701398787</c:v>
                </c:pt>
                <c:pt idx="383">
                  <c:v>0.89495038097127178</c:v>
                </c:pt>
                <c:pt idx="384">
                  <c:v>0.89495038097127178</c:v>
                </c:pt>
                <c:pt idx="385">
                  <c:v>0.89436198492855556</c:v>
                </c:pt>
                <c:pt idx="386">
                  <c:v>0.89436198492855556</c:v>
                </c:pt>
                <c:pt idx="387">
                  <c:v>0.89377358888583935</c:v>
                </c:pt>
                <c:pt idx="388">
                  <c:v>0.89377358888583935</c:v>
                </c:pt>
                <c:pt idx="389">
                  <c:v>0.89318519284312325</c:v>
                </c:pt>
                <c:pt idx="390">
                  <c:v>0.89318519284312325</c:v>
                </c:pt>
                <c:pt idx="391">
                  <c:v>0.89259679680040716</c:v>
                </c:pt>
                <c:pt idx="392">
                  <c:v>0.89259679680040716</c:v>
                </c:pt>
                <c:pt idx="393">
                  <c:v>0.89259679680040716</c:v>
                </c:pt>
                <c:pt idx="394">
                  <c:v>0.89259679680040716</c:v>
                </c:pt>
                <c:pt idx="395">
                  <c:v>0.89200762399723854</c:v>
                </c:pt>
                <c:pt idx="396">
                  <c:v>0.89200762399723854</c:v>
                </c:pt>
                <c:pt idx="397">
                  <c:v>0.89141845119406993</c:v>
                </c:pt>
                <c:pt idx="398">
                  <c:v>0.89141845119406993</c:v>
                </c:pt>
                <c:pt idx="399">
                  <c:v>0.89082927839090131</c:v>
                </c:pt>
                <c:pt idx="400">
                  <c:v>0.89082927839090131</c:v>
                </c:pt>
                <c:pt idx="401">
                  <c:v>0.8902401055877327</c:v>
                </c:pt>
                <c:pt idx="402">
                  <c:v>0.8902401055877327</c:v>
                </c:pt>
                <c:pt idx="403">
                  <c:v>0.88965093278456409</c:v>
                </c:pt>
                <c:pt idx="404">
                  <c:v>0.88965093278456409</c:v>
                </c:pt>
                <c:pt idx="405">
                  <c:v>0.88965093278456409</c:v>
                </c:pt>
                <c:pt idx="406">
                  <c:v>0.88965093278456409</c:v>
                </c:pt>
                <c:pt idx="407">
                  <c:v>0.8890609785851048</c:v>
                </c:pt>
                <c:pt idx="408">
                  <c:v>0.8890609785851048</c:v>
                </c:pt>
                <c:pt idx="409">
                  <c:v>0.88847102438564551</c:v>
                </c:pt>
                <c:pt idx="410">
                  <c:v>0.88847102438564551</c:v>
                </c:pt>
                <c:pt idx="411">
                  <c:v>0.88788107018618623</c:v>
                </c:pt>
                <c:pt idx="412">
                  <c:v>0.88788107018618623</c:v>
                </c:pt>
                <c:pt idx="413">
                  <c:v>0.88729111598672694</c:v>
                </c:pt>
                <c:pt idx="414">
                  <c:v>0.88729111598672694</c:v>
                </c:pt>
                <c:pt idx="415">
                  <c:v>0.88729111598672694</c:v>
                </c:pt>
                <c:pt idx="416">
                  <c:v>0.88670076926950359</c:v>
                </c:pt>
                <c:pt idx="417">
                  <c:v>0.88670076926950359</c:v>
                </c:pt>
                <c:pt idx="418">
                  <c:v>0.88552007583505687</c:v>
                </c:pt>
                <c:pt idx="419">
                  <c:v>0.88552007583505687</c:v>
                </c:pt>
                <c:pt idx="420">
                  <c:v>0.88492972911783352</c:v>
                </c:pt>
                <c:pt idx="421">
                  <c:v>0.88492972911783352</c:v>
                </c:pt>
                <c:pt idx="422">
                  <c:v>0.88433938240061016</c:v>
                </c:pt>
                <c:pt idx="423">
                  <c:v>0.88433938240061016</c:v>
                </c:pt>
                <c:pt idx="424">
                  <c:v>0.88374903568338681</c:v>
                </c:pt>
                <c:pt idx="425">
                  <c:v>0.88374903568338681</c:v>
                </c:pt>
                <c:pt idx="426">
                  <c:v>0.88315868896616345</c:v>
                </c:pt>
                <c:pt idx="427">
                  <c:v>0.88315868896616345</c:v>
                </c:pt>
                <c:pt idx="428">
                  <c:v>0.88138764881449339</c:v>
                </c:pt>
                <c:pt idx="429">
                  <c:v>0.88138764881449339</c:v>
                </c:pt>
                <c:pt idx="430">
                  <c:v>0.88138764881449339</c:v>
                </c:pt>
                <c:pt idx="431">
                  <c:v>0.88079690642252662</c:v>
                </c:pt>
                <c:pt idx="432">
                  <c:v>0.88079690642252662</c:v>
                </c:pt>
                <c:pt idx="433">
                  <c:v>0.88020616403055985</c:v>
                </c:pt>
                <c:pt idx="434">
                  <c:v>0.88020616403055985</c:v>
                </c:pt>
                <c:pt idx="435">
                  <c:v>0.87961542163859308</c:v>
                </c:pt>
                <c:pt idx="436">
                  <c:v>0.87961542163859308</c:v>
                </c:pt>
                <c:pt idx="437">
                  <c:v>0.87843393685465943</c:v>
                </c:pt>
                <c:pt idx="438">
                  <c:v>0.87843393685465943</c:v>
                </c:pt>
                <c:pt idx="439">
                  <c:v>0.87784279692407086</c:v>
                </c:pt>
                <c:pt idx="440">
                  <c:v>0.87784279692407086</c:v>
                </c:pt>
                <c:pt idx="441">
                  <c:v>0.87725165699348229</c:v>
                </c:pt>
                <c:pt idx="442">
                  <c:v>0.87725165699348229</c:v>
                </c:pt>
                <c:pt idx="443">
                  <c:v>0.87666051706289372</c:v>
                </c:pt>
                <c:pt idx="444">
                  <c:v>0.87666051706289372</c:v>
                </c:pt>
                <c:pt idx="445">
                  <c:v>0.87666051706289372</c:v>
                </c:pt>
                <c:pt idx="446">
                  <c:v>0.87606897825245988</c:v>
                </c:pt>
                <c:pt idx="447">
                  <c:v>0.87606897825245988</c:v>
                </c:pt>
                <c:pt idx="448">
                  <c:v>0.87547743944202605</c:v>
                </c:pt>
                <c:pt idx="449">
                  <c:v>0.87547743944202605</c:v>
                </c:pt>
                <c:pt idx="450">
                  <c:v>0.87488590063159222</c:v>
                </c:pt>
                <c:pt idx="451">
                  <c:v>0.87488590063159222</c:v>
                </c:pt>
                <c:pt idx="452">
                  <c:v>0.87488590063159222</c:v>
                </c:pt>
                <c:pt idx="453">
                  <c:v>0.87429396159192263</c:v>
                </c:pt>
                <c:pt idx="454">
                  <c:v>0.87429396159192263</c:v>
                </c:pt>
                <c:pt idx="455">
                  <c:v>0.87370202255225304</c:v>
                </c:pt>
                <c:pt idx="456">
                  <c:v>0.87370202255225304</c:v>
                </c:pt>
                <c:pt idx="457">
                  <c:v>0.87311008351258346</c:v>
                </c:pt>
                <c:pt idx="458">
                  <c:v>0.87311008351258346</c:v>
                </c:pt>
                <c:pt idx="459">
                  <c:v>0.87251814447291387</c:v>
                </c:pt>
                <c:pt idx="460">
                  <c:v>0.87251814447291387</c:v>
                </c:pt>
                <c:pt idx="461">
                  <c:v>0.87192580357374694</c:v>
                </c:pt>
                <c:pt idx="462">
                  <c:v>0.87192580357374694</c:v>
                </c:pt>
                <c:pt idx="463">
                  <c:v>0.87133346267458001</c:v>
                </c:pt>
                <c:pt idx="464">
                  <c:v>0.87133346267458001</c:v>
                </c:pt>
                <c:pt idx="465">
                  <c:v>0.87014878087624614</c:v>
                </c:pt>
                <c:pt idx="466">
                  <c:v>0.87014878087624614</c:v>
                </c:pt>
                <c:pt idx="467">
                  <c:v>0.86896409907791228</c:v>
                </c:pt>
                <c:pt idx="468">
                  <c:v>0.86896409907791228</c:v>
                </c:pt>
                <c:pt idx="469">
                  <c:v>0.86837175817874535</c:v>
                </c:pt>
                <c:pt idx="470">
                  <c:v>0.86837175817874535</c:v>
                </c:pt>
                <c:pt idx="471">
                  <c:v>0.86777941727957841</c:v>
                </c:pt>
                <c:pt idx="472">
                  <c:v>0.86777941727957841</c:v>
                </c:pt>
                <c:pt idx="473">
                  <c:v>0.86777941727957841</c:v>
                </c:pt>
                <c:pt idx="474">
                  <c:v>0.8671866717759722</c:v>
                </c:pt>
                <c:pt idx="475">
                  <c:v>0.8671866717759722</c:v>
                </c:pt>
                <c:pt idx="476">
                  <c:v>0.8671866717759722</c:v>
                </c:pt>
                <c:pt idx="477">
                  <c:v>0.86659352083768493</c:v>
                </c:pt>
                <c:pt idx="478">
                  <c:v>0.86659352083768493</c:v>
                </c:pt>
                <c:pt idx="479">
                  <c:v>0.86600036989939766</c:v>
                </c:pt>
                <c:pt idx="480">
                  <c:v>0.86600036989939766</c:v>
                </c:pt>
                <c:pt idx="481">
                  <c:v>0.86540721896111039</c:v>
                </c:pt>
                <c:pt idx="482">
                  <c:v>0.86540721896111039</c:v>
                </c:pt>
                <c:pt idx="483">
                  <c:v>0.86481406802282312</c:v>
                </c:pt>
                <c:pt idx="484">
                  <c:v>0.86481406802282312</c:v>
                </c:pt>
                <c:pt idx="485">
                  <c:v>0.86362776614624859</c:v>
                </c:pt>
                <c:pt idx="486">
                  <c:v>0.86362776614624859</c:v>
                </c:pt>
                <c:pt idx="487">
                  <c:v>0.86303461520796132</c:v>
                </c:pt>
                <c:pt idx="488">
                  <c:v>0.86303461520796132</c:v>
                </c:pt>
                <c:pt idx="489">
                  <c:v>0.86244146426967405</c:v>
                </c:pt>
                <c:pt idx="490">
                  <c:v>0.86244146426967405</c:v>
                </c:pt>
                <c:pt idx="491">
                  <c:v>0.86184831333138678</c:v>
                </c:pt>
                <c:pt idx="492">
                  <c:v>0.86184831333138678</c:v>
                </c:pt>
                <c:pt idx="493">
                  <c:v>0.86006886051652498</c:v>
                </c:pt>
                <c:pt idx="494">
                  <c:v>0.86006886051652498</c:v>
                </c:pt>
                <c:pt idx="495">
                  <c:v>0.85947570957823771</c:v>
                </c:pt>
                <c:pt idx="496">
                  <c:v>0.85947570957823771</c:v>
                </c:pt>
                <c:pt idx="497">
                  <c:v>0.85888255863995044</c:v>
                </c:pt>
                <c:pt idx="498">
                  <c:v>0.85888255863995044</c:v>
                </c:pt>
                <c:pt idx="499">
                  <c:v>0.85769625676337591</c:v>
                </c:pt>
                <c:pt idx="500">
                  <c:v>0.85769625676337591</c:v>
                </c:pt>
                <c:pt idx="501">
                  <c:v>0.85769625676337591</c:v>
                </c:pt>
                <c:pt idx="502">
                  <c:v>0.85769625676337591</c:v>
                </c:pt>
                <c:pt idx="503">
                  <c:v>0.85710228428639301</c:v>
                </c:pt>
                <c:pt idx="504">
                  <c:v>0.85710228428639301</c:v>
                </c:pt>
                <c:pt idx="505">
                  <c:v>0.85650831180941012</c:v>
                </c:pt>
                <c:pt idx="506">
                  <c:v>0.85650831180941012</c:v>
                </c:pt>
                <c:pt idx="507">
                  <c:v>0.85532036685544421</c:v>
                </c:pt>
                <c:pt idx="508">
                  <c:v>0.85532036685544421</c:v>
                </c:pt>
                <c:pt idx="509">
                  <c:v>0.85532036685544421</c:v>
                </c:pt>
                <c:pt idx="510">
                  <c:v>0.85472598161093039</c:v>
                </c:pt>
                <c:pt idx="511">
                  <c:v>0.85472598161093039</c:v>
                </c:pt>
                <c:pt idx="512">
                  <c:v>0.85413159636641656</c:v>
                </c:pt>
                <c:pt idx="513">
                  <c:v>0.85413159636641656</c:v>
                </c:pt>
                <c:pt idx="514">
                  <c:v>0.85353721112190273</c:v>
                </c:pt>
                <c:pt idx="515">
                  <c:v>0.85353721112190273</c:v>
                </c:pt>
                <c:pt idx="516">
                  <c:v>0.8529428258773889</c:v>
                </c:pt>
                <c:pt idx="517">
                  <c:v>0.8529428258773889</c:v>
                </c:pt>
                <c:pt idx="518">
                  <c:v>0.85234844063287507</c:v>
                </c:pt>
                <c:pt idx="519">
                  <c:v>0.85234844063287507</c:v>
                </c:pt>
                <c:pt idx="520">
                  <c:v>0.85175405538836124</c:v>
                </c:pt>
                <c:pt idx="521">
                  <c:v>0.85175405538836124</c:v>
                </c:pt>
                <c:pt idx="522">
                  <c:v>0.85175405538836124</c:v>
                </c:pt>
                <c:pt idx="523">
                  <c:v>0.85115925507035262</c:v>
                </c:pt>
                <c:pt idx="524">
                  <c:v>0.85115925507035262</c:v>
                </c:pt>
                <c:pt idx="525">
                  <c:v>0.85115925507035262</c:v>
                </c:pt>
                <c:pt idx="526">
                  <c:v>0.85056403880806564</c:v>
                </c:pt>
                <c:pt idx="527">
                  <c:v>0.85056403880806564</c:v>
                </c:pt>
                <c:pt idx="528">
                  <c:v>0.84996882254577866</c:v>
                </c:pt>
                <c:pt idx="529">
                  <c:v>0.84996882254577866</c:v>
                </c:pt>
                <c:pt idx="530">
                  <c:v>0.84996882254577866</c:v>
                </c:pt>
                <c:pt idx="531">
                  <c:v>0.84877755580079506</c:v>
                </c:pt>
                <c:pt idx="532">
                  <c:v>0.84877755580079506</c:v>
                </c:pt>
                <c:pt idx="533">
                  <c:v>0.84818192242830326</c:v>
                </c:pt>
                <c:pt idx="534">
                  <c:v>0.84818192242830326</c:v>
                </c:pt>
                <c:pt idx="535">
                  <c:v>0.84699065568331966</c:v>
                </c:pt>
                <c:pt idx="536">
                  <c:v>0.84699065568331966</c:v>
                </c:pt>
                <c:pt idx="537">
                  <c:v>0.84639502231082786</c:v>
                </c:pt>
                <c:pt idx="538">
                  <c:v>0.84639502231082786</c:v>
                </c:pt>
                <c:pt idx="539">
                  <c:v>0.84639502231082786</c:v>
                </c:pt>
                <c:pt idx="540">
                  <c:v>0.84520291664560132</c:v>
                </c:pt>
                <c:pt idx="541">
                  <c:v>0.84520291664560132</c:v>
                </c:pt>
                <c:pt idx="542">
                  <c:v>0.84460686381298811</c:v>
                </c:pt>
                <c:pt idx="543">
                  <c:v>0.84460686381298811</c:v>
                </c:pt>
                <c:pt idx="544">
                  <c:v>0.84401081098037489</c:v>
                </c:pt>
                <c:pt idx="545">
                  <c:v>0.84401081098037489</c:v>
                </c:pt>
                <c:pt idx="546">
                  <c:v>0.84341475814776168</c:v>
                </c:pt>
                <c:pt idx="547">
                  <c:v>0.84341475814776168</c:v>
                </c:pt>
                <c:pt idx="548">
                  <c:v>0.84281870531514846</c:v>
                </c:pt>
                <c:pt idx="549">
                  <c:v>0.84281870531514846</c:v>
                </c:pt>
                <c:pt idx="550">
                  <c:v>0.84222265248253525</c:v>
                </c:pt>
                <c:pt idx="551">
                  <c:v>0.84222265248253525</c:v>
                </c:pt>
                <c:pt idx="552">
                  <c:v>0.84103054681730871</c:v>
                </c:pt>
                <c:pt idx="553">
                  <c:v>0.84103054681730871</c:v>
                </c:pt>
                <c:pt idx="554">
                  <c:v>0.8404344939846955</c:v>
                </c:pt>
                <c:pt idx="555">
                  <c:v>0.8404344939846955</c:v>
                </c:pt>
                <c:pt idx="556">
                  <c:v>0.83983844115208228</c:v>
                </c:pt>
                <c:pt idx="557">
                  <c:v>0.83983844115208228</c:v>
                </c:pt>
                <c:pt idx="558">
                  <c:v>0.83924238831946907</c:v>
                </c:pt>
                <c:pt idx="559">
                  <c:v>0.83924238831946907</c:v>
                </c:pt>
                <c:pt idx="560">
                  <c:v>0.83864633548685585</c:v>
                </c:pt>
                <c:pt idx="561">
                  <c:v>0.83864633548685585</c:v>
                </c:pt>
                <c:pt idx="562">
                  <c:v>0.83864633548685585</c:v>
                </c:pt>
                <c:pt idx="563">
                  <c:v>0.83804985871908422</c:v>
                </c:pt>
                <c:pt idx="564">
                  <c:v>0.83804985871908422</c:v>
                </c:pt>
                <c:pt idx="565">
                  <c:v>0.83685690518354106</c:v>
                </c:pt>
                <c:pt idx="566">
                  <c:v>0.83685690518354106</c:v>
                </c:pt>
                <c:pt idx="567">
                  <c:v>0.83626042841576942</c:v>
                </c:pt>
                <c:pt idx="568">
                  <c:v>0.83626042841576942</c:v>
                </c:pt>
                <c:pt idx="569">
                  <c:v>0.83446972086027527</c:v>
                </c:pt>
                <c:pt idx="570">
                  <c:v>0.83446972086027527</c:v>
                </c:pt>
                <c:pt idx="571">
                  <c:v>0.83387281834177718</c:v>
                </c:pt>
                <c:pt idx="572">
                  <c:v>0.83387281834177718</c:v>
                </c:pt>
                <c:pt idx="573">
                  <c:v>0.83327591582327909</c:v>
                </c:pt>
                <c:pt idx="574">
                  <c:v>0.83327591582327909</c:v>
                </c:pt>
                <c:pt idx="575">
                  <c:v>0.832679013304781</c:v>
                </c:pt>
                <c:pt idx="576">
                  <c:v>0.832679013304781</c:v>
                </c:pt>
                <c:pt idx="577">
                  <c:v>0.83208211078628291</c:v>
                </c:pt>
                <c:pt idx="578">
                  <c:v>0.83208211078628291</c:v>
                </c:pt>
                <c:pt idx="579">
                  <c:v>0.83148477976633584</c:v>
                </c:pt>
                <c:pt idx="580">
                  <c:v>0.83148477976633584</c:v>
                </c:pt>
                <c:pt idx="581">
                  <c:v>0.83148477976633584</c:v>
                </c:pt>
                <c:pt idx="582">
                  <c:v>0.83088701932078135</c:v>
                </c:pt>
                <c:pt idx="583">
                  <c:v>0.83088701932078135</c:v>
                </c:pt>
                <c:pt idx="584">
                  <c:v>0.82969149842967227</c:v>
                </c:pt>
                <c:pt idx="585">
                  <c:v>0.82969149842967227</c:v>
                </c:pt>
                <c:pt idx="586">
                  <c:v>0.82909373798411778</c:v>
                </c:pt>
                <c:pt idx="587">
                  <c:v>0.82909373798411778</c:v>
                </c:pt>
                <c:pt idx="588">
                  <c:v>0.8284959775385633</c:v>
                </c:pt>
                <c:pt idx="589">
                  <c:v>0.8284959775385633</c:v>
                </c:pt>
                <c:pt idx="590">
                  <c:v>0.8278977854970192</c:v>
                </c:pt>
                <c:pt idx="591">
                  <c:v>0.8278977854970192</c:v>
                </c:pt>
                <c:pt idx="592">
                  <c:v>0.8278977854970192</c:v>
                </c:pt>
                <c:pt idx="593">
                  <c:v>0.82729916092326861</c:v>
                </c:pt>
                <c:pt idx="594">
                  <c:v>0.82729916092326861</c:v>
                </c:pt>
                <c:pt idx="595">
                  <c:v>0.82729916092326861</c:v>
                </c:pt>
                <c:pt idx="596">
                  <c:v>0.82610104483214153</c:v>
                </c:pt>
                <c:pt idx="597">
                  <c:v>0.82610104483214153</c:v>
                </c:pt>
                <c:pt idx="598">
                  <c:v>0.82550198678657793</c:v>
                </c:pt>
                <c:pt idx="599">
                  <c:v>0.82550198678657793</c:v>
                </c:pt>
                <c:pt idx="600">
                  <c:v>0.82490292874101434</c:v>
                </c:pt>
                <c:pt idx="601">
                  <c:v>0.82490292874101434</c:v>
                </c:pt>
                <c:pt idx="602">
                  <c:v>0.82430387069545075</c:v>
                </c:pt>
                <c:pt idx="603">
                  <c:v>0.82430387069545075</c:v>
                </c:pt>
                <c:pt idx="604">
                  <c:v>0.82310575460432367</c:v>
                </c:pt>
                <c:pt idx="605">
                  <c:v>0.82310575460432367</c:v>
                </c:pt>
                <c:pt idx="606">
                  <c:v>0.82250669655876008</c:v>
                </c:pt>
                <c:pt idx="607">
                  <c:v>0.82250669655876008</c:v>
                </c:pt>
                <c:pt idx="608">
                  <c:v>0.82250669655876008</c:v>
                </c:pt>
                <c:pt idx="609">
                  <c:v>0.82130770720517587</c:v>
                </c:pt>
                <c:pt idx="610">
                  <c:v>0.82130770720517587</c:v>
                </c:pt>
                <c:pt idx="611">
                  <c:v>0.82130770720517587</c:v>
                </c:pt>
                <c:pt idx="612">
                  <c:v>0.82070777462138833</c:v>
                </c:pt>
                <c:pt idx="613">
                  <c:v>0.82070777462138833</c:v>
                </c:pt>
                <c:pt idx="614">
                  <c:v>0.82010784203760079</c:v>
                </c:pt>
                <c:pt idx="615">
                  <c:v>0.82010784203760079</c:v>
                </c:pt>
                <c:pt idx="616">
                  <c:v>0.81950790945381324</c:v>
                </c:pt>
                <c:pt idx="617">
                  <c:v>0.81950790945381324</c:v>
                </c:pt>
                <c:pt idx="618">
                  <c:v>0.81830804428623816</c:v>
                </c:pt>
                <c:pt idx="619">
                  <c:v>0.81830804428623816</c:v>
                </c:pt>
                <c:pt idx="620">
                  <c:v>0.81830804428623816</c:v>
                </c:pt>
                <c:pt idx="621">
                  <c:v>0.81770767154648305</c:v>
                </c:pt>
                <c:pt idx="622">
                  <c:v>0.81770767154648305</c:v>
                </c:pt>
                <c:pt idx="623">
                  <c:v>0.81710685768054148</c:v>
                </c:pt>
                <c:pt idx="624">
                  <c:v>0.81710685768054148</c:v>
                </c:pt>
                <c:pt idx="625">
                  <c:v>0.8165060438145999</c:v>
                </c:pt>
                <c:pt idx="626">
                  <c:v>0.8165060438145999</c:v>
                </c:pt>
                <c:pt idx="627">
                  <c:v>0.8165060438145999</c:v>
                </c:pt>
                <c:pt idx="628">
                  <c:v>0.81590390071444163</c:v>
                </c:pt>
                <c:pt idx="629">
                  <c:v>0.81590390071444163</c:v>
                </c:pt>
                <c:pt idx="630">
                  <c:v>0.81530175761428336</c:v>
                </c:pt>
                <c:pt idx="631">
                  <c:v>0.81530175761428336</c:v>
                </c:pt>
                <c:pt idx="632">
                  <c:v>0.81469961451412509</c:v>
                </c:pt>
                <c:pt idx="633">
                  <c:v>0.81469961451412509</c:v>
                </c:pt>
                <c:pt idx="634">
                  <c:v>0.81409747141396682</c:v>
                </c:pt>
                <c:pt idx="635">
                  <c:v>0.81409747141396682</c:v>
                </c:pt>
                <c:pt idx="636">
                  <c:v>0.81409747141396682</c:v>
                </c:pt>
                <c:pt idx="637">
                  <c:v>0.81349443624995643</c:v>
                </c:pt>
                <c:pt idx="638">
                  <c:v>0.81349443624995643</c:v>
                </c:pt>
                <c:pt idx="639">
                  <c:v>0.81289140108594604</c:v>
                </c:pt>
                <c:pt idx="640">
                  <c:v>0.81289140108594604</c:v>
                </c:pt>
                <c:pt idx="641">
                  <c:v>0.81289140108594604</c:v>
                </c:pt>
                <c:pt idx="642">
                  <c:v>0.81289140108594604</c:v>
                </c:pt>
                <c:pt idx="643">
                  <c:v>0.81228746988157308</c:v>
                </c:pt>
                <c:pt idx="644">
                  <c:v>0.81228746988157308</c:v>
                </c:pt>
                <c:pt idx="645">
                  <c:v>0.81228746988157308</c:v>
                </c:pt>
                <c:pt idx="646">
                  <c:v>0.81228746988157308</c:v>
                </c:pt>
                <c:pt idx="647">
                  <c:v>0.81168263930087203</c:v>
                </c:pt>
                <c:pt idx="648">
                  <c:v>0.81168263930087203</c:v>
                </c:pt>
                <c:pt idx="649">
                  <c:v>0.81107780872017099</c:v>
                </c:pt>
                <c:pt idx="650">
                  <c:v>0.81107780872017099</c:v>
                </c:pt>
                <c:pt idx="651">
                  <c:v>0.81107780872017099</c:v>
                </c:pt>
                <c:pt idx="652">
                  <c:v>0.8104725267733649</c:v>
                </c:pt>
                <c:pt idx="653">
                  <c:v>0.8104725267733649</c:v>
                </c:pt>
                <c:pt idx="654">
                  <c:v>0.80865668093294663</c:v>
                </c:pt>
                <c:pt idx="655">
                  <c:v>0.80865668093294663</c:v>
                </c:pt>
                <c:pt idx="656">
                  <c:v>0.80805139898614053</c:v>
                </c:pt>
                <c:pt idx="657">
                  <c:v>0.80805139898614053</c:v>
                </c:pt>
                <c:pt idx="658">
                  <c:v>0.80744611703933444</c:v>
                </c:pt>
                <c:pt idx="659">
                  <c:v>0.80744611703933444</c:v>
                </c:pt>
                <c:pt idx="660">
                  <c:v>0.80744611703933444</c:v>
                </c:pt>
                <c:pt idx="661">
                  <c:v>0.80744611703933444</c:v>
                </c:pt>
                <c:pt idx="662">
                  <c:v>0.80744611703933444</c:v>
                </c:pt>
                <c:pt idx="663">
                  <c:v>0.80683947082067231</c:v>
                </c:pt>
                <c:pt idx="664">
                  <c:v>0.80683947082067231</c:v>
                </c:pt>
                <c:pt idx="665">
                  <c:v>0.80683947082067231</c:v>
                </c:pt>
                <c:pt idx="666">
                  <c:v>0.80683947082067231</c:v>
                </c:pt>
                <c:pt idx="667">
                  <c:v>0.80623145313354294</c:v>
                </c:pt>
                <c:pt idx="668">
                  <c:v>0.80623145313354294</c:v>
                </c:pt>
                <c:pt idx="669">
                  <c:v>0.8050154177592842</c:v>
                </c:pt>
                <c:pt idx="670">
                  <c:v>0.8050154177592842</c:v>
                </c:pt>
                <c:pt idx="671">
                  <c:v>0.80379846323508275</c:v>
                </c:pt>
                <c:pt idx="672">
                  <c:v>0.80379846323508275</c:v>
                </c:pt>
                <c:pt idx="673">
                  <c:v>0.80318998597298197</c:v>
                </c:pt>
                <c:pt idx="674">
                  <c:v>0.80318998597298197</c:v>
                </c:pt>
                <c:pt idx="675">
                  <c:v>0.80258150871088119</c:v>
                </c:pt>
                <c:pt idx="676">
                  <c:v>0.80258150871088119</c:v>
                </c:pt>
                <c:pt idx="677">
                  <c:v>0.8019730314487804</c:v>
                </c:pt>
                <c:pt idx="678">
                  <c:v>0.8019730314487804</c:v>
                </c:pt>
                <c:pt idx="679">
                  <c:v>0.80136455418667962</c:v>
                </c:pt>
                <c:pt idx="680">
                  <c:v>0.80136455418667962</c:v>
                </c:pt>
                <c:pt idx="681">
                  <c:v>0.80136455418667962</c:v>
                </c:pt>
                <c:pt idx="682">
                  <c:v>0.80136455418667962</c:v>
                </c:pt>
                <c:pt idx="683">
                  <c:v>0.8007551514838761</c:v>
                </c:pt>
                <c:pt idx="684">
                  <c:v>0.8007551514838761</c:v>
                </c:pt>
                <c:pt idx="685">
                  <c:v>0.80014574878107259</c:v>
                </c:pt>
                <c:pt idx="686">
                  <c:v>0.80014574878107259</c:v>
                </c:pt>
                <c:pt idx="687">
                  <c:v>0.79953634607826907</c:v>
                </c:pt>
                <c:pt idx="688">
                  <c:v>0.79953634607826907</c:v>
                </c:pt>
                <c:pt idx="689">
                  <c:v>0.79953634607826907</c:v>
                </c:pt>
                <c:pt idx="690">
                  <c:v>0.79892601298965971</c:v>
                </c:pt>
                <c:pt idx="691">
                  <c:v>0.79892601298965971</c:v>
                </c:pt>
                <c:pt idx="692">
                  <c:v>0.79831567990105035</c:v>
                </c:pt>
                <c:pt idx="693">
                  <c:v>0.79831567990105035</c:v>
                </c:pt>
                <c:pt idx="694">
                  <c:v>0.79831567990105035</c:v>
                </c:pt>
                <c:pt idx="695">
                  <c:v>0.79831567990105035</c:v>
                </c:pt>
                <c:pt idx="696">
                  <c:v>0.79831567990105035</c:v>
                </c:pt>
                <c:pt idx="697">
                  <c:v>0.79770394374786946</c:v>
                </c:pt>
                <c:pt idx="698">
                  <c:v>0.79770394374786946</c:v>
                </c:pt>
                <c:pt idx="699">
                  <c:v>0.79709220759468857</c:v>
                </c:pt>
                <c:pt idx="700">
                  <c:v>0.79709220759468857</c:v>
                </c:pt>
                <c:pt idx="701">
                  <c:v>0.79709220759468857</c:v>
                </c:pt>
                <c:pt idx="702">
                  <c:v>0.79648000159807208</c:v>
                </c:pt>
                <c:pt idx="703">
                  <c:v>0.79648000159807208</c:v>
                </c:pt>
                <c:pt idx="704">
                  <c:v>0.79648000159807208</c:v>
                </c:pt>
                <c:pt idx="705">
                  <c:v>0.79586732467376586</c:v>
                </c:pt>
                <c:pt idx="706">
                  <c:v>0.79586732467376586</c:v>
                </c:pt>
                <c:pt idx="707">
                  <c:v>0.79525464774945964</c:v>
                </c:pt>
                <c:pt idx="708">
                  <c:v>0.79525464774945964</c:v>
                </c:pt>
                <c:pt idx="709">
                  <c:v>0.79464197082515342</c:v>
                </c:pt>
                <c:pt idx="710">
                  <c:v>0.79464197082515342</c:v>
                </c:pt>
                <c:pt idx="711">
                  <c:v>0.7940292939008472</c:v>
                </c:pt>
                <c:pt idx="712">
                  <c:v>0.7940292939008472</c:v>
                </c:pt>
                <c:pt idx="713">
                  <c:v>0.79280394005223476</c:v>
                </c:pt>
                <c:pt idx="714">
                  <c:v>0.79280394005223476</c:v>
                </c:pt>
                <c:pt idx="715">
                  <c:v>0.79280394005223476</c:v>
                </c:pt>
                <c:pt idx="716">
                  <c:v>0.79219031471163703</c:v>
                </c:pt>
                <c:pt idx="717">
                  <c:v>0.79219031471163703</c:v>
                </c:pt>
                <c:pt idx="718">
                  <c:v>0.79096306403044159</c:v>
                </c:pt>
                <c:pt idx="719">
                  <c:v>0.79096306403044159</c:v>
                </c:pt>
                <c:pt idx="720">
                  <c:v>0.79034943868984386</c:v>
                </c:pt>
                <c:pt idx="721">
                  <c:v>0.79034943868984386</c:v>
                </c:pt>
                <c:pt idx="722">
                  <c:v>0.78973581334924614</c:v>
                </c:pt>
                <c:pt idx="723">
                  <c:v>0.78973581334924614</c:v>
                </c:pt>
                <c:pt idx="724">
                  <c:v>0.78912218800864842</c:v>
                </c:pt>
                <c:pt idx="725">
                  <c:v>0.78912218800864842</c:v>
                </c:pt>
                <c:pt idx="726">
                  <c:v>0.78912218800864842</c:v>
                </c:pt>
                <c:pt idx="727">
                  <c:v>0.78850760686533949</c:v>
                </c:pt>
                <c:pt idx="728">
                  <c:v>0.78850760686533949</c:v>
                </c:pt>
                <c:pt idx="729">
                  <c:v>0.78789302572203057</c:v>
                </c:pt>
                <c:pt idx="730">
                  <c:v>0.78789302572203057</c:v>
                </c:pt>
                <c:pt idx="731">
                  <c:v>0.78789302572203057</c:v>
                </c:pt>
                <c:pt idx="732">
                  <c:v>0.78789302572203057</c:v>
                </c:pt>
                <c:pt idx="733">
                  <c:v>0.78789302572203057</c:v>
                </c:pt>
                <c:pt idx="734">
                  <c:v>0.78727652100706813</c:v>
                </c:pt>
                <c:pt idx="735">
                  <c:v>0.78727652100706813</c:v>
                </c:pt>
                <c:pt idx="736">
                  <c:v>0.78666001629210569</c:v>
                </c:pt>
                <c:pt idx="737">
                  <c:v>0.78666001629210569</c:v>
                </c:pt>
                <c:pt idx="738">
                  <c:v>0.78666001629210569</c:v>
                </c:pt>
                <c:pt idx="739">
                  <c:v>0.78666001629210569</c:v>
                </c:pt>
                <c:pt idx="740">
                  <c:v>0.78604254375184501</c:v>
                </c:pt>
                <c:pt idx="741">
                  <c:v>0.78604254375184501</c:v>
                </c:pt>
                <c:pt idx="742">
                  <c:v>0.78604254375184501</c:v>
                </c:pt>
                <c:pt idx="743">
                  <c:v>0.78604254375184501</c:v>
                </c:pt>
                <c:pt idx="744">
                  <c:v>0.78604254375184501</c:v>
                </c:pt>
                <c:pt idx="745">
                  <c:v>0.78480468147822002</c:v>
                </c:pt>
                <c:pt idx="746">
                  <c:v>0.78480468147822002</c:v>
                </c:pt>
                <c:pt idx="747">
                  <c:v>0.78418575034140758</c:v>
                </c:pt>
                <c:pt idx="748">
                  <c:v>0.78418575034140758</c:v>
                </c:pt>
                <c:pt idx="749">
                  <c:v>0.78356681920459514</c:v>
                </c:pt>
                <c:pt idx="750">
                  <c:v>0.78356681920459514</c:v>
                </c:pt>
                <c:pt idx="751">
                  <c:v>0.78356681920459514</c:v>
                </c:pt>
                <c:pt idx="752">
                  <c:v>0.78294739879415676</c:v>
                </c:pt>
                <c:pt idx="753">
                  <c:v>0.78294739879415676</c:v>
                </c:pt>
                <c:pt idx="754">
                  <c:v>0.78232797838371837</c:v>
                </c:pt>
                <c:pt idx="755">
                  <c:v>0.78232797838371837</c:v>
                </c:pt>
                <c:pt idx="756">
                  <c:v>0.78232797838371837</c:v>
                </c:pt>
                <c:pt idx="757">
                  <c:v>0.78170806714886598</c:v>
                </c:pt>
                <c:pt idx="758">
                  <c:v>0.78170806714886598</c:v>
                </c:pt>
                <c:pt idx="759">
                  <c:v>0.78170806714886598</c:v>
                </c:pt>
                <c:pt idx="760">
                  <c:v>0.78108717114636494</c:v>
                </c:pt>
                <c:pt idx="761">
                  <c:v>0.78108717114636494</c:v>
                </c:pt>
                <c:pt idx="762">
                  <c:v>0.78046578119318566</c:v>
                </c:pt>
                <c:pt idx="763">
                  <c:v>0.78046578119318566</c:v>
                </c:pt>
                <c:pt idx="764">
                  <c:v>0.78046578119318566</c:v>
                </c:pt>
                <c:pt idx="765">
                  <c:v>0.78046578119318566</c:v>
                </c:pt>
                <c:pt idx="766">
                  <c:v>0.77984340018744946</c:v>
                </c:pt>
                <c:pt idx="767">
                  <c:v>0.77984340018744946</c:v>
                </c:pt>
                <c:pt idx="768">
                  <c:v>0.77984340018744946</c:v>
                </c:pt>
                <c:pt idx="769">
                  <c:v>0.77922052207228376</c:v>
                </c:pt>
                <c:pt idx="770">
                  <c:v>0.77922052207228376</c:v>
                </c:pt>
                <c:pt idx="771">
                  <c:v>0.77859764395711806</c:v>
                </c:pt>
                <c:pt idx="772">
                  <c:v>0.77859764395711806</c:v>
                </c:pt>
                <c:pt idx="773">
                  <c:v>0.77859764395711806</c:v>
                </c:pt>
                <c:pt idx="774">
                  <c:v>0.77797426714049911</c:v>
                </c:pt>
                <c:pt idx="775">
                  <c:v>0.77797426714049911</c:v>
                </c:pt>
                <c:pt idx="776">
                  <c:v>0.77735039042266385</c:v>
                </c:pt>
                <c:pt idx="777">
                  <c:v>0.77735039042266385</c:v>
                </c:pt>
                <c:pt idx="778">
                  <c:v>0.77672601259903118</c:v>
                </c:pt>
                <c:pt idx="779">
                  <c:v>0.77672601259903118</c:v>
                </c:pt>
                <c:pt idx="780">
                  <c:v>0.77610163477539851</c:v>
                </c:pt>
                <c:pt idx="781">
                  <c:v>0.77610163477539851</c:v>
                </c:pt>
                <c:pt idx="782">
                  <c:v>0.77547725695176584</c:v>
                </c:pt>
                <c:pt idx="783">
                  <c:v>0.77547725695176584</c:v>
                </c:pt>
                <c:pt idx="784">
                  <c:v>0.77547725695176584</c:v>
                </c:pt>
                <c:pt idx="785">
                  <c:v>0.77422648718248877</c:v>
                </c:pt>
                <c:pt idx="786">
                  <c:v>0.77422648718248877</c:v>
                </c:pt>
                <c:pt idx="787">
                  <c:v>0.77360110229785028</c:v>
                </c:pt>
                <c:pt idx="788">
                  <c:v>0.77360110229785028</c:v>
                </c:pt>
                <c:pt idx="789">
                  <c:v>0.77360110229785028</c:v>
                </c:pt>
                <c:pt idx="790">
                  <c:v>0.77297521143838599</c:v>
                </c:pt>
                <c:pt idx="791">
                  <c:v>0.77297521143838599</c:v>
                </c:pt>
                <c:pt idx="792">
                  <c:v>0.77297521143838599</c:v>
                </c:pt>
                <c:pt idx="793">
                  <c:v>0.77234881337401129</c:v>
                </c:pt>
                <c:pt idx="794">
                  <c:v>0.77234881337401129</c:v>
                </c:pt>
                <c:pt idx="795">
                  <c:v>0.77234881337401129</c:v>
                </c:pt>
                <c:pt idx="796">
                  <c:v>0.77172190686964925</c:v>
                </c:pt>
                <c:pt idx="797">
                  <c:v>0.77172190686964925</c:v>
                </c:pt>
                <c:pt idx="798">
                  <c:v>0.77109500036528722</c:v>
                </c:pt>
                <c:pt idx="799">
                  <c:v>0.77109500036528722</c:v>
                </c:pt>
                <c:pt idx="800">
                  <c:v>0.77109500036528722</c:v>
                </c:pt>
                <c:pt idx="801">
                  <c:v>0.76984016716697101</c:v>
                </c:pt>
                <c:pt idx="802">
                  <c:v>0.76984016716697101</c:v>
                </c:pt>
                <c:pt idx="803">
                  <c:v>0.76984016716697101</c:v>
                </c:pt>
                <c:pt idx="804">
                  <c:v>0.76921223880875977</c:v>
                </c:pt>
                <c:pt idx="805">
                  <c:v>0.76921223880875977</c:v>
                </c:pt>
                <c:pt idx="806">
                  <c:v>0.76921223880875977</c:v>
                </c:pt>
                <c:pt idx="807">
                  <c:v>0.76921223880875977</c:v>
                </c:pt>
                <c:pt idx="808">
                  <c:v>0.76921223880875977</c:v>
                </c:pt>
                <c:pt idx="809">
                  <c:v>0.76858276889156762</c:v>
                </c:pt>
                <c:pt idx="810">
                  <c:v>0.76858276889156762</c:v>
                </c:pt>
                <c:pt idx="811">
                  <c:v>0.76795329897437548</c:v>
                </c:pt>
                <c:pt idx="812">
                  <c:v>0.76795329897437548</c:v>
                </c:pt>
                <c:pt idx="813">
                  <c:v>0.76795329897437548</c:v>
                </c:pt>
                <c:pt idx="814">
                  <c:v>0.76732331267497078</c:v>
                </c:pt>
                <c:pt idx="815">
                  <c:v>0.76732331267497078</c:v>
                </c:pt>
                <c:pt idx="816">
                  <c:v>0.76669332637556609</c:v>
                </c:pt>
                <c:pt idx="817">
                  <c:v>0.76669332637556609</c:v>
                </c:pt>
                <c:pt idx="818">
                  <c:v>0.76606282199532305</c:v>
                </c:pt>
                <c:pt idx="819">
                  <c:v>0.76606282199532305</c:v>
                </c:pt>
                <c:pt idx="820">
                  <c:v>0.76606282199532305</c:v>
                </c:pt>
                <c:pt idx="821">
                  <c:v>0.765431798253976</c:v>
                </c:pt>
                <c:pt idx="822">
                  <c:v>0.765431798253976</c:v>
                </c:pt>
                <c:pt idx="823">
                  <c:v>0.765431798253976</c:v>
                </c:pt>
                <c:pt idx="824">
                  <c:v>0.765431798253976</c:v>
                </c:pt>
                <c:pt idx="825">
                  <c:v>0.765431798253976</c:v>
                </c:pt>
                <c:pt idx="826">
                  <c:v>0.76479920999095619</c:v>
                </c:pt>
                <c:pt idx="827">
                  <c:v>0.76479920999095619</c:v>
                </c:pt>
                <c:pt idx="828">
                  <c:v>0.76416609806215574</c:v>
                </c:pt>
                <c:pt idx="829">
                  <c:v>0.76416609806215574</c:v>
                </c:pt>
                <c:pt idx="830">
                  <c:v>0.76416609806215574</c:v>
                </c:pt>
                <c:pt idx="831">
                  <c:v>0.76353140861193802</c:v>
                </c:pt>
                <c:pt idx="832">
                  <c:v>0.76353140861193802</c:v>
                </c:pt>
                <c:pt idx="833">
                  <c:v>0.76353140861193802</c:v>
                </c:pt>
                <c:pt idx="834">
                  <c:v>0.76289566222674909</c:v>
                </c:pt>
                <c:pt idx="835">
                  <c:v>0.76289566222674909</c:v>
                </c:pt>
                <c:pt idx="836">
                  <c:v>0.76289566222674909</c:v>
                </c:pt>
                <c:pt idx="837">
                  <c:v>0.76289566222674909</c:v>
                </c:pt>
                <c:pt idx="838">
                  <c:v>0.76225885449534114</c:v>
                </c:pt>
                <c:pt idx="839">
                  <c:v>0.76225885449534114</c:v>
                </c:pt>
                <c:pt idx="840">
                  <c:v>0.76162204676393319</c:v>
                </c:pt>
                <c:pt idx="841">
                  <c:v>0.76162204676393319</c:v>
                </c:pt>
                <c:pt idx="842">
                  <c:v>0.76162204676393319</c:v>
                </c:pt>
                <c:pt idx="843">
                  <c:v>0.76162204676393319</c:v>
                </c:pt>
                <c:pt idx="844">
                  <c:v>0.76162204676393319</c:v>
                </c:pt>
                <c:pt idx="845">
                  <c:v>0.76098310209382924</c:v>
                </c:pt>
                <c:pt idx="846">
                  <c:v>0.76098310209382924</c:v>
                </c:pt>
                <c:pt idx="847">
                  <c:v>0.7603441574237253</c:v>
                </c:pt>
                <c:pt idx="848">
                  <c:v>0.7603441574237253</c:v>
                </c:pt>
                <c:pt idx="849">
                  <c:v>0.7603441574237253</c:v>
                </c:pt>
                <c:pt idx="850">
                  <c:v>0.7603441574237253</c:v>
                </c:pt>
                <c:pt idx="851">
                  <c:v>0.7603441574237253</c:v>
                </c:pt>
                <c:pt idx="852">
                  <c:v>0.7603441574237253</c:v>
                </c:pt>
                <c:pt idx="853">
                  <c:v>0.7603441574237253</c:v>
                </c:pt>
                <c:pt idx="854">
                  <c:v>0.75970197485833368</c:v>
                </c:pt>
                <c:pt idx="855">
                  <c:v>0.75970197485833368</c:v>
                </c:pt>
                <c:pt idx="856">
                  <c:v>0.75970197485833368</c:v>
                </c:pt>
                <c:pt idx="857">
                  <c:v>0.75970197485833368</c:v>
                </c:pt>
                <c:pt idx="858">
                  <c:v>0.75970197485833368</c:v>
                </c:pt>
                <c:pt idx="859">
                  <c:v>0.75970197485833368</c:v>
                </c:pt>
                <c:pt idx="860">
                  <c:v>0.75840996469700994</c:v>
                </c:pt>
                <c:pt idx="861">
                  <c:v>0.75840996469700994</c:v>
                </c:pt>
                <c:pt idx="862">
                  <c:v>0.75840996469700994</c:v>
                </c:pt>
                <c:pt idx="863">
                  <c:v>0.75776230460760174</c:v>
                </c:pt>
                <c:pt idx="864">
                  <c:v>0.75776230460760174</c:v>
                </c:pt>
                <c:pt idx="865">
                  <c:v>0.75776230460760174</c:v>
                </c:pt>
                <c:pt idx="866">
                  <c:v>0.75711353551119109</c:v>
                </c:pt>
                <c:pt idx="867">
                  <c:v>0.75711353551119109</c:v>
                </c:pt>
                <c:pt idx="868">
                  <c:v>0.75711353551119109</c:v>
                </c:pt>
                <c:pt idx="869">
                  <c:v>0.75711353551119109</c:v>
                </c:pt>
                <c:pt idx="870">
                  <c:v>0.75711353551119109</c:v>
                </c:pt>
                <c:pt idx="871">
                  <c:v>0.75711353551119109</c:v>
                </c:pt>
                <c:pt idx="872">
                  <c:v>0.75711353551119109</c:v>
                </c:pt>
                <c:pt idx="873">
                  <c:v>0.75711353551119109</c:v>
                </c:pt>
                <c:pt idx="874">
                  <c:v>0.75711353551119109</c:v>
                </c:pt>
                <c:pt idx="875">
                  <c:v>0.75645972416791718</c:v>
                </c:pt>
                <c:pt idx="876">
                  <c:v>0.75645972416791718</c:v>
                </c:pt>
                <c:pt idx="877">
                  <c:v>0.75645972416791718</c:v>
                </c:pt>
                <c:pt idx="878">
                  <c:v>0.75580478068378909</c:v>
                </c:pt>
                <c:pt idx="879">
                  <c:v>0.75580478068378909</c:v>
                </c:pt>
                <c:pt idx="880">
                  <c:v>0.75580478068378909</c:v>
                </c:pt>
                <c:pt idx="881">
                  <c:v>0.75580478068378909</c:v>
                </c:pt>
                <c:pt idx="882">
                  <c:v>0.75514870014500113</c:v>
                </c:pt>
                <c:pt idx="883">
                  <c:v>0.75514870014500113</c:v>
                </c:pt>
                <c:pt idx="884">
                  <c:v>0.75449261960621317</c:v>
                </c:pt>
                <c:pt idx="885">
                  <c:v>0.75449261960621317</c:v>
                </c:pt>
                <c:pt idx="886">
                  <c:v>0.75449261960621317</c:v>
                </c:pt>
                <c:pt idx="887">
                  <c:v>0.75449261960621317</c:v>
                </c:pt>
                <c:pt idx="888">
                  <c:v>0.75383539606997085</c:v>
                </c:pt>
                <c:pt idx="889">
                  <c:v>0.75383539606997085</c:v>
                </c:pt>
                <c:pt idx="890">
                  <c:v>0.7531775990402414</c:v>
                </c:pt>
                <c:pt idx="891">
                  <c:v>0.7531775990402414</c:v>
                </c:pt>
                <c:pt idx="892">
                  <c:v>0.75251980201051194</c:v>
                </c:pt>
                <c:pt idx="893">
                  <c:v>0.75251980201051194</c:v>
                </c:pt>
                <c:pt idx="894">
                  <c:v>0.75251980201051194</c:v>
                </c:pt>
                <c:pt idx="895">
                  <c:v>0.75251980201051194</c:v>
                </c:pt>
                <c:pt idx="896">
                  <c:v>0.7518608529719738</c:v>
                </c:pt>
                <c:pt idx="897">
                  <c:v>0.7518608529719738</c:v>
                </c:pt>
                <c:pt idx="898">
                  <c:v>0.75120132590796329</c:v>
                </c:pt>
                <c:pt idx="899">
                  <c:v>0.75120132590796329</c:v>
                </c:pt>
                <c:pt idx="900">
                  <c:v>0.75120132590796329</c:v>
                </c:pt>
                <c:pt idx="901">
                  <c:v>0.75120132590796329</c:v>
                </c:pt>
                <c:pt idx="902">
                  <c:v>0.75120132590796329</c:v>
                </c:pt>
                <c:pt idx="903">
                  <c:v>0.75053889087629844</c:v>
                </c:pt>
                <c:pt idx="904">
                  <c:v>0.75053889087629844</c:v>
                </c:pt>
                <c:pt idx="905">
                  <c:v>0.75053889087629844</c:v>
                </c:pt>
                <c:pt idx="906">
                  <c:v>0.75053889087629844</c:v>
                </c:pt>
                <c:pt idx="907">
                  <c:v>0.74987469716755839</c:v>
                </c:pt>
                <c:pt idx="908">
                  <c:v>0.74987469716755839</c:v>
                </c:pt>
                <c:pt idx="909">
                  <c:v>0.74987469716755839</c:v>
                </c:pt>
                <c:pt idx="910">
                  <c:v>0.74987469716755839</c:v>
                </c:pt>
                <c:pt idx="911">
                  <c:v>0.74987469716755839</c:v>
                </c:pt>
                <c:pt idx="912">
                  <c:v>0.74920873384858189</c:v>
                </c:pt>
                <c:pt idx="913">
                  <c:v>0.74920873384858189</c:v>
                </c:pt>
                <c:pt idx="914">
                  <c:v>0.74920873384858189</c:v>
                </c:pt>
                <c:pt idx="915">
                  <c:v>0.74920873384858189</c:v>
                </c:pt>
                <c:pt idx="916">
                  <c:v>0.7485415844862946</c:v>
                </c:pt>
                <c:pt idx="917">
                  <c:v>0.7485415844862946</c:v>
                </c:pt>
                <c:pt idx="918">
                  <c:v>0.74787443512400731</c:v>
                </c:pt>
                <c:pt idx="919">
                  <c:v>0.74787443512400731</c:v>
                </c:pt>
                <c:pt idx="920">
                  <c:v>0.74720728576172002</c:v>
                </c:pt>
                <c:pt idx="921">
                  <c:v>0.74720728576172002</c:v>
                </c:pt>
                <c:pt idx="922">
                  <c:v>0.74654013639943273</c:v>
                </c:pt>
                <c:pt idx="923">
                  <c:v>0.74654013639943273</c:v>
                </c:pt>
                <c:pt idx="924">
                  <c:v>0.74587239030247443</c:v>
                </c:pt>
                <c:pt idx="925">
                  <c:v>0.74587239030247443</c:v>
                </c:pt>
                <c:pt idx="926">
                  <c:v>0.74587239030247443</c:v>
                </c:pt>
                <c:pt idx="927">
                  <c:v>0.74520404586671951</c:v>
                </c:pt>
                <c:pt idx="928">
                  <c:v>0.74520404586671951</c:v>
                </c:pt>
                <c:pt idx="929">
                  <c:v>0.74453570143096459</c:v>
                </c:pt>
                <c:pt idx="930">
                  <c:v>0.74453570143096459</c:v>
                </c:pt>
                <c:pt idx="931">
                  <c:v>0.74386735699520967</c:v>
                </c:pt>
                <c:pt idx="932">
                  <c:v>0.74386735699520967</c:v>
                </c:pt>
                <c:pt idx="933">
                  <c:v>0.74386735699520967</c:v>
                </c:pt>
                <c:pt idx="934">
                  <c:v>0.74319841153028587</c:v>
                </c:pt>
                <c:pt idx="935">
                  <c:v>0.74319841153028587</c:v>
                </c:pt>
                <c:pt idx="936">
                  <c:v>0.74319841153028587</c:v>
                </c:pt>
                <c:pt idx="937">
                  <c:v>0.74319841153028587</c:v>
                </c:pt>
                <c:pt idx="938">
                  <c:v>0.7425282596713767</c:v>
                </c:pt>
                <c:pt idx="939">
                  <c:v>0.7425282596713767</c:v>
                </c:pt>
                <c:pt idx="940">
                  <c:v>0.7425282596713767</c:v>
                </c:pt>
                <c:pt idx="941">
                  <c:v>0.7425282596713767</c:v>
                </c:pt>
                <c:pt idx="942">
                  <c:v>0.7425282596713767</c:v>
                </c:pt>
                <c:pt idx="943">
                  <c:v>0.74185567972602218</c:v>
                </c:pt>
                <c:pt idx="944">
                  <c:v>0.74185567972602218</c:v>
                </c:pt>
                <c:pt idx="945">
                  <c:v>0.74185567972602218</c:v>
                </c:pt>
                <c:pt idx="946">
                  <c:v>0.74118248945403853</c:v>
                </c:pt>
                <c:pt idx="947">
                  <c:v>0.74118248945403853</c:v>
                </c:pt>
                <c:pt idx="948">
                  <c:v>0.74118248945403853</c:v>
                </c:pt>
                <c:pt idx="949">
                  <c:v>0.74118248945403853</c:v>
                </c:pt>
                <c:pt idx="950">
                  <c:v>0.74118248945403853</c:v>
                </c:pt>
                <c:pt idx="951">
                  <c:v>0.74118248945403853</c:v>
                </c:pt>
                <c:pt idx="952">
                  <c:v>0.74118248945403853</c:v>
                </c:pt>
                <c:pt idx="953">
                  <c:v>0.74118248945403853</c:v>
                </c:pt>
                <c:pt idx="954">
                  <c:v>0.74118248945403853</c:v>
                </c:pt>
                <c:pt idx="955">
                  <c:v>0.74118248945403853</c:v>
                </c:pt>
                <c:pt idx="956">
                  <c:v>0.74118248945403853</c:v>
                </c:pt>
                <c:pt idx="957">
                  <c:v>0.74118248945403853</c:v>
                </c:pt>
                <c:pt idx="958">
                  <c:v>0.74118248945403853</c:v>
                </c:pt>
                <c:pt idx="959">
                  <c:v>0.73982002164254212</c:v>
                </c:pt>
                <c:pt idx="960">
                  <c:v>0.73982002164254212</c:v>
                </c:pt>
                <c:pt idx="961">
                  <c:v>0.73982002164254212</c:v>
                </c:pt>
                <c:pt idx="962">
                  <c:v>0.73982002164254212</c:v>
                </c:pt>
                <c:pt idx="963">
                  <c:v>0.73982002164254212</c:v>
                </c:pt>
                <c:pt idx="964">
                  <c:v>0.73845125194477612</c:v>
                </c:pt>
                <c:pt idx="965">
                  <c:v>0.73845125194477612</c:v>
                </c:pt>
                <c:pt idx="966">
                  <c:v>0.73776686709589312</c:v>
                </c:pt>
                <c:pt idx="967">
                  <c:v>0.73776686709589312</c:v>
                </c:pt>
                <c:pt idx="968">
                  <c:v>0.73708248224701012</c:v>
                </c:pt>
                <c:pt idx="969">
                  <c:v>0.73708248224701012</c:v>
                </c:pt>
                <c:pt idx="970">
                  <c:v>0.73639809739812712</c:v>
                </c:pt>
                <c:pt idx="971">
                  <c:v>0.73639809739812712</c:v>
                </c:pt>
                <c:pt idx="972">
                  <c:v>0.73571371254924411</c:v>
                </c:pt>
                <c:pt idx="973">
                  <c:v>0.73571371254924411</c:v>
                </c:pt>
                <c:pt idx="974">
                  <c:v>0.73571371254924411</c:v>
                </c:pt>
                <c:pt idx="975">
                  <c:v>0.73571371254924411</c:v>
                </c:pt>
                <c:pt idx="976">
                  <c:v>0.7350280520529261</c:v>
                </c:pt>
                <c:pt idx="977">
                  <c:v>0.7350280520529261</c:v>
                </c:pt>
                <c:pt idx="978">
                  <c:v>0.7343417513507291</c:v>
                </c:pt>
                <c:pt idx="979">
                  <c:v>0.7343417513507291</c:v>
                </c:pt>
                <c:pt idx="980">
                  <c:v>0.73365480864600441</c:v>
                </c:pt>
                <c:pt idx="981">
                  <c:v>0.73365480864600441</c:v>
                </c:pt>
                <c:pt idx="982">
                  <c:v>0.73365480864600441</c:v>
                </c:pt>
                <c:pt idx="983">
                  <c:v>0.73365480864600441</c:v>
                </c:pt>
                <c:pt idx="984">
                  <c:v>0.73365480864600441</c:v>
                </c:pt>
                <c:pt idx="985">
                  <c:v>0.73365480864600441</c:v>
                </c:pt>
                <c:pt idx="986">
                  <c:v>0.73296398490904957</c:v>
                </c:pt>
                <c:pt idx="987">
                  <c:v>0.73296398490904957</c:v>
                </c:pt>
                <c:pt idx="988">
                  <c:v>0.73227316117209473</c:v>
                </c:pt>
                <c:pt idx="989">
                  <c:v>0.73227316117209473</c:v>
                </c:pt>
                <c:pt idx="990">
                  <c:v>0.73227316117209473</c:v>
                </c:pt>
                <c:pt idx="991">
                  <c:v>0.73227316117209473</c:v>
                </c:pt>
                <c:pt idx="992">
                  <c:v>0.73227316117209473</c:v>
                </c:pt>
                <c:pt idx="993">
                  <c:v>0.73227316117209473</c:v>
                </c:pt>
                <c:pt idx="994">
                  <c:v>0.73157906338899326</c:v>
                </c:pt>
                <c:pt idx="995">
                  <c:v>0.73157906338899326</c:v>
                </c:pt>
                <c:pt idx="996">
                  <c:v>0.73088496560589178</c:v>
                </c:pt>
                <c:pt idx="997">
                  <c:v>0.73088496560589178</c:v>
                </c:pt>
                <c:pt idx="998">
                  <c:v>0.7301908678227903</c:v>
                </c:pt>
                <c:pt idx="999">
                  <c:v>0.7301908678227903</c:v>
                </c:pt>
                <c:pt idx="1000">
                  <c:v>0.7301908678227903</c:v>
                </c:pt>
                <c:pt idx="1001">
                  <c:v>0.72949544794867338</c:v>
                </c:pt>
                <c:pt idx="1002">
                  <c:v>0.72949544794867338</c:v>
                </c:pt>
                <c:pt idx="1003">
                  <c:v>0.72949544794867338</c:v>
                </c:pt>
                <c:pt idx="1004">
                  <c:v>0.72879936450597427</c:v>
                </c:pt>
                <c:pt idx="1005">
                  <c:v>0.72879936450597427</c:v>
                </c:pt>
                <c:pt idx="1006">
                  <c:v>0.72740586667709095</c:v>
                </c:pt>
                <c:pt idx="1007">
                  <c:v>0.72740586667709095</c:v>
                </c:pt>
                <c:pt idx="1008">
                  <c:v>0.72740586667709095</c:v>
                </c:pt>
                <c:pt idx="1009">
                  <c:v>0.72740586667709095</c:v>
                </c:pt>
                <c:pt idx="1010">
                  <c:v>0.72670778043267914</c:v>
                </c:pt>
                <c:pt idx="1011">
                  <c:v>0.72670778043267914</c:v>
                </c:pt>
                <c:pt idx="1012">
                  <c:v>0.72600969418826733</c:v>
                </c:pt>
                <c:pt idx="1013">
                  <c:v>0.72600969418826733</c:v>
                </c:pt>
                <c:pt idx="1014">
                  <c:v>0.72600969418826733</c:v>
                </c:pt>
                <c:pt idx="1015">
                  <c:v>0.7253102628836543</c:v>
                </c:pt>
                <c:pt idx="1016">
                  <c:v>0.7253102628836543</c:v>
                </c:pt>
                <c:pt idx="1017">
                  <c:v>0.7253102628836543</c:v>
                </c:pt>
                <c:pt idx="1018">
                  <c:v>0.72461015645229943</c:v>
                </c:pt>
                <c:pt idx="1019">
                  <c:v>0.72461015645229943</c:v>
                </c:pt>
                <c:pt idx="1020">
                  <c:v>0.72461015645229943</c:v>
                </c:pt>
                <c:pt idx="1021">
                  <c:v>0.72390869453898643</c:v>
                </c:pt>
                <c:pt idx="1022">
                  <c:v>0.72390869453898643</c:v>
                </c:pt>
                <c:pt idx="1023">
                  <c:v>0.72320723262567344</c:v>
                </c:pt>
                <c:pt idx="1024">
                  <c:v>0.72320723262567344</c:v>
                </c:pt>
                <c:pt idx="1025">
                  <c:v>0.72320723262567344</c:v>
                </c:pt>
                <c:pt idx="1026">
                  <c:v>0.72320723262567344</c:v>
                </c:pt>
                <c:pt idx="1027">
                  <c:v>0.72320723262567344</c:v>
                </c:pt>
                <c:pt idx="1028">
                  <c:v>0.72180021466336663</c:v>
                </c:pt>
                <c:pt idx="1029">
                  <c:v>0.72180021466336663</c:v>
                </c:pt>
                <c:pt idx="1030">
                  <c:v>0.72109670568221329</c:v>
                </c:pt>
                <c:pt idx="1031">
                  <c:v>0.72109670568221329</c:v>
                </c:pt>
                <c:pt idx="1032">
                  <c:v>0.72039319670105995</c:v>
                </c:pt>
                <c:pt idx="1033">
                  <c:v>0.72039319670105995</c:v>
                </c:pt>
                <c:pt idx="1034">
                  <c:v>0.72039319670105995</c:v>
                </c:pt>
                <c:pt idx="1035">
                  <c:v>0.72039319670105995</c:v>
                </c:pt>
                <c:pt idx="1036">
                  <c:v>0.71968692886115693</c:v>
                </c:pt>
                <c:pt idx="1037">
                  <c:v>0.71968692886115693</c:v>
                </c:pt>
                <c:pt idx="1038">
                  <c:v>0.71968692886115693</c:v>
                </c:pt>
                <c:pt idx="1039">
                  <c:v>0.71968692886115693</c:v>
                </c:pt>
                <c:pt idx="1040">
                  <c:v>0.71897927209728163</c:v>
                </c:pt>
                <c:pt idx="1041">
                  <c:v>0.71897927209728163</c:v>
                </c:pt>
                <c:pt idx="1042">
                  <c:v>0.71827161533340633</c:v>
                </c:pt>
                <c:pt idx="1043">
                  <c:v>0.71827161533340633</c:v>
                </c:pt>
                <c:pt idx="1044">
                  <c:v>0.71827161533340633</c:v>
                </c:pt>
                <c:pt idx="1045">
                  <c:v>0.71756326068317611</c:v>
                </c:pt>
                <c:pt idx="1046">
                  <c:v>0.71756326068317611</c:v>
                </c:pt>
                <c:pt idx="1047">
                  <c:v>0.71756326068317611</c:v>
                </c:pt>
                <c:pt idx="1048">
                  <c:v>0.71756326068317611</c:v>
                </c:pt>
                <c:pt idx="1049">
                  <c:v>0.71685350473789111</c:v>
                </c:pt>
                <c:pt idx="1050">
                  <c:v>0.71685350473789111</c:v>
                </c:pt>
                <c:pt idx="1051">
                  <c:v>0.71685350473789111</c:v>
                </c:pt>
                <c:pt idx="1052">
                  <c:v>0.71614304536748685</c:v>
                </c:pt>
                <c:pt idx="1053">
                  <c:v>0.71614304536748685</c:v>
                </c:pt>
                <c:pt idx="1054">
                  <c:v>0.71543188047635731</c:v>
                </c:pt>
                <c:pt idx="1055">
                  <c:v>0.71543188047635731</c:v>
                </c:pt>
                <c:pt idx="1056">
                  <c:v>0.71472071558522776</c:v>
                </c:pt>
                <c:pt idx="1057">
                  <c:v>0.71472071558522776</c:v>
                </c:pt>
                <c:pt idx="1058">
                  <c:v>0.71472071558522776</c:v>
                </c:pt>
                <c:pt idx="1059">
                  <c:v>0.71472071558522776</c:v>
                </c:pt>
                <c:pt idx="1060">
                  <c:v>0.71400813261854257</c:v>
                </c:pt>
                <c:pt idx="1061">
                  <c:v>0.71400813261854257</c:v>
                </c:pt>
                <c:pt idx="1062">
                  <c:v>0.71400813261854257</c:v>
                </c:pt>
                <c:pt idx="1063">
                  <c:v>0.71400813261854257</c:v>
                </c:pt>
                <c:pt idx="1064">
                  <c:v>0.71400813261854257</c:v>
                </c:pt>
                <c:pt idx="1065">
                  <c:v>0.71329340976306854</c:v>
                </c:pt>
                <c:pt idx="1066">
                  <c:v>0.71329340976306854</c:v>
                </c:pt>
                <c:pt idx="1067">
                  <c:v>0.71257868690759452</c:v>
                </c:pt>
                <c:pt idx="1068">
                  <c:v>0.71257868690759452</c:v>
                </c:pt>
                <c:pt idx="1069">
                  <c:v>0.71257868690759452</c:v>
                </c:pt>
                <c:pt idx="1070">
                  <c:v>0.71257868690759452</c:v>
                </c:pt>
                <c:pt idx="1071">
                  <c:v>0.71186252742326528</c:v>
                </c:pt>
                <c:pt idx="1072">
                  <c:v>0.71186252742326528</c:v>
                </c:pt>
                <c:pt idx="1073">
                  <c:v>0.71114636793893604</c:v>
                </c:pt>
                <c:pt idx="1074">
                  <c:v>0.71114636793893604</c:v>
                </c:pt>
                <c:pt idx="1075">
                  <c:v>0.71114636793893604</c:v>
                </c:pt>
                <c:pt idx="1076">
                  <c:v>0.71114636793893604</c:v>
                </c:pt>
                <c:pt idx="1077">
                  <c:v>0.71114636793893604</c:v>
                </c:pt>
                <c:pt idx="1078">
                  <c:v>0.71114636793893604</c:v>
                </c:pt>
                <c:pt idx="1079">
                  <c:v>0.71114636793893604</c:v>
                </c:pt>
                <c:pt idx="1080">
                  <c:v>0.71114636793893604</c:v>
                </c:pt>
                <c:pt idx="1081">
                  <c:v>0.71042512415806491</c:v>
                </c:pt>
                <c:pt idx="1082">
                  <c:v>0.71042512415806491</c:v>
                </c:pt>
                <c:pt idx="1083">
                  <c:v>0.71042512415806491</c:v>
                </c:pt>
                <c:pt idx="1084">
                  <c:v>0.70970241294325509</c:v>
                </c:pt>
                <c:pt idx="1085">
                  <c:v>0.70970241294325509</c:v>
                </c:pt>
                <c:pt idx="1086">
                  <c:v>0.70897970172844527</c:v>
                </c:pt>
                <c:pt idx="1087">
                  <c:v>0.70897970172844527</c:v>
                </c:pt>
                <c:pt idx="1088">
                  <c:v>0.70897970172844527</c:v>
                </c:pt>
                <c:pt idx="1089">
                  <c:v>0.70825625305321216</c:v>
                </c:pt>
                <c:pt idx="1090">
                  <c:v>0.70825625305321216</c:v>
                </c:pt>
                <c:pt idx="1091">
                  <c:v>0.70825625305321216</c:v>
                </c:pt>
                <c:pt idx="1092">
                  <c:v>0.70825625305321216</c:v>
                </c:pt>
                <c:pt idx="1093">
                  <c:v>0.70825625305321216</c:v>
                </c:pt>
                <c:pt idx="1094">
                  <c:v>0.70825625305321216</c:v>
                </c:pt>
                <c:pt idx="1095">
                  <c:v>0.70752909057574476</c:v>
                </c:pt>
                <c:pt idx="1096">
                  <c:v>0.70752909057574476</c:v>
                </c:pt>
                <c:pt idx="1097">
                  <c:v>0.70680117998873271</c:v>
                </c:pt>
                <c:pt idx="1098">
                  <c:v>0.70680117998873271</c:v>
                </c:pt>
                <c:pt idx="1099">
                  <c:v>0.70680117998873271</c:v>
                </c:pt>
                <c:pt idx="1100">
                  <c:v>0.70680117998873271</c:v>
                </c:pt>
                <c:pt idx="1101">
                  <c:v>0.70607025839619009</c:v>
                </c:pt>
                <c:pt idx="1102">
                  <c:v>0.70607025839619009</c:v>
                </c:pt>
                <c:pt idx="1103">
                  <c:v>0.70607025839619009</c:v>
                </c:pt>
                <c:pt idx="1104">
                  <c:v>0.70533857937194533</c:v>
                </c:pt>
                <c:pt idx="1105">
                  <c:v>0.70533857937194533</c:v>
                </c:pt>
                <c:pt idx="1106">
                  <c:v>0.70460690034770057</c:v>
                </c:pt>
                <c:pt idx="1107">
                  <c:v>0.70460690034770057</c:v>
                </c:pt>
                <c:pt idx="1108">
                  <c:v>0.70387522132345581</c:v>
                </c:pt>
                <c:pt idx="1109">
                  <c:v>0.70387522132345581</c:v>
                </c:pt>
                <c:pt idx="1110">
                  <c:v>0.70387522132345581</c:v>
                </c:pt>
                <c:pt idx="1111">
                  <c:v>0.70314278092665716</c:v>
                </c:pt>
                <c:pt idx="1112">
                  <c:v>0.70314278092665716</c:v>
                </c:pt>
                <c:pt idx="1113">
                  <c:v>0.70314278092665716</c:v>
                </c:pt>
                <c:pt idx="1114">
                  <c:v>0.70314278092665716</c:v>
                </c:pt>
                <c:pt idx="1115">
                  <c:v>0.70314278092665716</c:v>
                </c:pt>
                <c:pt idx="1116">
                  <c:v>0.70240804447845795</c:v>
                </c:pt>
                <c:pt idx="1117">
                  <c:v>0.70240804447845795</c:v>
                </c:pt>
                <c:pt idx="1118">
                  <c:v>0.70167330803025874</c:v>
                </c:pt>
                <c:pt idx="1119">
                  <c:v>0.70167330803025874</c:v>
                </c:pt>
                <c:pt idx="1120">
                  <c:v>0.70167330803025874</c:v>
                </c:pt>
                <c:pt idx="1121">
                  <c:v>0.70093780141806772</c:v>
                </c:pt>
                <c:pt idx="1122">
                  <c:v>0.70093780141806772</c:v>
                </c:pt>
                <c:pt idx="1123">
                  <c:v>0.70093780141806772</c:v>
                </c:pt>
                <c:pt idx="1124">
                  <c:v>0.70093780141806772</c:v>
                </c:pt>
                <c:pt idx="1125">
                  <c:v>0.70020074799912124</c:v>
                </c:pt>
                <c:pt idx="1126">
                  <c:v>0.70020074799912124</c:v>
                </c:pt>
                <c:pt idx="1127">
                  <c:v>0.69946369458017477</c:v>
                </c:pt>
                <c:pt idx="1128">
                  <c:v>0.69946369458017477</c:v>
                </c:pt>
                <c:pt idx="1129">
                  <c:v>0.69946369458017477</c:v>
                </c:pt>
                <c:pt idx="1130">
                  <c:v>0.69872508455421889</c:v>
                </c:pt>
                <c:pt idx="1131">
                  <c:v>0.69872508455421889</c:v>
                </c:pt>
                <c:pt idx="1132">
                  <c:v>0.69872508455421889</c:v>
                </c:pt>
                <c:pt idx="1133">
                  <c:v>0.69724630130648513</c:v>
                </c:pt>
                <c:pt idx="1134">
                  <c:v>0.69724630130648513</c:v>
                </c:pt>
                <c:pt idx="1135">
                  <c:v>0.69650690968261819</c:v>
                </c:pt>
                <c:pt idx="1136">
                  <c:v>0.69650690968261819</c:v>
                </c:pt>
                <c:pt idx="1137">
                  <c:v>0.69576751805875126</c:v>
                </c:pt>
                <c:pt idx="1138">
                  <c:v>0.69576751805875126</c:v>
                </c:pt>
                <c:pt idx="1139">
                  <c:v>0.69502812643488432</c:v>
                </c:pt>
                <c:pt idx="1140">
                  <c:v>0.69502812643488432</c:v>
                </c:pt>
                <c:pt idx="1141">
                  <c:v>0.69428873481101738</c:v>
                </c:pt>
                <c:pt idx="1142">
                  <c:v>0.69428873481101738</c:v>
                </c:pt>
                <c:pt idx="1143">
                  <c:v>0.69354934318715045</c:v>
                </c:pt>
                <c:pt idx="1144">
                  <c:v>0.69354934318715045</c:v>
                </c:pt>
                <c:pt idx="1145">
                  <c:v>0.69280995156328351</c:v>
                </c:pt>
                <c:pt idx="1146">
                  <c:v>0.69280995156328351</c:v>
                </c:pt>
                <c:pt idx="1147">
                  <c:v>0.69280995156328351</c:v>
                </c:pt>
                <c:pt idx="1148">
                  <c:v>0.69280995156328351</c:v>
                </c:pt>
                <c:pt idx="1149">
                  <c:v>0.69206897835305536</c:v>
                </c:pt>
                <c:pt idx="1150">
                  <c:v>0.69206897835305536</c:v>
                </c:pt>
                <c:pt idx="1151">
                  <c:v>0.69132800514282722</c:v>
                </c:pt>
                <c:pt idx="1152">
                  <c:v>0.69132800514282722</c:v>
                </c:pt>
                <c:pt idx="1153">
                  <c:v>0.69058623689696585</c:v>
                </c:pt>
                <c:pt idx="1154">
                  <c:v>0.69058623689696585</c:v>
                </c:pt>
                <c:pt idx="1155">
                  <c:v>0.69058623689696585</c:v>
                </c:pt>
                <c:pt idx="1156">
                  <c:v>0.6898436710508401</c:v>
                </c:pt>
                <c:pt idx="1157">
                  <c:v>0.6898436710508401</c:v>
                </c:pt>
                <c:pt idx="1158">
                  <c:v>0.68835853935858859</c:v>
                </c:pt>
                <c:pt idx="1159">
                  <c:v>0.68835853935858859</c:v>
                </c:pt>
                <c:pt idx="1160">
                  <c:v>0.68835853935858859</c:v>
                </c:pt>
                <c:pt idx="1161">
                  <c:v>0.68835853935858859</c:v>
                </c:pt>
                <c:pt idx="1162">
                  <c:v>0.68761436796468745</c:v>
                </c:pt>
                <c:pt idx="1163">
                  <c:v>0.68761436796468745</c:v>
                </c:pt>
                <c:pt idx="1164">
                  <c:v>0.6868701965707863</c:v>
                </c:pt>
                <c:pt idx="1165">
                  <c:v>0.6868701965707863</c:v>
                </c:pt>
                <c:pt idx="1166">
                  <c:v>0.68612602517688515</c:v>
                </c:pt>
                <c:pt idx="1167">
                  <c:v>0.68612602517688515</c:v>
                </c:pt>
                <c:pt idx="1168">
                  <c:v>0.685381853782984</c:v>
                </c:pt>
                <c:pt idx="1169">
                  <c:v>0.685381853782984</c:v>
                </c:pt>
                <c:pt idx="1170">
                  <c:v>0.68463768238908285</c:v>
                </c:pt>
                <c:pt idx="1171">
                  <c:v>0.68463768238908285</c:v>
                </c:pt>
                <c:pt idx="1172">
                  <c:v>0.68463768238908285</c:v>
                </c:pt>
                <c:pt idx="1173">
                  <c:v>0.68389188970674175</c:v>
                </c:pt>
                <c:pt idx="1174">
                  <c:v>0.68389188970674175</c:v>
                </c:pt>
                <c:pt idx="1175">
                  <c:v>0.68314609702440066</c:v>
                </c:pt>
                <c:pt idx="1176">
                  <c:v>0.68314609702440066</c:v>
                </c:pt>
                <c:pt idx="1177">
                  <c:v>0.68240030434205956</c:v>
                </c:pt>
                <c:pt idx="1178">
                  <c:v>0.68240030434205956</c:v>
                </c:pt>
                <c:pt idx="1179">
                  <c:v>0.68165451165971847</c:v>
                </c:pt>
                <c:pt idx="1180">
                  <c:v>0.68165451165971847</c:v>
                </c:pt>
                <c:pt idx="1181">
                  <c:v>0.68090871897737737</c:v>
                </c:pt>
                <c:pt idx="1182">
                  <c:v>0.68090871897737737</c:v>
                </c:pt>
                <c:pt idx="1183">
                  <c:v>0.68016292629503627</c:v>
                </c:pt>
                <c:pt idx="1184">
                  <c:v>0.68016292629503627</c:v>
                </c:pt>
                <c:pt idx="1185">
                  <c:v>0.67941713361269518</c:v>
                </c:pt>
                <c:pt idx="1186">
                  <c:v>0.67941713361269518</c:v>
                </c:pt>
                <c:pt idx="1187">
                  <c:v>0.67867134093035408</c:v>
                </c:pt>
                <c:pt idx="1188">
                  <c:v>0.67867134093035408</c:v>
                </c:pt>
                <c:pt idx="1189">
                  <c:v>0.67867134093035408</c:v>
                </c:pt>
                <c:pt idx="1190">
                  <c:v>0.67792472779401702</c:v>
                </c:pt>
                <c:pt idx="1191">
                  <c:v>0.67792472779401702</c:v>
                </c:pt>
                <c:pt idx="1192">
                  <c:v>0.67717811465767996</c:v>
                </c:pt>
                <c:pt idx="1193">
                  <c:v>0.67717811465767996</c:v>
                </c:pt>
                <c:pt idx="1194">
                  <c:v>0.67717811465767996</c:v>
                </c:pt>
                <c:pt idx="1195">
                  <c:v>0.67642985154756097</c:v>
                </c:pt>
                <c:pt idx="1196">
                  <c:v>0.67642985154756097</c:v>
                </c:pt>
                <c:pt idx="1197">
                  <c:v>0.67642985154756097</c:v>
                </c:pt>
                <c:pt idx="1198">
                  <c:v>0.6756799293174639</c:v>
                </c:pt>
                <c:pt idx="1199">
                  <c:v>0.6756799293174639</c:v>
                </c:pt>
                <c:pt idx="1200">
                  <c:v>0.6756799293174639</c:v>
                </c:pt>
                <c:pt idx="1201">
                  <c:v>0.67492917384044449</c:v>
                </c:pt>
                <c:pt idx="1202">
                  <c:v>0.67492917384044449</c:v>
                </c:pt>
                <c:pt idx="1203">
                  <c:v>0.67492917384044449</c:v>
                </c:pt>
                <c:pt idx="1204">
                  <c:v>0.6741775823328271</c:v>
                </c:pt>
                <c:pt idx="1205">
                  <c:v>0.6741775823328271</c:v>
                </c:pt>
                <c:pt idx="1206">
                  <c:v>0.6741775823328271</c:v>
                </c:pt>
                <c:pt idx="1207">
                  <c:v>0.67267272165797709</c:v>
                </c:pt>
                <c:pt idx="1208">
                  <c:v>0.67267272165797709</c:v>
                </c:pt>
                <c:pt idx="1209">
                  <c:v>0.67192029132055209</c:v>
                </c:pt>
                <c:pt idx="1210">
                  <c:v>0.67192029132055209</c:v>
                </c:pt>
                <c:pt idx="1211">
                  <c:v>0.67192029132055209</c:v>
                </c:pt>
                <c:pt idx="1212">
                  <c:v>0.67192029132055209</c:v>
                </c:pt>
                <c:pt idx="1213">
                  <c:v>0.67192029132055209</c:v>
                </c:pt>
                <c:pt idx="1214">
                  <c:v>0.67192029132055209</c:v>
                </c:pt>
                <c:pt idx="1215">
                  <c:v>0.6704086596190435</c:v>
                </c:pt>
                <c:pt idx="1216">
                  <c:v>0.6704086596190435</c:v>
                </c:pt>
                <c:pt idx="1217">
                  <c:v>0.66965284376828926</c:v>
                </c:pt>
                <c:pt idx="1218">
                  <c:v>0.66965284376828926</c:v>
                </c:pt>
                <c:pt idx="1219">
                  <c:v>0.66814121206678068</c:v>
                </c:pt>
                <c:pt idx="1220">
                  <c:v>0.66814121206678068</c:v>
                </c:pt>
                <c:pt idx="1221">
                  <c:v>0.66738539621602644</c:v>
                </c:pt>
                <c:pt idx="1222">
                  <c:v>0.66738539621602644</c:v>
                </c:pt>
                <c:pt idx="1223">
                  <c:v>0.6666295803652722</c:v>
                </c:pt>
                <c:pt idx="1224">
                  <c:v>0.6666295803652722</c:v>
                </c:pt>
                <c:pt idx="1225">
                  <c:v>0.66587376451451796</c:v>
                </c:pt>
                <c:pt idx="1226">
                  <c:v>0.66587376451451796</c:v>
                </c:pt>
                <c:pt idx="1227">
                  <c:v>0.66587376451451796</c:v>
                </c:pt>
                <c:pt idx="1228">
                  <c:v>0.66511708978211515</c:v>
                </c:pt>
                <c:pt idx="1229">
                  <c:v>0.66511708978211515</c:v>
                </c:pt>
                <c:pt idx="1230">
                  <c:v>0.66511708978211515</c:v>
                </c:pt>
                <c:pt idx="1231">
                  <c:v>0.66511708978211515</c:v>
                </c:pt>
                <c:pt idx="1232">
                  <c:v>0.66511708978211515</c:v>
                </c:pt>
                <c:pt idx="1233">
                  <c:v>0.66511708978211515</c:v>
                </c:pt>
                <c:pt idx="1234">
                  <c:v>0.66435695596522126</c:v>
                </c:pt>
                <c:pt idx="1235">
                  <c:v>0.66435695596522126</c:v>
                </c:pt>
                <c:pt idx="1236">
                  <c:v>0.66359682214832738</c:v>
                </c:pt>
                <c:pt idx="1237">
                  <c:v>0.66359682214832738</c:v>
                </c:pt>
                <c:pt idx="1238">
                  <c:v>0.6628366883314335</c:v>
                </c:pt>
                <c:pt idx="1239">
                  <c:v>0.6628366883314335</c:v>
                </c:pt>
                <c:pt idx="1240">
                  <c:v>0.66207655451453962</c:v>
                </c:pt>
                <c:pt idx="1241">
                  <c:v>0.66207655451453962</c:v>
                </c:pt>
                <c:pt idx="1242">
                  <c:v>0.66131642069764573</c:v>
                </c:pt>
                <c:pt idx="1243">
                  <c:v>0.66131642069764573</c:v>
                </c:pt>
                <c:pt idx="1244">
                  <c:v>0.65979615306385808</c:v>
                </c:pt>
                <c:pt idx="1245">
                  <c:v>0.65979615306385808</c:v>
                </c:pt>
                <c:pt idx="1246">
                  <c:v>0.65903514250669104</c:v>
                </c:pt>
                <c:pt idx="1247">
                  <c:v>0.65903514250669104</c:v>
                </c:pt>
                <c:pt idx="1248">
                  <c:v>0.65827325216853305</c:v>
                </c:pt>
                <c:pt idx="1249">
                  <c:v>0.65827325216853305</c:v>
                </c:pt>
                <c:pt idx="1250">
                  <c:v>0.65827325216853305</c:v>
                </c:pt>
                <c:pt idx="1251">
                  <c:v>0.65827325216853305</c:v>
                </c:pt>
                <c:pt idx="1252">
                  <c:v>0.65750959410337229</c:v>
                </c:pt>
                <c:pt idx="1253">
                  <c:v>0.65750959410337229</c:v>
                </c:pt>
                <c:pt idx="1254">
                  <c:v>0.65674593603821152</c:v>
                </c:pt>
                <c:pt idx="1255">
                  <c:v>0.65674593603821152</c:v>
                </c:pt>
                <c:pt idx="1256">
                  <c:v>0.65598227797305075</c:v>
                </c:pt>
                <c:pt idx="1257">
                  <c:v>0.65598227797305075</c:v>
                </c:pt>
                <c:pt idx="1258">
                  <c:v>0.65521861990788999</c:v>
                </c:pt>
                <c:pt idx="1259">
                  <c:v>0.65521861990788999</c:v>
                </c:pt>
                <c:pt idx="1260">
                  <c:v>0.65369130377756857</c:v>
                </c:pt>
                <c:pt idx="1261">
                  <c:v>0.65369130377756857</c:v>
                </c:pt>
                <c:pt idx="1262">
                  <c:v>0.6529276457124078</c:v>
                </c:pt>
                <c:pt idx="1263">
                  <c:v>0.6529276457124078</c:v>
                </c:pt>
                <c:pt idx="1264">
                  <c:v>0.65216398764724703</c:v>
                </c:pt>
                <c:pt idx="1265">
                  <c:v>0.65216398764724703</c:v>
                </c:pt>
                <c:pt idx="1266">
                  <c:v>0.65216398764724703</c:v>
                </c:pt>
                <c:pt idx="1267">
                  <c:v>0.65139943432057967</c:v>
                </c:pt>
                <c:pt idx="1268">
                  <c:v>0.65139943432057967</c:v>
                </c:pt>
                <c:pt idx="1269">
                  <c:v>0.65063488099391231</c:v>
                </c:pt>
                <c:pt idx="1270">
                  <c:v>0.65063488099391231</c:v>
                </c:pt>
                <c:pt idx="1271">
                  <c:v>0.65063488099391231</c:v>
                </c:pt>
                <c:pt idx="1272">
                  <c:v>0.65063488099391231</c:v>
                </c:pt>
                <c:pt idx="1273">
                  <c:v>0.64986852659933758</c:v>
                </c:pt>
                <c:pt idx="1274">
                  <c:v>0.64986852659933758</c:v>
                </c:pt>
                <c:pt idx="1275">
                  <c:v>0.64833581781018823</c:v>
                </c:pt>
                <c:pt idx="1276">
                  <c:v>0.64833581781018823</c:v>
                </c:pt>
                <c:pt idx="1277">
                  <c:v>0.64833581781018823</c:v>
                </c:pt>
                <c:pt idx="1278">
                  <c:v>0.64833581781018823</c:v>
                </c:pt>
                <c:pt idx="1279">
                  <c:v>0.64833581781018823</c:v>
                </c:pt>
                <c:pt idx="1280">
                  <c:v>0.6475667361757752</c:v>
                </c:pt>
                <c:pt idx="1281">
                  <c:v>0.6475667361757752</c:v>
                </c:pt>
                <c:pt idx="1282">
                  <c:v>0.64679765454136218</c:v>
                </c:pt>
                <c:pt idx="1283">
                  <c:v>0.64679765454136218</c:v>
                </c:pt>
                <c:pt idx="1284">
                  <c:v>0.64679765454136218</c:v>
                </c:pt>
                <c:pt idx="1285">
                  <c:v>0.64679765454136218</c:v>
                </c:pt>
                <c:pt idx="1286">
                  <c:v>0.64679765454136218</c:v>
                </c:pt>
                <c:pt idx="1287">
                  <c:v>0.64602581963140826</c:v>
                </c:pt>
                <c:pt idx="1288">
                  <c:v>0.64602581963140826</c:v>
                </c:pt>
                <c:pt idx="1289">
                  <c:v>0.64525398472145434</c:v>
                </c:pt>
                <c:pt idx="1290">
                  <c:v>0.64525398472145434</c:v>
                </c:pt>
                <c:pt idx="1291">
                  <c:v>0.64525398472145434</c:v>
                </c:pt>
                <c:pt idx="1292">
                  <c:v>0.64448122545831488</c:v>
                </c:pt>
                <c:pt idx="1293">
                  <c:v>0.64448122545831488</c:v>
                </c:pt>
                <c:pt idx="1294">
                  <c:v>0.64370846619517541</c:v>
                </c:pt>
                <c:pt idx="1295">
                  <c:v>0.64370846619517541</c:v>
                </c:pt>
                <c:pt idx="1296">
                  <c:v>0.64293570693203594</c:v>
                </c:pt>
                <c:pt idx="1297">
                  <c:v>0.64293570693203594</c:v>
                </c:pt>
                <c:pt idx="1298">
                  <c:v>0.64293570693203594</c:v>
                </c:pt>
                <c:pt idx="1299">
                  <c:v>0.64216201775401904</c:v>
                </c:pt>
                <c:pt idx="1300">
                  <c:v>0.64216201775401904</c:v>
                </c:pt>
                <c:pt idx="1301">
                  <c:v>0.64138832857600214</c:v>
                </c:pt>
                <c:pt idx="1302">
                  <c:v>0.64138832857600214</c:v>
                </c:pt>
                <c:pt idx="1303">
                  <c:v>0.64061463939798524</c:v>
                </c:pt>
                <c:pt idx="1304">
                  <c:v>0.64061463939798524</c:v>
                </c:pt>
                <c:pt idx="1305">
                  <c:v>0.63984095021996834</c:v>
                </c:pt>
                <c:pt idx="1306">
                  <c:v>0.63984095021996834</c:v>
                </c:pt>
                <c:pt idx="1307">
                  <c:v>0.63906726104195144</c:v>
                </c:pt>
                <c:pt idx="1308">
                  <c:v>0.63906726104195144</c:v>
                </c:pt>
                <c:pt idx="1309">
                  <c:v>0.63829357186393454</c:v>
                </c:pt>
                <c:pt idx="1310">
                  <c:v>0.63829357186393454</c:v>
                </c:pt>
                <c:pt idx="1311">
                  <c:v>0.63751988268591764</c:v>
                </c:pt>
                <c:pt idx="1312">
                  <c:v>0.63751988268591764</c:v>
                </c:pt>
                <c:pt idx="1313">
                  <c:v>0.63597250432988384</c:v>
                </c:pt>
                <c:pt idx="1314">
                  <c:v>0.63597250432988384</c:v>
                </c:pt>
                <c:pt idx="1315">
                  <c:v>0.63597250432988384</c:v>
                </c:pt>
                <c:pt idx="1316">
                  <c:v>0.63519787277771589</c:v>
                </c:pt>
                <c:pt idx="1317">
                  <c:v>0.63519787277771589</c:v>
                </c:pt>
                <c:pt idx="1318">
                  <c:v>0.63519787277771589</c:v>
                </c:pt>
                <c:pt idx="1319">
                  <c:v>0.63442229539947692</c:v>
                </c:pt>
                <c:pt idx="1320">
                  <c:v>0.63442229539947692</c:v>
                </c:pt>
                <c:pt idx="1321">
                  <c:v>0.63442229539947692</c:v>
                </c:pt>
                <c:pt idx="1322">
                  <c:v>0.63442229539947692</c:v>
                </c:pt>
                <c:pt idx="1323">
                  <c:v>0.63442229539947692</c:v>
                </c:pt>
                <c:pt idx="1324">
                  <c:v>0.63442229539947692</c:v>
                </c:pt>
                <c:pt idx="1325">
                  <c:v>0.63364290683019009</c:v>
                </c:pt>
                <c:pt idx="1326">
                  <c:v>0.63364290683019009</c:v>
                </c:pt>
                <c:pt idx="1327">
                  <c:v>0.63286351826090326</c:v>
                </c:pt>
                <c:pt idx="1328">
                  <c:v>0.63286351826090326</c:v>
                </c:pt>
                <c:pt idx="1329">
                  <c:v>0.63208316866995273</c:v>
                </c:pt>
                <c:pt idx="1330">
                  <c:v>0.63208316866995273</c:v>
                </c:pt>
                <c:pt idx="1331">
                  <c:v>0.63130281907900221</c:v>
                </c:pt>
                <c:pt idx="1332">
                  <c:v>0.63130281907900221</c:v>
                </c:pt>
                <c:pt idx="1333">
                  <c:v>0.63052246948805168</c:v>
                </c:pt>
                <c:pt idx="1334">
                  <c:v>0.63052246948805168</c:v>
                </c:pt>
                <c:pt idx="1335">
                  <c:v>0.62974115292115196</c:v>
                </c:pt>
                <c:pt idx="1336">
                  <c:v>0.62974115292115196</c:v>
                </c:pt>
                <c:pt idx="1337">
                  <c:v>0.62895983635425223</c:v>
                </c:pt>
                <c:pt idx="1338">
                  <c:v>0.62895983635425223</c:v>
                </c:pt>
                <c:pt idx="1339">
                  <c:v>0.62817754800057779</c:v>
                </c:pt>
                <c:pt idx="1340">
                  <c:v>0.62817754800057779</c:v>
                </c:pt>
                <c:pt idx="1341">
                  <c:v>0.62817754800057779</c:v>
                </c:pt>
                <c:pt idx="1342">
                  <c:v>0.62739428422501597</c:v>
                </c:pt>
                <c:pt idx="1343">
                  <c:v>0.62739428422501597</c:v>
                </c:pt>
                <c:pt idx="1344">
                  <c:v>0.62661102044945416</c:v>
                </c:pt>
                <c:pt idx="1345">
                  <c:v>0.62661102044945416</c:v>
                </c:pt>
                <c:pt idx="1346">
                  <c:v>0.62661102044945416</c:v>
                </c:pt>
                <c:pt idx="1347">
                  <c:v>0.62661102044945416</c:v>
                </c:pt>
                <c:pt idx="1348">
                  <c:v>0.6258257936067857</c:v>
                </c:pt>
                <c:pt idx="1349">
                  <c:v>0.6258257936067857</c:v>
                </c:pt>
                <c:pt idx="1350">
                  <c:v>0.62504056676411723</c:v>
                </c:pt>
                <c:pt idx="1351">
                  <c:v>0.62504056676411723</c:v>
                </c:pt>
                <c:pt idx="1352">
                  <c:v>0.62425533992144877</c:v>
                </c:pt>
                <c:pt idx="1353">
                  <c:v>0.62425533992144877</c:v>
                </c:pt>
                <c:pt idx="1354">
                  <c:v>0.62425533992144877</c:v>
                </c:pt>
                <c:pt idx="1355">
                  <c:v>0.62425533992144877</c:v>
                </c:pt>
                <c:pt idx="1356">
                  <c:v>0.62346813268321244</c:v>
                </c:pt>
                <c:pt idx="1357">
                  <c:v>0.62346813268321244</c:v>
                </c:pt>
                <c:pt idx="1358">
                  <c:v>0.62268092544497611</c:v>
                </c:pt>
                <c:pt idx="1359">
                  <c:v>0.62268092544497611</c:v>
                </c:pt>
                <c:pt idx="1360">
                  <c:v>0.62268092544497611</c:v>
                </c:pt>
                <c:pt idx="1361">
                  <c:v>0.62189272174188115</c:v>
                </c:pt>
                <c:pt idx="1362">
                  <c:v>0.62189272174188115</c:v>
                </c:pt>
                <c:pt idx="1363">
                  <c:v>0.62189272174188115</c:v>
                </c:pt>
                <c:pt idx="1364">
                  <c:v>0.62110351778027972</c:v>
                </c:pt>
                <c:pt idx="1365">
                  <c:v>0.62110351778027972</c:v>
                </c:pt>
                <c:pt idx="1366">
                  <c:v>0.62110351778027972</c:v>
                </c:pt>
                <c:pt idx="1367">
                  <c:v>0.62110351778027972</c:v>
                </c:pt>
                <c:pt idx="1368">
                  <c:v>0.62031230310794816</c:v>
                </c:pt>
                <c:pt idx="1369">
                  <c:v>0.62031230310794816</c:v>
                </c:pt>
                <c:pt idx="1370">
                  <c:v>0.62031230310794816</c:v>
                </c:pt>
                <c:pt idx="1371">
                  <c:v>0.6195200779443365</c:v>
                </c:pt>
                <c:pt idx="1372">
                  <c:v>0.6195200779443365</c:v>
                </c:pt>
                <c:pt idx="1373">
                  <c:v>0.6195200779443365</c:v>
                </c:pt>
                <c:pt idx="1374">
                  <c:v>0.6195200779443365</c:v>
                </c:pt>
                <c:pt idx="1375">
                  <c:v>0.61872480184941436</c:v>
                </c:pt>
                <c:pt idx="1376">
                  <c:v>0.61872480184941436</c:v>
                </c:pt>
                <c:pt idx="1377">
                  <c:v>0.61792952575449223</c:v>
                </c:pt>
                <c:pt idx="1378">
                  <c:v>0.61792952575449223</c:v>
                </c:pt>
                <c:pt idx="1379">
                  <c:v>0.61713424965957009</c:v>
                </c:pt>
                <c:pt idx="1380">
                  <c:v>0.61713424965957009</c:v>
                </c:pt>
                <c:pt idx="1381">
                  <c:v>0.61633897356464795</c:v>
                </c:pt>
                <c:pt idx="1382">
                  <c:v>0.61633897356464795</c:v>
                </c:pt>
                <c:pt idx="1383">
                  <c:v>0.61554369746972581</c:v>
                </c:pt>
                <c:pt idx="1384">
                  <c:v>0.61554369746972581</c:v>
                </c:pt>
                <c:pt idx="1385">
                  <c:v>0.61395314527988154</c:v>
                </c:pt>
                <c:pt idx="1386">
                  <c:v>0.61395314527988154</c:v>
                </c:pt>
                <c:pt idx="1387">
                  <c:v>0.6131578691849594</c:v>
                </c:pt>
                <c:pt idx="1388">
                  <c:v>0.6131578691849594</c:v>
                </c:pt>
                <c:pt idx="1389">
                  <c:v>0.6131578691849594</c:v>
                </c:pt>
                <c:pt idx="1390">
                  <c:v>0.61236156026393995</c:v>
                </c:pt>
                <c:pt idx="1391">
                  <c:v>0.61236156026393995</c:v>
                </c:pt>
                <c:pt idx="1392">
                  <c:v>0.6115652513429205</c:v>
                </c:pt>
                <c:pt idx="1393">
                  <c:v>0.6115652513429205</c:v>
                </c:pt>
                <c:pt idx="1394">
                  <c:v>0.61076894242190105</c:v>
                </c:pt>
                <c:pt idx="1395">
                  <c:v>0.61076894242190105</c:v>
                </c:pt>
                <c:pt idx="1396">
                  <c:v>0.6099726335008816</c:v>
                </c:pt>
                <c:pt idx="1397">
                  <c:v>0.6099726335008816</c:v>
                </c:pt>
                <c:pt idx="1398">
                  <c:v>0.60917632457986215</c:v>
                </c:pt>
                <c:pt idx="1399">
                  <c:v>0.60917632457986215</c:v>
                </c:pt>
                <c:pt idx="1400">
                  <c:v>0.60917632457986215</c:v>
                </c:pt>
                <c:pt idx="1401">
                  <c:v>0.60917632457986215</c:v>
                </c:pt>
                <c:pt idx="1402">
                  <c:v>0.60837792834843374</c:v>
                </c:pt>
                <c:pt idx="1403">
                  <c:v>0.60837792834843374</c:v>
                </c:pt>
                <c:pt idx="1404">
                  <c:v>0.60757953211700533</c:v>
                </c:pt>
                <c:pt idx="1405">
                  <c:v>0.60757953211700533</c:v>
                </c:pt>
                <c:pt idx="1406">
                  <c:v>0.60757953211700533</c:v>
                </c:pt>
                <c:pt idx="1407">
                  <c:v>0.60757953211700533</c:v>
                </c:pt>
                <c:pt idx="1408">
                  <c:v>0.60677903207469042</c:v>
                </c:pt>
                <c:pt idx="1409">
                  <c:v>0.60677903207469042</c:v>
                </c:pt>
                <c:pt idx="1410">
                  <c:v>0.60677903207469042</c:v>
                </c:pt>
                <c:pt idx="1411">
                  <c:v>0.60597747456864726</c:v>
                </c:pt>
                <c:pt idx="1412">
                  <c:v>0.60597747456864726</c:v>
                </c:pt>
                <c:pt idx="1413">
                  <c:v>0.60597747456864726</c:v>
                </c:pt>
                <c:pt idx="1414">
                  <c:v>0.60597747456864726</c:v>
                </c:pt>
                <c:pt idx="1415">
                  <c:v>0.60517379091537316</c:v>
                </c:pt>
                <c:pt idx="1416">
                  <c:v>0.60517379091537316</c:v>
                </c:pt>
                <c:pt idx="1417">
                  <c:v>0.60517379091537316</c:v>
                </c:pt>
                <c:pt idx="1418">
                  <c:v>0.60436903853383672</c:v>
                </c:pt>
                <c:pt idx="1419">
                  <c:v>0.60436903853383672</c:v>
                </c:pt>
                <c:pt idx="1420">
                  <c:v>0.60436903853383672</c:v>
                </c:pt>
                <c:pt idx="1421">
                  <c:v>0.60356321314912498</c:v>
                </c:pt>
                <c:pt idx="1422">
                  <c:v>0.60356321314912498</c:v>
                </c:pt>
                <c:pt idx="1423">
                  <c:v>0.60275738776441323</c:v>
                </c:pt>
                <c:pt idx="1424">
                  <c:v>0.60275738776441323</c:v>
                </c:pt>
                <c:pt idx="1425">
                  <c:v>0.60195156237970149</c:v>
                </c:pt>
                <c:pt idx="1426">
                  <c:v>0.60195156237970149</c:v>
                </c:pt>
                <c:pt idx="1427">
                  <c:v>0.60114573699498974</c:v>
                </c:pt>
                <c:pt idx="1428">
                  <c:v>0.60114573699498974</c:v>
                </c:pt>
                <c:pt idx="1429">
                  <c:v>0.60114573699498974</c:v>
                </c:pt>
                <c:pt idx="1430">
                  <c:v>0.60114573699498974</c:v>
                </c:pt>
                <c:pt idx="1431">
                  <c:v>0.59952975383102469</c:v>
                </c:pt>
                <c:pt idx="1432">
                  <c:v>0.59952975383102469</c:v>
                </c:pt>
                <c:pt idx="1433">
                  <c:v>0.59872067184204891</c:v>
                </c:pt>
                <c:pt idx="1434">
                  <c:v>0.59872067184204891</c:v>
                </c:pt>
                <c:pt idx="1435">
                  <c:v>0.59791158985307313</c:v>
                </c:pt>
                <c:pt idx="1436">
                  <c:v>0.59791158985307313</c:v>
                </c:pt>
                <c:pt idx="1437">
                  <c:v>0.59710250786409735</c:v>
                </c:pt>
                <c:pt idx="1438">
                  <c:v>0.59710250786409735</c:v>
                </c:pt>
                <c:pt idx="1439">
                  <c:v>0.59710250786409735</c:v>
                </c:pt>
                <c:pt idx="1440">
                  <c:v>0.59710250786409735</c:v>
                </c:pt>
                <c:pt idx="1441">
                  <c:v>0.59629122728276029</c:v>
                </c:pt>
                <c:pt idx="1442">
                  <c:v>0.59629122728276029</c:v>
                </c:pt>
                <c:pt idx="1443">
                  <c:v>0.59629122728276029</c:v>
                </c:pt>
                <c:pt idx="1444">
                  <c:v>0.59547884141452767</c:v>
                </c:pt>
                <c:pt idx="1445">
                  <c:v>0.59547884141452767</c:v>
                </c:pt>
                <c:pt idx="1446">
                  <c:v>0.59547884141452767</c:v>
                </c:pt>
                <c:pt idx="1447">
                  <c:v>0.59547884141452767</c:v>
                </c:pt>
                <c:pt idx="1448">
                  <c:v>0.59466423287634085</c:v>
                </c:pt>
                <c:pt idx="1449">
                  <c:v>0.59466423287634085</c:v>
                </c:pt>
                <c:pt idx="1450">
                  <c:v>0.59466423287634085</c:v>
                </c:pt>
                <c:pt idx="1451">
                  <c:v>0.59466423287634085</c:v>
                </c:pt>
                <c:pt idx="1452">
                  <c:v>0.59466423287634085</c:v>
                </c:pt>
                <c:pt idx="1453">
                  <c:v>0.59466423287634085</c:v>
                </c:pt>
                <c:pt idx="1454">
                  <c:v>0.59466423287634085</c:v>
                </c:pt>
                <c:pt idx="1455">
                  <c:v>0.59384400634823553</c:v>
                </c:pt>
                <c:pt idx="1456">
                  <c:v>0.59384400634823553</c:v>
                </c:pt>
                <c:pt idx="1457">
                  <c:v>0.59302377982013021</c:v>
                </c:pt>
                <c:pt idx="1458">
                  <c:v>0.59302377982013021</c:v>
                </c:pt>
                <c:pt idx="1459">
                  <c:v>0.59302377982013021</c:v>
                </c:pt>
                <c:pt idx="1460">
                  <c:v>0.59220241724420208</c:v>
                </c:pt>
                <c:pt idx="1461">
                  <c:v>0.59220241724420208</c:v>
                </c:pt>
                <c:pt idx="1462">
                  <c:v>0.59137991388691846</c:v>
                </c:pt>
                <c:pt idx="1463">
                  <c:v>0.59137991388691846</c:v>
                </c:pt>
                <c:pt idx="1464">
                  <c:v>0.59137991388691846</c:v>
                </c:pt>
                <c:pt idx="1465">
                  <c:v>0.59055626498178349</c:v>
                </c:pt>
                <c:pt idx="1466">
                  <c:v>0.59055626498178349</c:v>
                </c:pt>
                <c:pt idx="1467">
                  <c:v>0.59055626498178349</c:v>
                </c:pt>
                <c:pt idx="1468">
                  <c:v>0.59055626498178349</c:v>
                </c:pt>
                <c:pt idx="1469">
                  <c:v>0.59055626498178349</c:v>
                </c:pt>
                <c:pt idx="1470">
                  <c:v>0.58972799532542752</c:v>
                </c:pt>
                <c:pt idx="1471">
                  <c:v>0.58972799532542752</c:v>
                </c:pt>
                <c:pt idx="1472">
                  <c:v>0.58889972566907156</c:v>
                </c:pt>
                <c:pt idx="1473">
                  <c:v>0.58889972566907156</c:v>
                </c:pt>
                <c:pt idx="1474">
                  <c:v>0.5880714560127156</c:v>
                </c:pt>
                <c:pt idx="1475">
                  <c:v>0.5880714560127156</c:v>
                </c:pt>
                <c:pt idx="1476">
                  <c:v>0.5880714560127156</c:v>
                </c:pt>
                <c:pt idx="1477">
                  <c:v>0.5880714560127156</c:v>
                </c:pt>
                <c:pt idx="1478">
                  <c:v>0.58724084661156772</c:v>
                </c:pt>
                <c:pt idx="1479">
                  <c:v>0.58724084661156772</c:v>
                </c:pt>
                <c:pt idx="1480">
                  <c:v>0.58641023721041985</c:v>
                </c:pt>
                <c:pt idx="1481">
                  <c:v>0.58641023721041985</c:v>
                </c:pt>
                <c:pt idx="1482">
                  <c:v>0.58641023721041985</c:v>
                </c:pt>
                <c:pt idx="1483">
                  <c:v>0.58641023721041985</c:v>
                </c:pt>
                <c:pt idx="1484">
                  <c:v>0.58557489499217141</c:v>
                </c:pt>
                <c:pt idx="1485">
                  <c:v>0.58557489499217141</c:v>
                </c:pt>
                <c:pt idx="1486">
                  <c:v>0.58473955277392298</c:v>
                </c:pt>
                <c:pt idx="1487">
                  <c:v>0.58473955277392298</c:v>
                </c:pt>
                <c:pt idx="1488">
                  <c:v>0.58473955277392298</c:v>
                </c:pt>
                <c:pt idx="1489">
                  <c:v>0.58390301550242951</c:v>
                </c:pt>
                <c:pt idx="1490">
                  <c:v>0.58390301550242951</c:v>
                </c:pt>
                <c:pt idx="1491">
                  <c:v>0.58390301550242951</c:v>
                </c:pt>
                <c:pt idx="1492">
                  <c:v>0.58390301550242951</c:v>
                </c:pt>
                <c:pt idx="1493">
                  <c:v>0.58390301550242951</c:v>
                </c:pt>
                <c:pt idx="1494">
                  <c:v>0.58390301550242951</c:v>
                </c:pt>
                <c:pt idx="1495">
                  <c:v>0.58390301550242951</c:v>
                </c:pt>
                <c:pt idx="1496">
                  <c:v>0.58306044260848666</c:v>
                </c:pt>
                <c:pt idx="1497">
                  <c:v>0.58306044260848666</c:v>
                </c:pt>
                <c:pt idx="1498">
                  <c:v>0.58306044260848666</c:v>
                </c:pt>
                <c:pt idx="1499">
                  <c:v>0.58221542747427146</c:v>
                </c:pt>
                <c:pt idx="1500">
                  <c:v>0.58221542747427146</c:v>
                </c:pt>
                <c:pt idx="1501">
                  <c:v>0.58137041234005626</c:v>
                </c:pt>
                <c:pt idx="1502">
                  <c:v>0.58137041234005626</c:v>
                </c:pt>
                <c:pt idx="1503">
                  <c:v>0.58052539720584106</c:v>
                </c:pt>
                <c:pt idx="1504">
                  <c:v>0.58052539720584106</c:v>
                </c:pt>
                <c:pt idx="1505">
                  <c:v>0.58052539720584106</c:v>
                </c:pt>
                <c:pt idx="1506">
                  <c:v>0.57883290333643633</c:v>
                </c:pt>
                <c:pt idx="1507">
                  <c:v>0.57883290333643633</c:v>
                </c:pt>
                <c:pt idx="1508">
                  <c:v>0.57883290333643633</c:v>
                </c:pt>
                <c:pt idx="1509">
                  <c:v>0.57883290333643633</c:v>
                </c:pt>
                <c:pt idx="1510">
                  <c:v>0.57883290333643633</c:v>
                </c:pt>
                <c:pt idx="1511">
                  <c:v>0.57883290333643633</c:v>
                </c:pt>
                <c:pt idx="1512">
                  <c:v>0.57798167847858861</c:v>
                </c:pt>
                <c:pt idx="1513">
                  <c:v>0.57798167847858861</c:v>
                </c:pt>
                <c:pt idx="1514">
                  <c:v>0.57798167847858861</c:v>
                </c:pt>
                <c:pt idx="1515">
                  <c:v>0.57798167847858861</c:v>
                </c:pt>
                <c:pt idx="1516">
                  <c:v>0.57712793892396741</c:v>
                </c:pt>
                <c:pt idx="1517">
                  <c:v>0.57712793892396741</c:v>
                </c:pt>
                <c:pt idx="1518">
                  <c:v>0.57627419936934621</c:v>
                </c:pt>
                <c:pt idx="1519">
                  <c:v>0.57627419936934621</c:v>
                </c:pt>
                <c:pt idx="1520">
                  <c:v>0.575420459814725</c:v>
                </c:pt>
                <c:pt idx="1521">
                  <c:v>0.575420459814725</c:v>
                </c:pt>
                <c:pt idx="1522">
                  <c:v>0.5745667202601038</c:v>
                </c:pt>
                <c:pt idx="1523">
                  <c:v>0.5745667202601038</c:v>
                </c:pt>
                <c:pt idx="1524">
                  <c:v>0.5737129807054826</c:v>
                </c:pt>
                <c:pt idx="1525">
                  <c:v>0.5737129807054826</c:v>
                </c:pt>
                <c:pt idx="1526">
                  <c:v>0.5737129807054826</c:v>
                </c:pt>
                <c:pt idx="1527">
                  <c:v>0.5737129807054826</c:v>
                </c:pt>
                <c:pt idx="1528">
                  <c:v>0.5737129807054826</c:v>
                </c:pt>
                <c:pt idx="1529">
                  <c:v>0.5737129807054826</c:v>
                </c:pt>
                <c:pt idx="1530">
                  <c:v>0.5737129807054826</c:v>
                </c:pt>
                <c:pt idx="1531">
                  <c:v>0.57285025441870741</c:v>
                </c:pt>
                <c:pt idx="1532">
                  <c:v>0.57285025441870741</c:v>
                </c:pt>
                <c:pt idx="1533">
                  <c:v>0.57285025441870741</c:v>
                </c:pt>
                <c:pt idx="1534">
                  <c:v>0.57285025441870741</c:v>
                </c:pt>
                <c:pt idx="1535">
                  <c:v>0.5719836125814628</c:v>
                </c:pt>
                <c:pt idx="1536">
                  <c:v>0.5719836125814628</c:v>
                </c:pt>
                <c:pt idx="1537">
                  <c:v>0.5719836125814628</c:v>
                </c:pt>
                <c:pt idx="1538">
                  <c:v>0.56937578456057469</c:v>
                </c:pt>
                <c:pt idx="1539">
                  <c:v>0.56937578456057469</c:v>
                </c:pt>
                <c:pt idx="1540">
                  <c:v>0.56937578456057469</c:v>
                </c:pt>
                <c:pt idx="1541">
                  <c:v>0.56850517938540557</c:v>
                </c:pt>
                <c:pt idx="1542">
                  <c:v>0.56850517938540557</c:v>
                </c:pt>
                <c:pt idx="1543">
                  <c:v>0.56850517938540557</c:v>
                </c:pt>
                <c:pt idx="1544">
                  <c:v>0.56763323892622553</c:v>
                </c:pt>
                <c:pt idx="1545">
                  <c:v>0.56763323892622553</c:v>
                </c:pt>
                <c:pt idx="1546">
                  <c:v>0.56676129846704548</c:v>
                </c:pt>
                <c:pt idx="1547">
                  <c:v>0.56676129846704548</c:v>
                </c:pt>
                <c:pt idx="1548">
                  <c:v>0.56676129846704548</c:v>
                </c:pt>
                <c:pt idx="1549">
                  <c:v>0.56588801449406079</c:v>
                </c:pt>
                <c:pt idx="1550">
                  <c:v>0.56588801449406079</c:v>
                </c:pt>
                <c:pt idx="1551">
                  <c:v>0.56501473052107609</c:v>
                </c:pt>
                <c:pt idx="1552">
                  <c:v>0.56501473052107609</c:v>
                </c:pt>
                <c:pt idx="1553">
                  <c:v>0.5641414465480914</c:v>
                </c:pt>
                <c:pt idx="1554">
                  <c:v>0.5641414465480914</c:v>
                </c:pt>
                <c:pt idx="1555">
                  <c:v>0.5632681625751067</c:v>
                </c:pt>
                <c:pt idx="1556">
                  <c:v>0.5632681625751067</c:v>
                </c:pt>
                <c:pt idx="1557">
                  <c:v>0.5632681625751067</c:v>
                </c:pt>
                <c:pt idx="1558">
                  <c:v>0.56239352257110808</c:v>
                </c:pt>
                <c:pt idx="1559">
                  <c:v>0.56239352257110808</c:v>
                </c:pt>
                <c:pt idx="1560">
                  <c:v>0.56239352257110808</c:v>
                </c:pt>
                <c:pt idx="1561">
                  <c:v>0.56151752019950196</c:v>
                </c:pt>
                <c:pt idx="1562">
                  <c:v>0.56151752019950196</c:v>
                </c:pt>
                <c:pt idx="1563">
                  <c:v>0.56151752019950196</c:v>
                </c:pt>
                <c:pt idx="1564">
                  <c:v>0.56064014907419024</c:v>
                </c:pt>
                <c:pt idx="1565">
                  <c:v>0.56064014907419024</c:v>
                </c:pt>
                <c:pt idx="1566">
                  <c:v>0.56064014907419024</c:v>
                </c:pt>
                <c:pt idx="1567">
                  <c:v>0.55976140275902697</c:v>
                </c:pt>
                <c:pt idx="1568">
                  <c:v>0.55976140275902697</c:v>
                </c:pt>
                <c:pt idx="1569">
                  <c:v>0.55976140275902697</c:v>
                </c:pt>
                <c:pt idx="1570">
                  <c:v>0.55800114677550805</c:v>
                </c:pt>
                <c:pt idx="1571">
                  <c:v>0.55800114677550805</c:v>
                </c:pt>
                <c:pt idx="1572">
                  <c:v>0.55800114677550805</c:v>
                </c:pt>
                <c:pt idx="1573">
                  <c:v>0.55800114677550805</c:v>
                </c:pt>
                <c:pt idx="1574">
                  <c:v>0.55711823356858481</c:v>
                </c:pt>
                <c:pt idx="1575">
                  <c:v>0.55711823356858481</c:v>
                </c:pt>
                <c:pt idx="1576">
                  <c:v>0.55711823356858481</c:v>
                </c:pt>
                <c:pt idx="1577">
                  <c:v>0.55711823356858481</c:v>
                </c:pt>
                <c:pt idx="1578">
                  <c:v>0.55711823356858481</c:v>
                </c:pt>
                <c:pt idx="1579">
                  <c:v>0.55622826833924199</c:v>
                </c:pt>
                <c:pt idx="1580">
                  <c:v>0.55622826833924199</c:v>
                </c:pt>
                <c:pt idx="1581">
                  <c:v>0.55622826833924199</c:v>
                </c:pt>
                <c:pt idx="1582">
                  <c:v>0.55622826833924199</c:v>
                </c:pt>
                <c:pt idx="1583">
                  <c:v>0.55622826833924199</c:v>
                </c:pt>
                <c:pt idx="1584">
                  <c:v>0.55622826833924199</c:v>
                </c:pt>
                <c:pt idx="1585">
                  <c:v>0.55622826833924199</c:v>
                </c:pt>
                <c:pt idx="1586">
                  <c:v>0.55622826833924199</c:v>
                </c:pt>
                <c:pt idx="1587">
                  <c:v>0.55532967662948551</c:v>
                </c:pt>
                <c:pt idx="1588">
                  <c:v>0.55532967662948551</c:v>
                </c:pt>
                <c:pt idx="1589">
                  <c:v>0.55532967662948551</c:v>
                </c:pt>
                <c:pt idx="1590">
                  <c:v>0.55532967662948551</c:v>
                </c:pt>
                <c:pt idx="1591">
                  <c:v>0.55442816741417789</c:v>
                </c:pt>
                <c:pt idx="1592">
                  <c:v>0.55442816741417789</c:v>
                </c:pt>
                <c:pt idx="1593">
                  <c:v>0.55442816741417789</c:v>
                </c:pt>
                <c:pt idx="1594">
                  <c:v>0.55442816741417789</c:v>
                </c:pt>
                <c:pt idx="1595">
                  <c:v>0.55442816741417789</c:v>
                </c:pt>
                <c:pt idx="1596">
                  <c:v>0.55442816741417789</c:v>
                </c:pt>
                <c:pt idx="1597">
                  <c:v>0.55442816741417789</c:v>
                </c:pt>
                <c:pt idx="1598">
                  <c:v>0.55351926877907265</c:v>
                </c:pt>
                <c:pt idx="1599">
                  <c:v>0.55351926877907265</c:v>
                </c:pt>
                <c:pt idx="1600">
                  <c:v>0.55170147150886228</c:v>
                </c:pt>
                <c:pt idx="1601">
                  <c:v>0.55170147150886228</c:v>
                </c:pt>
                <c:pt idx="1602">
                  <c:v>0.55170147150886228</c:v>
                </c:pt>
                <c:pt idx="1603">
                  <c:v>0.55170147150886228</c:v>
                </c:pt>
                <c:pt idx="1604">
                  <c:v>0.55170147150886228</c:v>
                </c:pt>
                <c:pt idx="1605">
                  <c:v>0.5507865436954148</c:v>
                </c:pt>
                <c:pt idx="1606">
                  <c:v>0.5507865436954148</c:v>
                </c:pt>
                <c:pt idx="1607">
                  <c:v>0.54987161588196731</c:v>
                </c:pt>
                <c:pt idx="1608">
                  <c:v>0.54987161588196731</c:v>
                </c:pt>
                <c:pt idx="1609">
                  <c:v>0.54987161588196731</c:v>
                </c:pt>
                <c:pt idx="1610">
                  <c:v>0.54987161588196731</c:v>
                </c:pt>
                <c:pt idx="1611">
                  <c:v>0.54987161588196731</c:v>
                </c:pt>
                <c:pt idx="1612">
                  <c:v>0.54987161588196731</c:v>
                </c:pt>
                <c:pt idx="1613">
                  <c:v>0.54987161588196731</c:v>
                </c:pt>
                <c:pt idx="1614">
                  <c:v>0.5489474619056951</c:v>
                </c:pt>
                <c:pt idx="1615">
                  <c:v>0.5489474619056951</c:v>
                </c:pt>
                <c:pt idx="1616">
                  <c:v>0.5489474619056951</c:v>
                </c:pt>
                <c:pt idx="1617">
                  <c:v>0.5489474619056951</c:v>
                </c:pt>
                <c:pt idx="1618">
                  <c:v>0.54708977167927986</c:v>
                </c:pt>
                <c:pt idx="1619">
                  <c:v>0.54708977167927986</c:v>
                </c:pt>
                <c:pt idx="1620">
                  <c:v>0.54708977167927986</c:v>
                </c:pt>
                <c:pt idx="1621">
                  <c:v>0.54708977167927986</c:v>
                </c:pt>
                <c:pt idx="1622">
                  <c:v>0.54708977167927986</c:v>
                </c:pt>
                <c:pt idx="1623">
                  <c:v>0.54615457548837509</c:v>
                </c:pt>
                <c:pt idx="1624">
                  <c:v>0.54615457548837509</c:v>
                </c:pt>
                <c:pt idx="1625">
                  <c:v>0.54521777518736592</c:v>
                </c:pt>
                <c:pt idx="1626">
                  <c:v>0.54521777518736592</c:v>
                </c:pt>
                <c:pt idx="1627">
                  <c:v>0.54428097488635674</c:v>
                </c:pt>
                <c:pt idx="1628">
                  <c:v>0.54428097488635674</c:v>
                </c:pt>
                <c:pt idx="1629">
                  <c:v>0.54428097488635674</c:v>
                </c:pt>
                <c:pt idx="1630">
                  <c:v>0.54334093866030087</c:v>
                </c:pt>
                <c:pt idx="1631">
                  <c:v>0.54334093866030087</c:v>
                </c:pt>
                <c:pt idx="1632">
                  <c:v>0.54334093866030087</c:v>
                </c:pt>
                <c:pt idx="1633">
                  <c:v>0.54239927325534365</c:v>
                </c:pt>
                <c:pt idx="1634">
                  <c:v>0.54239927325534365</c:v>
                </c:pt>
                <c:pt idx="1635">
                  <c:v>0.54145760785038644</c:v>
                </c:pt>
                <c:pt idx="1636">
                  <c:v>0.54145760785038644</c:v>
                </c:pt>
                <c:pt idx="1637">
                  <c:v>0.54145760785038644</c:v>
                </c:pt>
                <c:pt idx="1638">
                  <c:v>0.5405143019133648</c:v>
                </c:pt>
                <c:pt idx="1639">
                  <c:v>0.5405143019133648</c:v>
                </c:pt>
                <c:pt idx="1640">
                  <c:v>0.53957099597634317</c:v>
                </c:pt>
                <c:pt idx="1641">
                  <c:v>0.53957099597634317</c:v>
                </c:pt>
                <c:pt idx="1642">
                  <c:v>0.53957099597634317</c:v>
                </c:pt>
                <c:pt idx="1643">
                  <c:v>0.53862603801491349</c:v>
                </c:pt>
                <c:pt idx="1644">
                  <c:v>0.53862603801491349</c:v>
                </c:pt>
                <c:pt idx="1645">
                  <c:v>0.53862603801491349</c:v>
                </c:pt>
                <c:pt idx="1646">
                  <c:v>0.53767941931892949</c:v>
                </c:pt>
                <c:pt idx="1647">
                  <c:v>0.53767941931892949</c:v>
                </c:pt>
                <c:pt idx="1648">
                  <c:v>0.53767941931892949</c:v>
                </c:pt>
                <c:pt idx="1649">
                  <c:v>0.53767941931892949</c:v>
                </c:pt>
                <c:pt idx="1650">
                  <c:v>0.53767941931892949</c:v>
                </c:pt>
                <c:pt idx="1651">
                  <c:v>0.53672777432898444</c:v>
                </c:pt>
                <c:pt idx="1652">
                  <c:v>0.53672777432898444</c:v>
                </c:pt>
                <c:pt idx="1653">
                  <c:v>0.53482448434909446</c:v>
                </c:pt>
                <c:pt idx="1654">
                  <c:v>0.53482448434909446</c:v>
                </c:pt>
                <c:pt idx="1655">
                  <c:v>0.53387283935914942</c:v>
                </c:pt>
                <c:pt idx="1656">
                  <c:v>0.53387283935914942</c:v>
                </c:pt>
                <c:pt idx="1657">
                  <c:v>0.53292119436920438</c:v>
                </c:pt>
                <c:pt idx="1658">
                  <c:v>0.53292119436920438</c:v>
                </c:pt>
                <c:pt idx="1659">
                  <c:v>0.53292119436920438</c:v>
                </c:pt>
                <c:pt idx="1660">
                  <c:v>0.53292119436920438</c:v>
                </c:pt>
                <c:pt idx="1661">
                  <c:v>0.53292119436920438</c:v>
                </c:pt>
                <c:pt idx="1662">
                  <c:v>0.53292119436920438</c:v>
                </c:pt>
                <c:pt idx="1663">
                  <c:v>0.53292119436920438</c:v>
                </c:pt>
                <c:pt idx="1664">
                  <c:v>0.53292119436920438</c:v>
                </c:pt>
                <c:pt idx="1665">
                  <c:v>0.53292119436920438</c:v>
                </c:pt>
                <c:pt idx="1666">
                  <c:v>0.53292119436920438</c:v>
                </c:pt>
                <c:pt idx="1667">
                  <c:v>0.53292119436920438</c:v>
                </c:pt>
                <c:pt idx="1668">
                  <c:v>0.53195400526871583</c:v>
                </c:pt>
                <c:pt idx="1669">
                  <c:v>0.53195400526871583</c:v>
                </c:pt>
                <c:pt idx="1670">
                  <c:v>0.53098681616822729</c:v>
                </c:pt>
                <c:pt idx="1671">
                  <c:v>0.53098681616822729</c:v>
                </c:pt>
                <c:pt idx="1672">
                  <c:v>0.53098681616822729</c:v>
                </c:pt>
                <c:pt idx="1673">
                  <c:v>0.53001786212412472</c:v>
                </c:pt>
                <c:pt idx="1674">
                  <c:v>0.53001786212412472</c:v>
                </c:pt>
                <c:pt idx="1675">
                  <c:v>0.52904713343891574</c:v>
                </c:pt>
                <c:pt idx="1676">
                  <c:v>0.52904713343891574</c:v>
                </c:pt>
                <c:pt idx="1677">
                  <c:v>0.52807640475370676</c:v>
                </c:pt>
                <c:pt idx="1678">
                  <c:v>0.52807640475370676</c:v>
                </c:pt>
                <c:pt idx="1679">
                  <c:v>0.52807640475370676</c:v>
                </c:pt>
                <c:pt idx="1680">
                  <c:v>0.52807640475370676</c:v>
                </c:pt>
                <c:pt idx="1681">
                  <c:v>0.52807640475370676</c:v>
                </c:pt>
                <c:pt idx="1682">
                  <c:v>0.52807640475370676</c:v>
                </c:pt>
                <c:pt idx="1683">
                  <c:v>0.52709848548564431</c:v>
                </c:pt>
                <c:pt idx="1684">
                  <c:v>0.52709848548564431</c:v>
                </c:pt>
                <c:pt idx="1685">
                  <c:v>0.52612056621758185</c:v>
                </c:pt>
                <c:pt idx="1686">
                  <c:v>0.52612056621758185</c:v>
                </c:pt>
                <c:pt idx="1687">
                  <c:v>0.52612056621758185</c:v>
                </c:pt>
                <c:pt idx="1688">
                  <c:v>0.52513899799702668</c:v>
                </c:pt>
                <c:pt idx="1689">
                  <c:v>0.52513899799702668</c:v>
                </c:pt>
                <c:pt idx="1690">
                  <c:v>0.52513899799702668</c:v>
                </c:pt>
                <c:pt idx="1691">
                  <c:v>0.52513899799702668</c:v>
                </c:pt>
                <c:pt idx="1692">
                  <c:v>0.5241537465936551</c:v>
                </c:pt>
                <c:pt idx="1693">
                  <c:v>0.5241537465936551</c:v>
                </c:pt>
                <c:pt idx="1694">
                  <c:v>0.5241537465936551</c:v>
                </c:pt>
                <c:pt idx="1695">
                  <c:v>0.52316663972624711</c:v>
                </c:pt>
                <c:pt idx="1696">
                  <c:v>0.52316663972624711</c:v>
                </c:pt>
                <c:pt idx="1697">
                  <c:v>0.52119242599143112</c:v>
                </c:pt>
                <c:pt idx="1698">
                  <c:v>0.52119242599143112</c:v>
                </c:pt>
                <c:pt idx="1699">
                  <c:v>0.52020531912402312</c:v>
                </c:pt>
                <c:pt idx="1700">
                  <c:v>0.52020531912402312</c:v>
                </c:pt>
                <c:pt idx="1701">
                  <c:v>0.52020531912402312</c:v>
                </c:pt>
                <c:pt idx="1702">
                  <c:v>0.52020531912402312</c:v>
                </c:pt>
                <c:pt idx="1703">
                  <c:v>0.52020531912402312</c:v>
                </c:pt>
                <c:pt idx="1704">
                  <c:v>0.51921066268210336</c:v>
                </c:pt>
                <c:pt idx="1705">
                  <c:v>0.51921066268210336</c:v>
                </c:pt>
                <c:pt idx="1706">
                  <c:v>0.51921066268210336</c:v>
                </c:pt>
                <c:pt idx="1707">
                  <c:v>0.51921066268210336</c:v>
                </c:pt>
                <c:pt idx="1708">
                  <c:v>0.51921066268210336</c:v>
                </c:pt>
                <c:pt idx="1709">
                  <c:v>0.51821025678098176</c:v>
                </c:pt>
                <c:pt idx="1710">
                  <c:v>0.51821025678098176</c:v>
                </c:pt>
                <c:pt idx="1711">
                  <c:v>0.51821025678098176</c:v>
                </c:pt>
                <c:pt idx="1712">
                  <c:v>0.51821025678098176</c:v>
                </c:pt>
                <c:pt idx="1713">
                  <c:v>0.51821025678098176</c:v>
                </c:pt>
                <c:pt idx="1714">
                  <c:v>0.51821025678098176</c:v>
                </c:pt>
                <c:pt idx="1715">
                  <c:v>0.51821025678098176</c:v>
                </c:pt>
                <c:pt idx="1716">
                  <c:v>0.51821025678098176</c:v>
                </c:pt>
                <c:pt idx="1717">
                  <c:v>0.51821025678098176</c:v>
                </c:pt>
                <c:pt idx="1718">
                  <c:v>0.51719614668943381</c:v>
                </c:pt>
                <c:pt idx="1719">
                  <c:v>0.51719614668943381</c:v>
                </c:pt>
                <c:pt idx="1720">
                  <c:v>0.51719614668943381</c:v>
                </c:pt>
                <c:pt idx="1721">
                  <c:v>0.51719614668943381</c:v>
                </c:pt>
                <c:pt idx="1722">
                  <c:v>0.51617401991732026</c:v>
                </c:pt>
                <c:pt idx="1723">
                  <c:v>0.51617401991732026</c:v>
                </c:pt>
                <c:pt idx="1724">
                  <c:v>0.51617401991732026</c:v>
                </c:pt>
                <c:pt idx="1725">
                  <c:v>0.51617401991732026</c:v>
                </c:pt>
                <c:pt idx="1726">
                  <c:v>0.51617401991732026</c:v>
                </c:pt>
                <c:pt idx="1727">
                  <c:v>0.51617401991732026</c:v>
                </c:pt>
                <c:pt idx="1728">
                  <c:v>0.51617401991732026</c:v>
                </c:pt>
                <c:pt idx="1729">
                  <c:v>0.51617401991732026</c:v>
                </c:pt>
                <c:pt idx="1730">
                  <c:v>0.51617401991732026</c:v>
                </c:pt>
                <c:pt idx="1731">
                  <c:v>0.51617401991732026</c:v>
                </c:pt>
                <c:pt idx="1732">
                  <c:v>0.51617401991732026</c:v>
                </c:pt>
                <c:pt idx="1733">
                  <c:v>0.51617401991732026</c:v>
                </c:pt>
                <c:pt idx="1734">
                  <c:v>0.51617401991732026</c:v>
                </c:pt>
                <c:pt idx="1735">
                  <c:v>0.51617401991732026</c:v>
                </c:pt>
                <c:pt idx="1736">
                  <c:v>0.51512274900099175</c:v>
                </c:pt>
                <c:pt idx="1737">
                  <c:v>0.51512274900099175</c:v>
                </c:pt>
                <c:pt idx="1738">
                  <c:v>0.51512274900099175</c:v>
                </c:pt>
                <c:pt idx="1739">
                  <c:v>0.51512274900099175</c:v>
                </c:pt>
                <c:pt idx="1740">
                  <c:v>0.51512274900099175</c:v>
                </c:pt>
                <c:pt idx="1741">
                  <c:v>0.51512274900099175</c:v>
                </c:pt>
                <c:pt idx="1742">
                  <c:v>0.51512274900099175</c:v>
                </c:pt>
                <c:pt idx="1743">
                  <c:v>0.51512274900099175</c:v>
                </c:pt>
                <c:pt idx="1744">
                  <c:v>0.51405844580057647</c:v>
                </c:pt>
                <c:pt idx="1745">
                  <c:v>0.51405844580057647</c:v>
                </c:pt>
                <c:pt idx="1746">
                  <c:v>0.51405844580057647</c:v>
                </c:pt>
                <c:pt idx="1747">
                  <c:v>0.51405844580057647</c:v>
                </c:pt>
                <c:pt idx="1748">
                  <c:v>0.51298971722302844</c:v>
                </c:pt>
                <c:pt idx="1749">
                  <c:v>0.51298971722302844</c:v>
                </c:pt>
                <c:pt idx="1750">
                  <c:v>0.51192098864548041</c:v>
                </c:pt>
                <c:pt idx="1751">
                  <c:v>0.51192098864548041</c:v>
                </c:pt>
                <c:pt idx="1752">
                  <c:v>0.51192098864548041</c:v>
                </c:pt>
                <c:pt idx="1753">
                  <c:v>0.51192098864548041</c:v>
                </c:pt>
                <c:pt idx="1754">
                  <c:v>0.51192098864548041</c:v>
                </c:pt>
                <c:pt idx="1755">
                  <c:v>0.51192098864548041</c:v>
                </c:pt>
                <c:pt idx="1756">
                  <c:v>0.51192098864548041</c:v>
                </c:pt>
                <c:pt idx="1757">
                  <c:v>0.51192098864548041</c:v>
                </c:pt>
                <c:pt idx="1758">
                  <c:v>0.51083641027970605</c:v>
                </c:pt>
                <c:pt idx="1759">
                  <c:v>0.51083641027970605</c:v>
                </c:pt>
                <c:pt idx="1760">
                  <c:v>0.51083641027970605</c:v>
                </c:pt>
                <c:pt idx="1761">
                  <c:v>0.51083641027970605</c:v>
                </c:pt>
                <c:pt idx="1762">
                  <c:v>0.51083641027970605</c:v>
                </c:pt>
                <c:pt idx="1763">
                  <c:v>0.51083641027970605</c:v>
                </c:pt>
                <c:pt idx="1764">
                  <c:v>0.51083641027970605</c:v>
                </c:pt>
                <c:pt idx="1765">
                  <c:v>0.51083641027970605</c:v>
                </c:pt>
                <c:pt idx="1766">
                  <c:v>0.50973783735437339</c:v>
                </c:pt>
                <c:pt idx="1767">
                  <c:v>0.50973783735437339</c:v>
                </c:pt>
                <c:pt idx="1768">
                  <c:v>0.50863926442904073</c:v>
                </c:pt>
                <c:pt idx="1769">
                  <c:v>0.50863926442904073</c:v>
                </c:pt>
                <c:pt idx="1770">
                  <c:v>0.50863926442904073</c:v>
                </c:pt>
                <c:pt idx="1771">
                  <c:v>0.50863926442904073</c:v>
                </c:pt>
                <c:pt idx="1772">
                  <c:v>0.50753592546064796</c:v>
                </c:pt>
                <c:pt idx="1773">
                  <c:v>0.50753592546064796</c:v>
                </c:pt>
                <c:pt idx="1774">
                  <c:v>0.50753592546064796</c:v>
                </c:pt>
                <c:pt idx="1775">
                  <c:v>0.50643018270365314</c:v>
                </c:pt>
                <c:pt idx="1776">
                  <c:v>0.50643018270365314</c:v>
                </c:pt>
                <c:pt idx="1777">
                  <c:v>0.50532202037826224</c:v>
                </c:pt>
                <c:pt idx="1778">
                  <c:v>0.50532202037826224</c:v>
                </c:pt>
                <c:pt idx="1779">
                  <c:v>0.50532202037826224</c:v>
                </c:pt>
                <c:pt idx="1780">
                  <c:v>0.50421142253127704</c:v>
                </c:pt>
                <c:pt idx="1781">
                  <c:v>0.50421142253127704</c:v>
                </c:pt>
                <c:pt idx="1782">
                  <c:v>0.50310082468429185</c:v>
                </c:pt>
                <c:pt idx="1783">
                  <c:v>0.50310082468429185</c:v>
                </c:pt>
                <c:pt idx="1784">
                  <c:v>0.50199022683730665</c:v>
                </c:pt>
                <c:pt idx="1785">
                  <c:v>0.50199022683730665</c:v>
                </c:pt>
                <c:pt idx="1786">
                  <c:v>0.50199022683730665</c:v>
                </c:pt>
                <c:pt idx="1787">
                  <c:v>0.50087716646737912</c:v>
                </c:pt>
                <c:pt idx="1788">
                  <c:v>0.50087716646737912</c:v>
                </c:pt>
                <c:pt idx="1789">
                  <c:v>0.50087716646737912</c:v>
                </c:pt>
                <c:pt idx="1790">
                  <c:v>0.50087716646737912</c:v>
                </c:pt>
                <c:pt idx="1791">
                  <c:v>0.49975913707794301</c:v>
                </c:pt>
                <c:pt idx="1792">
                  <c:v>0.49975913707794301</c:v>
                </c:pt>
                <c:pt idx="1793">
                  <c:v>0.49975913707794301</c:v>
                </c:pt>
                <c:pt idx="1794">
                  <c:v>0.49863608283731842</c:v>
                </c:pt>
                <c:pt idx="1795">
                  <c:v>0.49863608283731842</c:v>
                </c:pt>
                <c:pt idx="1796">
                  <c:v>0.49863608283731842</c:v>
                </c:pt>
                <c:pt idx="1797">
                  <c:v>0.49863608283731842</c:v>
                </c:pt>
                <c:pt idx="1798">
                  <c:v>0.49863608283731842</c:v>
                </c:pt>
                <c:pt idx="1799">
                  <c:v>0.49750538877192768</c:v>
                </c:pt>
                <c:pt idx="1800">
                  <c:v>0.49750538877192768</c:v>
                </c:pt>
                <c:pt idx="1801">
                  <c:v>0.49750538877192768</c:v>
                </c:pt>
                <c:pt idx="1802">
                  <c:v>0.49636953171993697</c:v>
                </c:pt>
                <c:pt idx="1803">
                  <c:v>0.49636953171993697</c:v>
                </c:pt>
                <c:pt idx="1804">
                  <c:v>0.49636953171993697</c:v>
                </c:pt>
                <c:pt idx="1805">
                  <c:v>0.49636953171993697</c:v>
                </c:pt>
                <c:pt idx="1806">
                  <c:v>0.49636953171993697</c:v>
                </c:pt>
                <c:pt idx="1807">
                  <c:v>0.49636953171993697</c:v>
                </c:pt>
                <c:pt idx="1808">
                  <c:v>0.49636953171993697</c:v>
                </c:pt>
                <c:pt idx="1809">
                  <c:v>0.49636953171993697</c:v>
                </c:pt>
                <c:pt idx="1810">
                  <c:v>0.49636953171993697</c:v>
                </c:pt>
                <c:pt idx="1811">
                  <c:v>0.49636953171993697</c:v>
                </c:pt>
                <c:pt idx="1812">
                  <c:v>0.49520160341000768</c:v>
                </c:pt>
                <c:pt idx="1813">
                  <c:v>0.49520160341000768</c:v>
                </c:pt>
                <c:pt idx="1814">
                  <c:v>0.49520160341000768</c:v>
                </c:pt>
                <c:pt idx="1815">
                  <c:v>0.49403091404024407</c:v>
                </c:pt>
                <c:pt idx="1816">
                  <c:v>0.49403091404024407</c:v>
                </c:pt>
                <c:pt idx="1817">
                  <c:v>0.49403091404024407</c:v>
                </c:pt>
                <c:pt idx="1818">
                  <c:v>0.49285744393563541</c:v>
                </c:pt>
                <c:pt idx="1819">
                  <c:v>0.49285744393563541</c:v>
                </c:pt>
                <c:pt idx="1820">
                  <c:v>0.49285744393563541</c:v>
                </c:pt>
                <c:pt idx="1821">
                  <c:v>0.49285744393563541</c:v>
                </c:pt>
                <c:pt idx="1822">
                  <c:v>0.49285744393563541</c:v>
                </c:pt>
                <c:pt idx="1823">
                  <c:v>0.49285744393563541</c:v>
                </c:pt>
                <c:pt idx="1824">
                  <c:v>0.49285744393563541</c:v>
                </c:pt>
                <c:pt idx="1825">
                  <c:v>0.49166696701791646</c:v>
                </c:pt>
                <c:pt idx="1826">
                  <c:v>0.49166696701791646</c:v>
                </c:pt>
                <c:pt idx="1827">
                  <c:v>0.4904764901001975</c:v>
                </c:pt>
                <c:pt idx="1828">
                  <c:v>0.4904764901001975</c:v>
                </c:pt>
                <c:pt idx="1829">
                  <c:v>0.4904764901001975</c:v>
                </c:pt>
                <c:pt idx="1830">
                  <c:v>0.4904764901001975</c:v>
                </c:pt>
                <c:pt idx="1831">
                  <c:v>0.4904764901001975</c:v>
                </c:pt>
                <c:pt idx="1832">
                  <c:v>0.4904764901001975</c:v>
                </c:pt>
                <c:pt idx="1833">
                  <c:v>0.48927434184014801</c:v>
                </c:pt>
                <c:pt idx="1834">
                  <c:v>0.48927434184014801</c:v>
                </c:pt>
                <c:pt idx="1835">
                  <c:v>0.48807219358009851</c:v>
                </c:pt>
                <c:pt idx="1836">
                  <c:v>0.48807219358009851</c:v>
                </c:pt>
                <c:pt idx="1837">
                  <c:v>0.48566789705999952</c:v>
                </c:pt>
                <c:pt idx="1838">
                  <c:v>0.48566789705999952</c:v>
                </c:pt>
                <c:pt idx="1839">
                  <c:v>0.48446574879995002</c:v>
                </c:pt>
                <c:pt idx="1840">
                  <c:v>0.48446574879995002</c:v>
                </c:pt>
                <c:pt idx="1841">
                  <c:v>0.48446574879995002</c:v>
                </c:pt>
                <c:pt idx="1842">
                  <c:v>0.48446574879995002</c:v>
                </c:pt>
                <c:pt idx="1843">
                  <c:v>0.48446574879995002</c:v>
                </c:pt>
                <c:pt idx="1844">
                  <c:v>0.48446574879995002</c:v>
                </c:pt>
                <c:pt idx="1845">
                  <c:v>0.48446574879995002</c:v>
                </c:pt>
                <c:pt idx="1846">
                  <c:v>0.48446574879995002</c:v>
                </c:pt>
                <c:pt idx="1847">
                  <c:v>0.4832454320523431</c:v>
                </c:pt>
                <c:pt idx="1848">
                  <c:v>0.4832454320523431</c:v>
                </c:pt>
                <c:pt idx="1849">
                  <c:v>0.4832454320523431</c:v>
                </c:pt>
                <c:pt idx="1850">
                  <c:v>0.4832454320523431</c:v>
                </c:pt>
                <c:pt idx="1851">
                  <c:v>0.4832454320523431</c:v>
                </c:pt>
                <c:pt idx="1852">
                  <c:v>0.48201579990971627</c:v>
                </c:pt>
                <c:pt idx="1853">
                  <c:v>0.48201579990971627</c:v>
                </c:pt>
                <c:pt idx="1854">
                  <c:v>0.48201579990971627</c:v>
                </c:pt>
                <c:pt idx="1855">
                  <c:v>0.48201579990971627</c:v>
                </c:pt>
                <c:pt idx="1856">
                  <c:v>0.48201579990971627</c:v>
                </c:pt>
                <c:pt idx="1857">
                  <c:v>0.48077349114706236</c:v>
                </c:pt>
                <c:pt idx="1858">
                  <c:v>0.48077349114706236</c:v>
                </c:pt>
                <c:pt idx="1859">
                  <c:v>0.48077349114706236</c:v>
                </c:pt>
                <c:pt idx="1860">
                  <c:v>0.48077349114706236</c:v>
                </c:pt>
                <c:pt idx="1861">
                  <c:v>0.48077349114706236</c:v>
                </c:pt>
                <c:pt idx="1862">
                  <c:v>0.47825635244995734</c:v>
                </c:pt>
                <c:pt idx="1863">
                  <c:v>0.47825635244995734</c:v>
                </c:pt>
                <c:pt idx="1864">
                  <c:v>0.47825635244995734</c:v>
                </c:pt>
                <c:pt idx="1865">
                  <c:v>0.47825635244995734</c:v>
                </c:pt>
                <c:pt idx="1866">
                  <c:v>0.47825635244995734</c:v>
                </c:pt>
                <c:pt idx="1867">
                  <c:v>0.47825635244995734</c:v>
                </c:pt>
                <c:pt idx="1868">
                  <c:v>0.47825635244995734</c:v>
                </c:pt>
                <c:pt idx="1869">
                  <c:v>0.47825635244995734</c:v>
                </c:pt>
                <c:pt idx="1870">
                  <c:v>0.47697759214928903</c:v>
                </c:pt>
                <c:pt idx="1871">
                  <c:v>0.47697759214928903</c:v>
                </c:pt>
                <c:pt idx="1872">
                  <c:v>0.47569883184862072</c:v>
                </c:pt>
                <c:pt idx="1873">
                  <c:v>0.47569883184862072</c:v>
                </c:pt>
                <c:pt idx="1874">
                  <c:v>0.47569883184862072</c:v>
                </c:pt>
                <c:pt idx="1875">
                  <c:v>0.47569883184862072</c:v>
                </c:pt>
                <c:pt idx="1876">
                  <c:v>0.47441315933011091</c:v>
                </c:pt>
                <c:pt idx="1877">
                  <c:v>0.47441315933011091</c:v>
                </c:pt>
                <c:pt idx="1878">
                  <c:v>0.47312748681160111</c:v>
                </c:pt>
                <c:pt idx="1879">
                  <c:v>0.47312748681160111</c:v>
                </c:pt>
                <c:pt idx="1880">
                  <c:v>0.47312748681160111</c:v>
                </c:pt>
                <c:pt idx="1881">
                  <c:v>0.47183478876020329</c:v>
                </c:pt>
                <c:pt idx="1882">
                  <c:v>0.47183478876020329</c:v>
                </c:pt>
                <c:pt idx="1883">
                  <c:v>0.47053853934053241</c:v>
                </c:pt>
                <c:pt idx="1884">
                  <c:v>0.47053853934053241</c:v>
                </c:pt>
                <c:pt idx="1885">
                  <c:v>0.47053853934053241</c:v>
                </c:pt>
                <c:pt idx="1886">
                  <c:v>0.47053853934053241</c:v>
                </c:pt>
                <c:pt idx="1887">
                  <c:v>0.47053853934053241</c:v>
                </c:pt>
                <c:pt idx="1888">
                  <c:v>0.46922418587868736</c:v>
                </c:pt>
                <c:pt idx="1889">
                  <c:v>0.46922418587868736</c:v>
                </c:pt>
                <c:pt idx="1890">
                  <c:v>0.46790983241684231</c:v>
                </c:pt>
                <c:pt idx="1891">
                  <c:v>0.46790983241684231</c:v>
                </c:pt>
                <c:pt idx="1892">
                  <c:v>0.46790983241684231</c:v>
                </c:pt>
                <c:pt idx="1893">
                  <c:v>0.46659177655087936</c:v>
                </c:pt>
                <c:pt idx="1894">
                  <c:v>0.46659177655087936</c:v>
                </c:pt>
                <c:pt idx="1895">
                  <c:v>0.46659177655087936</c:v>
                </c:pt>
                <c:pt idx="1896">
                  <c:v>0.46659177655087936</c:v>
                </c:pt>
                <c:pt idx="1897">
                  <c:v>0.46526623173113252</c:v>
                </c:pt>
                <c:pt idx="1898">
                  <c:v>0.46526623173113252</c:v>
                </c:pt>
                <c:pt idx="1899">
                  <c:v>0.46526623173113252</c:v>
                </c:pt>
                <c:pt idx="1900">
                  <c:v>0.46526623173113252</c:v>
                </c:pt>
                <c:pt idx="1901">
                  <c:v>0.46393309066600036</c:v>
                </c:pt>
                <c:pt idx="1902">
                  <c:v>0.46393309066600036</c:v>
                </c:pt>
                <c:pt idx="1903">
                  <c:v>0.46393309066600036</c:v>
                </c:pt>
                <c:pt idx="1904">
                  <c:v>0.46393309066600036</c:v>
                </c:pt>
                <c:pt idx="1905">
                  <c:v>0.46393309066600036</c:v>
                </c:pt>
                <c:pt idx="1906">
                  <c:v>0.46393309066600036</c:v>
                </c:pt>
                <c:pt idx="1907">
                  <c:v>0.46393309066600036</c:v>
                </c:pt>
                <c:pt idx="1908">
                  <c:v>0.46258051605764466</c:v>
                </c:pt>
                <c:pt idx="1909">
                  <c:v>0.46258051605764466</c:v>
                </c:pt>
                <c:pt idx="1910">
                  <c:v>0.46258051605764466</c:v>
                </c:pt>
                <c:pt idx="1911">
                  <c:v>0.46258051605764466</c:v>
                </c:pt>
                <c:pt idx="1912">
                  <c:v>0.46258051605764466</c:v>
                </c:pt>
                <c:pt idx="1913">
                  <c:v>0.46258051605764466</c:v>
                </c:pt>
                <c:pt idx="1914">
                  <c:v>0.46258051605764466</c:v>
                </c:pt>
                <c:pt idx="1915">
                  <c:v>0.46258051605764466</c:v>
                </c:pt>
                <c:pt idx="1916">
                  <c:v>0.46258051605764466</c:v>
                </c:pt>
                <c:pt idx="1917">
                  <c:v>0.46258051605764466</c:v>
                </c:pt>
                <c:pt idx="1918">
                  <c:v>0.46258051605764466</c:v>
                </c:pt>
                <c:pt idx="1919">
                  <c:v>0.46258051605764466</c:v>
                </c:pt>
                <c:pt idx="1920">
                  <c:v>0.46258051605764466</c:v>
                </c:pt>
                <c:pt idx="1921">
                  <c:v>0.46258051605764466</c:v>
                </c:pt>
                <c:pt idx="1922">
                  <c:v>0.4611744962519983</c:v>
                </c:pt>
                <c:pt idx="1923">
                  <c:v>0.4611744962519983</c:v>
                </c:pt>
                <c:pt idx="1924">
                  <c:v>0.4611744962519983</c:v>
                </c:pt>
                <c:pt idx="1925">
                  <c:v>0.4611744962519983</c:v>
                </c:pt>
                <c:pt idx="1926">
                  <c:v>0.4611744962519983</c:v>
                </c:pt>
                <c:pt idx="1927">
                  <c:v>0.4611744962519983</c:v>
                </c:pt>
                <c:pt idx="1928">
                  <c:v>0.4611744962519983</c:v>
                </c:pt>
                <c:pt idx="1929">
                  <c:v>0.4611744962519983</c:v>
                </c:pt>
                <c:pt idx="1930">
                  <c:v>0.4611744962519983</c:v>
                </c:pt>
                <c:pt idx="1931">
                  <c:v>0.4611744962519983</c:v>
                </c:pt>
                <c:pt idx="1932">
                  <c:v>0.4597333259512108</c:v>
                </c:pt>
                <c:pt idx="1933">
                  <c:v>0.4597333259512108</c:v>
                </c:pt>
                <c:pt idx="1934">
                  <c:v>0.4597333259512108</c:v>
                </c:pt>
                <c:pt idx="1935">
                  <c:v>0.4597333259512108</c:v>
                </c:pt>
                <c:pt idx="1936">
                  <c:v>0.4597333259512108</c:v>
                </c:pt>
                <c:pt idx="1937">
                  <c:v>0.4597333259512108</c:v>
                </c:pt>
                <c:pt idx="1938">
                  <c:v>0.45827385507517521</c:v>
                </c:pt>
                <c:pt idx="1939">
                  <c:v>0.45827385507517521</c:v>
                </c:pt>
                <c:pt idx="1940">
                  <c:v>0.45827385507517521</c:v>
                </c:pt>
                <c:pt idx="1941">
                  <c:v>0.45827385507517521</c:v>
                </c:pt>
                <c:pt idx="1942">
                  <c:v>0.45827385507517521</c:v>
                </c:pt>
                <c:pt idx="1943">
                  <c:v>0.45827385507517521</c:v>
                </c:pt>
                <c:pt idx="1944">
                  <c:v>0.45827385507517521</c:v>
                </c:pt>
                <c:pt idx="1945">
                  <c:v>0.45827385507517521</c:v>
                </c:pt>
                <c:pt idx="1946">
                  <c:v>0.45678110636157526</c:v>
                </c:pt>
                <c:pt idx="1947">
                  <c:v>0.45678110636157526</c:v>
                </c:pt>
                <c:pt idx="1948">
                  <c:v>0.45678110636157526</c:v>
                </c:pt>
                <c:pt idx="1949">
                  <c:v>0.45678110636157526</c:v>
                </c:pt>
                <c:pt idx="1950">
                  <c:v>0.45678110636157526</c:v>
                </c:pt>
                <c:pt idx="1951">
                  <c:v>0.45678110636157526</c:v>
                </c:pt>
                <c:pt idx="1952">
                  <c:v>0.45526858614183496</c:v>
                </c:pt>
                <c:pt idx="1953">
                  <c:v>0.45526858614183496</c:v>
                </c:pt>
                <c:pt idx="1954">
                  <c:v>0.45526858614183496</c:v>
                </c:pt>
                <c:pt idx="1955">
                  <c:v>0.45375102418802887</c:v>
                </c:pt>
                <c:pt idx="1956">
                  <c:v>0.45375102418802887</c:v>
                </c:pt>
                <c:pt idx="1957">
                  <c:v>0.45375102418802887</c:v>
                </c:pt>
                <c:pt idx="1958">
                  <c:v>0.45375102418802887</c:v>
                </c:pt>
                <c:pt idx="1959">
                  <c:v>0.45375102418802887</c:v>
                </c:pt>
                <c:pt idx="1960">
                  <c:v>0.45375102418802887</c:v>
                </c:pt>
                <c:pt idx="1961">
                  <c:v>0.45375102418802887</c:v>
                </c:pt>
                <c:pt idx="1962">
                  <c:v>0.45375102418802887</c:v>
                </c:pt>
                <c:pt idx="1963">
                  <c:v>0.45375102418802887</c:v>
                </c:pt>
                <c:pt idx="1964">
                  <c:v>0.45218636548393221</c:v>
                </c:pt>
                <c:pt idx="1965">
                  <c:v>0.45218636548393221</c:v>
                </c:pt>
                <c:pt idx="1966">
                  <c:v>0.45218636548393221</c:v>
                </c:pt>
                <c:pt idx="1967">
                  <c:v>0.45218636548393221</c:v>
                </c:pt>
                <c:pt idx="1968">
                  <c:v>0.44903524098578634</c:v>
                </c:pt>
                <c:pt idx="1969">
                  <c:v>0.44903524098578634</c:v>
                </c:pt>
                <c:pt idx="1970">
                  <c:v>0.44903524098578634</c:v>
                </c:pt>
                <c:pt idx="1971">
                  <c:v>0.44903524098578634</c:v>
                </c:pt>
                <c:pt idx="1972">
                  <c:v>0.44903524098578634</c:v>
                </c:pt>
                <c:pt idx="1973">
                  <c:v>0.44903524098578634</c:v>
                </c:pt>
                <c:pt idx="1974">
                  <c:v>0.44903524098578634</c:v>
                </c:pt>
                <c:pt idx="1975">
                  <c:v>0.44903524098578634</c:v>
                </c:pt>
                <c:pt idx="1976">
                  <c:v>0.44742579567759355</c:v>
                </c:pt>
                <c:pt idx="1977">
                  <c:v>0.44742579567759355</c:v>
                </c:pt>
                <c:pt idx="1978">
                  <c:v>0.44742579567759355</c:v>
                </c:pt>
                <c:pt idx="1979">
                  <c:v>0.44581054009753002</c:v>
                </c:pt>
                <c:pt idx="1980">
                  <c:v>0.44581054009753002</c:v>
                </c:pt>
                <c:pt idx="1981">
                  <c:v>0.44581054009753002</c:v>
                </c:pt>
                <c:pt idx="1982">
                  <c:v>0.44581054009753002</c:v>
                </c:pt>
                <c:pt idx="1983">
                  <c:v>0.4441654827539967</c:v>
                </c:pt>
                <c:pt idx="1984">
                  <c:v>0.4441654827539967</c:v>
                </c:pt>
                <c:pt idx="1985">
                  <c:v>0.4441654827539967</c:v>
                </c:pt>
                <c:pt idx="1986">
                  <c:v>0.4441654827539967</c:v>
                </c:pt>
                <c:pt idx="1987">
                  <c:v>0.4441654827539967</c:v>
                </c:pt>
                <c:pt idx="1988">
                  <c:v>0.4441654827539967</c:v>
                </c:pt>
                <c:pt idx="1989">
                  <c:v>0.44249568770604936</c:v>
                </c:pt>
                <c:pt idx="1990">
                  <c:v>0.44249568770604936</c:v>
                </c:pt>
                <c:pt idx="1991">
                  <c:v>0.44249568770604936</c:v>
                </c:pt>
                <c:pt idx="1992">
                  <c:v>0.44249568770604936</c:v>
                </c:pt>
                <c:pt idx="1993">
                  <c:v>0.44249568770604936</c:v>
                </c:pt>
                <c:pt idx="1994">
                  <c:v>0.44249568770604936</c:v>
                </c:pt>
                <c:pt idx="1995">
                  <c:v>0.44249568770604936</c:v>
                </c:pt>
                <c:pt idx="1996">
                  <c:v>0.44249568770604936</c:v>
                </c:pt>
                <c:pt idx="1997">
                  <c:v>0.44249568770604936</c:v>
                </c:pt>
                <c:pt idx="1998">
                  <c:v>0.44249568770604936</c:v>
                </c:pt>
                <c:pt idx="1999">
                  <c:v>0.44249568770604936</c:v>
                </c:pt>
                <c:pt idx="2000">
                  <c:v>0.44075357869933263</c:v>
                </c:pt>
                <c:pt idx="2001">
                  <c:v>0.44075357869933263</c:v>
                </c:pt>
                <c:pt idx="2002">
                  <c:v>0.44075357869933263</c:v>
                </c:pt>
                <c:pt idx="2003">
                  <c:v>0.43899758834594882</c:v>
                </c:pt>
                <c:pt idx="2004">
                  <c:v>0.43899758834594882</c:v>
                </c:pt>
                <c:pt idx="2005">
                  <c:v>0.43723454582247112</c:v>
                </c:pt>
                <c:pt idx="2006">
                  <c:v>0.43723454582247112</c:v>
                </c:pt>
                <c:pt idx="2007">
                  <c:v>0.43723454582247112</c:v>
                </c:pt>
                <c:pt idx="2008">
                  <c:v>0.43723454582247112</c:v>
                </c:pt>
                <c:pt idx="2009">
                  <c:v>0.43723454582247112</c:v>
                </c:pt>
                <c:pt idx="2010">
                  <c:v>0.43543522670386015</c:v>
                </c:pt>
                <c:pt idx="2011">
                  <c:v>0.43543522670386015</c:v>
                </c:pt>
                <c:pt idx="2012">
                  <c:v>0.43543522670386015</c:v>
                </c:pt>
                <c:pt idx="2013">
                  <c:v>0.43543522670386015</c:v>
                </c:pt>
                <c:pt idx="2014">
                  <c:v>0.43543522670386015</c:v>
                </c:pt>
                <c:pt idx="2015">
                  <c:v>0.43543522670386015</c:v>
                </c:pt>
                <c:pt idx="2016">
                  <c:v>0.43543522670386015</c:v>
                </c:pt>
                <c:pt idx="2017">
                  <c:v>0.43543522670386015</c:v>
                </c:pt>
                <c:pt idx="2018">
                  <c:v>0.43543522670386015</c:v>
                </c:pt>
                <c:pt idx="2019">
                  <c:v>0.43543522670386015</c:v>
                </c:pt>
                <c:pt idx="2020">
                  <c:v>0.43357439240170692</c:v>
                </c:pt>
                <c:pt idx="2021">
                  <c:v>0.43357439240170692</c:v>
                </c:pt>
                <c:pt idx="2022">
                  <c:v>0.43357439240170692</c:v>
                </c:pt>
                <c:pt idx="2023">
                  <c:v>0.43357439240170692</c:v>
                </c:pt>
                <c:pt idx="2024">
                  <c:v>0.43168928634778647</c:v>
                </c:pt>
                <c:pt idx="2025">
                  <c:v>0.43168928634778647</c:v>
                </c:pt>
                <c:pt idx="2026">
                  <c:v>0.43168928634778647</c:v>
                </c:pt>
                <c:pt idx="2027">
                  <c:v>0.43168928634778647</c:v>
                </c:pt>
                <c:pt idx="2028">
                  <c:v>0.42978757142995483</c:v>
                </c:pt>
                <c:pt idx="2029">
                  <c:v>0.42978757142995483</c:v>
                </c:pt>
                <c:pt idx="2030">
                  <c:v>0.42978757142995483</c:v>
                </c:pt>
                <c:pt idx="2031">
                  <c:v>0.42978757142995483</c:v>
                </c:pt>
                <c:pt idx="2032">
                  <c:v>0.42978757142995483</c:v>
                </c:pt>
                <c:pt idx="2033">
                  <c:v>0.42978757142995483</c:v>
                </c:pt>
                <c:pt idx="2034">
                  <c:v>0.42978757142995483</c:v>
                </c:pt>
                <c:pt idx="2035">
                  <c:v>0.42978757142995483</c:v>
                </c:pt>
                <c:pt idx="2036">
                  <c:v>0.42978757142995483</c:v>
                </c:pt>
                <c:pt idx="2037">
                  <c:v>0.42782507110379064</c:v>
                </c:pt>
                <c:pt idx="2038">
                  <c:v>0.42782507110379064</c:v>
                </c:pt>
                <c:pt idx="2039">
                  <c:v>0.42782507110379064</c:v>
                </c:pt>
                <c:pt idx="2040">
                  <c:v>0.42782507110379064</c:v>
                </c:pt>
                <c:pt idx="2041">
                  <c:v>0.42782507110379064</c:v>
                </c:pt>
                <c:pt idx="2042">
                  <c:v>0.42782507110379064</c:v>
                </c:pt>
                <c:pt idx="2043">
                  <c:v>0.42782507110379064</c:v>
                </c:pt>
                <c:pt idx="2044">
                  <c:v>0.42782507110379064</c:v>
                </c:pt>
                <c:pt idx="2045">
                  <c:v>0.42782507110379064</c:v>
                </c:pt>
                <c:pt idx="2046">
                  <c:v>0.42579746413173475</c:v>
                </c:pt>
                <c:pt idx="2047">
                  <c:v>0.42579746413173475</c:v>
                </c:pt>
                <c:pt idx="2048">
                  <c:v>0.42579746413173475</c:v>
                </c:pt>
                <c:pt idx="2049">
                  <c:v>0.42579746413173475</c:v>
                </c:pt>
                <c:pt idx="2050">
                  <c:v>0.42579746413173475</c:v>
                </c:pt>
                <c:pt idx="2051">
                  <c:v>0.42374047155138822</c:v>
                </c:pt>
                <c:pt idx="2052">
                  <c:v>0.42374047155138822</c:v>
                </c:pt>
                <c:pt idx="2053">
                  <c:v>0.42374047155138822</c:v>
                </c:pt>
                <c:pt idx="2054">
                  <c:v>0.42374047155138822</c:v>
                </c:pt>
                <c:pt idx="2055">
                  <c:v>0.42163231000138129</c:v>
                </c:pt>
                <c:pt idx="2056">
                  <c:v>0.42163231000138129</c:v>
                </c:pt>
                <c:pt idx="2057">
                  <c:v>0.41951355467474116</c:v>
                </c:pt>
                <c:pt idx="2058">
                  <c:v>0.41951355467474116</c:v>
                </c:pt>
                <c:pt idx="2059">
                  <c:v>0.41739479934810103</c:v>
                </c:pt>
                <c:pt idx="2060">
                  <c:v>0.41739479934810103</c:v>
                </c:pt>
                <c:pt idx="2061">
                  <c:v>0.41739479934810103</c:v>
                </c:pt>
                <c:pt idx="2062">
                  <c:v>0.41739479934810103</c:v>
                </c:pt>
                <c:pt idx="2063">
                  <c:v>0.41739479934810103</c:v>
                </c:pt>
                <c:pt idx="2064">
                  <c:v>0.41739479934810103</c:v>
                </c:pt>
                <c:pt idx="2065">
                  <c:v>0.41739479934810103</c:v>
                </c:pt>
                <c:pt idx="2066">
                  <c:v>0.41739479934810103</c:v>
                </c:pt>
                <c:pt idx="2067">
                  <c:v>0.41520948626250886</c:v>
                </c:pt>
                <c:pt idx="2068">
                  <c:v>0.41520948626250886</c:v>
                </c:pt>
                <c:pt idx="2069">
                  <c:v>0.41520948626250886</c:v>
                </c:pt>
                <c:pt idx="2070">
                  <c:v>0.41301261067381834</c:v>
                </c:pt>
                <c:pt idx="2071">
                  <c:v>0.41301261067381834</c:v>
                </c:pt>
                <c:pt idx="2072">
                  <c:v>0.41080398708732735</c:v>
                </c:pt>
                <c:pt idx="2073">
                  <c:v>0.41080398708732735</c:v>
                </c:pt>
                <c:pt idx="2074">
                  <c:v>0.41080398708732735</c:v>
                </c:pt>
                <c:pt idx="2075">
                  <c:v>0.41080398708732735</c:v>
                </c:pt>
                <c:pt idx="2076">
                  <c:v>0.41080398708732735</c:v>
                </c:pt>
                <c:pt idx="2077">
                  <c:v>0.41080398708732735</c:v>
                </c:pt>
                <c:pt idx="2078">
                  <c:v>0.41080398708732735</c:v>
                </c:pt>
                <c:pt idx="2079">
                  <c:v>0.41080398708732735</c:v>
                </c:pt>
                <c:pt idx="2080">
                  <c:v>0.41080398708732735</c:v>
                </c:pt>
                <c:pt idx="2081">
                  <c:v>0.41080398708732735</c:v>
                </c:pt>
                <c:pt idx="2082">
                  <c:v>0.41080398708732735</c:v>
                </c:pt>
                <c:pt idx="2083">
                  <c:v>0.41080398708732735</c:v>
                </c:pt>
                <c:pt idx="2084">
                  <c:v>0.41080398708732735</c:v>
                </c:pt>
                <c:pt idx="2085">
                  <c:v>0.41080398708732735</c:v>
                </c:pt>
                <c:pt idx="2086">
                  <c:v>0.41080398708732735</c:v>
                </c:pt>
                <c:pt idx="2087">
                  <c:v>0.40840162458974066</c:v>
                </c:pt>
                <c:pt idx="2088">
                  <c:v>0.40840162458974066</c:v>
                </c:pt>
                <c:pt idx="2089">
                  <c:v>0.40840162458974066</c:v>
                </c:pt>
                <c:pt idx="2090">
                  <c:v>0.40840162458974066</c:v>
                </c:pt>
                <c:pt idx="2091">
                  <c:v>0.40840162458974066</c:v>
                </c:pt>
                <c:pt idx="2092">
                  <c:v>0.40840162458974066</c:v>
                </c:pt>
                <c:pt idx="2093">
                  <c:v>0.40840162458974066</c:v>
                </c:pt>
                <c:pt idx="2094">
                  <c:v>0.40840162458974066</c:v>
                </c:pt>
                <c:pt idx="2095">
                  <c:v>0.40840162458974066</c:v>
                </c:pt>
                <c:pt idx="2096">
                  <c:v>0.40840162458974066</c:v>
                </c:pt>
                <c:pt idx="2097">
                  <c:v>0.40588062690708793</c:v>
                </c:pt>
                <c:pt idx="2098">
                  <c:v>0.40588062690708793</c:v>
                </c:pt>
                <c:pt idx="2099">
                  <c:v>0.40588062690708793</c:v>
                </c:pt>
                <c:pt idx="2100">
                  <c:v>0.40334387298891861</c:v>
                </c:pt>
                <c:pt idx="2101">
                  <c:v>0.40334387298891861</c:v>
                </c:pt>
                <c:pt idx="2102">
                  <c:v>0.40334387298891861</c:v>
                </c:pt>
                <c:pt idx="2103">
                  <c:v>0.40334387298891861</c:v>
                </c:pt>
                <c:pt idx="2104">
                  <c:v>0.40334387298891861</c:v>
                </c:pt>
                <c:pt idx="2105">
                  <c:v>0.40334387298891861</c:v>
                </c:pt>
                <c:pt idx="2106">
                  <c:v>0.40334387298891861</c:v>
                </c:pt>
                <c:pt idx="2107">
                  <c:v>0.40334387298891861</c:v>
                </c:pt>
                <c:pt idx="2108">
                  <c:v>0.40334387298891861</c:v>
                </c:pt>
                <c:pt idx="2109">
                  <c:v>0.40065491383565915</c:v>
                </c:pt>
                <c:pt idx="2110">
                  <c:v>0.40065491383565915</c:v>
                </c:pt>
                <c:pt idx="2111">
                  <c:v>0.40065491383565915</c:v>
                </c:pt>
                <c:pt idx="2112">
                  <c:v>0.39794778603947228</c:v>
                </c:pt>
                <c:pt idx="2113">
                  <c:v>0.39794778603947228</c:v>
                </c:pt>
                <c:pt idx="2114">
                  <c:v>0.39794778603947228</c:v>
                </c:pt>
                <c:pt idx="2115">
                  <c:v>0.39794778603947228</c:v>
                </c:pt>
                <c:pt idx="2116">
                  <c:v>0.39794778603947228</c:v>
                </c:pt>
                <c:pt idx="2117">
                  <c:v>0.39794778603947228</c:v>
                </c:pt>
                <c:pt idx="2118">
                  <c:v>0.39794778603947228</c:v>
                </c:pt>
                <c:pt idx="2119">
                  <c:v>0.3951453368420112</c:v>
                </c:pt>
                <c:pt idx="2120">
                  <c:v>0.3951453368420112</c:v>
                </c:pt>
                <c:pt idx="2121">
                  <c:v>0.3951453368420112</c:v>
                </c:pt>
                <c:pt idx="2122">
                  <c:v>0.3951453368420112</c:v>
                </c:pt>
                <c:pt idx="2123">
                  <c:v>0.39230256463451474</c:v>
                </c:pt>
                <c:pt idx="2124">
                  <c:v>0.39230256463451474</c:v>
                </c:pt>
                <c:pt idx="2125">
                  <c:v>0.39230256463451474</c:v>
                </c:pt>
                <c:pt idx="2126">
                  <c:v>0.39230256463451474</c:v>
                </c:pt>
                <c:pt idx="2127">
                  <c:v>0.39230256463451474</c:v>
                </c:pt>
                <c:pt idx="2128">
                  <c:v>0.39230256463451474</c:v>
                </c:pt>
                <c:pt idx="2129">
                  <c:v>0.39230256463451474</c:v>
                </c:pt>
                <c:pt idx="2130">
                  <c:v>0.39230256463451474</c:v>
                </c:pt>
                <c:pt idx="2131">
                  <c:v>0.39230256463451474</c:v>
                </c:pt>
                <c:pt idx="2132">
                  <c:v>0.39230256463451474</c:v>
                </c:pt>
                <c:pt idx="2133">
                  <c:v>0.39230256463451474</c:v>
                </c:pt>
                <c:pt idx="2134">
                  <c:v>0.39230256463451474</c:v>
                </c:pt>
                <c:pt idx="2135">
                  <c:v>0.38921356806258944</c:v>
                </c:pt>
                <c:pt idx="2136">
                  <c:v>0.38921356806258944</c:v>
                </c:pt>
                <c:pt idx="2137">
                  <c:v>0.38921356806258944</c:v>
                </c:pt>
                <c:pt idx="2138">
                  <c:v>0.38921356806258944</c:v>
                </c:pt>
                <c:pt idx="2139">
                  <c:v>0.38921356806258944</c:v>
                </c:pt>
                <c:pt idx="2140">
                  <c:v>0.38921356806258944</c:v>
                </c:pt>
                <c:pt idx="2141">
                  <c:v>0.38921356806258944</c:v>
                </c:pt>
                <c:pt idx="2142">
                  <c:v>0.38921356806258944</c:v>
                </c:pt>
                <c:pt idx="2143">
                  <c:v>0.38921356806258944</c:v>
                </c:pt>
                <c:pt idx="2144">
                  <c:v>0.38921356806258944</c:v>
                </c:pt>
                <c:pt idx="2145">
                  <c:v>0.38921356806258944</c:v>
                </c:pt>
                <c:pt idx="2146">
                  <c:v>0.38921356806258944</c:v>
                </c:pt>
                <c:pt idx="2147">
                  <c:v>0.38921356806258944</c:v>
                </c:pt>
                <c:pt idx="2148">
                  <c:v>0.38921356806258944</c:v>
                </c:pt>
                <c:pt idx="2149">
                  <c:v>0.38921356806258944</c:v>
                </c:pt>
                <c:pt idx="2150">
                  <c:v>0.38576920020362848</c:v>
                </c:pt>
                <c:pt idx="2151">
                  <c:v>0.38576920020362848</c:v>
                </c:pt>
                <c:pt idx="2152">
                  <c:v>0.38576920020362848</c:v>
                </c:pt>
                <c:pt idx="2153">
                  <c:v>0.38576920020362848</c:v>
                </c:pt>
                <c:pt idx="2154">
                  <c:v>0.38576920020362848</c:v>
                </c:pt>
                <c:pt idx="2155">
                  <c:v>0.38576920020362848</c:v>
                </c:pt>
                <c:pt idx="2156">
                  <c:v>0.38576920020362848</c:v>
                </c:pt>
                <c:pt idx="2157">
                  <c:v>0.38576920020362848</c:v>
                </c:pt>
                <c:pt idx="2158">
                  <c:v>0.38576920020362848</c:v>
                </c:pt>
                <c:pt idx="2159">
                  <c:v>0.38205988097090127</c:v>
                </c:pt>
                <c:pt idx="2160">
                  <c:v>0.38205988097090127</c:v>
                </c:pt>
                <c:pt idx="2161">
                  <c:v>0.38205988097090127</c:v>
                </c:pt>
                <c:pt idx="2162">
                  <c:v>0.38205988097090127</c:v>
                </c:pt>
                <c:pt idx="2163">
                  <c:v>0.38205988097090127</c:v>
                </c:pt>
                <c:pt idx="2164">
                  <c:v>0.38205988097090127</c:v>
                </c:pt>
                <c:pt idx="2165">
                  <c:v>0.37816131075691251</c:v>
                </c:pt>
                <c:pt idx="2166">
                  <c:v>0.37816131075691251</c:v>
                </c:pt>
                <c:pt idx="2167">
                  <c:v>0.37816131075691251</c:v>
                </c:pt>
                <c:pt idx="2168">
                  <c:v>0.37816131075691251</c:v>
                </c:pt>
                <c:pt idx="2169">
                  <c:v>0.37816131075691251</c:v>
                </c:pt>
                <c:pt idx="2170">
                  <c:v>0.37409506010361238</c:v>
                </c:pt>
                <c:pt idx="2171">
                  <c:v>0.37409506010361238</c:v>
                </c:pt>
                <c:pt idx="2172">
                  <c:v>0.37409506010361238</c:v>
                </c:pt>
                <c:pt idx="2173">
                  <c:v>0.36993844832468337</c:v>
                </c:pt>
                <c:pt idx="2174">
                  <c:v>0.36993844832468337</c:v>
                </c:pt>
                <c:pt idx="2175">
                  <c:v>0.36993844832468337</c:v>
                </c:pt>
                <c:pt idx="2176">
                  <c:v>0.36993844832468337</c:v>
                </c:pt>
                <c:pt idx="2177">
                  <c:v>0.36568628225198585</c:v>
                </c:pt>
                <c:pt idx="2178">
                  <c:v>0.36568628225198585</c:v>
                </c:pt>
                <c:pt idx="2179">
                  <c:v>0.36568628225198585</c:v>
                </c:pt>
                <c:pt idx="2180">
                  <c:v>0.36138409069608013</c:v>
                </c:pt>
                <c:pt idx="2181">
                  <c:v>0.36138409069608013</c:v>
                </c:pt>
                <c:pt idx="2182">
                  <c:v>0.36138409069608013</c:v>
                </c:pt>
                <c:pt idx="2183">
                  <c:v>0.36138409069608013</c:v>
                </c:pt>
                <c:pt idx="2184">
                  <c:v>0.35697696763881087</c:v>
                </c:pt>
                <c:pt idx="2185">
                  <c:v>0.35697696763881087</c:v>
                </c:pt>
                <c:pt idx="2186">
                  <c:v>0.35697696763881087</c:v>
                </c:pt>
                <c:pt idx="2187">
                  <c:v>0.35697696763881087</c:v>
                </c:pt>
                <c:pt idx="2188">
                  <c:v>0.35697696763881087</c:v>
                </c:pt>
                <c:pt idx="2189">
                  <c:v>0.35240033984856972</c:v>
                </c:pt>
                <c:pt idx="2190">
                  <c:v>0.35240033984856972</c:v>
                </c:pt>
                <c:pt idx="2191">
                  <c:v>0.35240033984856972</c:v>
                </c:pt>
                <c:pt idx="2192">
                  <c:v>0.35240033984856972</c:v>
                </c:pt>
                <c:pt idx="2193">
                  <c:v>0.34770166865058877</c:v>
                </c:pt>
                <c:pt idx="2194">
                  <c:v>0.34770166865058877</c:v>
                </c:pt>
                <c:pt idx="2195">
                  <c:v>0.34770166865058877</c:v>
                </c:pt>
                <c:pt idx="2196">
                  <c:v>0.34770166865058877</c:v>
                </c:pt>
                <c:pt idx="2197">
                  <c:v>0.34770166865058877</c:v>
                </c:pt>
                <c:pt idx="2198">
                  <c:v>0.34280446204987625</c:v>
                </c:pt>
                <c:pt idx="2199">
                  <c:v>0.34280446204987625</c:v>
                </c:pt>
                <c:pt idx="2200">
                  <c:v>0.34280446204987625</c:v>
                </c:pt>
                <c:pt idx="2201">
                  <c:v>0.34280446204987625</c:v>
                </c:pt>
                <c:pt idx="2202">
                  <c:v>0.34280446204987625</c:v>
                </c:pt>
                <c:pt idx="2203">
                  <c:v>0.33768797754166913</c:v>
                </c:pt>
                <c:pt idx="2204">
                  <c:v>0.33768797754166913</c:v>
                </c:pt>
                <c:pt idx="2205">
                  <c:v>0.33768797754166913</c:v>
                </c:pt>
                <c:pt idx="2206">
                  <c:v>0.33768797754166913</c:v>
                </c:pt>
                <c:pt idx="2207">
                  <c:v>0.33241160289258054</c:v>
                </c:pt>
                <c:pt idx="2208">
                  <c:v>0.33241160289258054</c:v>
                </c:pt>
                <c:pt idx="2209">
                  <c:v>0.33241160289258054</c:v>
                </c:pt>
                <c:pt idx="2210">
                  <c:v>0.33241160289258054</c:v>
                </c:pt>
                <c:pt idx="2211">
                  <c:v>0.32696223235335792</c:v>
                </c:pt>
                <c:pt idx="2212">
                  <c:v>0.32696223235335792</c:v>
                </c:pt>
                <c:pt idx="2213">
                  <c:v>0.32696223235335792</c:v>
                </c:pt>
                <c:pt idx="2214">
                  <c:v>0.32696223235335792</c:v>
                </c:pt>
                <c:pt idx="2215">
                  <c:v>0.32122605283838673</c:v>
                </c:pt>
                <c:pt idx="2216">
                  <c:v>0.32122605283838673</c:v>
                </c:pt>
                <c:pt idx="2217">
                  <c:v>0.32122605283838673</c:v>
                </c:pt>
                <c:pt idx="2218">
                  <c:v>0.32122605283838673</c:v>
                </c:pt>
                <c:pt idx="2219">
                  <c:v>0.31527742223026844</c:v>
                </c:pt>
                <c:pt idx="2220">
                  <c:v>0.31527742223026844</c:v>
                </c:pt>
                <c:pt idx="2221">
                  <c:v>0.31527742223026844</c:v>
                </c:pt>
                <c:pt idx="2222">
                  <c:v>0.31527742223026844</c:v>
                </c:pt>
                <c:pt idx="2223">
                  <c:v>0.30909551199045926</c:v>
                </c:pt>
                <c:pt idx="2224">
                  <c:v>0.30909551199045926</c:v>
                </c:pt>
                <c:pt idx="2225">
                  <c:v>0.30909551199045926</c:v>
                </c:pt>
                <c:pt idx="2226">
                  <c:v>0.30278744031718458</c:v>
                </c:pt>
                <c:pt idx="2227">
                  <c:v>0.30278744031718458</c:v>
                </c:pt>
                <c:pt idx="2228">
                  <c:v>0.29647936864390989</c:v>
                </c:pt>
                <c:pt idx="2229">
                  <c:v>0.29647936864390989</c:v>
                </c:pt>
                <c:pt idx="2230">
                  <c:v>0.29647936864390989</c:v>
                </c:pt>
                <c:pt idx="2231">
                  <c:v>0.29003416497773793</c:v>
                </c:pt>
                <c:pt idx="2232">
                  <c:v>0.29003416497773793</c:v>
                </c:pt>
                <c:pt idx="2233">
                  <c:v>0.29003416497773793</c:v>
                </c:pt>
                <c:pt idx="2234">
                  <c:v>0.29003416497773793</c:v>
                </c:pt>
                <c:pt idx="2235">
                  <c:v>0.29003416497773793</c:v>
                </c:pt>
                <c:pt idx="2236">
                  <c:v>0.29003416497773793</c:v>
                </c:pt>
                <c:pt idx="2237">
                  <c:v>0.28296016095389065</c:v>
                </c:pt>
                <c:pt idx="2238">
                  <c:v>0.28296016095389065</c:v>
                </c:pt>
                <c:pt idx="2239">
                  <c:v>0.28296016095389065</c:v>
                </c:pt>
                <c:pt idx="2240">
                  <c:v>0.27570477221148321</c:v>
                </c:pt>
                <c:pt idx="2241">
                  <c:v>0.27570477221148321</c:v>
                </c:pt>
                <c:pt idx="2242">
                  <c:v>0.27570477221148321</c:v>
                </c:pt>
                <c:pt idx="2243">
                  <c:v>0.27570477221148321</c:v>
                </c:pt>
                <c:pt idx="2244">
                  <c:v>0.27570477221148321</c:v>
                </c:pt>
                <c:pt idx="2245">
                  <c:v>0.27570477221148321</c:v>
                </c:pt>
                <c:pt idx="2246">
                  <c:v>0.27570477221148321</c:v>
                </c:pt>
                <c:pt idx="2247">
                  <c:v>0.27570477221148321</c:v>
                </c:pt>
                <c:pt idx="2248">
                  <c:v>0.27570477221148321</c:v>
                </c:pt>
                <c:pt idx="2249">
                  <c:v>0.27570477221148321</c:v>
                </c:pt>
                <c:pt idx="2250">
                  <c:v>0.27570477221148321</c:v>
                </c:pt>
                <c:pt idx="2251">
                  <c:v>0.26619771110074242</c:v>
                </c:pt>
                <c:pt idx="2252">
                  <c:v>0.26619771110074242</c:v>
                </c:pt>
                <c:pt idx="2253">
                  <c:v>0.26619771110074242</c:v>
                </c:pt>
                <c:pt idx="2254">
                  <c:v>0.25633853661552974</c:v>
                </c:pt>
                <c:pt idx="2255">
                  <c:v>0.25633853661552974</c:v>
                </c:pt>
                <c:pt idx="2256">
                  <c:v>0.25633853661552974</c:v>
                </c:pt>
                <c:pt idx="2257">
                  <c:v>0.25633853661552974</c:v>
                </c:pt>
                <c:pt idx="2258">
                  <c:v>0.25633853661552974</c:v>
                </c:pt>
                <c:pt idx="2259">
                  <c:v>0.25633853661552974</c:v>
                </c:pt>
                <c:pt idx="2260">
                  <c:v>0.24468678495118748</c:v>
                </c:pt>
                <c:pt idx="2261">
                  <c:v>0.24468678495118748</c:v>
                </c:pt>
                <c:pt idx="2262">
                  <c:v>0.23303503328684522</c:v>
                </c:pt>
                <c:pt idx="2263">
                  <c:v>0.23303503328684522</c:v>
                </c:pt>
                <c:pt idx="2264">
                  <c:v>0.23303503328684522</c:v>
                </c:pt>
                <c:pt idx="2265">
                  <c:v>0.23303503328684522</c:v>
                </c:pt>
                <c:pt idx="2266">
                  <c:v>0.23303503328684522</c:v>
                </c:pt>
                <c:pt idx="2267">
                  <c:v>0.21932709015232491</c:v>
                </c:pt>
                <c:pt idx="2268">
                  <c:v>0.21932709015232491</c:v>
                </c:pt>
                <c:pt idx="2269">
                  <c:v>0.21932709015232491</c:v>
                </c:pt>
                <c:pt idx="2270">
                  <c:v>0.2047052841421699</c:v>
                </c:pt>
                <c:pt idx="2271">
                  <c:v>0.2047052841421699</c:v>
                </c:pt>
                <c:pt idx="2272">
                  <c:v>0.1900834781320149</c:v>
                </c:pt>
                <c:pt idx="2273">
                  <c:v>0.1900834781320149</c:v>
                </c:pt>
                <c:pt idx="2274">
                  <c:v>0.1754616721218599</c:v>
                </c:pt>
                <c:pt idx="2275">
                  <c:v>0.1754616721218599</c:v>
                </c:pt>
                <c:pt idx="2276">
                  <c:v>0.1754616721218599</c:v>
                </c:pt>
                <c:pt idx="2277">
                  <c:v>0.15951061101987263</c:v>
                </c:pt>
                <c:pt idx="2278">
                  <c:v>0.15951061101987263</c:v>
                </c:pt>
                <c:pt idx="2279">
                  <c:v>0.15951061101987263</c:v>
                </c:pt>
                <c:pt idx="2280">
                  <c:v>0.15951061101987263</c:v>
                </c:pt>
                <c:pt idx="2281">
                  <c:v>0.13957178464238856</c:v>
                </c:pt>
                <c:pt idx="2282">
                  <c:v>0.13957178464238856</c:v>
                </c:pt>
                <c:pt idx="2283">
                  <c:v>0.13957178464238856</c:v>
                </c:pt>
                <c:pt idx="2284">
                  <c:v>0.13957178464238856</c:v>
                </c:pt>
                <c:pt idx="2285">
                  <c:v>0.13957178464238856</c:v>
                </c:pt>
                <c:pt idx="2286">
                  <c:v>0.13957178464238856</c:v>
                </c:pt>
                <c:pt idx="2287">
                  <c:v>9.3047856428259051E-2</c:v>
                </c:pt>
                <c:pt idx="2288">
                  <c:v>9.3047856428259051E-2</c:v>
                </c:pt>
                <c:pt idx="2289">
                  <c:v>9.3047856428259051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5BE-4834-A852-601CC64CF30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9340928"/>
        <c:axId val="89343104"/>
      </c:scatterChart>
      <c:valAx>
        <c:axId val="89340928"/>
        <c:scaling>
          <c:orientation val="minMax"/>
          <c:max val="8000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 dirty="0" smtClean="0"/>
                  <a:t>Days</a:t>
                </a:r>
                <a:endParaRPr lang="en-US" sz="800" dirty="0"/>
              </a:p>
            </c:rich>
          </c:tx>
          <c:layout>
            <c:manualLayout>
              <c:xMode val="edge"/>
              <c:yMode val="edge"/>
              <c:x val="0.48083455029889943"/>
              <c:y val="0.90011570064580415"/>
            </c:manualLayout>
          </c:layout>
          <c:overlay val="0"/>
          <c:spPr>
            <a:noFill/>
            <a:ln w="25400">
              <a:noFill/>
            </a:ln>
            <a:effectLst/>
          </c:spPr>
        </c:title>
        <c:numFmt formatCode="General" sourceLinked="1"/>
        <c:majorTickMark val="out"/>
        <c:minorTickMark val="out"/>
        <c:tickLblPos val="nextTo"/>
        <c:spPr>
          <a:ln w="1905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/>
            </a:pPr>
            <a:endParaRPr lang="en-US"/>
          </a:p>
        </c:txPr>
        <c:crossAx val="89343104"/>
        <c:crosses val="autoZero"/>
        <c:crossBetween val="midCat"/>
        <c:majorUnit val="2000"/>
        <c:minorUnit val="1000"/>
      </c:valAx>
      <c:valAx>
        <c:axId val="89343104"/>
        <c:scaling>
          <c:orientation val="minMax"/>
          <c:max val="1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800" b="1"/>
                </a:pPr>
                <a:r>
                  <a:rPr lang="en-US" sz="800" b="1"/>
                  <a:t>Overall Survival</a:t>
                </a:r>
              </a:p>
            </c:rich>
          </c:tx>
          <c:layout>
            <c:manualLayout>
              <c:xMode val="edge"/>
              <c:yMode val="edge"/>
              <c:x val="0"/>
              <c:y val="0.21843625030753319"/>
            </c:manualLayout>
          </c:layout>
          <c:overlay val="0"/>
          <c:spPr>
            <a:noFill/>
            <a:ln w="25400">
              <a:noFill/>
            </a:ln>
            <a:effectLst/>
          </c:spPr>
        </c:title>
        <c:numFmt formatCode="General" sourceLinked="1"/>
        <c:majorTickMark val="out"/>
        <c:minorTickMark val="out"/>
        <c:tickLblPos val="nextTo"/>
        <c:spPr>
          <a:ln w="1905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/>
            </a:pPr>
            <a:endParaRPr lang="en-US"/>
          </a:p>
        </c:txPr>
        <c:crossAx val="89340928"/>
        <c:crosses val="autoZero"/>
        <c:crossBetween val="midCat"/>
        <c:majorUnit val="0.2"/>
        <c:minorUnit val="0.1"/>
      </c:valAx>
      <c:spPr>
        <a:noFill/>
        <a:ln w="19050">
          <a:solidFill>
            <a:schemeClr val="tx1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1875262467191601"/>
          <c:y val="0.63643810148731406"/>
          <c:w val="0.28251093613298339"/>
          <c:h val="0.12418300653594772"/>
        </c:manualLayout>
      </c:layout>
      <c:overlay val="0"/>
      <c:spPr>
        <a:noFill/>
        <a:ln w="3175">
          <a:noFill/>
          <a:prstDash val="solid"/>
        </a:ln>
      </c:spPr>
      <c:txPr>
        <a:bodyPr/>
        <a:lstStyle/>
        <a:p>
          <a:pPr>
            <a:defRPr sz="800" b="0"/>
          </a:pPr>
          <a:endParaRPr lang="en-US"/>
        </a:p>
      </c:txPr>
    </c:legend>
    <c:plotVisOnly val="0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12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745261009040537"/>
          <c:y val="0.16666719856515064"/>
          <c:w val="0.7366181831437737"/>
          <c:h val="0.6143810456911436"/>
        </c:manualLayout>
      </c:layout>
      <c:scatterChart>
        <c:scatterStyle val="lineMarker"/>
        <c:varyColors val="0"/>
        <c:ser>
          <c:idx val="1"/>
          <c:order val="0"/>
          <c:tx>
            <c:v>high</c:v>
          </c:tx>
          <c:spPr>
            <a:ln w="25400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Survival!$B$532:$B$588</c:f>
              <c:numCache>
                <c:formatCode>General</c:formatCode>
                <c:ptCount val="57"/>
                <c:pt idx="0">
                  <c:v>0</c:v>
                </c:pt>
                <c:pt idx="1">
                  <c:v>0.48199999999999998</c:v>
                </c:pt>
                <c:pt idx="2">
                  <c:v>0.91400000000000003</c:v>
                </c:pt>
                <c:pt idx="3">
                  <c:v>1.0540725529999999</c:v>
                </c:pt>
                <c:pt idx="4">
                  <c:v>1.0540725529999999</c:v>
                </c:pt>
                <c:pt idx="5">
                  <c:v>1.133</c:v>
                </c:pt>
                <c:pt idx="6">
                  <c:v>1.361</c:v>
                </c:pt>
                <c:pt idx="7">
                  <c:v>1.5409999999999999</c:v>
                </c:pt>
                <c:pt idx="8">
                  <c:v>1.64</c:v>
                </c:pt>
                <c:pt idx="9">
                  <c:v>1.7850787130000001</c:v>
                </c:pt>
                <c:pt idx="10">
                  <c:v>2.0259999999999998</c:v>
                </c:pt>
                <c:pt idx="11">
                  <c:v>2.0859999999999999</c:v>
                </c:pt>
                <c:pt idx="12">
                  <c:v>2.1190000000000002</c:v>
                </c:pt>
                <c:pt idx="13">
                  <c:v>2.1459999999999999</c:v>
                </c:pt>
                <c:pt idx="14">
                  <c:v>2.198</c:v>
                </c:pt>
                <c:pt idx="15">
                  <c:v>2.2559999999999998</c:v>
                </c:pt>
                <c:pt idx="16">
                  <c:v>2.2559999999999998</c:v>
                </c:pt>
                <c:pt idx="17">
                  <c:v>2.2749999999999999</c:v>
                </c:pt>
                <c:pt idx="18">
                  <c:v>2.4009999999999998</c:v>
                </c:pt>
                <c:pt idx="19">
                  <c:v>2.415</c:v>
                </c:pt>
                <c:pt idx="20">
                  <c:v>2.4529999999999998</c:v>
                </c:pt>
                <c:pt idx="21">
                  <c:v>2.4780000000000002</c:v>
                </c:pt>
                <c:pt idx="22">
                  <c:v>2.552</c:v>
                </c:pt>
                <c:pt idx="23">
                  <c:v>2.552</c:v>
                </c:pt>
                <c:pt idx="24">
                  <c:v>2.5870000000000002</c:v>
                </c:pt>
                <c:pt idx="25">
                  <c:v>2.5954825459999999</c:v>
                </c:pt>
                <c:pt idx="26">
                  <c:v>2.600958248</c:v>
                </c:pt>
                <c:pt idx="27">
                  <c:v>2.6669999999999998</c:v>
                </c:pt>
                <c:pt idx="28">
                  <c:v>2.9020000000000001</c:v>
                </c:pt>
                <c:pt idx="29">
                  <c:v>2.9322381929999999</c:v>
                </c:pt>
                <c:pt idx="30">
                  <c:v>3.0089999999999999</c:v>
                </c:pt>
                <c:pt idx="31">
                  <c:v>3.0171115670000002</c:v>
                </c:pt>
                <c:pt idx="32">
                  <c:v>3.1047227930000001</c:v>
                </c:pt>
                <c:pt idx="33">
                  <c:v>3.1759069129999999</c:v>
                </c:pt>
                <c:pt idx="34">
                  <c:v>3.181382615</c:v>
                </c:pt>
                <c:pt idx="35">
                  <c:v>3.1920000000000002</c:v>
                </c:pt>
                <c:pt idx="36">
                  <c:v>3.2770000000000001</c:v>
                </c:pt>
                <c:pt idx="37">
                  <c:v>3.2770000000000001</c:v>
                </c:pt>
                <c:pt idx="38">
                  <c:v>3.4798083499999999</c:v>
                </c:pt>
                <c:pt idx="39">
                  <c:v>3.617</c:v>
                </c:pt>
                <c:pt idx="40">
                  <c:v>3.6960000000000002</c:v>
                </c:pt>
                <c:pt idx="41">
                  <c:v>3.7320000000000002</c:v>
                </c:pt>
                <c:pt idx="42">
                  <c:v>3.8410000000000002</c:v>
                </c:pt>
                <c:pt idx="43">
                  <c:v>4.0190000000000001</c:v>
                </c:pt>
                <c:pt idx="44">
                  <c:v>4.0629999999999997</c:v>
                </c:pt>
                <c:pt idx="45">
                  <c:v>4.1040000000000001</c:v>
                </c:pt>
                <c:pt idx="46">
                  <c:v>4.1423682409999998</c:v>
                </c:pt>
                <c:pt idx="47">
                  <c:v>4.1559999999999997</c:v>
                </c:pt>
                <c:pt idx="48">
                  <c:v>4.1619999999999999</c:v>
                </c:pt>
                <c:pt idx="49">
                  <c:v>4.1724845999999998</c:v>
                </c:pt>
                <c:pt idx="50">
                  <c:v>4.1724845999999998</c:v>
                </c:pt>
                <c:pt idx="51">
                  <c:v>4.58</c:v>
                </c:pt>
                <c:pt idx="52">
                  <c:v>4.7830000000000004</c:v>
                </c:pt>
                <c:pt idx="53">
                  <c:v>5.0157426420000002</c:v>
                </c:pt>
                <c:pt idx="54">
                  <c:v>5.0650239560000001</c:v>
                </c:pt>
                <c:pt idx="55">
                  <c:v>6.0205338810000004</c:v>
                </c:pt>
                <c:pt idx="56">
                  <c:v>6.0752908970000004</c:v>
                </c:pt>
              </c:numCache>
            </c:numRef>
          </c:xVal>
          <c:yVal>
            <c:numRef>
              <c:f>Survival!$C$532:$C$588</c:f>
              <c:numCache>
                <c:formatCode>General</c:formatCode>
                <c:ptCount val="57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0.97959183673469385</c:v>
                </c:pt>
                <c:pt idx="5">
                  <c:v>0.97959183673469385</c:v>
                </c:pt>
                <c:pt idx="6">
                  <c:v>0.97959183673469385</c:v>
                </c:pt>
                <c:pt idx="7">
                  <c:v>0.97959183673469385</c:v>
                </c:pt>
                <c:pt idx="8">
                  <c:v>0.97959183673469385</c:v>
                </c:pt>
                <c:pt idx="9">
                  <c:v>0.97959183673469385</c:v>
                </c:pt>
                <c:pt idx="10">
                  <c:v>0.97959183673469385</c:v>
                </c:pt>
                <c:pt idx="11">
                  <c:v>0.97959183673469385</c:v>
                </c:pt>
                <c:pt idx="12">
                  <c:v>0.97959183673469385</c:v>
                </c:pt>
                <c:pt idx="13">
                  <c:v>0.97959183673469385</c:v>
                </c:pt>
                <c:pt idx="14">
                  <c:v>0.97959183673469385</c:v>
                </c:pt>
                <c:pt idx="15">
                  <c:v>0.97959183673469385</c:v>
                </c:pt>
                <c:pt idx="16">
                  <c:v>0.95381310418904397</c:v>
                </c:pt>
                <c:pt idx="17">
                  <c:v>0.95381310418904397</c:v>
                </c:pt>
                <c:pt idx="18">
                  <c:v>0.95381310418904397</c:v>
                </c:pt>
                <c:pt idx="19">
                  <c:v>0.95381310418904397</c:v>
                </c:pt>
                <c:pt idx="20">
                  <c:v>0.95381310418904397</c:v>
                </c:pt>
                <c:pt idx="21">
                  <c:v>0.95381310418904397</c:v>
                </c:pt>
                <c:pt idx="22">
                  <c:v>0.95381310418904397</c:v>
                </c:pt>
                <c:pt idx="23">
                  <c:v>0.92400644468313631</c:v>
                </c:pt>
                <c:pt idx="24">
                  <c:v>0.92400644468313631</c:v>
                </c:pt>
                <c:pt idx="25">
                  <c:v>0.92400644468313631</c:v>
                </c:pt>
                <c:pt idx="26">
                  <c:v>0.92400644468313631</c:v>
                </c:pt>
                <c:pt idx="27">
                  <c:v>0.92400644468313631</c:v>
                </c:pt>
                <c:pt idx="28">
                  <c:v>0.92400644468313631</c:v>
                </c:pt>
                <c:pt idx="29">
                  <c:v>0.92400644468313631</c:v>
                </c:pt>
                <c:pt idx="30">
                  <c:v>0.92400644468313631</c:v>
                </c:pt>
                <c:pt idx="31">
                  <c:v>0.92400644468313631</c:v>
                </c:pt>
                <c:pt idx="32">
                  <c:v>0.92400644468313631</c:v>
                </c:pt>
                <c:pt idx="33">
                  <c:v>0.92400644468313631</c:v>
                </c:pt>
                <c:pt idx="34">
                  <c:v>0.92400644468313631</c:v>
                </c:pt>
                <c:pt idx="35">
                  <c:v>0.92400644468313631</c:v>
                </c:pt>
                <c:pt idx="36">
                  <c:v>0.92400644468313631</c:v>
                </c:pt>
                <c:pt idx="37">
                  <c:v>0.87537452654191861</c:v>
                </c:pt>
                <c:pt idx="38">
                  <c:v>0.87537452654191861</c:v>
                </c:pt>
                <c:pt idx="39">
                  <c:v>0.87537452654191861</c:v>
                </c:pt>
                <c:pt idx="40">
                  <c:v>0.87537452654191861</c:v>
                </c:pt>
                <c:pt idx="41">
                  <c:v>0.87537452654191861</c:v>
                </c:pt>
                <c:pt idx="42">
                  <c:v>0.87537452654191861</c:v>
                </c:pt>
                <c:pt idx="43">
                  <c:v>0.87537452654191861</c:v>
                </c:pt>
                <c:pt idx="44">
                  <c:v>0.87537452654191861</c:v>
                </c:pt>
                <c:pt idx="45">
                  <c:v>0.87537452654191861</c:v>
                </c:pt>
                <c:pt idx="46">
                  <c:v>0.87537452654191861</c:v>
                </c:pt>
                <c:pt idx="47">
                  <c:v>0.87537452654191861</c:v>
                </c:pt>
                <c:pt idx="48">
                  <c:v>0.87537452654191861</c:v>
                </c:pt>
                <c:pt idx="49">
                  <c:v>0.87537452654191861</c:v>
                </c:pt>
                <c:pt idx="50">
                  <c:v>0.75032102275021595</c:v>
                </c:pt>
                <c:pt idx="51">
                  <c:v>0.75032102275021595</c:v>
                </c:pt>
                <c:pt idx="52">
                  <c:v>0.75032102275021595</c:v>
                </c:pt>
                <c:pt idx="53">
                  <c:v>0.75032102275021595</c:v>
                </c:pt>
                <c:pt idx="54">
                  <c:v>0.75032102275021595</c:v>
                </c:pt>
                <c:pt idx="55">
                  <c:v>0.75032102275021595</c:v>
                </c:pt>
                <c:pt idx="56">
                  <c:v>0.7503210227502159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42F8-444F-ABCC-E202436AC43A}"/>
            </c:ext>
          </c:extLst>
        </c:ser>
        <c:ser>
          <c:idx val="2"/>
          <c:order val="1"/>
          <c:tx>
            <c:v>low</c:v>
          </c:tx>
          <c:spPr>
            <a:ln w="25400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Survival!$B$589:$B$1129</c:f>
              <c:numCache>
                <c:formatCode>General</c:formatCode>
                <c:ptCount val="54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.1999999999999998E-2</c:v>
                </c:pt>
                <c:pt idx="4">
                  <c:v>5.1999999999999998E-2</c:v>
                </c:pt>
                <c:pt idx="5">
                  <c:v>8.5000000000000006E-2</c:v>
                </c:pt>
                <c:pt idx="6">
                  <c:v>8.5000000000000006E-2</c:v>
                </c:pt>
                <c:pt idx="7">
                  <c:v>0.115</c:v>
                </c:pt>
                <c:pt idx="8">
                  <c:v>0.115</c:v>
                </c:pt>
                <c:pt idx="9">
                  <c:v>0.13689253900000001</c:v>
                </c:pt>
                <c:pt idx="10">
                  <c:v>0.13689253900000001</c:v>
                </c:pt>
                <c:pt idx="11">
                  <c:v>0.151</c:v>
                </c:pt>
                <c:pt idx="12">
                  <c:v>0.151</c:v>
                </c:pt>
                <c:pt idx="13">
                  <c:v>0.17</c:v>
                </c:pt>
                <c:pt idx="14">
                  <c:v>0.17</c:v>
                </c:pt>
                <c:pt idx="15">
                  <c:v>0.192</c:v>
                </c:pt>
                <c:pt idx="16">
                  <c:v>0.192</c:v>
                </c:pt>
                <c:pt idx="17">
                  <c:v>0.307</c:v>
                </c:pt>
                <c:pt idx="18">
                  <c:v>0.307</c:v>
                </c:pt>
                <c:pt idx="19">
                  <c:v>0.38300000000000001</c:v>
                </c:pt>
                <c:pt idx="20">
                  <c:v>0.38300000000000001</c:v>
                </c:pt>
                <c:pt idx="21">
                  <c:v>0.42436687200000001</c:v>
                </c:pt>
                <c:pt idx="22">
                  <c:v>0.42436687200000001</c:v>
                </c:pt>
                <c:pt idx="23">
                  <c:v>0.44900752900000002</c:v>
                </c:pt>
                <c:pt idx="24">
                  <c:v>0.44900752900000002</c:v>
                </c:pt>
                <c:pt idx="25">
                  <c:v>0.46817248500000003</c:v>
                </c:pt>
                <c:pt idx="26">
                  <c:v>0.46817248500000003</c:v>
                </c:pt>
                <c:pt idx="27">
                  <c:v>0.49281314199999998</c:v>
                </c:pt>
                <c:pt idx="28">
                  <c:v>0.49281314199999998</c:v>
                </c:pt>
                <c:pt idx="29">
                  <c:v>0.51197809699999997</c:v>
                </c:pt>
                <c:pt idx="30">
                  <c:v>0.51700000000000002</c:v>
                </c:pt>
                <c:pt idx="31">
                  <c:v>0.51700000000000002</c:v>
                </c:pt>
                <c:pt idx="32">
                  <c:v>0.52300000000000002</c:v>
                </c:pt>
                <c:pt idx="33">
                  <c:v>0.53114305299999998</c:v>
                </c:pt>
                <c:pt idx="34">
                  <c:v>0.53114305299999998</c:v>
                </c:pt>
                <c:pt idx="35">
                  <c:v>0.54500000000000004</c:v>
                </c:pt>
                <c:pt idx="36">
                  <c:v>0.54500000000000004</c:v>
                </c:pt>
                <c:pt idx="37">
                  <c:v>0.57499999999999996</c:v>
                </c:pt>
                <c:pt idx="38">
                  <c:v>0.57499999999999996</c:v>
                </c:pt>
                <c:pt idx="39">
                  <c:v>0.624</c:v>
                </c:pt>
                <c:pt idx="40">
                  <c:v>0.624</c:v>
                </c:pt>
                <c:pt idx="41">
                  <c:v>0.70899999999999996</c:v>
                </c:pt>
                <c:pt idx="42">
                  <c:v>0.70899999999999996</c:v>
                </c:pt>
                <c:pt idx="43">
                  <c:v>0.71499999999999997</c:v>
                </c:pt>
                <c:pt idx="44">
                  <c:v>0.71499999999999997</c:v>
                </c:pt>
                <c:pt idx="45">
                  <c:v>0.722792608</c:v>
                </c:pt>
                <c:pt idx="46">
                  <c:v>0.722792608</c:v>
                </c:pt>
                <c:pt idx="47">
                  <c:v>0.72799999999999998</c:v>
                </c:pt>
                <c:pt idx="48">
                  <c:v>0.72799999999999998</c:v>
                </c:pt>
                <c:pt idx="49">
                  <c:v>0.76386036999999996</c:v>
                </c:pt>
                <c:pt idx="50">
                  <c:v>0.76386036999999996</c:v>
                </c:pt>
                <c:pt idx="51">
                  <c:v>0.76400000000000001</c:v>
                </c:pt>
                <c:pt idx="52">
                  <c:v>0.76400000000000001</c:v>
                </c:pt>
                <c:pt idx="53">
                  <c:v>0.77800000000000002</c:v>
                </c:pt>
                <c:pt idx="54">
                  <c:v>0.78300000000000003</c:v>
                </c:pt>
                <c:pt idx="55">
                  <c:v>0.78300000000000003</c:v>
                </c:pt>
                <c:pt idx="56">
                  <c:v>0.78302532499999999</c:v>
                </c:pt>
                <c:pt idx="57">
                  <c:v>0.78302532499999999</c:v>
                </c:pt>
                <c:pt idx="58">
                  <c:v>0.79100000000000004</c:v>
                </c:pt>
                <c:pt idx="59">
                  <c:v>0.79100000000000004</c:v>
                </c:pt>
                <c:pt idx="60">
                  <c:v>0.79123887699999995</c:v>
                </c:pt>
                <c:pt idx="61">
                  <c:v>0.79123887699999995</c:v>
                </c:pt>
                <c:pt idx="62">
                  <c:v>0.79400000000000004</c:v>
                </c:pt>
                <c:pt idx="63">
                  <c:v>0.79400000000000004</c:v>
                </c:pt>
                <c:pt idx="64">
                  <c:v>0.79700000000000004</c:v>
                </c:pt>
                <c:pt idx="65">
                  <c:v>0.79700000000000004</c:v>
                </c:pt>
                <c:pt idx="66">
                  <c:v>0.79900000000000004</c:v>
                </c:pt>
                <c:pt idx="67">
                  <c:v>0.79900000000000004</c:v>
                </c:pt>
                <c:pt idx="68">
                  <c:v>0.81861738500000003</c:v>
                </c:pt>
                <c:pt idx="69">
                  <c:v>0.81861738500000003</c:v>
                </c:pt>
                <c:pt idx="70">
                  <c:v>0.82399999999999995</c:v>
                </c:pt>
                <c:pt idx="71">
                  <c:v>0.82409308699999995</c:v>
                </c:pt>
                <c:pt idx="72">
                  <c:v>0.82409308699999995</c:v>
                </c:pt>
                <c:pt idx="73">
                  <c:v>0.85399999999999998</c:v>
                </c:pt>
                <c:pt idx="74">
                  <c:v>0.85399999999999998</c:v>
                </c:pt>
                <c:pt idx="75">
                  <c:v>0.87611225199999998</c:v>
                </c:pt>
                <c:pt idx="76">
                  <c:v>0.87611225199999998</c:v>
                </c:pt>
                <c:pt idx="77">
                  <c:v>0.879</c:v>
                </c:pt>
                <c:pt idx="78">
                  <c:v>0.89</c:v>
                </c:pt>
                <c:pt idx="79">
                  <c:v>0.89</c:v>
                </c:pt>
                <c:pt idx="80">
                  <c:v>0.89800000000000002</c:v>
                </c:pt>
                <c:pt idx="81">
                  <c:v>0.92300000000000004</c:v>
                </c:pt>
                <c:pt idx="82">
                  <c:v>0.92300000000000004</c:v>
                </c:pt>
                <c:pt idx="83">
                  <c:v>0.93100000000000005</c:v>
                </c:pt>
                <c:pt idx="84">
                  <c:v>0.95299999999999996</c:v>
                </c:pt>
                <c:pt idx="85">
                  <c:v>0.95299999999999996</c:v>
                </c:pt>
                <c:pt idx="86">
                  <c:v>0.96399999999999997</c:v>
                </c:pt>
                <c:pt idx="87">
                  <c:v>0.96399999999999997</c:v>
                </c:pt>
                <c:pt idx="88">
                  <c:v>0.98015058200000005</c:v>
                </c:pt>
                <c:pt idx="89">
                  <c:v>0.98799999999999999</c:v>
                </c:pt>
                <c:pt idx="90">
                  <c:v>0.98799999999999999</c:v>
                </c:pt>
                <c:pt idx="91">
                  <c:v>1.008</c:v>
                </c:pt>
                <c:pt idx="92">
                  <c:v>1.0289999999999999</c:v>
                </c:pt>
                <c:pt idx="93">
                  <c:v>1.032</c:v>
                </c:pt>
                <c:pt idx="94">
                  <c:v>1.0376454479999999</c:v>
                </c:pt>
                <c:pt idx="95">
                  <c:v>1.0509999999999999</c:v>
                </c:pt>
                <c:pt idx="96">
                  <c:v>1.0620000000000001</c:v>
                </c:pt>
                <c:pt idx="97">
                  <c:v>1.0760000000000001</c:v>
                </c:pt>
                <c:pt idx="98">
                  <c:v>1.1200000000000001</c:v>
                </c:pt>
                <c:pt idx="99">
                  <c:v>1.1279999999999999</c:v>
                </c:pt>
                <c:pt idx="100">
                  <c:v>1.133</c:v>
                </c:pt>
                <c:pt idx="101">
                  <c:v>1.133</c:v>
                </c:pt>
                <c:pt idx="102">
                  <c:v>1.1419999999999999</c:v>
                </c:pt>
                <c:pt idx="103">
                  <c:v>1.1439999999999999</c:v>
                </c:pt>
                <c:pt idx="104">
                  <c:v>1.1439999999999999</c:v>
                </c:pt>
                <c:pt idx="105">
                  <c:v>1.147</c:v>
                </c:pt>
                <c:pt idx="106">
                  <c:v>1.161</c:v>
                </c:pt>
                <c:pt idx="107">
                  <c:v>1.1879999999999999</c:v>
                </c:pt>
                <c:pt idx="108">
                  <c:v>1.1937029429999999</c:v>
                </c:pt>
                <c:pt idx="109">
                  <c:v>1.1937029429999999</c:v>
                </c:pt>
                <c:pt idx="110">
                  <c:v>1.194</c:v>
                </c:pt>
                <c:pt idx="111">
                  <c:v>1.1991786449999999</c:v>
                </c:pt>
                <c:pt idx="112">
                  <c:v>1.1991786449999999</c:v>
                </c:pt>
                <c:pt idx="113">
                  <c:v>1.2128678989999999</c:v>
                </c:pt>
                <c:pt idx="114">
                  <c:v>1.2128678989999999</c:v>
                </c:pt>
                <c:pt idx="115">
                  <c:v>1.2347707050000001</c:v>
                </c:pt>
                <c:pt idx="116">
                  <c:v>1.2347707050000001</c:v>
                </c:pt>
                <c:pt idx="117">
                  <c:v>1.2375085560000001</c:v>
                </c:pt>
                <c:pt idx="118">
                  <c:v>1.2375085560000001</c:v>
                </c:pt>
                <c:pt idx="119">
                  <c:v>1.24</c:v>
                </c:pt>
                <c:pt idx="120">
                  <c:v>1.242984257</c:v>
                </c:pt>
                <c:pt idx="121">
                  <c:v>1.2430000000000001</c:v>
                </c:pt>
                <c:pt idx="122">
                  <c:v>1.248</c:v>
                </c:pt>
                <c:pt idx="123">
                  <c:v>1.248</c:v>
                </c:pt>
                <c:pt idx="124">
                  <c:v>1.259411362</c:v>
                </c:pt>
                <c:pt idx="125">
                  <c:v>1.259411362</c:v>
                </c:pt>
                <c:pt idx="126">
                  <c:v>1.2649999999999999</c:v>
                </c:pt>
                <c:pt idx="127">
                  <c:v>1.2649999999999999</c:v>
                </c:pt>
                <c:pt idx="128">
                  <c:v>1.273100616</c:v>
                </c:pt>
                <c:pt idx="129">
                  <c:v>1.273100616</c:v>
                </c:pt>
                <c:pt idx="130">
                  <c:v>1.284</c:v>
                </c:pt>
                <c:pt idx="131">
                  <c:v>1.306</c:v>
                </c:pt>
                <c:pt idx="132">
                  <c:v>1.3360000000000001</c:v>
                </c:pt>
                <c:pt idx="133">
                  <c:v>1.3388090349999999</c:v>
                </c:pt>
                <c:pt idx="134">
                  <c:v>1.3388090349999999</c:v>
                </c:pt>
                <c:pt idx="135">
                  <c:v>1.3440000000000001</c:v>
                </c:pt>
                <c:pt idx="136">
                  <c:v>1.3440000000000001</c:v>
                </c:pt>
                <c:pt idx="137">
                  <c:v>1.3470225870000001</c:v>
                </c:pt>
                <c:pt idx="138">
                  <c:v>1.35</c:v>
                </c:pt>
                <c:pt idx="139">
                  <c:v>1.35</c:v>
                </c:pt>
                <c:pt idx="140">
                  <c:v>1.3720000000000001</c:v>
                </c:pt>
                <c:pt idx="141">
                  <c:v>1.3720000000000001</c:v>
                </c:pt>
                <c:pt idx="142">
                  <c:v>1.377</c:v>
                </c:pt>
                <c:pt idx="143">
                  <c:v>1.377</c:v>
                </c:pt>
                <c:pt idx="144">
                  <c:v>1.391</c:v>
                </c:pt>
                <c:pt idx="145">
                  <c:v>1.415</c:v>
                </c:pt>
                <c:pt idx="146">
                  <c:v>1.4319999999999999</c:v>
                </c:pt>
                <c:pt idx="147">
                  <c:v>1.4370000000000001</c:v>
                </c:pt>
                <c:pt idx="148">
                  <c:v>1.4370000000000001</c:v>
                </c:pt>
                <c:pt idx="149">
                  <c:v>1.440109514</c:v>
                </c:pt>
                <c:pt idx="150">
                  <c:v>1.442847365</c:v>
                </c:pt>
                <c:pt idx="151">
                  <c:v>1.442847365</c:v>
                </c:pt>
                <c:pt idx="152">
                  <c:v>1.4870000000000001</c:v>
                </c:pt>
                <c:pt idx="153">
                  <c:v>1.5085557839999999</c:v>
                </c:pt>
                <c:pt idx="154">
                  <c:v>1.5085557839999999</c:v>
                </c:pt>
                <c:pt idx="155">
                  <c:v>1.5169999999999999</c:v>
                </c:pt>
                <c:pt idx="156">
                  <c:v>1.5304585900000001</c:v>
                </c:pt>
                <c:pt idx="157">
                  <c:v>1.536</c:v>
                </c:pt>
                <c:pt idx="158">
                  <c:v>1.536</c:v>
                </c:pt>
                <c:pt idx="159">
                  <c:v>1.5740000000000001</c:v>
                </c:pt>
                <c:pt idx="160">
                  <c:v>1.58</c:v>
                </c:pt>
                <c:pt idx="161">
                  <c:v>1.58</c:v>
                </c:pt>
                <c:pt idx="162">
                  <c:v>1.6043805609999999</c:v>
                </c:pt>
                <c:pt idx="163">
                  <c:v>1.613</c:v>
                </c:pt>
                <c:pt idx="164">
                  <c:v>1.6317590689999999</c:v>
                </c:pt>
                <c:pt idx="165">
                  <c:v>1.6317590689999999</c:v>
                </c:pt>
                <c:pt idx="166">
                  <c:v>1.6509240249999999</c:v>
                </c:pt>
                <c:pt idx="167">
                  <c:v>1.6509240249999999</c:v>
                </c:pt>
                <c:pt idx="168">
                  <c:v>1.665</c:v>
                </c:pt>
                <c:pt idx="169">
                  <c:v>1.67</c:v>
                </c:pt>
                <c:pt idx="170">
                  <c:v>1.6892539360000001</c:v>
                </c:pt>
                <c:pt idx="171">
                  <c:v>1.6919999999999999</c:v>
                </c:pt>
                <c:pt idx="172">
                  <c:v>1.694729637</c:v>
                </c:pt>
                <c:pt idx="173">
                  <c:v>1.6950000000000001</c:v>
                </c:pt>
                <c:pt idx="174">
                  <c:v>1.7029431900000001</c:v>
                </c:pt>
                <c:pt idx="175">
                  <c:v>1.7029431900000001</c:v>
                </c:pt>
                <c:pt idx="176">
                  <c:v>1.706</c:v>
                </c:pt>
                <c:pt idx="177">
                  <c:v>1.706</c:v>
                </c:pt>
                <c:pt idx="178">
                  <c:v>1.708418891</c:v>
                </c:pt>
                <c:pt idx="179">
                  <c:v>1.7110000000000001</c:v>
                </c:pt>
                <c:pt idx="180">
                  <c:v>1.7170000000000001</c:v>
                </c:pt>
                <c:pt idx="181">
                  <c:v>1.7170000000000001</c:v>
                </c:pt>
                <c:pt idx="182">
                  <c:v>1.7190000000000001</c:v>
                </c:pt>
                <c:pt idx="183">
                  <c:v>1.728</c:v>
                </c:pt>
                <c:pt idx="184">
                  <c:v>1.73853525</c:v>
                </c:pt>
                <c:pt idx="185">
                  <c:v>1.744</c:v>
                </c:pt>
                <c:pt idx="186">
                  <c:v>1.752</c:v>
                </c:pt>
                <c:pt idx="187">
                  <c:v>1.752</c:v>
                </c:pt>
                <c:pt idx="188">
                  <c:v>1.7741273099999999</c:v>
                </c:pt>
                <c:pt idx="189">
                  <c:v>1.8180000000000001</c:v>
                </c:pt>
                <c:pt idx="190">
                  <c:v>1.8180000000000001</c:v>
                </c:pt>
                <c:pt idx="191">
                  <c:v>1.820670773</c:v>
                </c:pt>
                <c:pt idx="192">
                  <c:v>1.8320000000000001</c:v>
                </c:pt>
                <c:pt idx="193">
                  <c:v>1.8320000000000001</c:v>
                </c:pt>
                <c:pt idx="194">
                  <c:v>1.837097878</c:v>
                </c:pt>
                <c:pt idx="195">
                  <c:v>1.845</c:v>
                </c:pt>
                <c:pt idx="196">
                  <c:v>1.845</c:v>
                </c:pt>
                <c:pt idx="197">
                  <c:v>1.851</c:v>
                </c:pt>
                <c:pt idx="198">
                  <c:v>1.8560000000000001</c:v>
                </c:pt>
                <c:pt idx="199">
                  <c:v>1.8726899379999999</c:v>
                </c:pt>
                <c:pt idx="200">
                  <c:v>1.8779999999999999</c:v>
                </c:pt>
                <c:pt idx="201">
                  <c:v>1.881</c:v>
                </c:pt>
                <c:pt idx="202">
                  <c:v>1.881</c:v>
                </c:pt>
                <c:pt idx="203">
                  <c:v>1.8839999999999999</c:v>
                </c:pt>
                <c:pt idx="204">
                  <c:v>1.8919999999999999</c:v>
                </c:pt>
                <c:pt idx="205">
                  <c:v>1.8973305949999999</c:v>
                </c:pt>
                <c:pt idx="206">
                  <c:v>1.8973305949999999</c:v>
                </c:pt>
                <c:pt idx="207">
                  <c:v>1.9</c:v>
                </c:pt>
                <c:pt idx="208">
                  <c:v>1.9159999999999999</c:v>
                </c:pt>
                <c:pt idx="209">
                  <c:v>1.9247091030000001</c:v>
                </c:pt>
                <c:pt idx="210">
                  <c:v>1.927</c:v>
                </c:pt>
                <c:pt idx="211">
                  <c:v>1.9359999999999999</c:v>
                </c:pt>
                <c:pt idx="212">
                  <c:v>1.9438740590000001</c:v>
                </c:pt>
                <c:pt idx="213">
                  <c:v>1.9438740590000001</c:v>
                </c:pt>
                <c:pt idx="214">
                  <c:v>1.94934976</c:v>
                </c:pt>
                <c:pt idx="215">
                  <c:v>1.9548254620000001</c:v>
                </c:pt>
                <c:pt idx="216">
                  <c:v>1.958</c:v>
                </c:pt>
                <c:pt idx="217">
                  <c:v>1.9630000000000001</c:v>
                </c:pt>
                <c:pt idx="218">
                  <c:v>1.9790000000000001</c:v>
                </c:pt>
                <c:pt idx="219">
                  <c:v>2.0099999999999998</c:v>
                </c:pt>
                <c:pt idx="220">
                  <c:v>2.0260095819999999</c:v>
                </c:pt>
                <c:pt idx="221">
                  <c:v>2.0260095819999999</c:v>
                </c:pt>
                <c:pt idx="222">
                  <c:v>2.0449999999999999</c:v>
                </c:pt>
                <c:pt idx="223">
                  <c:v>2.0479123889999999</c:v>
                </c:pt>
                <c:pt idx="224">
                  <c:v>2.0590000000000002</c:v>
                </c:pt>
                <c:pt idx="225">
                  <c:v>2.0640000000000001</c:v>
                </c:pt>
                <c:pt idx="226">
                  <c:v>2.0862422999999999</c:v>
                </c:pt>
                <c:pt idx="227">
                  <c:v>2.0939999999999999</c:v>
                </c:pt>
                <c:pt idx="228">
                  <c:v>2.0999315539999999</c:v>
                </c:pt>
                <c:pt idx="229">
                  <c:v>2.0999315539999999</c:v>
                </c:pt>
                <c:pt idx="230">
                  <c:v>2.105</c:v>
                </c:pt>
                <c:pt idx="231">
                  <c:v>2.1054072549999998</c:v>
                </c:pt>
                <c:pt idx="232">
                  <c:v>2.133</c:v>
                </c:pt>
                <c:pt idx="233">
                  <c:v>2.133</c:v>
                </c:pt>
                <c:pt idx="234">
                  <c:v>2.1355236139999998</c:v>
                </c:pt>
                <c:pt idx="235">
                  <c:v>2.1355236139999998</c:v>
                </c:pt>
                <c:pt idx="236">
                  <c:v>2.16</c:v>
                </c:pt>
                <c:pt idx="237">
                  <c:v>2.1709999999999998</c:v>
                </c:pt>
                <c:pt idx="238">
                  <c:v>2.1739999999999999</c:v>
                </c:pt>
                <c:pt idx="239">
                  <c:v>2.1793292270000002</c:v>
                </c:pt>
                <c:pt idx="240">
                  <c:v>2.1793292270000002</c:v>
                </c:pt>
                <c:pt idx="241">
                  <c:v>2.1819999999999999</c:v>
                </c:pt>
                <c:pt idx="242">
                  <c:v>2.1875427790000002</c:v>
                </c:pt>
                <c:pt idx="243">
                  <c:v>2.1880000000000002</c:v>
                </c:pt>
                <c:pt idx="244">
                  <c:v>2.1880000000000002</c:v>
                </c:pt>
                <c:pt idx="245">
                  <c:v>2.198</c:v>
                </c:pt>
                <c:pt idx="246">
                  <c:v>2.2229999999999999</c:v>
                </c:pt>
                <c:pt idx="247">
                  <c:v>2.2231348390000001</c:v>
                </c:pt>
                <c:pt idx="248">
                  <c:v>2.234</c:v>
                </c:pt>
                <c:pt idx="249">
                  <c:v>2.2530000000000001</c:v>
                </c:pt>
                <c:pt idx="250">
                  <c:v>2.2530000000000001</c:v>
                </c:pt>
                <c:pt idx="251">
                  <c:v>2.2610000000000001</c:v>
                </c:pt>
                <c:pt idx="252">
                  <c:v>2.2639999999999998</c:v>
                </c:pt>
                <c:pt idx="253">
                  <c:v>2.278</c:v>
                </c:pt>
                <c:pt idx="254">
                  <c:v>2.278</c:v>
                </c:pt>
                <c:pt idx="255">
                  <c:v>2.2810000000000001</c:v>
                </c:pt>
                <c:pt idx="256">
                  <c:v>2.299794661</c:v>
                </c:pt>
                <c:pt idx="257">
                  <c:v>2.299794661</c:v>
                </c:pt>
                <c:pt idx="258">
                  <c:v>2.3029999999999999</c:v>
                </c:pt>
                <c:pt idx="259">
                  <c:v>2.318959617</c:v>
                </c:pt>
                <c:pt idx="260">
                  <c:v>2.3216974669999999</c:v>
                </c:pt>
                <c:pt idx="261">
                  <c:v>2.3330000000000002</c:v>
                </c:pt>
                <c:pt idx="262">
                  <c:v>2.3380000000000001</c:v>
                </c:pt>
                <c:pt idx="263">
                  <c:v>2.3410000000000002</c:v>
                </c:pt>
                <c:pt idx="264">
                  <c:v>2.3410000000000002</c:v>
                </c:pt>
                <c:pt idx="265">
                  <c:v>2.3439999999999999</c:v>
                </c:pt>
                <c:pt idx="266">
                  <c:v>2.3460000000000001</c:v>
                </c:pt>
                <c:pt idx="267">
                  <c:v>2.3460000000000001</c:v>
                </c:pt>
                <c:pt idx="268">
                  <c:v>2.3570000000000002</c:v>
                </c:pt>
                <c:pt idx="269">
                  <c:v>2.36</c:v>
                </c:pt>
                <c:pt idx="270">
                  <c:v>2.363</c:v>
                </c:pt>
                <c:pt idx="271">
                  <c:v>2.371</c:v>
                </c:pt>
                <c:pt idx="272">
                  <c:v>2.3764544829999998</c:v>
                </c:pt>
                <c:pt idx="273">
                  <c:v>2.39</c:v>
                </c:pt>
                <c:pt idx="274">
                  <c:v>2.3929999999999998</c:v>
                </c:pt>
                <c:pt idx="275">
                  <c:v>2.3959999999999999</c:v>
                </c:pt>
                <c:pt idx="276">
                  <c:v>2.3959999999999999</c:v>
                </c:pt>
                <c:pt idx="277">
                  <c:v>2.4503764540000001</c:v>
                </c:pt>
                <c:pt idx="278">
                  <c:v>2.4558521560000002</c:v>
                </c:pt>
                <c:pt idx="279">
                  <c:v>2.456</c:v>
                </c:pt>
                <c:pt idx="280">
                  <c:v>2.464</c:v>
                </c:pt>
                <c:pt idx="281">
                  <c:v>2.48</c:v>
                </c:pt>
                <c:pt idx="282">
                  <c:v>2.4859685150000002</c:v>
                </c:pt>
                <c:pt idx="283">
                  <c:v>2.4887063660000002</c:v>
                </c:pt>
                <c:pt idx="284">
                  <c:v>2.4889999999999999</c:v>
                </c:pt>
                <c:pt idx="285">
                  <c:v>2.508</c:v>
                </c:pt>
                <c:pt idx="286">
                  <c:v>2.5110000000000001</c:v>
                </c:pt>
                <c:pt idx="287">
                  <c:v>2.516</c:v>
                </c:pt>
                <c:pt idx="288">
                  <c:v>2.5270000000000001</c:v>
                </c:pt>
                <c:pt idx="289">
                  <c:v>2.5299999999999998</c:v>
                </c:pt>
                <c:pt idx="290">
                  <c:v>2.5329999999999999</c:v>
                </c:pt>
                <c:pt idx="291">
                  <c:v>2.5329999999999999</c:v>
                </c:pt>
                <c:pt idx="292">
                  <c:v>2.57357974</c:v>
                </c:pt>
                <c:pt idx="293">
                  <c:v>2.6040000000000001</c:v>
                </c:pt>
                <c:pt idx="294">
                  <c:v>2.617</c:v>
                </c:pt>
                <c:pt idx="295">
                  <c:v>2.6480000000000001</c:v>
                </c:pt>
                <c:pt idx="296">
                  <c:v>2.6480000000000001</c:v>
                </c:pt>
                <c:pt idx="297">
                  <c:v>2.6639288159999999</c:v>
                </c:pt>
                <c:pt idx="298">
                  <c:v>2.669</c:v>
                </c:pt>
                <c:pt idx="299">
                  <c:v>2.669</c:v>
                </c:pt>
                <c:pt idx="300">
                  <c:v>2.6694045169999998</c:v>
                </c:pt>
                <c:pt idx="301">
                  <c:v>2.6694045169999998</c:v>
                </c:pt>
                <c:pt idx="302">
                  <c:v>2.6720000000000002</c:v>
                </c:pt>
                <c:pt idx="303">
                  <c:v>2.694</c:v>
                </c:pt>
                <c:pt idx="304">
                  <c:v>2.7</c:v>
                </c:pt>
                <c:pt idx="305">
                  <c:v>2.7320000000000002</c:v>
                </c:pt>
                <c:pt idx="306">
                  <c:v>2.7320000000000002</c:v>
                </c:pt>
                <c:pt idx="307">
                  <c:v>2.7433264890000002</c:v>
                </c:pt>
                <c:pt idx="308">
                  <c:v>2.746</c:v>
                </c:pt>
                <c:pt idx="309">
                  <c:v>2.754</c:v>
                </c:pt>
                <c:pt idx="310">
                  <c:v>2.7652292950000001</c:v>
                </c:pt>
                <c:pt idx="311">
                  <c:v>2.7652292950000001</c:v>
                </c:pt>
                <c:pt idx="312">
                  <c:v>2.7789185490000001</c:v>
                </c:pt>
                <c:pt idx="313">
                  <c:v>2.798</c:v>
                </c:pt>
                <c:pt idx="314">
                  <c:v>2.8090349080000001</c:v>
                </c:pt>
                <c:pt idx="315">
                  <c:v>2.8170000000000002</c:v>
                </c:pt>
                <c:pt idx="316">
                  <c:v>2.8172484600000001</c:v>
                </c:pt>
                <c:pt idx="317">
                  <c:v>2.8227241620000001</c:v>
                </c:pt>
                <c:pt idx="318">
                  <c:v>2.8420000000000001</c:v>
                </c:pt>
                <c:pt idx="319">
                  <c:v>2.847364819</c:v>
                </c:pt>
                <c:pt idx="320">
                  <c:v>2.85284052</c:v>
                </c:pt>
                <c:pt idx="321">
                  <c:v>2.861054073</c:v>
                </c:pt>
                <c:pt idx="322">
                  <c:v>2.8719999999999999</c:v>
                </c:pt>
                <c:pt idx="323">
                  <c:v>2.8719999999999999</c:v>
                </c:pt>
                <c:pt idx="324">
                  <c:v>2.8769999999999998</c:v>
                </c:pt>
                <c:pt idx="325">
                  <c:v>2.8769999999999998</c:v>
                </c:pt>
                <c:pt idx="326">
                  <c:v>2.883</c:v>
                </c:pt>
                <c:pt idx="327">
                  <c:v>2.9075975359999999</c:v>
                </c:pt>
                <c:pt idx="328">
                  <c:v>2.9075975359999999</c:v>
                </c:pt>
                <c:pt idx="329">
                  <c:v>2.9349760439999999</c:v>
                </c:pt>
                <c:pt idx="330">
                  <c:v>2.9460000000000002</c:v>
                </c:pt>
                <c:pt idx="331">
                  <c:v>2.9514031489999999</c:v>
                </c:pt>
                <c:pt idx="332">
                  <c:v>2.9514031489999999</c:v>
                </c:pt>
                <c:pt idx="333">
                  <c:v>2.9540000000000002</c:v>
                </c:pt>
                <c:pt idx="334">
                  <c:v>2.9568788499999998</c:v>
                </c:pt>
                <c:pt idx="335">
                  <c:v>2.9729999999999999</c:v>
                </c:pt>
                <c:pt idx="336">
                  <c:v>2.9733059549999998</c:v>
                </c:pt>
                <c:pt idx="337">
                  <c:v>2.9787816559999998</c:v>
                </c:pt>
                <c:pt idx="338">
                  <c:v>2.99</c:v>
                </c:pt>
                <c:pt idx="339">
                  <c:v>2.992</c:v>
                </c:pt>
                <c:pt idx="340">
                  <c:v>3.0061601640000002</c:v>
                </c:pt>
                <c:pt idx="341">
                  <c:v>3.028</c:v>
                </c:pt>
                <c:pt idx="342">
                  <c:v>3.0335386720000002</c:v>
                </c:pt>
                <c:pt idx="343">
                  <c:v>3.0470000000000002</c:v>
                </c:pt>
                <c:pt idx="344">
                  <c:v>3.0499657770000002</c:v>
                </c:pt>
                <c:pt idx="345">
                  <c:v>3.0828199860000001</c:v>
                </c:pt>
                <c:pt idx="346">
                  <c:v>3.0855578370000001</c:v>
                </c:pt>
                <c:pt idx="347">
                  <c:v>3.0910335390000001</c:v>
                </c:pt>
                <c:pt idx="348">
                  <c:v>3.0910335390000001</c:v>
                </c:pt>
                <c:pt idx="349">
                  <c:v>3.126625599</c:v>
                </c:pt>
                <c:pt idx="350">
                  <c:v>3.137577002</c:v>
                </c:pt>
                <c:pt idx="351">
                  <c:v>3.1509999999999998</c:v>
                </c:pt>
                <c:pt idx="352">
                  <c:v>3.1589999999999998</c:v>
                </c:pt>
                <c:pt idx="353">
                  <c:v>3.181382615</c:v>
                </c:pt>
                <c:pt idx="354">
                  <c:v>3.1868583159999999</c:v>
                </c:pt>
                <c:pt idx="355">
                  <c:v>3.1869999999999998</c:v>
                </c:pt>
                <c:pt idx="356">
                  <c:v>3.195071869</c:v>
                </c:pt>
                <c:pt idx="357">
                  <c:v>3.214</c:v>
                </c:pt>
                <c:pt idx="358">
                  <c:v>3.2389999999999999</c:v>
                </c:pt>
                <c:pt idx="359">
                  <c:v>3.2470910339999999</c:v>
                </c:pt>
                <c:pt idx="360">
                  <c:v>3.25</c:v>
                </c:pt>
                <c:pt idx="361">
                  <c:v>3.2610000000000001</c:v>
                </c:pt>
                <c:pt idx="362">
                  <c:v>3.2719999999999998</c:v>
                </c:pt>
                <c:pt idx="363">
                  <c:v>3.2829999999999999</c:v>
                </c:pt>
                <c:pt idx="364">
                  <c:v>3.3100616020000002</c:v>
                </c:pt>
                <c:pt idx="365">
                  <c:v>3.3538672140000001</c:v>
                </c:pt>
                <c:pt idx="366">
                  <c:v>3.3538672140000001</c:v>
                </c:pt>
                <c:pt idx="367">
                  <c:v>3.3620000000000001</c:v>
                </c:pt>
                <c:pt idx="368">
                  <c:v>3.3620000000000001</c:v>
                </c:pt>
                <c:pt idx="369">
                  <c:v>3.3675564680000001</c:v>
                </c:pt>
                <c:pt idx="370">
                  <c:v>3.3679999999999999</c:v>
                </c:pt>
                <c:pt idx="371">
                  <c:v>3.3812457220000001</c:v>
                </c:pt>
                <c:pt idx="372">
                  <c:v>3.403148528</c:v>
                </c:pt>
                <c:pt idx="373">
                  <c:v>3.40862423</c:v>
                </c:pt>
                <c:pt idx="374">
                  <c:v>3.419575633</c:v>
                </c:pt>
                <c:pt idx="375">
                  <c:v>3.430527036</c:v>
                </c:pt>
                <c:pt idx="376">
                  <c:v>3.430527036</c:v>
                </c:pt>
                <c:pt idx="377">
                  <c:v>3.4470000000000001</c:v>
                </c:pt>
                <c:pt idx="378">
                  <c:v>3.452</c:v>
                </c:pt>
                <c:pt idx="379">
                  <c:v>3.452</c:v>
                </c:pt>
                <c:pt idx="380">
                  <c:v>3.4689999999999999</c:v>
                </c:pt>
                <c:pt idx="381">
                  <c:v>3.4798083499999999</c:v>
                </c:pt>
                <c:pt idx="382">
                  <c:v>3.4934976039999999</c:v>
                </c:pt>
                <c:pt idx="383">
                  <c:v>3.4934976039999999</c:v>
                </c:pt>
                <c:pt idx="384">
                  <c:v>3.504</c:v>
                </c:pt>
                <c:pt idx="385">
                  <c:v>3.5179999999999998</c:v>
                </c:pt>
                <c:pt idx="386">
                  <c:v>3.54</c:v>
                </c:pt>
                <c:pt idx="387">
                  <c:v>3.5865845310000002</c:v>
                </c:pt>
                <c:pt idx="388">
                  <c:v>3.5870000000000002</c:v>
                </c:pt>
                <c:pt idx="389">
                  <c:v>3.6303901440000002</c:v>
                </c:pt>
                <c:pt idx="390">
                  <c:v>3.6469999999999998</c:v>
                </c:pt>
                <c:pt idx="391">
                  <c:v>3.6687200550000001</c:v>
                </c:pt>
                <c:pt idx="392">
                  <c:v>3.6850000000000001</c:v>
                </c:pt>
                <c:pt idx="393">
                  <c:v>3.6960985630000001</c:v>
                </c:pt>
                <c:pt idx="394">
                  <c:v>3.701574264</c:v>
                </c:pt>
                <c:pt idx="395">
                  <c:v>3.7149999999999999</c:v>
                </c:pt>
                <c:pt idx="396">
                  <c:v>3.7450000000000001</c:v>
                </c:pt>
                <c:pt idx="397">
                  <c:v>3.754</c:v>
                </c:pt>
                <c:pt idx="398">
                  <c:v>3.7559999999999998</c:v>
                </c:pt>
                <c:pt idx="399">
                  <c:v>3.7559999999999998</c:v>
                </c:pt>
                <c:pt idx="400">
                  <c:v>3.7749999999999999</c:v>
                </c:pt>
                <c:pt idx="401">
                  <c:v>3.8</c:v>
                </c:pt>
                <c:pt idx="402">
                  <c:v>3.8029999999999999</c:v>
                </c:pt>
                <c:pt idx="403">
                  <c:v>3.8138261459999998</c:v>
                </c:pt>
                <c:pt idx="404">
                  <c:v>3.8220000000000001</c:v>
                </c:pt>
                <c:pt idx="405">
                  <c:v>3.8879999999999999</c:v>
                </c:pt>
                <c:pt idx="406">
                  <c:v>3.9039999999999999</c:v>
                </c:pt>
                <c:pt idx="407">
                  <c:v>3.9096509240000001</c:v>
                </c:pt>
                <c:pt idx="408">
                  <c:v>3.9260780290000001</c:v>
                </c:pt>
                <c:pt idx="409">
                  <c:v>3.9260780290000001</c:v>
                </c:pt>
                <c:pt idx="410">
                  <c:v>3.9342915810000001</c:v>
                </c:pt>
                <c:pt idx="411">
                  <c:v>3.9370294320000001</c:v>
                </c:pt>
                <c:pt idx="412">
                  <c:v>3.958932238</c:v>
                </c:pt>
                <c:pt idx="413">
                  <c:v>3.972621492</c:v>
                </c:pt>
                <c:pt idx="414">
                  <c:v>3.989048597</c:v>
                </c:pt>
                <c:pt idx="415">
                  <c:v>4.002737851</c:v>
                </c:pt>
                <c:pt idx="416">
                  <c:v>4.008</c:v>
                </c:pt>
                <c:pt idx="417">
                  <c:v>4.019164956</c:v>
                </c:pt>
                <c:pt idx="418">
                  <c:v>4.0219028059999999</c:v>
                </c:pt>
                <c:pt idx="419">
                  <c:v>4.024640657</c:v>
                </c:pt>
                <c:pt idx="420">
                  <c:v>4.0270000000000001</c:v>
                </c:pt>
                <c:pt idx="421">
                  <c:v>4.0570000000000004</c:v>
                </c:pt>
                <c:pt idx="422">
                  <c:v>4.0629705679999999</c:v>
                </c:pt>
                <c:pt idx="423">
                  <c:v>4.0739999999999998</c:v>
                </c:pt>
                <c:pt idx="424">
                  <c:v>4.0958247779999999</c:v>
                </c:pt>
                <c:pt idx="425">
                  <c:v>4.1100000000000003</c:v>
                </c:pt>
                <c:pt idx="426">
                  <c:v>4.1204654349999998</c:v>
                </c:pt>
                <c:pt idx="427">
                  <c:v>4.1232032849999998</c:v>
                </c:pt>
                <c:pt idx="428">
                  <c:v>4.1260000000000003</c:v>
                </c:pt>
                <c:pt idx="429">
                  <c:v>4.1529999999999996</c:v>
                </c:pt>
                <c:pt idx="430">
                  <c:v>4.1533196439999998</c:v>
                </c:pt>
                <c:pt idx="431">
                  <c:v>4.1779603009999997</c:v>
                </c:pt>
                <c:pt idx="432">
                  <c:v>4.1889117039999997</c:v>
                </c:pt>
                <c:pt idx="433">
                  <c:v>4.194</c:v>
                </c:pt>
                <c:pt idx="434">
                  <c:v>4.2220000000000004</c:v>
                </c:pt>
                <c:pt idx="435">
                  <c:v>4.2329999999999997</c:v>
                </c:pt>
                <c:pt idx="436">
                  <c:v>4.298</c:v>
                </c:pt>
                <c:pt idx="437">
                  <c:v>4.3040000000000003</c:v>
                </c:pt>
                <c:pt idx="438">
                  <c:v>4.3289999999999997</c:v>
                </c:pt>
                <c:pt idx="439">
                  <c:v>4.3479999999999999</c:v>
                </c:pt>
                <c:pt idx="440">
                  <c:v>4.37</c:v>
                </c:pt>
                <c:pt idx="441">
                  <c:v>4.3780000000000001</c:v>
                </c:pt>
                <c:pt idx="442">
                  <c:v>4.4188911700000002</c:v>
                </c:pt>
                <c:pt idx="443">
                  <c:v>4.4216290210000002</c:v>
                </c:pt>
                <c:pt idx="444">
                  <c:v>4.4271047230000002</c:v>
                </c:pt>
                <c:pt idx="445">
                  <c:v>4.4353182750000002</c:v>
                </c:pt>
                <c:pt idx="446">
                  <c:v>4.4462696780000002</c:v>
                </c:pt>
                <c:pt idx="447">
                  <c:v>4.4599589320000002</c:v>
                </c:pt>
                <c:pt idx="448">
                  <c:v>4.4626967830000002</c:v>
                </c:pt>
                <c:pt idx="449">
                  <c:v>4.4681724850000002</c:v>
                </c:pt>
                <c:pt idx="450">
                  <c:v>4.4818617390000002</c:v>
                </c:pt>
                <c:pt idx="451">
                  <c:v>4.4845995890000001</c:v>
                </c:pt>
                <c:pt idx="452">
                  <c:v>4.4850000000000003</c:v>
                </c:pt>
                <c:pt idx="453">
                  <c:v>4.5174537990000001</c:v>
                </c:pt>
                <c:pt idx="454">
                  <c:v>4.5279999999999996</c:v>
                </c:pt>
                <c:pt idx="455">
                  <c:v>4.533880903</c:v>
                </c:pt>
                <c:pt idx="456">
                  <c:v>4.5419999999999998</c:v>
                </c:pt>
                <c:pt idx="457">
                  <c:v>4.547570157</c:v>
                </c:pt>
                <c:pt idx="458">
                  <c:v>4.547570157</c:v>
                </c:pt>
                <c:pt idx="459">
                  <c:v>4.561259411</c:v>
                </c:pt>
                <c:pt idx="460">
                  <c:v>4.566735113</c:v>
                </c:pt>
                <c:pt idx="461">
                  <c:v>4.5750000000000002</c:v>
                </c:pt>
                <c:pt idx="462">
                  <c:v>4.580424367</c:v>
                </c:pt>
                <c:pt idx="463">
                  <c:v>4.5970000000000004</c:v>
                </c:pt>
                <c:pt idx="464">
                  <c:v>4.6239999999999997</c:v>
                </c:pt>
                <c:pt idx="465">
                  <c:v>4.6570841889999999</c:v>
                </c:pt>
                <c:pt idx="466">
                  <c:v>4.6840000000000002</c:v>
                </c:pt>
                <c:pt idx="467">
                  <c:v>4.6872005479999999</c:v>
                </c:pt>
                <c:pt idx="468">
                  <c:v>4.7060000000000004</c:v>
                </c:pt>
                <c:pt idx="469">
                  <c:v>4.7255304589999998</c:v>
                </c:pt>
                <c:pt idx="470">
                  <c:v>4.7529089659999997</c:v>
                </c:pt>
                <c:pt idx="471">
                  <c:v>4.7693360709999997</c:v>
                </c:pt>
                <c:pt idx="472">
                  <c:v>4.7912388769999996</c:v>
                </c:pt>
                <c:pt idx="473">
                  <c:v>4.8021902809999997</c:v>
                </c:pt>
                <c:pt idx="474">
                  <c:v>4.8158795349999997</c:v>
                </c:pt>
                <c:pt idx="475">
                  <c:v>4.8268309379999996</c:v>
                </c:pt>
                <c:pt idx="476">
                  <c:v>4.8869999999999996</c:v>
                </c:pt>
                <c:pt idx="477">
                  <c:v>4.8899999999999997</c:v>
                </c:pt>
                <c:pt idx="478">
                  <c:v>4.9171800140000004</c:v>
                </c:pt>
                <c:pt idx="479">
                  <c:v>4.9445585220000003</c:v>
                </c:pt>
                <c:pt idx="480">
                  <c:v>4.9582477750000002</c:v>
                </c:pt>
                <c:pt idx="481">
                  <c:v>4.9660000000000002</c:v>
                </c:pt>
                <c:pt idx="482">
                  <c:v>4.9774127310000003</c:v>
                </c:pt>
                <c:pt idx="483">
                  <c:v>5.0212183440000002</c:v>
                </c:pt>
                <c:pt idx="484">
                  <c:v>5.0540725530000001</c:v>
                </c:pt>
                <c:pt idx="485">
                  <c:v>5.133470226</c:v>
                </c:pt>
                <c:pt idx="486">
                  <c:v>5.1420000000000003</c:v>
                </c:pt>
                <c:pt idx="487">
                  <c:v>5.144421629</c:v>
                </c:pt>
                <c:pt idx="488">
                  <c:v>5.1772758379999999</c:v>
                </c:pt>
                <c:pt idx="489">
                  <c:v>5.1829999999999998</c:v>
                </c:pt>
                <c:pt idx="490">
                  <c:v>5.2050000000000001</c:v>
                </c:pt>
                <c:pt idx="491">
                  <c:v>5.2510000000000003</c:v>
                </c:pt>
                <c:pt idx="492">
                  <c:v>5.2895277209999998</c:v>
                </c:pt>
                <c:pt idx="493">
                  <c:v>5.3</c:v>
                </c:pt>
                <c:pt idx="494">
                  <c:v>5.3004791239999998</c:v>
                </c:pt>
                <c:pt idx="495">
                  <c:v>5.3689253939999997</c:v>
                </c:pt>
                <c:pt idx="496">
                  <c:v>5.3771389459999996</c:v>
                </c:pt>
                <c:pt idx="497">
                  <c:v>5.4072553049999996</c:v>
                </c:pt>
                <c:pt idx="498">
                  <c:v>5.4240000000000004</c:v>
                </c:pt>
                <c:pt idx="499">
                  <c:v>5.4647501710000004</c:v>
                </c:pt>
                <c:pt idx="500">
                  <c:v>5.5030000000000001</c:v>
                </c:pt>
                <c:pt idx="501">
                  <c:v>5.5359999999999996</c:v>
                </c:pt>
                <c:pt idx="502">
                  <c:v>5.5519999999999996</c:v>
                </c:pt>
                <c:pt idx="503">
                  <c:v>5.5910000000000002</c:v>
                </c:pt>
                <c:pt idx="504">
                  <c:v>5.5910000000000002</c:v>
                </c:pt>
                <c:pt idx="505">
                  <c:v>5.5934291580000002</c:v>
                </c:pt>
                <c:pt idx="506">
                  <c:v>5.6016427100000001</c:v>
                </c:pt>
                <c:pt idx="507">
                  <c:v>5.6449999999999996</c:v>
                </c:pt>
                <c:pt idx="508">
                  <c:v>5.7169999999999996</c:v>
                </c:pt>
                <c:pt idx="509">
                  <c:v>5.7577002049999999</c:v>
                </c:pt>
                <c:pt idx="510">
                  <c:v>5.758</c:v>
                </c:pt>
                <c:pt idx="511">
                  <c:v>5.7930000000000001</c:v>
                </c:pt>
                <c:pt idx="512">
                  <c:v>5.8289999999999997</c:v>
                </c:pt>
                <c:pt idx="513">
                  <c:v>5.8562628339999998</c:v>
                </c:pt>
                <c:pt idx="514">
                  <c:v>5.87</c:v>
                </c:pt>
                <c:pt idx="515">
                  <c:v>5.8920000000000003</c:v>
                </c:pt>
                <c:pt idx="516">
                  <c:v>6.0590000000000002</c:v>
                </c:pt>
                <c:pt idx="517">
                  <c:v>6.0862423000000003</c:v>
                </c:pt>
                <c:pt idx="518">
                  <c:v>6.1109999999999998</c:v>
                </c:pt>
                <c:pt idx="519">
                  <c:v>6.3109999999999999</c:v>
                </c:pt>
                <c:pt idx="520">
                  <c:v>6.3410000000000002</c:v>
                </c:pt>
                <c:pt idx="521">
                  <c:v>6.4065708419999998</c:v>
                </c:pt>
                <c:pt idx="522">
                  <c:v>6.4390000000000001</c:v>
                </c:pt>
                <c:pt idx="523">
                  <c:v>6.4530000000000003</c:v>
                </c:pt>
                <c:pt idx="524">
                  <c:v>6.4669999999999996</c:v>
                </c:pt>
                <c:pt idx="525">
                  <c:v>6.5049999999999999</c:v>
                </c:pt>
                <c:pt idx="526">
                  <c:v>6.5190000000000001</c:v>
                </c:pt>
                <c:pt idx="527">
                  <c:v>6.5350000000000001</c:v>
                </c:pt>
                <c:pt idx="528">
                  <c:v>6.593</c:v>
                </c:pt>
                <c:pt idx="529">
                  <c:v>6.6091718000000004</c:v>
                </c:pt>
                <c:pt idx="530">
                  <c:v>6.6120000000000001</c:v>
                </c:pt>
                <c:pt idx="531">
                  <c:v>6.6609999999999996</c:v>
                </c:pt>
                <c:pt idx="532">
                  <c:v>6.71</c:v>
                </c:pt>
                <c:pt idx="533">
                  <c:v>6.8339999999999996</c:v>
                </c:pt>
                <c:pt idx="534">
                  <c:v>7.0830000000000002</c:v>
                </c:pt>
                <c:pt idx="535">
                  <c:v>7.1269999999999998</c:v>
                </c:pt>
                <c:pt idx="536">
                  <c:v>7.3019999999999996</c:v>
                </c:pt>
                <c:pt idx="537">
                  <c:v>7.3259999999999996</c:v>
                </c:pt>
                <c:pt idx="538">
                  <c:v>7.3593429160000001</c:v>
                </c:pt>
                <c:pt idx="539">
                  <c:v>7.3949999999999996</c:v>
                </c:pt>
                <c:pt idx="540">
                  <c:v>7.4390000000000001</c:v>
                </c:pt>
              </c:numCache>
            </c:numRef>
          </c:xVal>
          <c:yVal>
            <c:numRef>
              <c:f>Survival!$C$589:$C$1129</c:f>
              <c:numCache>
                <c:formatCode>General</c:formatCode>
                <c:ptCount val="541"/>
                <c:pt idx="0">
                  <c:v>1</c:v>
                </c:pt>
                <c:pt idx="1">
                  <c:v>1</c:v>
                </c:pt>
                <c:pt idx="2">
                  <c:v>0.99781181619256021</c:v>
                </c:pt>
                <c:pt idx="3">
                  <c:v>0.99781181619256021</c:v>
                </c:pt>
                <c:pt idx="4">
                  <c:v>0.99562363238512042</c:v>
                </c:pt>
                <c:pt idx="5">
                  <c:v>0.99562363238512042</c:v>
                </c:pt>
                <c:pt idx="6">
                  <c:v>0.99343544857768062</c:v>
                </c:pt>
                <c:pt idx="7">
                  <c:v>0.99343544857768062</c:v>
                </c:pt>
                <c:pt idx="8">
                  <c:v>0.99124726477024083</c:v>
                </c:pt>
                <c:pt idx="9">
                  <c:v>0.99124726477024083</c:v>
                </c:pt>
                <c:pt idx="10">
                  <c:v>0.98905908096280104</c:v>
                </c:pt>
                <c:pt idx="11">
                  <c:v>0.98905908096280104</c:v>
                </c:pt>
                <c:pt idx="12">
                  <c:v>0.98687089715536125</c:v>
                </c:pt>
                <c:pt idx="13">
                  <c:v>0.98687089715536125</c:v>
                </c:pt>
                <c:pt idx="14">
                  <c:v>0.98468271334792146</c:v>
                </c:pt>
                <c:pt idx="15">
                  <c:v>0.98468271334792146</c:v>
                </c:pt>
                <c:pt idx="16">
                  <c:v>0.98249452954048166</c:v>
                </c:pt>
                <c:pt idx="17">
                  <c:v>0.98249452954048166</c:v>
                </c:pt>
                <c:pt idx="18">
                  <c:v>0.98030634573304187</c:v>
                </c:pt>
                <c:pt idx="19">
                  <c:v>0.98030634573304187</c:v>
                </c:pt>
                <c:pt idx="20">
                  <c:v>0.97811816192560208</c:v>
                </c:pt>
                <c:pt idx="21">
                  <c:v>0.97811816192560208</c:v>
                </c:pt>
                <c:pt idx="22">
                  <c:v>0.97592997811816229</c:v>
                </c:pt>
                <c:pt idx="23">
                  <c:v>0.97592997811816229</c:v>
                </c:pt>
                <c:pt idx="24">
                  <c:v>0.9737417943107225</c:v>
                </c:pt>
                <c:pt idx="25">
                  <c:v>0.9737417943107225</c:v>
                </c:pt>
                <c:pt idx="26">
                  <c:v>0.97155361050328271</c:v>
                </c:pt>
                <c:pt idx="27">
                  <c:v>0.97155361050328271</c:v>
                </c:pt>
                <c:pt idx="28">
                  <c:v>0.96936542669584291</c:v>
                </c:pt>
                <c:pt idx="29">
                  <c:v>0.96936542669584291</c:v>
                </c:pt>
                <c:pt idx="30">
                  <c:v>0.96936542669584291</c:v>
                </c:pt>
                <c:pt idx="31">
                  <c:v>0.96717229224630485</c:v>
                </c:pt>
                <c:pt idx="32">
                  <c:v>0.96717229224630485</c:v>
                </c:pt>
                <c:pt idx="33">
                  <c:v>0.96717229224630485</c:v>
                </c:pt>
                <c:pt idx="34">
                  <c:v>0.96497417340029057</c:v>
                </c:pt>
                <c:pt idx="35">
                  <c:v>0.96497417340029057</c:v>
                </c:pt>
                <c:pt idx="36">
                  <c:v>0.96277605455427628</c:v>
                </c:pt>
                <c:pt idx="37">
                  <c:v>0.96277605455427628</c:v>
                </c:pt>
                <c:pt idx="38">
                  <c:v>0.960577935708262</c:v>
                </c:pt>
                <c:pt idx="39">
                  <c:v>0.960577935708262</c:v>
                </c:pt>
                <c:pt idx="40">
                  <c:v>0.95837981686224771</c:v>
                </c:pt>
                <c:pt idx="41">
                  <c:v>0.95837981686224771</c:v>
                </c:pt>
                <c:pt idx="42">
                  <c:v>0.95618169801623343</c:v>
                </c:pt>
                <c:pt idx="43">
                  <c:v>0.95618169801623343</c:v>
                </c:pt>
                <c:pt idx="44">
                  <c:v>0.95398357917021914</c:v>
                </c:pt>
                <c:pt idx="45">
                  <c:v>0.95398357917021914</c:v>
                </c:pt>
                <c:pt idx="46">
                  <c:v>0.95178546032420486</c:v>
                </c:pt>
                <c:pt idx="47">
                  <c:v>0.95178546032420486</c:v>
                </c:pt>
                <c:pt idx="48">
                  <c:v>0.94958734147819057</c:v>
                </c:pt>
                <c:pt idx="49">
                  <c:v>0.94958734147819057</c:v>
                </c:pt>
                <c:pt idx="50">
                  <c:v>0.94738922263217629</c:v>
                </c:pt>
                <c:pt idx="51">
                  <c:v>0.94738922263217629</c:v>
                </c:pt>
                <c:pt idx="52">
                  <c:v>0.945191103786162</c:v>
                </c:pt>
                <c:pt idx="53">
                  <c:v>0.945191103786162</c:v>
                </c:pt>
                <c:pt idx="54">
                  <c:v>0.945191103786162</c:v>
                </c:pt>
                <c:pt idx="55">
                  <c:v>0.94298786111999378</c:v>
                </c:pt>
                <c:pt idx="56">
                  <c:v>0.94298786111999378</c:v>
                </c:pt>
                <c:pt idx="57">
                  <c:v>0.94078461845382555</c:v>
                </c:pt>
                <c:pt idx="58">
                  <c:v>0.94078461845382555</c:v>
                </c:pt>
                <c:pt idx="59">
                  <c:v>0.93858137578765732</c:v>
                </c:pt>
                <c:pt idx="60">
                  <c:v>0.93858137578765732</c:v>
                </c:pt>
                <c:pt idx="61">
                  <c:v>0.9363781331214891</c:v>
                </c:pt>
                <c:pt idx="62">
                  <c:v>0.9363781331214891</c:v>
                </c:pt>
                <c:pt idx="63">
                  <c:v>0.93417489045532087</c:v>
                </c:pt>
                <c:pt idx="64">
                  <c:v>0.93417489045532087</c:v>
                </c:pt>
                <c:pt idx="65">
                  <c:v>0.93197164778915265</c:v>
                </c:pt>
                <c:pt idx="66">
                  <c:v>0.93197164778915265</c:v>
                </c:pt>
                <c:pt idx="67">
                  <c:v>0.92976840512298442</c:v>
                </c:pt>
                <c:pt idx="68">
                  <c:v>0.92976840512298442</c:v>
                </c:pt>
                <c:pt idx="69">
                  <c:v>0.92756516245681619</c:v>
                </c:pt>
                <c:pt idx="70">
                  <c:v>0.92756516245681619</c:v>
                </c:pt>
                <c:pt idx="71">
                  <c:v>0.92756516245681619</c:v>
                </c:pt>
                <c:pt idx="72">
                  <c:v>0.92535667397477617</c:v>
                </c:pt>
                <c:pt idx="73">
                  <c:v>0.92535667397477617</c:v>
                </c:pt>
                <c:pt idx="74">
                  <c:v>0.92314818549273614</c:v>
                </c:pt>
                <c:pt idx="75">
                  <c:v>0.92314818549273614</c:v>
                </c:pt>
                <c:pt idx="76">
                  <c:v>0.92093969701069611</c:v>
                </c:pt>
                <c:pt idx="77">
                  <c:v>0.92093969701069611</c:v>
                </c:pt>
                <c:pt idx="78">
                  <c:v>0.92093969701069611</c:v>
                </c:pt>
                <c:pt idx="79">
                  <c:v>0.91872589966211271</c:v>
                </c:pt>
                <c:pt idx="80">
                  <c:v>0.91872589966211271</c:v>
                </c:pt>
                <c:pt idx="81">
                  <c:v>0.91872589966211271</c:v>
                </c:pt>
                <c:pt idx="82">
                  <c:v>0.91650675497693856</c:v>
                </c:pt>
                <c:pt idx="83">
                  <c:v>0.91650675497693856</c:v>
                </c:pt>
                <c:pt idx="84">
                  <c:v>0.91650675497693856</c:v>
                </c:pt>
                <c:pt idx="85">
                  <c:v>0.91428222401825665</c:v>
                </c:pt>
                <c:pt idx="86">
                  <c:v>0.91428222401825665</c:v>
                </c:pt>
                <c:pt idx="87">
                  <c:v>0.91205769305957474</c:v>
                </c:pt>
                <c:pt idx="88">
                  <c:v>0.91205769305957474</c:v>
                </c:pt>
                <c:pt idx="89">
                  <c:v>0.91205769305957474</c:v>
                </c:pt>
                <c:pt idx="90">
                  <c:v>0.90982772314989357</c:v>
                </c:pt>
                <c:pt idx="91">
                  <c:v>0.90982772314989357</c:v>
                </c:pt>
                <c:pt idx="92">
                  <c:v>0.90982772314989357</c:v>
                </c:pt>
                <c:pt idx="93">
                  <c:v>0.90982772314989357</c:v>
                </c:pt>
                <c:pt idx="94">
                  <c:v>0.90982772314989357</c:v>
                </c:pt>
                <c:pt idx="95">
                  <c:v>0.90982772314989357</c:v>
                </c:pt>
                <c:pt idx="96">
                  <c:v>0.90982772314989357</c:v>
                </c:pt>
                <c:pt idx="97">
                  <c:v>0.90982772314989357</c:v>
                </c:pt>
                <c:pt idx="98">
                  <c:v>0.90982772314989357</c:v>
                </c:pt>
                <c:pt idx="99">
                  <c:v>0.90982772314989357</c:v>
                </c:pt>
                <c:pt idx="100">
                  <c:v>0.90982772314989357</c:v>
                </c:pt>
                <c:pt idx="101">
                  <c:v>0.90754745316706176</c:v>
                </c:pt>
                <c:pt idx="102">
                  <c:v>0.90754745316706176</c:v>
                </c:pt>
                <c:pt idx="103">
                  <c:v>0.90754745316706176</c:v>
                </c:pt>
                <c:pt idx="104">
                  <c:v>0.90526143943112458</c:v>
                </c:pt>
                <c:pt idx="105">
                  <c:v>0.90526143943112458</c:v>
                </c:pt>
                <c:pt idx="106">
                  <c:v>0.90526143943112458</c:v>
                </c:pt>
                <c:pt idx="107">
                  <c:v>0.90526143943112458</c:v>
                </c:pt>
                <c:pt idx="108">
                  <c:v>0.90526143943112458</c:v>
                </c:pt>
                <c:pt idx="109">
                  <c:v>0.90295209902441254</c:v>
                </c:pt>
                <c:pt idx="110">
                  <c:v>0.90295209902441254</c:v>
                </c:pt>
                <c:pt idx="111">
                  <c:v>0.90295209902441254</c:v>
                </c:pt>
                <c:pt idx="112">
                  <c:v>0.90063683723204224</c:v>
                </c:pt>
                <c:pt idx="113">
                  <c:v>0.90063683723204224</c:v>
                </c:pt>
                <c:pt idx="114">
                  <c:v>0.89832157543967195</c:v>
                </c:pt>
                <c:pt idx="115">
                  <c:v>0.89832157543967195</c:v>
                </c:pt>
                <c:pt idx="116">
                  <c:v>0.89600631364730166</c:v>
                </c:pt>
                <c:pt idx="117">
                  <c:v>0.89600631364730166</c:v>
                </c:pt>
                <c:pt idx="118">
                  <c:v>0.89369105185493136</c:v>
                </c:pt>
                <c:pt idx="119">
                  <c:v>0.89369105185493136</c:v>
                </c:pt>
                <c:pt idx="120">
                  <c:v>0.89369105185493136</c:v>
                </c:pt>
                <c:pt idx="121">
                  <c:v>0.89369105185493136</c:v>
                </c:pt>
                <c:pt idx="122">
                  <c:v>0.89369105185493136</c:v>
                </c:pt>
                <c:pt idx="123">
                  <c:v>0.89135765485269913</c:v>
                </c:pt>
                <c:pt idx="124">
                  <c:v>0.89135765485269913</c:v>
                </c:pt>
                <c:pt idx="125">
                  <c:v>0.8890242578504669</c:v>
                </c:pt>
                <c:pt idx="126">
                  <c:v>0.8890242578504669</c:v>
                </c:pt>
                <c:pt idx="127">
                  <c:v>0.88669086084823467</c:v>
                </c:pt>
                <c:pt idx="128">
                  <c:v>0.88669086084823467</c:v>
                </c:pt>
                <c:pt idx="129">
                  <c:v>0.88435130712568</c:v>
                </c:pt>
                <c:pt idx="130">
                  <c:v>0.88435130712568</c:v>
                </c:pt>
                <c:pt idx="131">
                  <c:v>0.88435130712568</c:v>
                </c:pt>
                <c:pt idx="132">
                  <c:v>0.88435130712568</c:v>
                </c:pt>
                <c:pt idx="133">
                  <c:v>0.88435130712568</c:v>
                </c:pt>
                <c:pt idx="134">
                  <c:v>0.88199303697334486</c:v>
                </c:pt>
                <c:pt idx="135">
                  <c:v>0.88199303697334486</c:v>
                </c:pt>
                <c:pt idx="136">
                  <c:v>0.87963476682100972</c:v>
                </c:pt>
                <c:pt idx="137">
                  <c:v>0.87963476682100972</c:v>
                </c:pt>
                <c:pt idx="138">
                  <c:v>0.87963476682100972</c:v>
                </c:pt>
                <c:pt idx="139">
                  <c:v>0.87727015723278123</c:v>
                </c:pt>
                <c:pt idx="140">
                  <c:v>0.87727015723278123</c:v>
                </c:pt>
                <c:pt idx="141">
                  <c:v>0.87490554764455275</c:v>
                </c:pt>
                <c:pt idx="142">
                  <c:v>0.87490554764455275</c:v>
                </c:pt>
                <c:pt idx="143">
                  <c:v>0.87254093805632427</c:v>
                </c:pt>
                <c:pt idx="144">
                  <c:v>0.87254093805632427</c:v>
                </c:pt>
                <c:pt idx="145">
                  <c:v>0.87254093805632427</c:v>
                </c:pt>
                <c:pt idx="146">
                  <c:v>0.87254093805632427</c:v>
                </c:pt>
                <c:pt idx="147">
                  <c:v>0.87254093805632427</c:v>
                </c:pt>
                <c:pt idx="148">
                  <c:v>0.87015694642229058</c:v>
                </c:pt>
                <c:pt idx="149">
                  <c:v>0.87015694642229058</c:v>
                </c:pt>
                <c:pt idx="150">
                  <c:v>0.87015694642229058</c:v>
                </c:pt>
                <c:pt idx="151">
                  <c:v>0.86776640536069083</c:v>
                </c:pt>
                <c:pt idx="152">
                  <c:v>0.86776640536069083</c:v>
                </c:pt>
                <c:pt idx="153">
                  <c:v>0.86776640536069083</c:v>
                </c:pt>
                <c:pt idx="154">
                  <c:v>0.86536926059450103</c:v>
                </c:pt>
                <c:pt idx="155">
                  <c:v>0.86536926059450103</c:v>
                </c:pt>
                <c:pt idx="156">
                  <c:v>0.86536926059450103</c:v>
                </c:pt>
                <c:pt idx="157">
                  <c:v>0.86536926059450103</c:v>
                </c:pt>
                <c:pt idx="158">
                  <c:v>0.86295876126136872</c:v>
                </c:pt>
                <c:pt idx="159">
                  <c:v>0.86295876126136872</c:v>
                </c:pt>
                <c:pt idx="160">
                  <c:v>0.86295876126136872</c:v>
                </c:pt>
                <c:pt idx="161">
                  <c:v>0.86054150982926403</c:v>
                </c:pt>
                <c:pt idx="162">
                  <c:v>0.86054150982926403</c:v>
                </c:pt>
                <c:pt idx="163">
                  <c:v>0.86054150982926403</c:v>
                </c:pt>
                <c:pt idx="164">
                  <c:v>0.86054150982926403</c:v>
                </c:pt>
                <c:pt idx="165">
                  <c:v>0.85811060160940733</c:v>
                </c:pt>
                <c:pt idx="166">
                  <c:v>0.85811060160940733</c:v>
                </c:pt>
                <c:pt idx="167">
                  <c:v>0.85567278740028974</c:v>
                </c:pt>
                <c:pt idx="168">
                  <c:v>0.85567278740028974</c:v>
                </c:pt>
                <c:pt idx="169">
                  <c:v>0.85567278740028974</c:v>
                </c:pt>
                <c:pt idx="170">
                  <c:v>0.85567278740028974</c:v>
                </c:pt>
                <c:pt idx="171">
                  <c:v>0.85567278740028974</c:v>
                </c:pt>
                <c:pt idx="172">
                  <c:v>0.85567278740028974</c:v>
                </c:pt>
                <c:pt idx="173">
                  <c:v>0.85567278740028974</c:v>
                </c:pt>
                <c:pt idx="174">
                  <c:v>0.85567278740028974</c:v>
                </c:pt>
                <c:pt idx="175">
                  <c:v>0.85319257642231783</c:v>
                </c:pt>
                <c:pt idx="176">
                  <c:v>0.85319257642231783</c:v>
                </c:pt>
                <c:pt idx="177">
                  <c:v>0.85071236544434592</c:v>
                </c:pt>
                <c:pt idx="178">
                  <c:v>0.85071236544434592</c:v>
                </c:pt>
                <c:pt idx="179">
                  <c:v>0.85071236544434592</c:v>
                </c:pt>
                <c:pt idx="180">
                  <c:v>0.85071236544434592</c:v>
                </c:pt>
                <c:pt idx="181">
                  <c:v>0.84821760777442112</c:v>
                </c:pt>
                <c:pt idx="182">
                  <c:v>0.84821760777442112</c:v>
                </c:pt>
                <c:pt idx="183">
                  <c:v>0.84821760777442112</c:v>
                </c:pt>
                <c:pt idx="184">
                  <c:v>0.84821760777442112</c:v>
                </c:pt>
                <c:pt idx="185">
                  <c:v>0.84821760777442112</c:v>
                </c:pt>
                <c:pt idx="186">
                  <c:v>0.84821760777442112</c:v>
                </c:pt>
                <c:pt idx="187">
                  <c:v>0.84568561491539296</c:v>
                </c:pt>
                <c:pt idx="188">
                  <c:v>0.84568561491539296</c:v>
                </c:pt>
                <c:pt idx="189">
                  <c:v>0.84568561491539296</c:v>
                </c:pt>
                <c:pt idx="190">
                  <c:v>0.84314601847420556</c:v>
                </c:pt>
                <c:pt idx="191">
                  <c:v>0.84314601847420556</c:v>
                </c:pt>
                <c:pt idx="192">
                  <c:v>0.84314601847420556</c:v>
                </c:pt>
                <c:pt idx="193">
                  <c:v>0.84059874953621705</c:v>
                </c:pt>
                <c:pt idx="194">
                  <c:v>0.84059874953621705</c:v>
                </c:pt>
                <c:pt idx="195">
                  <c:v>0.84059874953621705</c:v>
                </c:pt>
                <c:pt idx="196">
                  <c:v>0.83804373813945043</c:v>
                </c:pt>
                <c:pt idx="197">
                  <c:v>0.83804373813945043</c:v>
                </c:pt>
                <c:pt idx="198">
                  <c:v>0.83804373813945043</c:v>
                </c:pt>
                <c:pt idx="199">
                  <c:v>0.83804373813945043</c:v>
                </c:pt>
                <c:pt idx="200">
                  <c:v>0.83804373813945043</c:v>
                </c:pt>
                <c:pt idx="201">
                  <c:v>0.83804373813945043</c:v>
                </c:pt>
                <c:pt idx="202">
                  <c:v>0.83544917548267195</c:v>
                </c:pt>
                <c:pt idx="203">
                  <c:v>0.83544917548267195</c:v>
                </c:pt>
                <c:pt idx="204">
                  <c:v>0.83544917548267195</c:v>
                </c:pt>
                <c:pt idx="205">
                  <c:v>0.83544917548267195</c:v>
                </c:pt>
                <c:pt idx="206">
                  <c:v>0.83282197681763215</c:v>
                </c:pt>
                <c:pt idx="207">
                  <c:v>0.83282197681763215</c:v>
                </c:pt>
                <c:pt idx="208">
                  <c:v>0.83282197681763215</c:v>
                </c:pt>
                <c:pt idx="209">
                  <c:v>0.83282197681763215</c:v>
                </c:pt>
                <c:pt idx="210">
                  <c:v>0.83282197681763215</c:v>
                </c:pt>
                <c:pt idx="211">
                  <c:v>0.83282197681763215</c:v>
                </c:pt>
                <c:pt idx="212">
                  <c:v>0.83282197681763215</c:v>
                </c:pt>
                <c:pt idx="213">
                  <c:v>0.83015267560988337</c:v>
                </c:pt>
                <c:pt idx="214">
                  <c:v>0.83015267560988337</c:v>
                </c:pt>
                <c:pt idx="215">
                  <c:v>0.83015267560988337</c:v>
                </c:pt>
                <c:pt idx="216">
                  <c:v>0.83015267560988337</c:v>
                </c:pt>
                <c:pt idx="217">
                  <c:v>0.83015267560988337</c:v>
                </c:pt>
                <c:pt idx="218">
                  <c:v>0.83015267560988337</c:v>
                </c:pt>
                <c:pt idx="219">
                  <c:v>0.83015267560988337</c:v>
                </c:pt>
                <c:pt idx="220">
                  <c:v>0.83015267560988337</c:v>
                </c:pt>
                <c:pt idx="221">
                  <c:v>0.82743086355870343</c:v>
                </c:pt>
                <c:pt idx="222">
                  <c:v>0.82743086355870343</c:v>
                </c:pt>
                <c:pt idx="223">
                  <c:v>0.82743086355870343</c:v>
                </c:pt>
                <c:pt idx="224">
                  <c:v>0.82743086355870343</c:v>
                </c:pt>
                <c:pt idx="225">
                  <c:v>0.82743086355870343</c:v>
                </c:pt>
                <c:pt idx="226">
                  <c:v>0.82743086355870343</c:v>
                </c:pt>
                <c:pt idx="227">
                  <c:v>0.82743086355870343</c:v>
                </c:pt>
                <c:pt idx="228">
                  <c:v>0.82743086355870343</c:v>
                </c:pt>
                <c:pt idx="229">
                  <c:v>0.82464490105513877</c:v>
                </c:pt>
                <c:pt idx="230">
                  <c:v>0.82464490105513877</c:v>
                </c:pt>
                <c:pt idx="231">
                  <c:v>0.82464490105513877</c:v>
                </c:pt>
                <c:pt idx="232">
                  <c:v>0.82464490105513877</c:v>
                </c:pt>
                <c:pt idx="233">
                  <c:v>0.82183998642569955</c:v>
                </c:pt>
                <c:pt idx="234">
                  <c:v>0.82183998642569955</c:v>
                </c:pt>
                <c:pt idx="235">
                  <c:v>0.81903507179626034</c:v>
                </c:pt>
                <c:pt idx="236">
                  <c:v>0.81903507179626034</c:v>
                </c:pt>
                <c:pt idx="237">
                  <c:v>0.81903507179626034</c:v>
                </c:pt>
                <c:pt idx="238">
                  <c:v>0.81903507179626034</c:v>
                </c:pt>
                <c:pt idx="239">
                  <c:v>0.81903507179626034</c:v>
                </c:pt>
                <c:pt idx="240">
                  <c:v>0.81620104040596186</c:v>
                </c:pt>
                <c:pt idx="241">
                  <c:v>0.81620104040596186</c:v>
                </c:pt>
                <c:pt idx="242">
                  <c:v>0.81620104040596186</c:v>
                </c:pt>
                <c:pt idx="243">
                  <c:v>0.81620104040596186</c:v>
                </c:pt>
                <c:pt idx="244">
                  <c:v>0.81334719061433258</c:v>
                </c:pt>
                <c:pt idx="245">
                  <c:v>0.81334719061433258</c:v>
                </c:pt>
                <c:pt idx="246">
                  <c:v>0.81334719061433258</c:v>
                </c:pt>
                <c:pt idx="247">
                  <c:v>0.81334719061433258</c:v>
                </c:pt>
                <c:pt idx="248">
                  <c:v>0.81334719061433258</c:v>
                </c:pt>
                <c:pt idx="249">
                  <c:v>0.81334719061433258</c:v>
                </c:pt>
                <c:pt idx="250">
                  <c:v>0.81043196770890491</c:v>
                </c:pt>
                <c:pt idx="251">
                  <c:v>0.81043196770890491</c:v>
                </c:pt>
                <c:pt idx="252">
                  <c:v>0.81043196770890491</c:v>
                </c:pt>
                <c:pt idx="253">
                  <c:v>0.81043196770890491</c:v>
                </c:pt>
                <c:pt idx="254">
                  <c:v>0.80748494237178159</c:v>
                </c:pt>
                <c:pt idx="255">
                  <c:v>0.80748494237178159</c:v>
                </c:pt>
                <c:pt idx="256">
                  <c:v>0.80748494237178159</c:v>
                </c:pt>
                <c:pt idx="257">
                  <c:v>0.80451624773070884</c:v>
                </c:pt>
                <c:pt idx="258">
                  <c:v>0.80451624773070884</c:v>
                </c:pt>
                <c:pt idx="259">
                  <c:v>0.80451624773070884</c:v>
                </c:pt>
                <c:pt idx="260">
                  <c:v>0.80451624773070884</c:v>
                </c:pt>
                <c:pt idx="261">
                  <c:v>0.80451624773070884</c:v>
                </c:pt>
                <c:pt idx="262">
                  <c:v>0.80451624773070884</c:v>
                </c:pt>
                <c:pt idx="263">
                  <c:v>0.80451624773070884</c:v>
                </c:pt>
                <c:pt idx="264">
                  <c:v>0.80149175055878885</c:v>
                </c:pt>
                <c:pt idx="265">
                  <c:v>0.80149175055878885</c:v>
                </c:pt>
                <c:pt idx="266">
                  <c:v>0.80149175055878885</c:v>
                </c:pt>
                <c:pt idx="267">
                  <c:v>0.79845579695818736</c:v>
                </c:pt>
                <c:pt idx="268">
                  <c:v>0.79845579695818736</c:v>
                </c:pt>
                <c:pt idx="269">
                  <c:v>0.79845579695818736</c:v>
                </c:pt>
                <c:pt idx="270">
                  <c:v>0.79845579695818736</c:v>
                </c:pt>
                <c:pt idx="271">
                  <c:v>0.79845579695818736</c:v>
                </c:pt>
                <c:pt idx="272">
                  <c:v>0.79845579695818736</c:v>
                </c:pt>
                <c:pt idx="273">
                  <c:v>0.79845579695818736</c:v>
                </c:pt>
                <c:pt idx="274">
                  <c:v>0.79845579695818736</c:v>
                </c:pt>
                <c:pt idx="275">
                  <c:v>0.79845579695818736</c:v>
                </c:pt>
                <c:pt idx="276">
                  <c:v>0.79532459775442976</c:v>
                </c:pt>
                <c:pt idx="277">
                  <c:v>0.79532459775442976</c:v>
                </c:pt>
                <c:pt idx="278">
                  <c:v>0.79532459775442976</c:v>
                </c:pt>
                <c:pt idx="279">
                  <c:v>0.79532459775442976</c:v>
                </c:pt>
                <c:pt idx="280">
                  <c:v>0.79532459775442976</c:v>
                </c:pt>
                <c:pt idx="281">
                  <c:v>0.79532459775442976</c:v>
                </c:pt>
                <c:pt idx="282">
                  <c:v>0.79532459775442976</c:v>
                </c:pt>
                <c:pt idx="283">
                  <c:v>0.79532459775442976</c:v>
                </c:pt>
                <c:pt idx="284">
                  <c:v>0.79532459775442976</c:v>
                </c:pt>
                <c:pt idx="285">
                  <c:v>0.79532459775442976</c:v>
                </c:pt>
                <c:pt idx="286">
                  <c:v>0.79532459775442976</c:v>
                </c:pt>
                <c:pt idx="287">
                  <c:v>0.79532459775442976</c:v>
                </c:pt>
                <c:pt idx="288">
                  <c:v>0.79532459775442976</c:v>
                </c:pt>
                <c:pt idx="289">
                  <c:v>0.79532459775442976</c:v>
                </c:pt>
                <c:pt idx="290">
                  <c:v>0.79532459775442976</c:v>
                </c:pt>
                <c:pt idx="291">
                  <c:v>0.79202449568905864</c:v>
                </c:pt>
                <c:pt idx="292">
                  <c:v>0.79202449568905864</c:v>
                </c:pt>
                <c:pt idx="293">
                  <c:v>0.79202449568905864</c:v>
                </c:pt>
                <c:pt idx="294">
                  <c:v>0.79202449568905864</c:v>
                </c:pt>
                <c:pt idx="295">
                  <c:v>0.79202449568905864</c:v>
                </c:pt>
                <c:pt idx="296">
                  <c:v>0.78866845969037613</c:v>
                </c:pt>
                <c:pt idx="297">
                  <c:v>0.78866845969037613</c:v>
                </c:pt>
                <c:pt idx="298">
                  <c:v>0.78866845969037613</c:v>
                </c:pt>
                <c:pt idx="299">
                  <c:v>0.78529808165751125</c:v>
                </c:pt>
                <c:pt idx="300">
                  <c:v>0.78529808165751125</c:v>
                </c:pt>
                <c:pt idx="301">
                  <c:v>0.78191317613312539</c:v>
                </c:pt>
                <c:pt idx="302">
                  <c:v>0.78191317613312539</c:v>
                </c:pt>
                <c:pt idx="303">
                  <c:v>0.78191317613312539</c:v>
                </c:pt>
                <c:pt idx="304">
                  <c:v>0.78191317613312539</c:v>
                </c:pt>
                <c:pt idx="305">
                  <c:v>0.78191317613312539</c:v>
                </c:pt>
                <c:pt idx="306">
                  <c:v>0.77848373237815549</c:v>
                </c:pt>
                <c:pt idx="307">
                  <c:v>0.77848373237815549</c:v>
                </c:pt>
                <c:pt idx="308">
                  <c:v>0.77848373237815549</c:v>
                </c:pt>
                <c:pt idx="309">
                  <c:v>0.77848373237815549</c:v>
                </c:pt>
                <c:pt idx="310">
                  <c:v>0.77848373237815549</c:v>
                </c:pt>
                <c:pt idx="311">
                  <c:v>0.77500835857289585</c:v>
                </c:pt>
                <c:pt idx="312">
                  <c:v>0.77500835857289585</c:v>
                </c:pt>
                <c:pt idx="313">
                  <c:v>0.77500835857289585</c:v>
                </c:pt>
                <c:pt idx="314">
                  <c:v>0.77500835857289585</c:v>
                </c:pt>
                <c:pt idx="315">
                  <c:v>0.77500835857289585</c:v>
                </c:pt>
                <c:pt idx="316">
                  <c:v>0.77500835857289585</c:v>
                </c:pt>
                <c:pt idx="317">
                  <c:v>0.77500835857289585</c:v>
                </c:pt>
                <c:pt idx="318">
                  <c:v>0.77500835857289585</c:v>
                </c:pt>
                <c:pt idx="319">
                  <c:v>0.77500835857289585</c:v>
                </c:pt>
                <c:pt idx="320">
                  <c:v>0.77500835857289585</c:v>
                </c:pt>
                <c:pt idx="321">
                  <c:v>0.77500835857289585</c:v>
                </c:pt>
                <c:pt idx="322">
                  <c:v>0.77500835857289585</c:v>
                </c:pt>
                <c:pt idx="323">
                  <c:v>0.77136982167818746</c:v>
                </c:pt>
                <c:pt idx="324">
                  <c:v>0.77136982167818746</c:v>
                </c:pt>
                <c:pt idx="325">
                  <c:v>0.76771404053279324</c:v>
                </c:pt>
                <c:pt idx="326">
                  <c:v>0.76771404053279324</c:v>
                </c:pt>
                <c:pt idx="327">
                  <c:v>0.76771404053279324</c:v>
                </c:pt>
                <c:pt idx="328">
                  <c:v>0.76404076761158368</c:v>
                </c:pt>
                <c:pt idx="329">
                  <c:v>0.76404076761158368</c:v>
                </c:pt>
                <c:pt idx="330">
                  <c:v>0.76404076761158368</c:v>
                </c:pt>
                <c:pt idx="331">
                  <c:v>0.76404076761158368</c:v>
                </c:pt>
                <c:pt idx="332">
                  <c:v>0.7603318318464789</c:v>
                </c:pt>
                <c:pt idx="333">
                  <c:v>0.7603318318464789</c:v>
                </c:pt>
                <c:pt idx="334">
                  <c:v>0.7603318318464789</c:v>
                </c:pt>
                <c:pt idx="335">
                  <c:v>0.7603318318464789</c:v>
                </c:pt>
                <c:pt idx="336">
                  <c:v>0.7603318318464789</c:v>
                </c:pt>
                <c:pt idx="337">
                  <c:v>0.7603318318464789</c:v>
                </c:pt>
                <c:pt idx="338">
                  <c:v>0.7603318318464789</c:v>
                </c:pt>
                <c:pt idx="339">
                  <c:v>0.7603318318464789</c:v>
                </c:pt>
                <c:pt idx="340">
                  <c:v>0.7603318318464789</c:v>
                </c:pt>
                <c:pt idx="341">
                  <c:v>0.7603318318464789</c:v>
                </c:pt>
                <c:pt idx="342">
                  <c:v>0.7603318318464789</c:v>
                </c:pt>
                <c:pt idx="343">
                  <c:v>0.7603318318464789</c:v>
                </c:pt>
                <c:pt idx="344">
                  <c:v>0.7603318318464789</c:v>
                </c:pt>
                <c:pt idx="345">
                  <c:v>0.7603318318464789</c:v>
                </c:pt>
                <c:pt idx="346">
                  <c:v>0.7603318318464789</c:v>
                </c:pt>
                <c:pt idx="347">
                  <c:v>0.7603318318464789</c:v>
                </c:pt>
                <c:pt idx="348">
                  <c:v>0.75635103691534555</c:v>
                </c:pt>
                <c:pt idx="349">
                  <c:v>0.75635103691534555</c:v>
                </c:pt>
                <c:pt idx="350">
                  <c:v>0.75635103691534555</c:v>
                </c:pt>
                <c:pt idx="351">
                  <c:v>0.75635103691534555</c:v>
                </c:pt>
                <c:pt idx="352">
                  <c:v>0.75635103691534555</c:v>
                </c:pt>
                <c:pt idx="353">
                  <c:v>0.75635103691534555</c:v>
                </c:pt>
                <c:pt idx="354">
                  <c:v>0.75635103691534555</c:v>
                </c:pt>
                <c:pt idx="355">
                  <c:v>0.75635103691534555</c:v>
                </c:pt>
                <c:pt idx="356">
                  <c:v>0.75635103691534555</c:v>
                </c:pt>
                <c:pt idx="357">
                  <c:v>0.75635103691534555</c:v>
                </c:pt>
                <c:pt idx="358">
                  <c:v>0.75635103691534555</c:v>
                </c:pt>
                <c:pt idx="359">
                  <c:v>0.75635103691534555</c:v>
                </c:pt>
                <c:pt idx="360">
                  <c:v>0.75635103691534555</c:v>
                </c:pt>
                <c:pt idx="361">
                  <c:v>0.75635103691534555</c:v>
                </c:pt>
                <c:pt idx="362">
                  <c:v>0.75635103691534555</c:v>
                </c:pt>
                <c:pt idx="363">
                  <c:v>0.75635103691534555</c:v>
                </c:pt>
                <c:pt idx="364">
                  <c:v>0.75635103691534555</c:v>
                </c:pt>
                <c:pt idx="365">
                  <c:v>0.75635103691534555</c:v>
                </c:pt>
                <c:pt idx="366">
                  <c:v>0.75200419187560219</c:v>
                </c:pt>
                <c:pt idx="367">
                  <c:v>0.75200419187560219</c:v>
                </c:pt>
                <c:pt idx="368">
                  <c:v>0.74765734683585883</c:v>
                </c:pt>
                <c:pt idx="369">
                  <c:v>0.74765734683585883</c:v>
                </c:pt>
                <c:pt idx="370">
                  <c:v>0.74765734683585883</c:v>
                </c:pt>
                <c:pt idx="371">
                  <c:v>0.74765734683585883</c:v>
                </c:pt>
                <c:pt idx="372">
                  <c:v>0.74765734683585883</c:v>
                </c:pt>
                <c:pt idx="373">
                  <c:v>0.74765734683585883</c:v>
                </c:pt>
                <c:pt idx="374">
                  <c:v>0.74765734683585883</c:v>
                </c:pt>
                <c:pt idx="375">
                  <c:v>0.74765734683585883</c:v>
                </c:pt>
                <c:pt idx="376">
                  <c:v>0.74315338691516086</c:v>
                </c:pt>
                <c:pt idx="377">
                  <c:v>0.74315338691516086</c:v>
                </c:pt>
                <c:pt idx="378">
                  <c:v>0.74315338691516086</c:v>
                </c:pt>
                <c:pt idx="379">
                  <c:v>0.73862196382421474</c:v>
                </c:pt>
                <c:pt idx="380">
                  <c:v>0.73862196382421474</c:v>
                </c:pt>
                <c:pt idx="381">
                  <c:v>0.73862196382421474</c:v>
                </c:pt>
                <c:pt idx="382">
                  <c:v>0.73862196382421474</c:v>
                </c:pt>
                <c:pt idx="383">
                  <c:v>0.73403424976319476</c:v>
                </c:pt>
                <c:pt idx="384">
                  <c:v>0.73403424976319476</c:v>
                </c:pt>
                <c:pt idx="385">
                  <c:v>0.73403424976319476</c:v>
                </c:pt>
                <c:pt idx="386">
                  <c:v>0.73403424976319476</c:v>
                </c:pt>
                <c:pt idx="387">
                  <c:v>0.73403424976319476</c:v>
                </c:pt>
                <c:pt idx="388">
                  <c:v>0.73403424976319476</c:v>
                </c:pt>
                <c:pt idx="389">
                  <c:v>0.73403424976319476</c:v>
                </c:pt>
                <c:pt idx="390">
                  <c:v>0.73403424976319476</c:v>
                </c:pt>
                <c:pt idx="391">
                  <c:v>0.73403424976319476</c:v>
                </c:pt>
                <c:pt idx="392">
                  <c:v>0.73403424976319476</c:v>
                </c:pt>
                <c:pt idx="393">
                  <c:v>0.73403424976319476</c:v>
                </c:pt>
                <c:pt idx="394">
                  <c:v>0.73403424976319476</c:v>
                </c:pt>
                <c:pt idx="395">
                  <c:v>0.73403424976319476</c:v>
                </c:pt>
                <c:pt idx="396">
                  <c:v>0.73403424976319476</c:v>
                </c:pt>
                <c:pt idx="397">
                  <c:v>0.73403424976319476</c:v>
                </c:pt>
                <c:pt idx="398">
                  <c:v>0.73403424976319476</c:v>
                </c:pt>
                <c:pt idx="399">
                  <c:v>0.7290066179155017</c:v>
                </c:pt>
                <c:pt idx="400">
                  <c:v>0.7290066179155017</c:v>
                </c:pt>
                <c:pt idx="401">
                  <c:v>0.7290066179155017</c:v>
                </c:pt>
                <c:pt idx="402">
                  <c:v>0.7290066179155017</c:v>
                </c:pt>
                <c:pt idx="403">
                  <c:v>0.7290066179155017</c:v>
                </c:pt>
                <c:pt idx="404">
                  <c:v>0.7290066179155017</c:v>
                </c:pt>
                <c:pt idx="405">
                  <c:v>0.7290066179155017</c:v>
                </c:pt>
                <c:pt idx="406">
                  <c:v>0.7290066179155017</c:v>
                </c:pt>
                <c:pt idx="407">
                  <c:v>0.7290066179155017</c:v>
                </c:pt>
                <c:pt idx="408">
                  <c:v>0.7290066179155017</c:v>
                </c:pt>
                <c:pt idx="409">
                  <c:v>0.72356627002060991</c:v>
                </c:pt>
                <c:pt idx="410">
                  <c:v>0.72356627002060991</c:v>
                </c:pt>
                <c:pt idx="411">
                  <c:v>0.72356627002060991</c:v>
                </c:pt>
                <c:pt idx="412">
                  <c:v>0.72356627002060991</c:v>
                </c:pt>
                <c:pt idx="413">
                  <c:v>0.72356627002060991</c:v>
                </c:pt>
                <c:pt idx="414">
                  <c:v>0.72356627002060991</c:v>
                </c:pt>
                <c:pt idx="415">
                  <c:v>0.72356627002060991</c:v>
                </c:pt>
                <c:pt idx="416">
                  <c:v>0.72356627002060991</c:v>
                </c:pt>
                <c:pt idx="417">
                  <c:v>0.72356627002060991</c:v>
                </c:pt>
                <c:pt idx="418">
                  <c:v>0.72356627002060991</c:v>
                </c:pt>
                <c:pt idx="419">
                  <c:v>0.72356627002060991</c:v>
                </c:pt>
                <c:pt idx="420">
                  <c:v>0.72356627002060991</c:v>
                </c:pt>
                <c:pt idx="421">
                  <c:v>0.72356627002060991</c:v>
                </c:pt>
                <c:pt idx="422">
                  <c:v>0.72356627002060991</c:v>
                </c:pt>
                <c:pt idx="423">
                  <c:v>0.72356627002060991</c:v>
                </c:pt>
                <c:pt idx="424">
                  <c:v>0.72356627002060991</c:v>
                </c:pt>
                <c:pt idx="425">
                  <c:v>0.72356627002060991</c:v>
                </c:pt>
                <c:pt idx="426">
                  <c:v>0.72356627002060991</c:v>
                </c:pt>
                <c:pt idx="427">
                  <c:v>0.72356627002060991</c:v>
                </c:pt>
                <c:pt idx="428">
                  <c:v>0.72356627002060991</c:v>
                </c:pt>
                <c:pt idx="429">
                  <c:v>0.72356627002060991</c:v>
                </c:pt>
                <c:pt idx="430">
                  <c:v>0.72356627002060991</c:v>
                </c:pt>
                <c:pt idx="431">
                  <c:v>0.72356627002060991</c:v>
                </c:pt>
                <c:pt idx="432">
                  <c:v>0.72356627002060991</c:v>
                </c:pt>
                <c:pt idx="433">
                  <c:v>0.72356627002060991</c:v>
                </c:pt>
                <c:pt idx="434">
                  <c:v>0.72356627002060991</c:v>
                </c:pt>
                <c:pt idx="435">
                  <c:v>0.72356627002060991</c:v>
                </c:pt>
                <c:pt idx="436">
                  <c:v>0.72356627002060991</c:v>
                </c:pt>
                <c:pt idx="437">
                  <c:v>0.72356627002060991</c:v>
                </c:pt>
                <c:pt idx="438">
                  <c:v>0.72356627002060991</c:v>
                </c:pt>
                <c:pt idx="439">
                  <c:v>0.72356627002060991</c:v>
                </c:pt>
                <c:pt idx="440">
                  <c:v>0.72356627002060991</c:v>
                </c:pt>
                <c:pt idx="441">
                  <c:v>0.72356627002060991</c:v>
                </c:pt>
                <c:pt idx="442">
                  <c:v>0.72356627002060991</c:v>
                </c:pt>
                <c:pt idx="443">
                  <c:v>0.72356627002060991</c:v>
                </c:pt>
                <c:pt idx="444">
                  <c:v>0.72356627002060991</c:v>
                </c:pt>
                <c:pt idx="445">
                  <c:v>0.72356627002060991</c:v>
                </c:pt>
                <c:pt idx="446">
                  <c:v>0.72356627002060991</c:v>
                </c:pt>
                <c:pt idx="447">
                  <c:v>0.72356627002060991</c:v>
                </c:pt>
                <c:pt idx="448">
                  <c:v>0.72356627002060991</c:v>
                </c:pt>
                <c:pt idx="449">
                  <c:v>0.72356627002060991</c:v>
                </c:pt>
                <c:pt idx="450">
                  <c:v>0.72356627002060991</c:v>
                </c:pt>
                <c:pt idx="451">
                  <c:v>0.72356627002060991</c:v>
                </c:pt>
                <c:pt idx="452">
                  <c:v>0.72356627002060991</c:v>
                </c:pt>
                <c:pt idx="453">
                  <c:v>0.72356627002060991</c:v>
                </c:pt>
                <c:pt idx="454">
                  <c:v>0.72356627002060991</c:v>
                </c:pt>
                <c:pt idx="455">
                  <c:v>0.72356627002060991</c:v>
                </c:pt>
                <c:pt idx="456">
                  <c:v>0.72356627002060991</c:v>
                </c:pt>
                <c:pt idx="457">
                  <c:v>0.72356627002060991</c:v>
                </c:pt>
                <c:pt idx="458">
                  <c:v>0.71505372566742631</c:v>
                </c:pt>
                <c:pt idx="459">
                  <c:v>0.71505372566742631</c:v>
                </c:pt>
                <c:pt idx="460">
                  <c:v>0.71505372566742631</c:v>
                </c:pt>
                <c:pt idx="461">
                  <c:v>0.71505372566742631</c:v>
                </c:pt>
                <c:pt idx="462">
                  <c:v>0.71505372566742631</c:v>
                </c:pt>
                <c:pt idx="463">
                  <c:v>0.71505372566742631</c:v>
                </c:pt>
                <c:pt idx="464">
                  <c:v>0.71505372566742631</c:v>
                </c:pt>
                <c:pt idx="465">
                  <c:v>0.71505372566742631</c:v>
                </c:pt>
                <c:pt idx="466">
                  <c:v>0.71505372566742631</c:v>
                </c:pt>
                <c:pt idx="467">
                  <c:v>0.71505372566742631</c:v>
                </c:pt>
                <c:pt idx="468">
                  <c:v>0.71505372566742631</c:v>
                </c:pt>
                <c:pt idx="469">
                  <c:v>0.71505372566742631</c:v>
                </c:pt>
                <c:pt idx="470">
                  <c:v>0.71505372566742631</c:v>
                </c:pt>
                <c:pt idx="471">
                  <c:v>0.71505372566742631</c:v>
                </c:pt>
                <c:pt idx="472">
                  <c:v>0.71505372566742631</c:v>
                </c:pt>
                <c:pt idx="473">
                  <c:v>0.71505372566742631</c:v>
                </c:pt>
                <c:pt idx="474">
                  <c:v>0.71505372566742631</c:v>
                </c:pt>
                <c:pt idx="475">
                  <c:v>0.71505372566742631</c:v>
                </c:pt>
                <c:pt idx="476">
                  <c:v>0.71505372566742631</c:v>
                </c:pt>
                <c:pt idx="477">
                  <c:v>0.71505372566742631</c:v>
                </c:pt>
                <c:pt idx="478">
                  <c:v>0.71505372566742631</c:v>
                </c:pt>
                <c:pt idx="479">
                  <c:v>0.71505372566742631</c:v>
                </c:pt>
                <c:pt idx="480">
                  <c:v>0.71505372566742631</c:v>
                </c:pt>
                <c:pt idx="481">
                  <c:v>0.71505372566742631</c:v>
                </c:pt>
                <c:pt idx="482">
                  <c:v>0.71505372566742631</c:v>
                </c:pt>
                <c:pt idx="483">
                  <c:v>0.71505372566742631</c:v>
                </c:pt>
                <c:pt idx="484">
                  <c:v>0.71505372566742631</c:v>
                </c:pt>
                <c:pt idx="485">
                  <c:v>0.71505372566742631</c:v>
                </c:pt>
                <c:pt idx="486">
                  <c:v>0.71505372566742631</c:v>
                </c:pt>
                <c:pt idx="487">
                  <c:v>0.71505372566742631</c:v>
                </c:pt>
                <c:pt idx="488">
                  <c:v>0.71505372566742631</c:v>
                </c:pt>
                <c:pt idx="489">
                  <c:v>0.71505372566742631</c:v>
                </c:pt>
                <c:pt idx="490">
                  <c:v>0.71505372566742631</c:v>
                </c:pt>
                <c:pt idx="491">
                  <c:v>0.71505372566742631</c:v>
                </c:pt>
                <c:pt idx="492">
                  <c:v>0.71505372566742631</c:v>
                </c:pt>
                <c:pt idx="493">
                  <c:v>0.71505372566742631</c:v>
                </c:pt>
                <c:pt idx="494">
                  <c:v>0.71505372566742631</c:v>
                </c:pt>
                <c:pt idx="495">
                  <c:v>0.71505372566742631</c:v>
                </c:pt>
                <c:pt idx="496">
                  <c:v>0.71505372566742631</c:v>
                </c:pt>
                <c:pt idx="497">
                  <c:v>0.71505372566742631</c:v>
                </c:pt>
                <c:pt idx="498">
                  <c:v>0.71505372566742631</c:v>
                </c:pt>
                <c:pt idx="499">
                  <c:v>0.71505372566742631</c:v>
                </c:pt>
                <c:pt idx="500">
                  <c:v>0.71505372566742631</c:v>
                </c:pt>
                <c:pt idx="501">
                  <c:v>0.71505372566742631</c:v>
                </c:pt>
                <c:pt idx="502">
                  <c:v>0.71505372566742631</c:v>
                </c:pt>
                <c:pt idx="503">
                  <c:v>0.71505372566742631</c:v>
                </c:pt>
                <c:pt idx="504">
                  <c:v>0.69572794929803639</c:v>
                </c:pt>
                <c:pt idx="505">
                  <c:v>0.69572794929803639</c:v>
                </c:pt>
                <c:pt idx="506">
                  <c:v>0.69572794929803639</c:v>
                </c:pt>
                <c:pt idx="507">
                  <c:v>0.69572794929803639</c:v>
                </c:pt>
                <c:pt idx="508">
                  <c:v>0.69572794929803639</c:v>
                </c:pt>
                <c:pt idx="509">
                  <c:v>0.69572794929803639</c:v>
                </c:pt>
                <c:pt idx="510">
                  <c:v>0.69572794929803639</c:v>
                </c:pt>
                <c:pt idx="511">
                  <c:v>0.69572794929803639</c:v>
                </c:pt>
                <c:pt idx="512">
                  <c:v>0.69572794929803639</c:v>
                </c:pt>
                <c:pt idx="513">
                  <c:v>0.69572794929803639</c:v>
                </c:pt>
                <c:pt idx="514">
                  <c:v>0.69572794929803639</c:v>
                </c:pt>
                <c:pt idx="515">
                  <c:v>0.69572794929803639</c:v>
                </c:pt>
                <c:pt idx="516">
                  <c:v>0.69572794929803639</c:v>
                </c:pt>
                <c:pt idx="517">
                  <c:v>0.69572794929803639</c:v>
                </c:pt>
                <c:pt idx="518">
                  <c:v>0.69572794929803639</c:v>
                </c:pt>
                <c:pt idx="519">
                  <c:v>0.69572794929803639</c:v>
                </c:pt>
                <c:pt idx="520">
                  <c:v>0.69572794929803639</c:v>
                </c:pt>
                <c:pt idx="521">
                  <c:v>0.69572794929803639</c:v>
                </c:pt>
                <c:pt idx="522">
                  <c:v>0.69572794929803639</c:v>
                </c:pt>
                <c:pt idx="523">
                  <c:v>0.69572794929803639</c:v>
                </c:pt>
                <c:pt idx="524">
                  <c:v>0.69572794929803639</c:v>
                </c:pt>
                <c:pt idx="525">
                  <c:v>0.69572794929803639</c:v>
                </c:pt>
                <c:pt idx="526">
                  <c:v>0.69572794929803639</c:v>
                </c:pt>
                <c:pt idx="527">
                  <c:v>0.69572794929803639</c:v>
                </c:pt>
                <c:pt idx="528">
                  <c:v>0.69572794929803639</c:v>
                </c:pt>
                <c:pt idx="529">
                  <c:v>0.69572794929803639</c:v>
                </c:pt>
                <c:pt idx="530">
                  <c:v>0.69572794929803639</c:v>
                </c:pt>
                <c:pt idx="531">
                  <c:v>0.69572794929803639</c:v>
                </c:pt>
                <c:pt idx="532">
                  <c:v>0.69572794929803639</c:v>
                </c:pt>
                <c:pt idx="533">
                  <c:v>0.69572794929803639</c:v>
                </c:pt>
                <c:pt idx="534">
                  <c:v>0.69572794929803639</c:v>
                </c:pt>
                <c:pt idx="535">
                  <c:v>0.69572794929803639</c:v>
                </c:pt>
                <c:pt idx="536">
                  <c:v>0.69572794929803639</c:v>
                </c:pt>
                <c:pt idx="537">
                  <c:v>0.69572794929803639</c:v>
                </c:pt>
                <c:pt idx="538">
                  <c:v>0.69572794929803639</c:v>
                </c:pt>
                <c:pt idx="539">
                  <c:v>0.69572794929803639</c:v>
                </c:pt>
                <c:pt idx="540">
                  <c:v>0.6957279492980363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42F8-444F-ABCC-E202436AC4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9389696"/>
        <c:axId val="89260800"/>
      </c:scatterChart>
      <c:valAx>
        <c:axId val="89389696"/>
        <c:scaling>
          <c:orientation val="minMax"/>
          <c:max val="6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 dirty="0" smtClean="0"/>
                  <a:t>Years</a:t>
                </a:r>
                <a:endParaRPr lang="en-US" sz="800" dirty="0"/>
              </a:p>
            </c:rich>
          </c:tx>
          <c:layout>
            <c:manualLayout>
              <c:xMode val="edge"/>
              <c:yMode val="edge"/>
              <c:x val="0.47872589943168947"/>
              <c:y val="0.8824346340928344"/>
            </c:manualLayout>
          </c:layout>
          <c:overlay val="0"/>
          <c:spPr>
            <a:noFill/>
            <a:ln w="25400">
              <a:noFill/>
            </a:ln>
            <a:effectLst/>
          </c:spPr>
        </c:title>
        <c:numFmt formatCode="General" sourceLinked="1"/>
        <c:majorTickMark val="out"/>
        <c:minorTickMark val="out"/>
        <c:tickLblPos val="nextTo"/>
        <c:spPr>
          <a:noFill/>
          <a:ln w="1905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/>
            </a:pPr>
            <a:endParaRPr lang="en-US"/>
          </a:p>
        </c:txPr>
        <c:crossAx val="89260800"/>
        <c:crosses val="autoZero"/>
        <c:crossBetween val="midCat"/>
        <c:majorUnit val="2"/>
        <c:minorUnit val="1"/>
      </c:valAx>
      <c:valAx>
        <c:axId val="89260800"/>
        <c:scaling>
          <c:orientation val="minMax"/>
          <c:max val="1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 dirty="0" smtClean="0"/>
                  <a:t>Metastasis</a:t>
                </a:r>
                <a:endParaRPr lang="en-US" sz="800" dirty="0"/>
              </a:p>
            </c:rich>
          </c:tx>
          <c:layout>
            <c:manualLayout>
              <c:xMode val="edge"/>
              <c:yMode val="edge"/>
              <c:x val="0"/>
              <c:y val="0.24349136045494316"/>
            </c:manualLayout>
          </c:layout>
          <c:overlay val="0"/>
          <c:spPr>
            <a:noFill/>
            <a:ln w="25400">
              <a:noFill/>
            </a:ln>
            <a:effectLst/>
          </c:spPr>
        </c:title>
        <c:numFmt formatCode="General" sourceLinked="1"/>
        <c:majorTickMark val="out"/>
        <c:minorTickMark val="out"/>
        <c:tickLblPos val="nextTo"/>
        <c:spPr>
          <a:ln w="1905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/>
            </a:pPr>
            <a:endParaRPr lang="en-US"/>
          </a:p>
        </c:txPr>
        <c:crossAx val="89389696"/>
        <c:crosses val="autoZero"/>
        <c:crossBetween val="midCat"/>
        <c:majorUnit val="0.2"/>
        <c:minorUnit val="0.1"/>
      </c:valAx>
      <c:spPr>
        <a:noFill/>
        <a:ln w="19050">
          <a:solidFill>
            <a:schemeClr val="tx1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20415718868474775"/>
          <c:y val="0.63300656167979008"/>
          <c:w val="0.2769553805774278"/>
          <c:h val="0.12843132108486438"/>
        </c:manualLayout>
      </c:layout>
      <c:overlay val="0"/>
      <c:spPr>
        <a:noFill/>
        <a:ln w="3175">
          <a:noFill/>
          <a:prstDash val="solid"/>
        </a:ln>
      </c:spPr>
      <c:txPr>
        <a:bodyPr/>
        <a:lstStyle/>
        <a:p>
          <a:pPr>
            <a:defRPr sz="800" b="0"/>
          </a:pPr>
          <a:endParaRPr lang="en-US"/>
        </a:p>
      </c:txPr>
    </c:legend>
    <c:plotVisOnly val="0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12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9578608923884513"/>
          <c:y val="0.16666719856515064"/>
          <c:w val="0.72964479440069996"/>
          <c:h val="0.6143810456911436"/>
        </c:manualLayout>
      </c:layout>
      <c:scatterChart>
        <c:scatterStyle val="lineMarker"/>
        <c:varyColors val="0"/>
        <c:ser>
          <c:idx val="1"/>
          <c:order val="0"/>
          <c:tx>
            <c:v>high</c:v>
          </c:tx>
          <c:spPr>
            <a:ln w="25400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Survival!$B$191:$B$223</c:f>
              <c:numCache>
                <c:formatCode>General</c:formatCode>
                <c:ptCount val="33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4</c:v>
                </c:pt>
                <c:pt idx="4">
                  <c:v>1.5</c:v>
                </c:pt>
                <c:pt idx="5">
                  <c:v>1.6</c:v>
                </c:pt>
                <c:pt idx="6">
                  <c:v>1.6</c:v>
                </c:pt>
                <c:pt idx="7">
                  <c:v>3.1</c:v>
                </c:pt>
                <c:pt idx="8">
                  <c:v>3.8</c:v>
                </c:pt>
                <c:pt idx="9">
                  <c:v>5.4</c:v>
                </c:pt>
                <c:pt idx="10">
                  <c:v>6</c:v>
                </c:pt>
                <c:pt idx="11">
                  <c:v>6.5</c:v>
                </c:pt>
                <c:pt idx="12">
                  <c:v>6.9</c:v>
                </c:pt>
                <c:pt idx="13">
                  <c:v>7</c:v>
                </c:pt>
                <c:pt idx="14">
                  <c:v>7.2</c:v>
                </c:pt>
                <c:pt idx="15">
                  <c:v>8</c:v>
                </c:pt>
                <c:pt idx="16">
                  <c:v>8.1</c:v>
                </c:pt>
                <c:pt idx="17">
                  <c:v>8.6999999999999993</c:v>
                </c:pt>
                <c:pt idx="18">
                  <c:v>8.9</c:v>
                </c:pt>
                <c:pt idx="19">
                  <c:v>9.3000000000000007</c:v>
                </c:pt>
                <c:pt idx="20">
                  <c:v>9.4</c:v>
                </c:pt>
                <c:pt idx="21">
                  <c:v>9.6</c:v>
                </c:pt>
                <c:pt idx="22">
                  <c:v>9.8000000000000007</c:v>
                </c:pt>
                <c:pt idx="23">
                  <c:v>10.1</c:v>
                </c:pt>
                <c:pt idx="24">
                  <c:v>10.199999999999999</c:v>
                </c:pt>
                <c:pt idx="25">
                  <c:v>10.3</c:v>
                </c:pt>
                <c:pt idx="26">
                  <c:v>10.5</c:v>
                </c:pt>
                <c:pt idx="27">
                  <c:v>10.9</c:v>
                </c:pt>
                <c:pt idx="28">
                  <c:v>11</c:v>
                </c:pt>
                <c:pt idx="29">
                  <c:v>11.1</c:v>
                </c:pt>
                <c:pt idx="30">
                  <c:v>11.3</c:v>
                </c:pt>
                <c:pt idx="31">
                  <c:v>11.9</c:v>
                </c:pt>
                <c:pt idx="32">
                  <c:v>12.8</c:v>
                </c:pt>
              </c:numCache>
            </c:numRef>
          </c:xVal>
          <c:yVal>
            <c:numRef>
              <c:f>Survival!$C$191:$C$223</c:f>
              <c:numCache>
                <c:formatCode>General</c:formatCode>
                <c:ptCount val="33"/>
                <c:pt idx="0">
                  <c:v>1</c:v>
                </c:pt>
                <c:pt idx="1">
                  <c:v>1</c:v>
                </c:pt>
                <c:pt idx="2">
                  <c:v>0.93939393939393945</c:v>
                </c:pt>
                <c:pt idx="3">
                  <c:v>0.93939393939393945</c:v>
                </c:pt>
                <c:pt idx="4">
                  <c:v>0.93939393939393945</c:v>
                </c:pt>
                <c:pt idx="5">
                  <c:v>0.93939393939393945</c:v>
                </c:pt>
                <c:pt idx="6">
                  <c:v>0.90700104493207945</c:v>
                </c:pt>
                <c:pt idx="7">
                  <c:v>0.90700104493207945</c:v>
                </c:pt>
                <c:pt idx="8">
                  <c:v>0.90700104493207945</c:v>
                </c:pt>
                <c:pt idx="9">
                  <c:v>0.90700104493207945</c:v>
                </c:pt>
                <c:pt idx="10">
                  <c:v>0.90700104493207945</c:v>
                </c:pt>
                <c:pt idx="11">
                  <c:v>0.90700104493207945</c:v>
                </c:pt>
                <c:pt idx="12">
                  <c:v>0.90700104493207945</c:v>
                </c:pt>
                <c:pt idx="13">
                  <c:v>0.90700104493207945</c:v>
                </c:pt>
                <c:pt idx="14">
                  <c:v>0.90700104493207945</c:v>
                </c:pt>
                <c:pt idx="15">
                  <c:v>0.90700104493207945</c:v>
                </c:pt>
                <c:pt idx="16">
                  <c:v>0.90700104493207945</c:v>
                </c:pt>
                <c:pt idx="17">
                  <c:v>0.90700104493207945</c:v>
                </c:pt>
                <c:pt idx="18">
                  <c:v>0.90700104493207945</c:v>
                </c:pt>
                <c:pt idx="19">
                  <c:v>0.90700104493207945</c:v>
                </c:pt>
                <c:pt idx="20">
                  <c:v>0.90700104493207945</c:v>
                </c:pt>
                <c:pt idx="21">
                  <c:v>0.90700104493207945</c:v>
                </c:pt>
                <c:pt idx="22">
                  <c:v>0.90700104493207945</c:v>
                </c:pt>
                <c:pt idx="23">
                  <c:v>0.90700104493207945</c:v>
                </c:pt>
                <c:pt idx="24">
                  <c:v>0.90700104493207945</c:v>
                </c:pt>
                <c:pt idx="25">
                  <c:v>0.90700104493207945</c:v>
                </c:pt>
                <c:pt idx="26">
                  <c:v>0.90700104493207945</c:v>
                </c:pt>
                <c:pt idx="27">
                  <c:v>0.90700104493207945</c:v>
                </c:pt>
                <c:pt idx="28">
                  <c:v>0.90700104493207945</c:v>
                </c:pt>
                <c:pt idx="29">
                  <c:v>0.90700104493207945</c:v>
                </c:pt>
                <c:pt idx="30">
                  <c:v>0.90700104493207945</c:v>
                </c:pt>
                <c:pt idx="31">
                  <c:v>0.90700104493207945</c:v>
                </c:pt>
                <c:pt idx="32">
                  <c:v>0.9070010449320794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DB3-4DB1-AD20-8EC3C7C9E2AA}"/>
            </c:ext>
          </c:extLst>
        </c:ser>
        <c:ser>
          <c:idx val="2"/>
          <c:order val="1"/>
          <c:tx>
            <c:v>low</c:v>
          </c:tx>
          <c:spPr>
            <a:ln w="25400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Survival!$B$224:$B$385</c:f>
              <c:numCache>
                <c:formatCode>General</c:formatCode>
                <c:ptCount val="16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2</c:v>
                </c:pt>
                <c:pt idx="4">
                  <c:v>0.2</c:v>
                </c:pt>
                <c:pt idx="5">
                  <c:v>0.5</c:v>
                </c:pt>
                <c:pt idx="6">
                  <c:v>0.5</c:v>
                </c:pt>
                <c:pt idx="7">
                  <c:v>0.7</c:v>
                </c:pt>
                <c:pt idx="8">
                  <c:v>0.7</c:v>
                </c:pt>
                <c:pt idx="9">
                  <c:v>0.8</c:v>
                </c:pt>
                <c:pt idx="10">
                  <c:v>0.8</c:v>
                </c:pt>
                <c:pt idx="11">
                  <c:v>0.9</c:v>
                </c:pt>
                <c:pt idx="12">
                  <c:v>0.9</c:v>
                </c:pt>
                <c:pt idx="13">
                  <c:v>1</c:v>
                </c:pt>
                <c:pt idx="14">
                  <c:v>1</c:v>
                </c:pt>
                <c:pt idx="15">
                  <c:v>1.1000000000000001</c:v>
                </c:pt>
                <c:pt idx="16">
                  <c:v>1.1000000000000001</c:v>
                </c:pt>
                <c:pt idx="17">
                  <c:v>1.2</c:v>
                </c:pt>
                <c:pt idx="18">
                  <c:v>1.2</c:v>
                </c:pt>
                <c:pt idx="19">
                  <c:v>1.3</c:v>
                </c:pt>
                <c:pt idx="20">
                  <c:v>1.3</c:v>
                </c:pt>
                <c:pt idx="21">
                  <c:v>1.4</c:v>
                </c:pt>
                <c:pt idx="22">
                  <c:v>1.4</c:v>
                </c:pt>
                <c:pt idx="23">
                  <c:v>1.5</c:v>
                </c:pt>
                <c:pt idx="24">
                  <c:v>1.5</c:v>
                </c:pt>
                <c:pt idx="25">
                  <c:v>1.6</c:v>
                </c:pt>
                <c:pt idx="26">
                  <c:v>1.6</c:v>
                </c:pt>
                <c:pt idx="27">
                  <c:v>1.7</c:v>
                </c:pt>
                <c:pt idx="28">
                  <c:v>1.7</c:v>
                </c:pt>
                <c:pt idx="29">
                  <c:v>1.8</c:v>
                </c:pt>
                <c:pt idx="30">
                  <c:v>1.8</c:v>
                </c:pt>
                <c:pt idx="31">
                  <c:v>2</c:v>
                </c:pt>
                <c:pt idx="32">
                  <c:v>2</c:v>
                </c:pt>
                <c:pt idx="33">
                  <c:v>2.1</c:v>
                </c:pt>
                <c:pt idx="34">
                  <c:v>2.1</c:v>
                </c:pt>
                <c:pt idx="35">
                  <c:v>2.2999999999999998</c:v>
                </c:pt>
                <c:pt idx="36">
                  <c:v>2.4</c:v>
                </c:pt>
                <c:pt idx="37">
                  <c:v>2.4</c:v>
                </c:pt>
                <c:pt idx="38">
                  <c:v>2.6</c:v>
                </c:pt>
                <c:pt idx="39">
                  <c:v>2.6</c:v>
                </c:pt>
                <c:pt idx="40">
                  <c:v>2.7</c:v>
                </c:pt>
                <c:pt idx="41">
                  <c:v>2.7</c:v>
                </c:pt>
                <c:pt idx="42">
                  <c:v>2.9</c:v>
                </c:pt>
                <c:pt idx="43">
                  <c:v>2.9</c:v>
                </c:pt>
                <c:pt idx="44">
                  <c:v>3</c:v>
                </c:pt>
                <c:pt idx="45">
                  <c:v>3</c:v>
                </c:pt>
                <c:pt idx="46">
                  <c:v>3.1</c:v>
                </c:pt>
                <c:pt idx="47">
                  <c:v>3.1</c:v>
                </c:pt>
                <c:pt idx="48">
                  <c:v>3.2</c:v>
                </c:pt>
                <c:pt idx="49">
                  <c:v>3.2</c:v>
                </c:pt>
                <c:pt idx="50">
                  <c:v>3.4</c:v>
                </c:pt>
                <c:pt idx="51">
                  <c:v>3.4</c:v>
                </c:pt>
                <c:pt idx="52">
                  <c:v>3.5</c:v>
                </c:pt>
                <c:pt idx="53">
                  <c:v>3.5</c:v>
                </c:pt>
                <c:pt idx="54">
                  <c:v>3.6</c:v>
                </c:pt>
                <c:pt idx="55">
                  <c:v>3.6</c:v>
                </c:pt>
                <c:pt idx="56">
                  <c:v>3.7</c:v>
                </c:pt>
                <c:pt idx="57">
                  <c:v>3.7</c:v>
                </c:pt>
                <c:pt idx="58">
                  <c:v>3.8</c:v>
                </c:pt>
                <c:pt idx="59">
                  <c:v>3.8</c:v>
                </c:pt>
                <c:pt idx="60">
                  <c:v>3.9</c:v>
                </c:pt>
                <c:pt idx="61">
                  <c:v>3.9</c:v>
                </c:pt>
                <c:pt idx="62">
                  <c:v>4</c:v>
                </c:pt>
                <c:pt idx="63">
                  <c:v>4</c:v>
                </c:pt>
                <c:pt idx="64">
                  <c:v>4.0999999999999996</c:v>
                </c:pt>
                <c:pt idx="65">
                  <c:v>4.0999999999999996</c:v>
                </c:pt>
                <c:pt idx="66">
                  <c:v>4.2</c:v>
                </c:pt>
                <c:pt idx="67">
                  <c:v>4.2</c:v>
                </c:pt>
                <c:pt idx="68">
                  <c:v>4.7</c:v>
                </c:pt>
                <c:pt idx="69">
                  <c:v>4.7</c:v>
                </c:pt>
                <c:pt idx="70">
                  <c:v>4.8</c:v>
                </c:pt>
                <c:pt idx="71">
                  <c:v>4.8</c:v>
                </c:pt>
                <c:pt idx="72">
                  <c:v>4.9000000000000004</c:v>
                </c:pt>
                <c:pt idx="73">
                  <c:v>5</c:v>
                </c:pt>
                <c:pt idx="74">
                  <c:v>5.0999999999999996</c:v>
                </c:pt>
                <c:pt idx="75">
                  <c:v>5.0999999999999996</c:v>
                </c:pt>
                <c:pt idx="76">
                  <c:v>5.2</c:v>
                </c:pt>
                <c:pt idx="77">
                  <c:v>5.3</c:v>
                </c:pt>
                <c:pt idx="78">
                  <c:v>5.3</c:v>
                </c:pt>
                <c:pt idx="79">
                  <c:v>5.4</c:v>
                </c:pt>
                <c:pt idx="80">
                  <c:v>5.7</c:v>
                </c:pt>
                <c:pt idx="81">
                  <c:v>5.7</c:v>
                </c:pt>
                <c:pt idx="82">
                  <c:v>5.8</c:v>
                </c:pt>
                <c:pt idx="83">
                  <c:v>5.8</c:v>
                </c:pt>
                <c:pt idx="84">
                  <c:v>5.9</c:v>
                </c:pt>
                <c:pt idx="85">
                  <c:v>5.9</c:v>
                </c:pt>
                <c:pt idx="86">
                  <c:v>6</c:v>
                </c:pt>
                <c:pt idx="87">
                  <c:v>6.1</c:v>
                </c:pt>
                <c:pt idx="88">
                  <c:v>6.1</c:v>
                </c:pt>
                <c:pt idx="89">
                  <c:v>6.3</c:v>
                </c:pt>
                <c:pt idx="90">
                  <c:v>6.4</c:v>
                </c:pt>
                <c:pt idx="91">
                  <c:v>6.5</c:v>
                </c:pt>
                <c:pt idx="92">
                  <c:v>6.6</c:v>
                </c:pt>
                <c:pt idx="93">
                  <c:v>6.7</c:v>
                </c:pt>
                <c:pt idx="94">
                  <c:v>6.7</c:v>
                </c:pt>
                <c:pt idx="95">
                  <c:v>6.8</c:v>
                </c:pt>
                <c:pt idx="96">
                  <c:v>6.8</c:v>
                </c:pt>
                <c:pt idx="97">
                  <c:v>6.9</c:v>
                </c:pt>
                <c:pt idx="98">
                  <c:v>7</c:v>
                </c:pt>
                <c:pt idx="99">
                  <c:v>7.1</c:v>
                </c:pt>
                <c:pt idx="100">
                  <c:v>7.2</c:v>
                </c:pt>
                <c:pt idx="101">
                  <c:v>7.3</c:v>
                </c:pt>
                <c:pt idx="102">
                  <c:v>7.3</c:v>
                </c:pt>
                <c:pt idx="103">
                  <c:v>7.4</c:v>
                </c:pt>
                <c:pt idx="104">
                  <c:v>7.5</c:v>
                </c:pt>
                <c:pt idx="105">
                  <c:v>7.7</c:v>
                </c:pt>
                <c:pt idx="106">
                  <c:v>7.8</c:v>
                </c:pt>
                <c:pt idx="107">
                  <c:v>7.9</c:v>
                </c:pt>
                <c:pt idx="108">
                  <c:v>8</c:v>
                </c:pt>
                <c:pt idx="109">
                  <c:v>8.1</c:v>
                </c:pt>
                <c:pt idx="110">
                  <c:v>8.1999999999999993</c:v>
                </c:pt>
                <c:pt idx="111">
                  <c:v>8.1999999999999993</c:v>
                </c:pt>
                <c:pt idx="112">
                  <c:v>8.3000000000000007</c:v>
                </c:pt>
                <c:pt idx="113">
                  <c:v>8.4</c:v>
                </c:pt>
                <c:pt idx="114">
                  <c:v>8.5</c:v>
                </c:pt>
                <c:pt idx="115">
                  <c:v>8.6</c:v>
                </c:pt>
                <c:pt idx="116">
                  <c:v>8.6999999999999993</c:v>
                </c:pt>
                <c:pt idx="117">
                  <c:v>8.8000000000000007</c:v>
                </c:pt>
                <c:pt idx="118">
                  <c:v>8.8000000000000007</c:v>
                </c:pt>
                <c:pt idx="119">
                  <c:v>8.9</c:v>
                </c:pt>
                <c:pt idx="120">
                  <c:v>9</c:v>
                </c:pt>
                <c:pt idx="121">
                  <c:v>9.1</c:v>
                </c:pt>
                <c:pt idx="122">
                  <c:v>9.1999999999999993</c:v>
                </c:pt>
                <c:pt idx="123">
                  <c:v>9.4</c:v>
                </c:pt>
                <c:pt idx="124">
                  <c:v>9.5</c:v>
                </c:pt>
                <c:pt idx="125">
                  <c:v>9.6</c:v>
                </c:pt>
                <c:pt idx="126">
                  <c:v>9.6999999999999993</c:v>
                </c:pt>
                <c:pt idx="127">
                  <c:v>9.8000000000000007</c:v>
                </c:pt>
                <c:pt idx="128">
                  <c:v>9.9</c:v>
                </c:pt>
                <c:pt idx="129">
                  <c:v>10</c:v>
                </c:pt>
                <c:pt idx="130">
                  <c:v>10.1</c:v>
                </c:pt>
                <c:pt idx="131">
                  <c:v>10.199999999999999</c:v>
                </c:pt>
                <c:pt idx="132">
                  <c:v>10.3</c:v>
                </c:pt>
                <c:pt idx="133">
                  <c:v>10.4</c:v>
                </c:pt>
                <c:pt idx="134">
                  <c:v>10.5</c:v>
                </c:pt>
                <c:pt idx="135">
                  <c:v>10.6</c:v>
                </c:pt>
                <c:pt idx="136">
                  <c:v>10.6</c:v>
                </c:pt>
                <c:pt idx="137">
                  <c:v>10.8</c:v>
                </c:pt>
                <c:pt idx="138">
                  <c:v>10.9</c:v>
                </c:pt>
                <c:pt idx="139">
                  <c:v>11</c:v>
                </c:pt>
                <c:pt idx="140">
                  <c:v>11.1</c:v>
                </c:pt>
                <c:pt idx="141">
                  <c:v>11.2</c:v>
                </c:pt>
                <c:pt idx="142">
                  <c:v>11.3</c:v>
                </c:pt>
                <c:pt idx="143">
                  <c:v>11.4</c:v>
                </c:pt>
                <c:pt idx="144">
                  <c:v>11.5</c:v>
                </c:pt>
                <c:pt idx="145">
                  <c:v>11.6</c:v>
                </c:pt>
                <c:pt idx="146">
                  <c:v>11.7</c:v>
                </c:pt>
                <c:pt idx="147">
                  <c:v>11.8</c:v>
                </c:pt>
                <c:pt idx="148">
                  <c:v>12.1</c:v>
                </c:pt>
                <c:pt idx="149">
                  <c:v>12.2</c:v>
                </c:pt>
                <c:pt idx="150">
                  <c:v>12.3</c:v>
                </c:pt>
                <c:pt idx="151">
                  <c:v>12.4</c:v>
                </c:pt>
                <c:pt idx="152">
                  <c:v>12.5</c:v>
                </c:pt>
                <c:pt idx="153">
                  <c:v>12.6</c:v>
                </c:pt>
                <c:pt idx="154">
                  <c:v>12.7</c:v>
                </c:pt>
                <c:pt idx="155">
                  <c:v>12.9</c:v>
                </c:pt>
                <c:pt idx="156">
                  <c:v>13</c:v>
                </c:pt>
                <c:pt idx="157">
                  <c:v>13.1</c:v>
                </c:pt>
                <c:pt idx="158">
                  <c:v>13.2</c:v>
                </c:pt>
                <c:pt idx="159">
                  <c:v>13.3</c:v>
                </c:pt>
                <c:pt idx="160">
                  <c:v>13.8</c:v>
                </c:pt>
                <c:pt idx="161">
                  <c:v>14.1</c:v>
                </c:pt>
              </c:numCache>
            </c:numRef>
          </c:xVal>
          <c:yVal>
            <c:numRef>
              <c:f>Survival!$C$224:$C$385</c:f>
              <c:numCache>
                <c:formatCode>General</c:formatCode>
                <c:ptCount val="162"/>
                <c:pt idx="0">
                  <c:v>1</c:v>
                </c:pt>
                <c:pt idx="1">
                  <c:v>1</c:v>
                </c:pt>
                <c:pt idx="2">
                  <c:v>0.97959183673469385</c:v>
                </c:pt>
                <c:pt idx="3">
                  <c:v>0.97959183673469385</c:v>
                </c:pt>
                <c:pt idx="4">
                  <c:v>0.97619047619047616</c:v>
                </c:pt>
                <c:pt idx="5">
                  <c:v>0.97619047619047616</c:v>
                </c:pt>
                <c:pt idx="6">
                  <c:v>0.97278911564625847</c:v>
                </c:pt>
                <c:pt idx="7">
                  <c:v>0.97278911564625847</c:v>
                </c:pt>
                <c:pt idx="8">
                  <c:v>0.96938775510204078</c:v>
                </c:pt>
                <c:pt idx="9">
                  <c:v>0.96938775510204078</c:v>
                </c:pt>
                <c:pt idx="10">
                  <c:v>0.96598639455782309</c:v>
                </c:pt>
                <c:pt idx="11">
                  <c:v>0.96598639455782309</c:v>
                </c:pt>
                <c:pt idx="12">
                  <c:v>0.95574625609961295</c:v>
                </c:pt>
                <c:pt idx="13">
                  <c:v>0.95574625609961295</c:v>
                </c:pt>
                <c:pt idx="14">
                  <c:v>0.95232064227846736</c:v>
                </c:pt>
                <c:pt idx="15">
                  <c:v>0.95232064227846736</c:v>
                </c:pt>
                <c:pt idx="16">
                  <c:v>0.94546941463617618</c:v>
                </c:pt>
                <c:pt idx="17">
                  <c:v>0.94546941463617618</c:v>
                </c:pt>
                <c:pt idx="18">
                  <c:v>0.938618186993885</c:v>
                </c:pt>
                <c:pt idx="19">
                  <c:v>0.938618186993885</c:v>
                </c:pt>
                <c:pt idx="20">
                  <c:v>0.93176695935159382</c:v>
                </c:pt>
                <c:pt idx="21">
                  <c:v>0.93176695935159382</c:v>
                </c:pt>
                <c:pt idx="22">
                  <c:v>0.92834134553044823</c:v>
                </c:pt>
                <c:pt idx="23">
                  <c:v>0.92834134553044823</c:v>
                </c:pt>
                <c:pt idx="24">
                  <c:v>0.92149011788815705</c:v>
                </c:pt>
                <c:pt idx="25">
                  <c:v>0.92149011788815705</c:v>
                </c:pt>
                <c:pt idx="26">
                  <c:v>0.91121327642472039</c:v>
                </c:pt>
                <c:pt idx="27">
                  <c:v>0.91121327642472039</c:v>
                </c:pt>
                <c:pt idx="28">
                  <c:v>0.89745911376170573</c:v>
                </c:pt>
                <c:pt idx="29">
                  <c:v>0.89745911376170573</c:v>
                </c:pt>
                <c:pt idx="30">
                  <c:v>0.89402057309595206</c:v>
                </c:pt>
                <c:pt idx="31">
                  <c:v>0.89402057309595206</c:v>
                </c:pt>
                <c:pt idx="32">
                  <c:v>0.8905820324301984</c:v>
                </c:pt>
                <c:pt idx="33">
                  <c:v>0.8905820324301984</c:v>
                </c:pt>
                <c:pt idx="34">
                  <c:v>0.87682786976718374</c:v>
                </c:pt>
                <c:pt idx="35">
                  <c:v>0.87682786976718374</c:v>
                </c:pt>
                <c:pt idx="36">
                  <c:v>0.87682786976718374</c:v>
                </c:pt>
                <c:pt idx="37">
                  <c:v>0.86301955685746434</c:v>
                </c:pt>
                <c:pt idx="38">
                  <c:v>0.86301955685746434</c:v>
                </c:pt>
                <c:pt idx="39">
                  <c:v>0.85611540040260459</c:v>
                </c:pt>
                <c:pt idx="40">
                  <c:v>0.85611540040260459</c:v>
                </c:pt>
                <c:pt idx="41">
                  <c:v>0.84921124394774483</c:v>
                </c:pt>
                <c:pt idx="42">
                  <c:v>0.84921124394774483</c:v>
                </c:pt>
                <c:pt idx="43">
                  <c:v>0.83885500926545531</c:v>
                </c:pt>
                <c:pt idx="44">
                  <c:v>0.83885500926545531</c:v>
                </c:pt>
                <c:pt idx="45">
                  <c:v>0.83540293103802543</c:v>
                </c:pt>
                <c:pt idx="46">
                  <c:v>0.83540293103802543</c:v>
                </c:pt>
                <c:pt idx="47">
                  <c:v>0.83195085281059555</c:v>
                </c:pt>
                <c:pt idx="48">
                  <c:v>0.83195085281059555</c:v>
                </c:pt>
                <c:pt idx="49">
                  <c:v>0.8250466963557358</c:v>
                </c:pt>
                <c:pt idx="50">
                  <c:v>0.8250466963557358</c:v>
                </c:pt>
                <c:pt idx="51">
                  <c:v>0.82159461812830592</c:v>
                </c:pt>
                <c:pt idx="52">
                  <c:v>0.82159461812830592</c:v>
                </c:pt>
                <c:pt idx="53">
                  <c:v>0.81814253990087604</c:v>
                </c:pt>
                <c:pt idx="54">
                  <c:v>0.81814253990087604</c:v>
                </c:pt>
                <c:pt idx="55">
                  <c:v>0.81469046167344616</c:v>
                </c:pt>
                <c:pt idx="56">
                  <c:v>0.81469046167344616</c:v>
                </c:pt>
                <c:pt idx="57">
                  <c:v>0.81123838344601629</c:v>
                </c:pt>
                <c:pt idx="58">
                  <c:v>0.81123838344601629</c:v>
                </c:pt>
                <c:pt idx="59">
                  <c:v>0.80778630521858641</c:v>
                </c:pt>
                <c:pt idx="60">
                  <c:v>0.80778630521858641</c:v>
                </c:pt>
                <c:pt idx="61">
                  <c:v>0.80085251719095907</c:v>
                </c:pt>
                <c:pt idx="62">
                  <c:v>0.80085251719095907</c:v>
                </c:pt>
                <c:pt idx="63">
                  <c:v>0.79738562317714534</c:v>
                </c:pt>
                <c:pt idx="64">
                  <c:v>0.79738562317714534</c:v>
                </c:pt>
                <c:pt idx="65">
                  <c:v>0.79391872916333162</c:v>
                </c:pt>
                <c:pt idx="66">
                  <c:v>0.79391872916333162</c:v>
                </c:pt>
                <c:pt idx="67">
                  <c:v>0.79043662947401871</c:v>
                </c:pt>
                <c:pt idx="68">
                  <c:v>0.79043662947401871</c:v>
                </c:pt>
                <c:pt idx="69">
                  <c:v>0.78695452978470581</c:v>
                </c:pt>
                <c:pt idx="70">
                  <c:v>0.78695452978470581</c:v>
                </c:pt>
                <c:pt idx="71">
                  <c:v>0.77995937840884177</c:v>
                </c:pt>
                <c:pt idx="72">
                  <c:v>0.77995937840884177</c:v>
                </c:pt>
                <c:pt idx="73">
                  <c:v>0.77995937840884177</c:v>
                </c:pt>
                <c:pt idx="74">
                  <c:v>0.77995937840884177</c:v>
                </c:pt>
                <c:pt idx="75">
                  <c:v>0.76927500336214527</c:v>
                </c:pt>
                <c:pt idx="76">
                  <c:v>0.76927500336214527</c:v>
                </c:pt>
                <c:pt idx="77">
                  <c:v>0.76927500336214527</c:v>
                </c:pt>
                <c:pt idx="78">
                  <c:v>0.76566338362805064</c:v>
                </c:pt>
                <c:pt idx="79">
                  <c:v>0.76566338362805064</c:v>
                </c:pt>
                <c:pt idx="80">
                  <c:v>0.76566338362805064</c:v>
                </c:pt>
                <c:pt idx="81">
                  <c:v>0.75462016174879987</c:v>
                </c:pt>
                <c:pt idx="82">
                  <c:v>0.75462016174879987</c:v>
                </c:pt>
                <c:pt idx="83">
                  <c:v>0.75092104330885479</c:v>
                </c:pt>
                <c:pt idx="84">
                  <c:v>0.75092104330885479</c:v>
                </c:pt>
                <c:pt idx="85">
                  <c:v>0.74718511772025353</c:v>
                </c:pt>
                <c:pt idx="86">
                  <c:v>0.74718511772025353</c:v>
                </c:pt>
                <c:pt idx="87">
                  <c:v>0.74718511772025353</c:v>
                </c:pt>
                <c:pt idx="88">
                  <c:v>0.7433336480412831</c:v>
                </c:pt>
                <c:pt idx="89">
                  <c:v>0.7433336480412831</c:v>
                </c:pt>
                <c:pt idx="90">
                  <c:v>0.7433336480412831</c:v>
                </c:pt>
                <c:pt idx="91">
                  <c:v>0.7433336480412831</c:v>
                </c:pt>
                <c:pt idx="92">
                  <c:v>0.7433336480412831</c:v>
                </c:pt>
                <c:pt idx="93">
                  <c:v>0.7433336480412831</c:v>
                </c:pt>
                <c:pt idx="94">
                  <c:v>0.73903692175202718</c:v>
                </c:pt>
                <c:pt idx="95">
                  <c:v>0.73903692175202718</c:v>
                </c:pt>
                <c:pt idx="96">
                  <c:v>0.73466392221503296</c:v>
                </c:pt>
                <c:pt idx="97">
                  <c:v>0.73466392221503296</c:v>
                </c:pt>
                <c:pt idx="98">
                  <c:v>0.73466392221503296</c:v>
                </c:pt>
                <c:pt idx="99">
                  <c:v>0.73466392221503296</c:v>
                </c:pt>
                <c:pt idx="100">
                  <c:v>0.73466392221503296</c:v>
                </c:pt>
                <c:pt idx="101">
                  <c:v>0.73466392221503296</c:v>
                </c:pt>
                <c:pt idx="102">
                  <c:v>0.72973329186459646</c:v>
                </c:pt>
                <c:pt idx="103">
                  <c:v>0.72973329186459646</c:v>
                </c:pt>
                <c:pt idx="104">
                  <c:v>0.72973329186459646</c:v>
                </c:pt>
                <c:pt idx="105">
                  <c:v>0.72973329186459646</c:v>
                </c:pt>
                <c:pt idx="106">
                  <c:v>0.72973329186459646</c:v>
                </c:pt>
                <c:pt idx="107">
                  <c:v>0.72973329186459646</c:v>
                </c:pt>
                <c:pt idx="108">
                  <c:v>0.72973329186459646</c:v>
                </c:pt>
                <c:pt idx="109">
                  <c:v>0.72973329186459646</c:v>
                </c:pt>
                <c:pt idx="110">
                  <c:v>0.72973329186459646</c:v>
                </c:pt>
                <c:pt idx="111">
                  <c:v>0.72420500935047072</c:v>
                </c:pt>
                <c:pt idx="112">
                  <c:v>0.72420500935047072</c:v>
                </c:pt>
                <c:pt idx="113">
                  <c:v>0.72420500935047072</c:v>
                </c:pt>
                <c:pt idx="114">
                  <c:v>0.72420500935047072</c:v>
                </c:pt>
                <c:pt idx="115">
                  <c:v>0.72420500935047072</c:v>
                </c:pt>
                <c:pt idx="116">
                  <c:v>0.72420500935047072</c:v>
                </c:pt>
                <c:pt idx="117">
                  <c:v>0.72420500935047072</c:v>
                </c:pt>
                <c:pt idx="118">
                  <c:v>0.7180676787627549</c:v>
                </c:pt>
                <c:pt idx="119">
                  <c:v>0.7180676787627549</c:v>
                </c:pt>
                <c:pt idx="120">
                  <c:v>0.7180676787627549</c:v>
                </c:pt>
                <c:pt idx="121">
                  <c:v>0.7180676787627549</c:v>
                </c:pt>
                <c:pt idx="122">
                  <c:v>0.7180676787627549</c:v>
                </c:pt>
                <c:pt idx="123">
                  <c:v>0.7180676787627549</c:v>
                </c:pt>
                <c:pt idx="124">
                  <c:v>0.7180676787627549</c:v>
                </c:pt>
                <c:pt idx="125">
                  <c:v>0.7180676787627549</c:v>
                </c:pt>
                <c:pt idx="126">
                  <c:v>0.7180676787627549</c:v>
                </c:pt>
                <c:pt idx="127">
                  <c:v>0.7180676787627549</c:v>
                </c:pt>
                <c:pt idx="128">
                  <c:v>0.7180676787627549</c:v>
                </c:pt>
                <c:pt idx="129">
                  <c:v>0.7180676787627549</c:v>
                </c:pt>
                <c:pt idx="130">
                  <c:v>0.7180676787627549</c:v>
                </c:pt>
                <c:pt idx="131">
                  <c:v>0.7180676787627549</c:v>
                </c:pt>
                <c:pt idx="132">
                  <c:v>0.7180676787627549</c:v>
                </c:pt>
                <c:pt idx="133">
                  <c:v>0.7180676787627549</c:v>
                </c:pt>
                <c:pt idx="134">
                  <c:v>0.7180676787627549</c:v>
                </c:pt>
                <c:pt idx="135">
                  <c:v>0.7180676787627549</c:v>
                </c:pt>
                <c:pt idx="136">
                  <c:v>0.70702048370486636</c:v>
                </c:pt>
                <c:pt idx="137">
                  <c:v>0.70702048370486636</c:v>
                </c:pt>
                <c:pt idx="138">
                  <c:v>0.70702048370486636</c:v>
                </c:pt>
                <c:pt idx="139">
                  <c:v>0.70702048370486636</c:v>
                </c:pt>
                <c:pt idx="140">
                  <c:v>0.70702048370486636</c:v>
                </c:pt>
                <c:pt idx="141">
                  <c:v>0.70702048370486636</c:v>
                </c:pt>
                <c:pt idx="142">
                  <c:v>0.70702048370486636</c:v>
                </c:pt>
                <c:pt idx="143">
                  <c:v>0.70702048370486636</c:v>
                </c:pt>
                <c:pt idx="144">
                  <c:v>0.70702048370486636</c:v>
                </c:pt>
                <c:pt idx="145">
                  <c:v>0.70702048370486636</c:v>
                </c:pt>
                <c:pt idx="146">
                  <c:v>0.70702048370486636</c:v>
                </c:pt>
                <c:pt idx="147">
                  <c:v>0.70702048370486636</c:v>
                </c:pt>
                <c:pt idx="148">
                  <c:v>0.70702048370486636</c:v>
                </c:pt>
                <c:pt idx="149">
                  <c:v>0.70702048370486636</c:v>
                </c:pt>
                <c:pt idx="150">
                  <c:v>0.70702048370486636</c:v>
                </c:pt>
                <c:pt idx="151">
                  <c:v>0.70702048370486636</c:v>
                </c:pt>
                <c:pt idx="152">
                  <c:v>0.70702048370486636</c:v>
                </c:pt>
                <c:pt idx="153">
                  <c:v>0.70702048370486636</c:v>
                </c:pt>
                <c:pt idx="154">
                  <c:v>0.70702048370486636</c:v>
                </c:pt>
                <c:pt idx="155">
                  <c:v>0.70702048370486636</c:v>
                </c:pt>
                <c:pt idx="156">
                  <c:v>0.70702048370486636</c:v>
                </c:pt>
                <c:pt idx="157">
                  <c:v>0.70702048370486636</c:v>
                </c:pt>
                <c:pt idx="158">
                  <c:v>0.70702048370486636</c:v>
                </c:pt>
                <c:pt idx="159">
                  <c:v>0.70702048370486636</c:v>
                </c:pt>
                <c:pt idx="160">
                  <c:v>0.70702048370486636</c:v>
                </c:pt>
                <c:pt idx="161">
                  <c:v>0.7070204837048663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DB3-4DB1-AD20-8EC3C7C9E2A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9291008"/>
        <c:axId val="89309568"/>
      </c:scatterChart>
      <c:valAx>
        <c:axId val="89291008"/>
        <c:scaling>
          <c:orientation val="minMax"/>
          <c:max val="12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 dirty="0" smtClean="0"/>
                  <a:t>Years</a:t>
                </a:r>
                <a:endParaRPr lang="en-US" sz="800" dirty="0"/>
              </a:p>
            </c:rich>
          </c:tx>
          <c:layout>
            <c:manualLayout>
              <c:xMode val="edge"/>
              <c:yMode val="edge"/>
              <c:x val="0.47563278806924614"/>
              <c:y val="0.89651392157020715"/>
            </c:manualLayout>
          </c:layout>
          <c:overlay val="0"/>
          <c:spPr>
            <a:noFill/>
            <a:ln w="25400">
              <a:noFill/>
            </a:ln>
            <a:effectLst/>
          </c:spPr>
        </c:title>
        <c:numFmt formatCode="General" sourceLinked="1"/>
        <c:majorTickMark val="out"/>
        <c:minorTickMark val="out"/>
        <c:tickLblPos val="nextTo"/>
        <c:spPr>
          <a:ln w="1905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/>
            </a:pPr>
            <a:endParaRPr lang="en-US"/>
          </a:p>
        </c:txPr>
        <c:crossAx val="89309568"/>
        <c:crosses val="autoZero"/>
        <c:crossBetween val="midCat"/>
        <c:majorUnit val="2"/>
        <c:minorUnit val="1"/>
      </c:valAx>
      <c:valAx>
        <c:axId val="89309568"/>
        <c:scaling>
          <c:orientation val="minMax"/>
          <c:max val="1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 dirty="0" smtClean="0"/>
                  <a:t>Metastasis</a:t>
                </a:r>
                <a:endParaRPr lang="en-US" sz="800" dirty="0"/>
              </a:p>
            </c:rich>
          </c:tx>
          <c:layout>
            <c:manualLayout>
              <c:xMode val="edge"/>
              <c:yMode val="edge"/>
              <c:x val="0"/>
              <c:y val="0.25340387139107612"/>
            </c:manualLayout>
          </c:layout>
          <c:overlay val="0"/>
          <c:spPr>
            <a:noFill/>
            <a:ln w="25400">
              <a:noFill/>
            </a:ln>
            <a:effectLst/>
          </c:spPr>
        </c:title>
        <c:numFmt formatCode="General" sourceLinked="1"/>
        <c:majorTickMark val="out"/>
        <c:minorTickMark val="out"/>
        <c:tickLblPos val="nextTo"/>
        <c:spPr>
          <a:ln w="19050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/>
            </a:pPr>
            <a:endParaRPr lang="en-US"/>
          </a:p>
        </c:txPr>
        <c:crossAx val="89291008"/>
        <c:crosses val="autoZero"/>
        <c:crossBetween val="midCat"/>
        <c:majorUnit val="0.2"/>
        <c:minorUnit val="0.1"/>
      </c:valAx>
      <c:spPr>
        <a:noFill/>
        <a:ln w="19050">
          <a:solidFill>
            <a:srgbClr val="000000"/>
          </a:solidFill>
          <a:prstDash val="solid"/>
        </a:ln>
      </c:spPr>
    </c:plotArea>
    <c:legend>
      <c:legendPos val="r"/>
      <c:layout>
        <c:manualLayout>
          <c:xMode val="edge"/>
          <c:yMode val="edge"/>
          <c:x val="0.16804593175853019"/>
          <c:y val="0.62922134733158352"/>
          <c:w val="0.31584426946631672"/>
          <c:h val="0.14093121172353454"/>
        </c:manualLayout>
      </c:layout>
      <c:overlay val="0"/>
      <c:spPr>
        <a:noFill/>
        <a:ln w="3175">
          <a:noFill/>
          <a:prstDash val="solid"/>
        </a:ln>
      </c:spPr>
      <c:txPr>
        <a:bodyPr/>
        <a:lstStyle/>
        <a:p>
          <a:pPr>
            <a:defRPr sz="800" b="0"/>
          </a:pPr>
          <a:endParaRPr lang="en-US"/>
        </a:p>
      </c:txPr>
    </c:legend>
    <c:plotVisOnly val="0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12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8612708421820714"/>
          <c:y val="0.16666719856515064"/>
          <c:w val="0.72425743203261417"/>
          <c:h val="0.6143810456911436"/>
        </c:manualLayout>
      </c:layout>
      <c:scatterChart>
        <c:scatterStyle val="lineMarker"/>
        <c:varyColors val="0"/>
        <c:ser>
          <c:idx val="1"/>
          <c:order val="0"/>
          <c:tx>
            <c:v>low</c:v>
          </c:tx>
          <c:spPr>
            <a:ln w="22225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Survival!$B$121:$B$225</c:f>
              <c:numCache>
                <c:formatCode>General</c:formatCode>
                <c:ptCount val="105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3</c:v>
                </c:pt>
                <c:pt idx="5">
                  <c:v>3</c:v>
                </c:pt>
                <c:pt idx="6">
                  <c:v>4</c:v>
                </c:pt>
                <c:pt idx="7">
                  <c:v>4</c:v>
                </c:pt>
                <c:pt idx="8">
                  <c:v>5</c:v>
                </c:pt>
                <c:pt idx="9">
                  <c:v>5</c:v>
                </c:pt>
                <c:pt idx="10">
                  <c:v>6</c:v>
                </c:pt>
                <c:pt idx="11">
                  <c:v>6</c:v>
                </c:pt>
                <c:pt idx="12">
                  <c:v>7</c:v>
                </c:pt>
                <c:pt idx="13">
                  <c:v>7</c:v>
                </c:pt>
                <c:pt idx="14">
                  <c:v>8</c:v>
                </c:pt>
                <c:pt idx="15">
                  <c:v>8</c:v>
                </c:pt>
                <c:pt idx="16">
                  <c:v>9</c:v>
                </c:pt>
                <c:pt idx="17">
                  <c:v>9</c:v>
                </c:pt>
                <c:pt idx="18">
                  <c:v>10</c:v>
                </c:pt>
                <c:pt idx="19">
                  <c:v>10</c:v>
                </c:pt>
                <c:pt idx="20">
                  <c:v>11</c:v>
                </c:pt>
                <c:pt idx="21">
                  <c:v>11</c:v>
                </c:pt>
                <c:pt idx="22">
                  <c:v>12</c:v>
                </c:pt>
                <c:pt idx="23">
                  <c:v>12</c:v>
                </c:pt>
                <c:pt idx="24">
                  <c:v>13</c:v>
                </c:pt>
                <c:pt idx="25">
                  <c:v>13</c:v>
                </c:pt>
                <c:pt idx="26">
                  <c:v>14</c:v>
                </c:pt>
                <c:pt idx="27">
                  <c:v>14</c:v>
                </c:pt>
                <c:pt idx="28">
                  <c:v>15</c:v>
                </c:pt>
                <c:pt idx="29">
                  <c:v>15</c:v>
                </c:pt>
                <c:pt idx="30">
                  <c:v>16</c:v>
                </c:pt>
                <c:pt idx="31">
                  <c:v>16</c:v>
                </c:pt>
                <c:pt idx="32">
                  <c:v>17</c:v>
                </c:pt>
                <c:pt idx="33">
                  <c:v>17</c:v>
                </c:pt>
                <c:pt idx="34">
                  <c:v>18</c:v>
                </c:pt>
                <c:pt idx="35">
                  <c:v>18</c:v>
                </c:pt>
                <c:pt idx="36">
                  <c:v>19</c:v>
                </c:pt>
                <c:pt idx="37">
                  <c:v>19</c:v>
                </c:pt>
                <c:pt idx="38">
                  <c:v>20</c:v>
                </c:pt>
                <c:pt idx="39">
                  <c:v>20</c:v>
                </c:pt>
                <c:pt idx="40">
                  <c:v>21</c:v>
                </c:pt>
                <c:pt idx="41">
                  <c:v>21</c:v>
                </c:pt>
                <c:pt idx="42">
                  <c:v>22</c:v>
                </c:pt>
                <c:pt idx="43">
                  <c:v>22</c:v>
                </c:pt>
                <c:pt idx="44">
                  <c:v>23</c:v>
                </c:pt>
                <c:pt idx="45">
                  <c:v>23</c:v>
                </c:pt>
                <c:pt idx="46">
                  <c:v>24</c:v>
                </c:pt>
                <c:pt idx="47">
                  <c:v>25</c:v>
                </c:pt>
                <c:pt idx="48">
                  <c:v>25</c:v>
                </c:pt>
                <c:pt idx="49">
                  <c:v>27</c:v>
                </c:pt>
                <c:pt idx="50">
                  <c:v>27</c:v>
                </c:pt>
                <c:pt idx="51">
                  <c:v>28</c:v>
                </c:pt>
                <c:pt idx="52">
                  <c:v>28</c:v>
                </c:pt>
                <c:pt idx="53">
                  <c:v>29</c:v>
                </c:pt>
                <c:pt idx="54">
                  <c:v>29</c:v>
                </c:pt>
                <c:pt idx="55">
                  <c:v>30</c:v>
                </c:pt>
                <c:pt idx="56">
                  <c:v>30</c:v>
                </c:pt>
                <c:pt idx="57">
                  <c:v>31</c:v>
                </c:pt>
                <c:pt idx="58">
                  <c:v>31</c:v>
                </c:pt>
                <c:pt idx="59">
                  <c:v>32</c:v>
                </c:pt>
                <c:pt idx="60">
                  <c:v>32</c:v>
                </c:pt>
                <c:pt idx="61">
                  <c:v>33</c:v>
                </c:pt>
                <c:pt idx="62">
                  <c:v>33</c:v>
                </c:pt>
                <c:pt idx="63">
                  <c:v>34</c:v>
                </c:pt>
                <c:pt idx="64">
                  <c:v>34</c:v>
                </c:pt>
                <c:pt idx="65">
                  <c:v>35</c:v>
                </c:pt>
                <c:pt idx="66">
                  <c:v>35</c:v>
                </c:pt>
                <c:pt idx="67">
                  <c:v>36</c:v>
                </c:pt>
                <c:pt idx="68">
                  <c:v>36</c:v>
                </c:pt>
                <c:pt idx="69">
                  <c:v>37</c:v>
                </c:pt>
                <c:pt idx="70">
                  <c:v>38</c:v>
                </c:pt>
                <c:pt idx="71">
                  <c:v>38</c:v>
                </c:pt>
                <c:pt idx="72">
                  <c:v>39</c:v>
                </c:pt>
                <c:pt idx="73">
                  <c:v>40</c:v>
                </c:pt>
                <c:pt idx="74">
                  <c:v>40</c:v>
                </c:pt>
                <c:pt idx="75">
                  <c:v>42</c:v>
                </c:pt>
                <c:pt idx="76">
                  <c:v>42</c:v>
                </c:pt>
                <c:pt idx="77">
                  <c:v>43</c:v>
                </c:pt>
                <c:pt idx="78">
                  <c:v>46</c:v>
                </c:pt>
                <c:pt idx="79">
                  <c:v>46</c:v>
                </c:pt>
                <c:pt idx="80">
                  <c:v>47</c:v>
                </c:pt>
                <c:pt idx="81">
                  <c:v>48</c:v>
                </c:pt>
                <c:pt idx="82">
                  <c:v>48</c:v>
                </c:pt>
                <c:pt idx="83">
                  <c:v>49</c:v>
                </c:pt>
                <c:pt idx="84">
                  <c:v>49</c:v>
                </c:pt>
                <c:pt idx="85">
                  <c:v>53</c:v>
                </c:pt>
                <c:pt idx="86">
                  <c:v>53</c:v>
                </c:pt>
                <c:pt idx="87">
                  <c:v>55</c:v>
                </c:pt>
                <c:pt idx="88">
                  <c:v>58</c:v>
                </c:pt>
                <c:pt idx="89">
                  <c:v>60</c:v>
                </c:pt>
                <c:pt idx="90">
                  <c:v>60</c:v>
                </c:pt>
                <c:pt idx="91">
                  <c:v>61</c:v>
                </c:pt>
                <c:pt idx="92">
                  <c:v>61</c:v>
                </c:pt>
                <c:pt idx="93">
                  <c:v>64</c:v>
                </c:pt>
                <c:pt idx="94">
                  <c:v>73</c:v>
                </c:pt>
                <c:pt idx="95">
                  <c:v>83</c:v>
                </c:pt>
                <c:pt idx="96">
                  <c:v>83</c:v>
                </c:pt>
                <c:pt idx="97">
                  <c:v>85</c:v>
                </c:pt>
                <c:pt idx="98">
                  <c:v>97</c:v>
                </c:pt>
                <c:pt idx="99">
                  <c:v>97</c:v>
                </c:pt>
                <c:pt idx="100">
                  <c:v>99</c:v>
                </c:pt>
                <c:pt idx="101">
                  <c:v>99</c:v>
                </c:pt>
                <c:pt idx="102">
                  <c:v>107</c:v>
                </c:pt>
                <c:pt idx="103">
                  <c:v>107</c:v>
                </c:pt>
                <c:pt idx="104">
                  <c:v>115</c:v>
                </c:pt>
              </c:numCache>
            </c:numRef>
          </c:xVal>
          <c:yVal>
            <c:numRef>
              <c:f>Survival!$C$121:$C$225</c:f>
              <c:numCache>
                <c:formatCode>General</c:formatCode>
                <c:ptCount val="105"/>
                <c:pt idx="0">
                  <c:v>1</c:v>
                </c:pt>
                <c:pt idx="1">
                  <c:v>1</c:v>
                </c:pt>
                <c:pt idx="2">
                  <c:v>0.96644295302013428</c:v>
                </c:pt>
                <c:pt idx="3">
                  <c:v>0.96644295302013428</c:v>
                </c:pt>
                <c:pt idx="4">
                  <c:v>0.96644295302013428</c:v>
                </c:pt>
                <c:pt idx="5">
                  <c:v>0.95963701673126012</c:v>
                </c:pt>
                <c:pt idx="6">
                  <c:v>0.95963701673126012</c:v>
                </c:pt>
                <c:pt idx="7">
                  <c:v>0.93921920786463753</c:v>
                </c:pt>
                <c:pt idx="8">
                  <c:v>0.93921920786463753</c:v>
                </c:pt>
                <c:pt idx="9">
                  <c:v>0.93236359320869122</c:v>
                </c:pt>
                <c:pt idx="10">
                  <c:v>0.93236359320869122</c:v>
                </c:pt>
                <c:pt idx="11">
                  <c:v>0.91865236389679872</c:v>
                </c:pt>
                <c:pt idx="12">
                  <c:v>0.91865236389679872</c:v>
                </c:pt>
                <c:pt idx="13">
                  <c:v>0.91169287629151996</c:v>
                </c:pt>
                <c:pt idx="14">
                  <c:v>0.91169287629151996</c:v>
                </c:pt>
                <c:pt idx="15">
                  <c:v>0.90467985416620056</c:v>
                </c:pt>
                <c:pt idx="16">
                  <c:v>0.90467985416620056</c:v>
                </c:pt>
                <c:pt idx="17">
                  <c:v>0.89043292732893753</c:v>
                </c:pt>
                <c:pt idx="18">
                  <c:v>0.89043292732893753</c:v>
                </c:pt>
                <c:pt idx="19">
                  <c:v>0.88330946391030607</c:v>
                </c:pt>
                <c:pt idx="20">
                  <c:v>0.88330946391030607</c:v>
                </c:pt>
                <c:pt idx="21">
                  <c:v>0.86176533064420102</c:v>
                </c:pt>
                <c:pt idx="22">
                  <c:v>0.86176533064420102</c:v>
                </c:pt>
                <c:pt idx="23">
                  <c:v>0.84715913859938408</c:v>
                </c:pt>
                <c:pt idx="24">
                  <c:v>0.84715913859938408</c:v>
                </c:pt>
                <c:pt idx="25">
                  <c:v>0.82505933498374795</c:v>
                </c:pt>
                <c:pt idx="26">
                  <c:v>0.82505933498374795</c:v>
                </c:pt>
                <c:pt idx="27">
                  <c:v>0.78046153309273458</c:v>
                </c:pt>
                <c:pt idx="28">
                  <c:v>0.78046153309273458</c:v>
                </c:pt>
                <c:pt idx="29">
                  <c:v>0.7432966981835567</c:v>
                </c:pt>
                <c:pt idx="30">
                  <c:v>0.7432966981835567</c:v>
                </c:pt>
                <c:pt idx="31">
                  <c:v>0.72054271762691724</c:v>
                </c:pt>
                <c:pt idx="32">
                  <c:v>0.72054271762691724</c:v>
                </c:pt>
                <c:pt idx="33">
                  <c:v>0.70487874550459295</c:v>
                </c:pt>
                <c:pt idx="34">
                  <c:v>0.70487874550459295</c:v>
                </c:pt>
                <c:pt idx="35">
                  <c:v>0.68903877369550093</c:v>
                </c:pt>
                <c:pt idx="36">
                  <c:v>0.68903877369550093</c:v>
                </c:pt>
                <c:pt idx="37">
                  <c:v>0.68073710172326596</c:v>
                </c:pt>
                <c:pt idx="38">
                  <c:v>0.68073710172326596</c:v>
                </c:pt>
                <c:pt idx="39">
                  <c:v>0.65520946040864347</c:v>
                </c:pt>
                <c:pt idx="40">
                  <c:v>0.65520946040864347</c:v>
                </c:pt>
                <c:pt idx="41">
                  <c:v>0.62968181909402099</c:v>
                </c:pt>
                <c:pt idx="42">
                  <c:v>0.62968181909402099</c:v>
                </c:pt>
                <c:pt idx="43">
                  <c:v>0.6211726053224802</c:v>
                </c:pt>
                <c:pt idx="44">
                  <c:v>0.6211726053224802</c:v>
                </c:pt>
                <c:pt idx="45">
                  <c:v>0.57803561884175236</c:v>
                </c:pt>
                <c:pt idx="46">
                  <c:v>0.57803561884175236</c:v>
                </c:pt>
                <c:pt idx="47">
                  <c:v>0.57803561884175236</c:v>
                </c:pt>
                <c:pt idx="48">
                  <c:v>0.54190839266414281</c:v>
                </c:pt>
                <c:pt idx="49">
                  <c:v>0.54190839266414281</c:v>
                </c:pt>
                <c:pt idx="50">
                  <c:v>0.52353861664162948</c:v>
                </c:pt>
                <c:pt idx="51">
                  <c:v>0.52353861664162948</c:v>
                </c:pt>
                <c:pt idx="52">
                  <c:v>0.51418971277302894</c:v>
                </c:pt>
                <c:pt idx="53">
                  <c:v>0.51418971277302894</c:v>
                </c:pt>
                <c:pt idx="54">
                  <c:v>0.48562361761897177</c:v>
                </c:pt>
                <c:pt idx="55">
                  <c:v>0.48562361761897177</c:v>
                </c:pt>
                <c:pt idx="56">
                  <c:v>0.47550645891857651</c:v>
                </c:pt>
                <c:pt idx="57">
                  <c:v>0.47550645891857651</c:v>
                </c:pt>
                <c:pt idx="58">
                  <c:v>0.46516936198556397</c:v>
                </c:pt>
                <c:pt idx="59">
                  <c:v>0.46516936198556397</c:v>
                </c:pt>
                <c:pt idx="60">
                  <c:v>0.45483226505255142</c:v>
                </c:pt>
                <c:pt idx="61">
                  <c:v>0.45483226505255142</c:v>
                </c:pt>
                <c:pt idx="62">
                  <c:v>0.43367727598033973</c:v>
                </c:pt>
                <c:pt idx="63">
                  <c:v>0.43367727598033973</c:v>
                </c:pt>
                <c:pt idx="64">
                  <c:v>0.42309978144423388</c:v>
                </c:pt>
                <c:pt idx="65">
                  <c:v>0.42309978144423388</c:v>
                </c:pt>
                <c:pt idx="66">
                  <c:v>0.38078980329981049</c:v>
                </c:pt>
                <c:pt idx="67">
                  <c:v>0.38078980329981049</c:v>
                </c:pt>
                <c:pt idx="68">
                  <c:v>0.3596348142275988</c:v>
                </c:pt>
                <c:pt idx="69">
                  <c:v>0.3596348142275988</c:v>
                </c:pt>
                <c:pt idx="70">
                  <c:v>0.3596348142275988</c:v>
                </c:pt>
                <c:pt idx="71">
                  <c:v>0.3259190503937614</c:v>
                </c:pt>
                <c:pt idx="72">
                  <c:v>0.3259190503937614</c:v>
                </c:pt>
                <c:pt idx="73">
                  <c:v>0.3259190503937614</c:v>
                </c:pt>
                <c:pt idx="74">
                  <c:v>0.31384797445325174</c:v>
                </c:pt>
                <c:pt idx="75">
                  <c:v>0.31384797445325174</c:v>
                </c:pt>
                <c:pt idx="76">
                  <c:v>0.28970582257223237</c:v>
                </c:pt>
                <c:pt idx="77">
                  <c:v>0.28970582257223237</c:v>
                </c:pt>
                <c:pt idx="78">
                  <c:v>0.28970582257223237</c:v>
                </c:pt>
                <c:pt idx="79">
                  <c:v>0.27591030721164989</c:v>
                </c:pt>
                <c:pt idx="80">
                  <c:v>0.27591030721164989</c:v>
                </c:pt>
                <c:pt idx="81">
                  <c:v>0.27591030721164989</c:v>
                </c:pt>
                <c:pt idx="82">
                  <c:v>0.24686711697884464</c:v>
                </c:pt>
                <c:pt idx="83">
                  <c:v>0.24686711697884464</c:v>
                </c:pt>
                <c:pt idx="84">
                  <c:v>0.23234552186244201</c:v>
                </c:pt>
                <c:pt idx="85">
                  <c:v>0.23234552186244201</c:v>
                </c:pt>
                <c:pt idx="86">
                  <c:v>0.21782392674603937</c:v>
                </c:pt>
                <c:pt idx="87">
                  <c:v>0.21782392674603937</c:v>
                </c:pt>
                <c:pt idx="88">
                  <c:v>0.21782392674603937</c:v>
                </c:pt>
                <c:pt idx="89">
                  <c:v>0.21782392674603937</c:v>
                </c:pt>
                <c:pt idx="90">
                  <c:v>0.18151993895503282</c:v>
                </c:pt>
                <c:pt idx="91">
                  <c:v>0.18151993895503282</c:v>
                </c:pt>
                <c:pt idx="92">
                  <c:v>0.14521595116402625</c:v>
                </c:pt>
                <c:pt idx="93">
                  <c:v>0.14521595116402625</c:v>
                </c:pt>
                <c:pt idx="94">
                  <c:v>0.14521595116402625</c:v>
                </c:pt>
                <c:pt idx="95">
                  <c:v>0.14521595116402625</c:v>
                </c:pt>
                <c:pt idx="96">
                  <c:v>0.12101329263668854</c:v>
                </c:pt>
                <c:pt idx="97">
                  <c:v>0.12101329263668854</c:v>
                </c:pt>
                <c:pt idx="98">
                  <c:v>0.12101329263668854</c:v>
                </c:pt>
                <c:pt idx="99">
                  <c:v>9.0759969477516411E-2</c:v>
                </c:pt>
                <c:pt idx="100">
                  <c:v>9.0759969477516411E-2</c:v>
                </c:pt>
                <c:pt idx="101">
                  <c:v>6.0506646318344279E-2</c:v>
                </c:pt>
                <c:pt idx="102">
                  <c:v>6.0506646318344279E-2</c:v>
                </c:pt>
                <c:pt idx="103">
                  <c:v>3.0253323159172139E-2</c:v>
                </c:pt>
                <c:pt idx="104">
                  <c:v>3.0253323159172139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2E62-4439-9045-3197F420FD93}"/>
            </c:ext>
          </c:extLst>
        </c:ser>
        <c:ser>
          <c:idx val="2"/>
          <c:order val="1"/>
          <c:tx>
            <c:v>high</c:v>
          </c:tx>
          <c:spPr>
            <a:ln w="22225">
              <a:solidFill>
                <a:srgbClr val="FF0000"/>
              </a:solidFill>
              <a:prstDash val="solid"/>
            </a:ln>
          </c:spPr>
          <c:marker>
            <c:symbol val="none"/>
          </c:marker>
          <c:xVal>
            <c:numRef>
              <c:f>Survival!$B$226:$B$256</c:f>
              <c:numCache>
                <c:formatCode>General</c:formatCode>
                <c:ptCount val="3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3</c:v>
                </c:pt>
                <c:pt idx="4">
                  <c:v>3</c:v>
                </c:pt>
                <c:pt idx="5">
                  <c:v>6</c:v>
                </c:pt>
                <c:pt idx="6">
                  <c:v>6</c:v>
                </c:pt>
                <c:pt idx="7">
                  <c:v>7</c:v>
                </c:pt>
                <c:pt idx="8">
                  <c:v>9</c:v>
                </c:pt>
                <c:pt idx="9">
                  <c:v>9</c:v>
                </c:pt>
                <c:pt idx="10">
                  <c:v>17</c:v>
                </c:pt>
                <c:pt idx="11">
                  <c:v>22</c:v>
                </c:pt>
                <c:pt idx="12">
                  <c:v>22</c:v>
                </c:pt>
                <c:pt idx="13">
                  <c:v>24</c:v>
                </c:pt>
                <c:pt idx="14">
                  <c:v>24</c:v>
                </c:pt>
                <c:pt idx="15">
                  <c:v>25</c:v>
                </c:pt>
                <c:pt idx="16">
                  <c:v>25</c:v>
                </c:pt>
                <c:pt idx="17">
                  <c:v>30</c:v>
                </c:pt>
                <c:pt idx="18">
                  <c:v>30</c:v>
                </c:pt>
                <c:pt idx="19">
                  <c:v>38</c:v>
                </c:pt>
                <c:pt idx="20">
                  <c:v>38</c:v>
                </c:pt>
                <c:pt idx="21">
                  <c:v>40</c:v>
                </c:pt>
                <c:pt idx="22">
                  <c:v>40</c:v>
                </c:pt>
                <c:pt idx="23">
                  <c:v>42</c:v>
                </c:pt>
                <c:pt idx="24">
                  <c:v>42</c:v>
                </c:pt>
                <c:pt idx="25">
                  <c:v>44</c:v>
                </c:pt>
                <c:pt idx="26">
                  <c:v>44</c:v>
                </c:pt>
                <c:pt idx="27">
                  <c:v>50</c:v>
                </c:pt>
                <c:pt idx="28">
                  <c:v>50</c:v>
                </c:pt>
                <c:pt idx="29">
                  <c:v>73</c:v>
                </c:pt>
                <c:pt idx="30">
                  <c:v>73</c:v>
                </c:pt>
              </c:numCache>
            </c:numRef>
          </c:xVal>
          <c:yVal>
            <c:numRef>
              <c:f>Survival!$C$226:$C$256</c:f>
              <c:numCache>
                <c:formatCode>General</c:formatCode>
                <c:ptCount val="31"/>
                <c:pt idx="0">
                  <c:v>1</c:v>
                </c:pt>
                <c:pt idx="1">
                  <c:v>1</c:v>
                </c:pt>
                <c:pt idx="2">
                  <c:v>0.94117647058823528</c:v>
                </c:pt>
                <c:pt idx="3">
                  <c:v>0.94117647058823528</c:v>
                </c:pt>
                <c:pt idx="4">
                  <c:v>0.88235294117647056</c:v>
                </c:pt>
                <c:pt idx="5">
                  <c:v>0.88235294117647056</c:v>
                </c:pt>
                <c:pt idx="6">
                  <c:v>0.81932773109243695</c:v>
                </c:pt>
                <c:pt idx="7">
                  <c:v>0.81932773109243695</c:v>
                </c:pt>
                <c:pt idx="8">
                  <c:v>0.81932773109243695</c:v>
                </c:pt>
                <c:pt idx="9">
                  <c:v>0.75105042016806722</c:v>
                </c:pt>
                <c:pt idx="10">
                  <c:v>0.75105042016806722</c:v>
                </c:pt>
                <c:pt idx="11">
                  <c:v>0.75105042016806722</c:v>
                </c:pt>
                <c:pt idx="12">
                  <c:v>0.67594537815126055</c:v>
                </c:pt>
                <c:pt idx="13">
                  <c:v>0.67594537815126055</c:v>
                </c:pt>
                <c:pt idx="14">
                  <c:v>0.60084033613445387</c:v>
                </c:pt>
                <c:pt idx="15">
                  <c:v>0.60084033613445387</c:v>
                </c:pt>
                <c:pt idx="16">
                  <c:v>0.52573529411764719</c:v>
                </c:pt>
                <c:pt idx="17">
                  <c:v>0.52573529411764719</c:v>
                </c:pt>
                <c:pt idx="18">
                  <c:v>0.45063025210084046</c:v>
                </c:pt>
                <c:pt idx="19">
                  <c:v>0.45063025210084046</c:v>
                </c:pt>
                <c:pt idx="20">
                  <c:v>0.37552521008403372</c:v>
                </c:pt>
                <c:pt idx="21">
                  <c:v>0.37552521008403372</c:v>
                </c:pt>
                <c:pt idx="22">
                  <c:v>0.30042016806722699</c:v>
                </c:pt>
                <c:pt idx="23">
                  <c:v>0.30042016806722699</c:v>
                </c:pt>
                <c:pt idx="24">
                  <c:v>0.22531512605042026</c:v>
                </c:pt>
                <c:pt idx="25">
                  <c:v>0.22531512605042026</c:v>
                </c:pt>
                <c:pt idx="26">
                  <c:v>0.15021008403361349</c:v>
                </c:pt>
                <c:pt idx="27">
                  <c:v>0.15021008403361349</c:v>
                </c:pt>
                <c:pt idx="28">
                  <c:v>7.5105042016806747E-2</c:v>
                </c:pt>
                <c:pt idx="29">
                  <c:v>7.5105042016806747E-2</c:v>
                </c:pt>
                <c:pt idx="30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2E62-4439-9045-3197F420FD9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9393024"/>
        <c:axId val="89394560"/>
      </c:scatterChart>
      <c:valAx>
        <c:axId val="89393024"/>
        <c:scaling>
          <c:orientation val="minMax"/>
          <c:max val="100"/>
          <c:min val="0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2222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600" b="0"/>
            </a:pPr>
            <a:endParaRPr lang="en-US"/>
          </a:p>
        </c:txPr>
        <c:crossAx val="89394560"/>
        <c:crosses val="autoZero"/>
        <c:crossBetween val="midCat"/>
        <c:majorUnit val="25"/>
        <c:minorUnit val="10"/>
      </c:valAx>
      <c:valAx>
        <c:axId val="89394560"/>
        <c:scaling>
          <c:orientation val="minMax"/>
          <c:max val="1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800"/>
                </a:pPr>
                <a:r>
                  <a:rPr lang="en-US" sz="800" dirty="0" smtClean="0"/>
                  <a:t>Probability</a:t>
                </a:r>
                <a:endParaRPr lang="en-US" sz="800" dirty="0"/>
              </a:p>
            </c:rich>
          </c:tx>
          <c:layout>
            <c:manualLayout>
              <c:xMode val="edge"/>
              <c:yMode val="edge"/>
              <c:x val="0"/>
              <c:y val="0.27240980470661508"/>
            </c:manualLayout>
          </c:layout>
          <c:overlay val="0"/>
        </c:title>
        <c:numFmt formatCode="General" sourceLinked="1"/>
        <c:majorTickMark val="out"/>
        <c:minorTickMark val="out"/>
        <c:tickLblPos val="nextTo"/>
        <c:spPr>
          <a:ln w="22225">
            <a:solidFill>
              <a:srgbClr val="000000"/>
            </a:solidFill>
            <a:prstDash val="solid"/>
          </a:ln>
        </c:spPr>
        <c:txPr>
          <a:bodyPr rot="0" vert="horz"/>
          <a:lstStyle/>
          <a:p>
            <a:pPr>
              <a:defRPr sz="800" b="0"/>
            </a:pPr>
            <a:endParaRPr lang="en-US"/>
          </a:p>
        </c:txPr>
        <c:crossAx val="89393024"/>
        <c:crosses val="autoZero"/>
        <c:crossBetween val="midCat"/>
        <c:majorUnit val="0.2"/>
        <c:minorUnit val="0.1"/>
      </c:valAx>
      <c:spPr>
        <a:noFill/>
        <a:ln w="19050">
          <a:solidFill>
            <a:schemeClr val="tx1"/>
          </a:solidFill>
          <a:prstDash val="solid"/>
        </a:ln>
      </c:spPr>
    </c:plotArea>
    <c:legend>
      <c:legendPos val="r"/>
      <c:legendEntry>
        <c:idx val="0"/>
        <c:txPr>
          <a:bodyPr/>
          <a:lstStyle/>
          <a:p>
            <a:pPr>
              <a:defRPr sz="600" b="1"/>
            </a:pPr>
            <a:endParaRPr lang="en-US"/>
          </a:p>
        </c:txPr>
      </c:legendEntry>
      <c:legendEntry>
        <c:idx val="1"/>
        <c:txPr>
          <a:bodyPr/>
          <a:lstStyle/>
          <a:p>
            <a:pPr>
              <a:defRPr sz="600" b="1"/>
            </a:pPr>
            <a:endParaRPr lang="en-US"/>
          </a:p>
        </c:txPr>
      </c:legendEntry>
      <c:layout>
        <c:manualLayout>
          <c:xMode val="edge"/>
          <c:yMode val="edge"/>
          <c:x val="0.15367946194225721"/>
          <c:y val="0.65071553555805528"/>
          <c:w val="0.29200158573928259"/>
          <c:h val="0.12009787839020122"/>
        </c:manualLayout>
      </c:layout>
      <c:overlay val="0"/>
      <c:spPr>
        <a:noFill/>
        <a:ln w="3175">
          <a:noFill/>
          <a:prstDash val="solid"/>
        </a:ln>
      </c:spPr>
      <c:txPr>
        <a:bodyPr/>
        <a:lstStyle/>
        <a:p>
          <a:pPr>
            <a:defRPr sz="800" b="0"/>
          </a:pPr>
          <a:endParaRPr lang="en-US"/>
        </a:p>
      </c:txPr>
    </c:legend>
    <c:plotVisOnly val="0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1200" b="1" i="0" u="none" strike="noStrike" baseline="0">
          <a:solidFill>
            <a:srgbClr val="000000"/>
          </a:solidFill>
          <a:latin typeface="Arial"/>
          <a:ea typeface="Arial"/>
          <a:cs typeface="Arial"/>
        </a:defRPr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69546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6049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054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78122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6275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230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5260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7309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14472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70492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1650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A46B24-BED8-4430-9023-262445EE06CB}" type="datetimeFigureOut">
              <a:rPr lang="en-US" smtClean="0"/>
              <a:t>5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B40884-3962-47C0-B013-69EAFBA6BA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665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TextBox 12"/>
          <p:cNvSpPr txBox="1"/>
          <p:nvPr/>
        </p:nvSpPr>
        <p:spPr>
          <a:xfrm>
            <a:off x="1143895" y="700999"/>
            <a:ext cx="3276586" cy="330948"/>
          </a:xfrm>
          <a:prstGeom prst="rect">
            <a:avLst/>
          </a:prstGeom>
          <a:noFill/>
        </p:spPr>
        <p:txBody>
          <a:bodyPr wrap="none" lIns="85749" tIns="42874" rIns="85749" bIns="42874" rtlCol="0">
            <a:spAutoFit/>
          </a:bodyPr>
          <a:lstStyle/>
          <a:p>
            <a:r>
              <a:rPr lang="en-US" sz="1588" dirty="0">
                <a:latin typeface="Arial" panose="020B0604020202020204" pitchFamily="34" charset="0"/>
                <a:cs typeface="Arial" panose="020B0604020202020204" pitchFamily="34" charset="0"/>
              </a:rPr>
              <a:t>Seachrist, Darcie et al</a:t>
            </a:r>
            <a:r>
              <a:rPr lang="en-US" sz="1588">
                <a:latin typeface="Arial" panose="020B0604020202020204" pitchFamily="34" charset="0"/>
                <a:cs typeface="Arial" panose="020B0604020202020204" pitchFamily="34" charset="0"/>
              </a:rPr>
              <a:t>., </a:t>
            </a:r>
            <a:r>
              <a:rPr lang="en-US" sz="1588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588" dirty="0" smtClean="0">
                <a:latin typeface="Arial" panose="020B0604020202020204" pitchFamily="34" charset="0"/>
                <a:cs typeface="Arial" panose="020B0604020202020204" pitchFamily="34" charset="0"/>
              </a:rPr>
              <a:t>S5 </a:t>
            </a:r>
            <a:endParaRPr lang="en-US" sz="1588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958890" y="1858054"/>
            <a:ext cx="2204253" cy="1613647"/>
            <a:chOff x="2412336" y="1206940"/>
            <a:chExt cx="2204253" cy="1613647"/>
          </a:xfrm>
        </p:grpSpPr>
        <p:graphicFrame>
          <p:nvGraphicFramePr>
            <p:cNvPr id="2" name="Chart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08343304"/>
                </p:ext>
              </p:extLst>
            </p:nvPr>
          </p:nvGraphicFramePr>
          <p:xfrm>
            <a:off x="2412336" y="1206940"/>
            <a:ext cx="2204253" cy="161364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3" name="TextBox 2"/>
            <p:cNvSpPr txBox="1"/>
            <p:nvPr/>
          </p:nvSpPr>
          <p:spPr>
            <a:xfrm>
              <a:off x="3247879" y="1206940"/>
              <a:ext cx="577402" cy="2553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Curtis</a:t>
              </a: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3736750" y="2233083"/>
              <a:ext cx="657552" cy="228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82" dirty="0">
                  <a:latin typeface="Arial" panose="020B0604020202020204" pitchFamily="34" charset="0"/>
                  <a:cs typeface="Arial" panose="020B0604020202020204" pitchFamily="34" charset="0"/>
                </a:rPr>
                <a:t>p&lt;0.0002</a:t>
              </a: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3385430" y="1858054"/>
            <a:ext cx="2204253" cy="1613647"/>
            <a:chOff x="2326874" y="2892335"/>
            <a:chExt cx="2204253" cy="1613647"/>
          </a:xfrm>
        </p:grpSpPr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51417948"/>
                </p:ext>
              </p:extLst>
            </p:nvPr>
          </p:nvGraphicFramePr>
          <p:xfrm>
            <a:off x="2326874" y="2892335"/>
            <a:ext cx="2204253" cy="161364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9" name="TextBox 8"/>
            <p:cNvSpPr txBox="1"/>
            <p:nvPr/>
          </p:nvSpPr>
          <p:spPr>
            <a:xfrm>
              <a:off x="3244673" y="2945956"/>
              <a:ext cx="583814" cy="2553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Hatzis</a:t>
              </a:r>
              <a:endParaRPr 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861784" y="3931263"/>
              <a:ext cx="532518" cy="228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82" dirty="0">
                  <a:latin typeface="Arial" panose="020B0604020202020204" pitchFamily="34" charset="0"/>
                  <a:cs typeface="Arial" panose="020B0604020202020204" pitchFamily="34" charset="0"/>
                </a:rPr>
                <a:t>p&lt;0.05</a:t>
              </a:r>
            </a:p>
          </p:txBody>
        </p:sp>
      </p:grpSp>
      <p:grpSp>
        <p:nvGrpSpPr>
          <p:cNvPr id="10" name="Group 9"/>
          <p:cNvGrpSpPr/>
          <p:nvPr/>
        </p:nvGrpSpPr>
        <p:grpSpPr>
          <a:xfrm>
            <a:off x="981007" y="3816485"/>
            <a:ext cx="2204253" cy="1613647"/>
            <a:chOff x="2326874" y="4605441"/>
            <a:chExt cx="2204253" cy="1613647"/>
          </a:xfrm>
        </p:grpSpPr>
        <p:graphicFrame>
          <p:nvGraphicFramePr>
            <p:cNvPr id="14" name="Chart 1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80461909"/>
                </p:ext>
              </p:extLst>
            </p:nvPr>
          </p:nvGraphicFramePr>
          <p:xfrm>
            <a:off x="2326874" y="4605441"/>
            <a:ext cx="2204253" cy="161364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15" name="TextBox 14"/>
            <p:cNvSpPr txBox="1"/>
            <p:nvPr/>
          </p:nvSpPr>
          <p:spPr>
            <a:xfrm>
              <a:off x="3316007" y="4608886"/>
              <a:ext cx="441146" cy="25532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Kao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3861784" y="5667305"/>
              <a:ext cx="532518" cy="2280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82" dirty="0">
                  <a:latin typeface="Arial" panose="020B0604020202020204" pitchFamily="34" charset="0"/>
                  <a:cs typeface="Arial" panose="020B0604020202020204" pitchFamily="34" charset="0"/>
                </a:rPr>
                <a:t>p&lt;0.05</a:t>
              </a: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3481493" y="3816485"/>
            <a:ext cx="2203704" cy="1618488"/>
            <a:chOff x="2327148" y="6341750"/>
            <a:chExt cx="2203704" cy="1618488"/>
          </a:xfrm>
        </p:grpSpPr>
        <p:graphicFrame>
          <p:nvGraphicFramePr>
            <p:cNvPr id="16" name="Chart 1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71046734"/>
                </p:ext>
              </p:extLst>
            </p:nvPr>
          </p:nvGraphicFramePr>
          <p:xfrm>
            <a:off x="2327148" y="6341750"/>
            <a:ext cx="2203704" cy="16184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7" name="TextBox 16"/>
            <p:cNvSpPr txBox="1"/>
            <p:nvPr/>
          </p:nvSpPr>
          <p:spPr>
            <a:xfrm>
              <a:off x="3917890" y="6595666"/>
              <a:ext cx="47641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=0.4</a:t>
              </a:r>
              <a:endParaRPr lang="en-US" sz="900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803847" y="6341750"/>
              <a:ext cx="1465466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Recurrence to Bone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090785" y="7721948"/>
              <a:ext cx="891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Time (months)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348960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1</TotalTime>
  <Words>30</Words>
  <Application>Microsoft Office PowerPoint</Application>
  <PresentationFormat>Letter Paper (8.5x11 in)</PresentationFormat>
  <Paragraphs>1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WRU S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ds8@case.edu</dc:creator>
  <cp:lastModifiedBy>Balindan, Danica Joy</cp:lastModifiedBy>
  <cp:revision>30</cp:revision>
  <dcterms:created xsi:type="dcterms:W3CDTF">2016-12-05T21:51:29Z</dcterms:created>
  <dcterms:modified xsi:type="dcterms:W3CDTF">2017-05-29T04:54:23Z</dcterms:modified>
</cp:coreProperties>
</file>